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2.xml" ContentType="application/vnd.openxmlformats-officedocument.themeOverride+xml"/>
  <Override PartName="/ppt/notesSlides/notesSlide1.xml" ContentType="application/vnd.openxmlformats-officedocument.presentationml.notesSl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3.xml" ContentType="application/vnd.openxmlformats-officedocument.themeOverr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4.xml" ContentType="application/vnd.openxmlformats-officedocument.themeOverride+xml"/>
  <Override PartName="/ppt/notesSlides/notesSlide2.xml" ContentType="application/vnd.openxmlformats-officedocument.presentationml.notesSl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bookmarkIdSeed="4">
  <p:sldMasterIdLst>
    <p:sldMasterId id="2147483672" r:id="rId1"/>
  </p:sldMasterIdLst>
  <p:notesMasterIdLst>
    <p:notesMasterId r:id="rId20"/>
  </p:notesMasterIdLst>
  <p:handoutMasterIdLst>
    <p:handoutMasterId r:id="rId21"/>
  </p:handoutMasterIdLst>
  <p:sldIdLst>
    <p:sldId id="266" r:id="rId2"/>
    <p:sldId id="284" r:id="rId3"/>
    <p:sldId id="273" r:id="rId4"/>
    <p:sldId id="282" r:id="rId5"/>
    <p:sldId id="274" r:id="rId6"/>
    <p:sldId id="286" r:id="rId7"/>
    <p:sldId id="275" r:id="rId8"/>
    <p:sldId id="276" r:id="rId9"/>
    <p:sldId id="277" r:id="rId10"/>
    <p:sldId id="278" r:id="rId11"/>
    <p:sldId id="283" r:id="rId12"/>
    <p:sldId id="279" r:id="rId13"/>
    <p:sldId id="280" r:id="rId14"/>
    <p:sldId id="281" r:id="rId15"/>
    <p:sldId id="267" r:id="rId16"/>
    <p:sldId id="268" r:id="rId17"/>
    <p:sldId id="269" r:id="rId18"/>
    <p:sldId id="285" r:id="rId19"/>
  </p:sldIdLst>
  <p:sldSz cx="7772400" cy="100584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General" id="{95FB4241-B7FE-4E3E-9D8B-B73A0286C377}">
          <p14:sldIdLst>
            <p14:sldId id="266"/>
            <p14:sldId id="284"/>
            <p14:sldId id="273"/>
            <p14:sldId id="282"/>
            <p14:sldId id="274"/>
            <p14:sldId id="286"/>
            <p14:sldId id="275"/>
            <p14:sldId id="276"/>
            <p14:sldId id="277"/>
            <p14:sldId id="278"/>
            <p14:sldId id="283"/>
            <p14:sldId id="279"/>
            <p14:sldId id="280"/>
            <p14:sldId id="281"/>
            <p14:sldId id="267"/>
            <p14:sldId id="268"/>
            <p14:sldId id="269"/>
            <p14:sldId id="285"/>
          </p14:sldIdLst>
        </p14:section>
      </p14:sectionLst>
    </p:ext>
    <p:ext uri="{EFAFB233-063F-42B5-8137-9DF3F51BA10A}">
      <p15:sldGuideLst xmlns:p15="http://schemas.microsoft.com/office/powerpoint/2012/main">
        <p15:guide id="1" orient="horz" pos="3168">
          <p15:clr>
            <a:srgbClr val="A4A3A4"/>
          </p15:clr>
        </p15:guide>
        <p15:guide id="2" pos="2448">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Dang, Harry" initials="DH" lastIdx="5" clrIdx="0">
    <p:extLst>
      <p:ext uri="{19B8F6BF-5375-455C-9EA6-DF929625EA0E}">
        <p15:presenceInfo xmlns:p15="http://schemas.microsoft.com/office/powerpoint/2012/main" userId="Dang, Harry" providerId="None"/>
      </p:ext>
    </p:extLst>
  </p:cmAuthor>
  <p:cmAuthor id="2" name="Leopold, Leo" initials="LL" lastIdx="2" clrIdx="1">
    <p:extLst>
      <p:ext uri="{19B8F6BF-5375-455C-9EA6-DF929625EA0E}">
        <p15:presenceInfo xmlns:p15="http://schemas.microsoft.com/office/powerpoint/2012/main" userId="S-1-5-21-1177238915-1767777339-682003330-11779"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F005E"/>
    <a:srgbClr val="0000C1"/>
    <a:srgbClr val="CC0066"/>
    <a:srgbClr val="25248F"/>
    <a:srgbClr val="C00000"/>
    <a:srgbClr val="C10000"/>
    <a:srgbClr val="FFFFFF"/>
    <a:srgbClr val="8B8BE3"/>
    <a:srgbClr val="10C510"/>
    <a:srgbClr val="C100C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949" autoAdjust="0"/>
    <p:restoredTop sz="94637"/>
  </p:normalViewPr>
  <p:slideViewPr>
    <p:cSldViewPr snapToGrid="0">
      <p:cViewPr varScale="1">
        <p:scale>
          <a:sx n="74" d="100"/>
          <a:sy n="74" d="100"/>
        </p:scale>
        <p:origin x="3312" y="72"/>
      </p:cViewPr>
      <p:guideLst>
        <p:guide orient="horz" pos="3168"/>
        <p:guide pos="2448"/>
      </p:guideLst>
    </p:cSldViewPr>
  </p:slideViewPr>
  <p:notesTextViewPr>
    <p:cViewPr>
      <p:scale>
        <a:sx n="1" d="1"/>
        <a:sy n="1" d="1"/>
      </p:scale>
      <p:origin x="0" y="0"/>
    </p:cViewPr>
  </p:notesTextViewPr>
  <p:sorterViewPr>
    <p:cViewPr>
      <p:scale>
        <a:sx n="100" d="100"/>
        <a:sy n="100" d="100"/>
      </p:scale>
      <p:origin x="0" y="0"/>
    </p:cViewPr>
  </p:sorterViewPr>
  <p:notesViewPr>
    <p:cSldViewPr snapToGrid="0">
      <p:cViewPr varScale="1">
        <p:scale>
          <a:sx n="66" d="100"/>
          <a:sy n="66" d="100"/>
        </p:scale>
        <p:origin x="0" y="0"/>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handoutMaster" Target="handoutMasters/handout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oleObject" Target="file:///\\Users\ahwemple\Desktop\DataAnalysis_CalibrationCurve_Xanthine_EnzymeLoading.xlsx" TargetMode="External"/></Relationships>
</file>

<file path=ppt/charts/_rels/chart10.xml.rels><?xml version="1.0" encoding="UTF-8" standalone="yes"?>
<Relationships xmlns="http://schemas.openxmlformats.org/package/2006/relationships"><Relationship Id="rId3" Type="http://schemas.openxmlformats.org/officeDocument/2006/relationships/oleObject" Target="file:///\\Users\ahwemple\Downloads\XanthineInterferentTemplate_C3_Day%203.xlsx" TargetMode="External"/><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oleObject" Target="file:///\\Users\ahwemple\Desktop\XanthineInterferentC4_2.xlsx" TargetMode="External"/><Relationship Id="rId2" Type="http://schemas.microsoft.com/office/2011/relationships/chartColorStyle" Target="colors11.xml"/><Relationship Id="rId1" Type="http://schemas.microsoft.com/office/2011/relationships/chartStyle" Target="style11.xml"/></Relationships>
</file>

<file path=ppt/charts/_rels/chart12.xml.rels><?xml version="1.0" encoding="UTF-8" standalone="yes"?>
<Relationships xmlns="http://schemas.openxmlformats.org/package/2006/relationships"><Relationship Id="rId3" Type="http://schemas.openxmlformats.org/officeDocument/2006/relationships/oleObject" Target="file:///\\Users\ahwemple\Desktop\XanthineInterferentTemplate_C6_2.xlsx" TargetMode="External"/><Relationship Id="rId2" Type="http://schemas.microsoft.com/office/2011/relationships/chartColorStyle" Target="colors12.xml"/><Relationship Id="rId1" Type="http://schemas.microsoft.com/office/2011/relationships/chartStyle" Target="style12.xml"/></Relationships>
</file>

<file path=ppt/charts/_rels/chart13.xml.rels><?xml version="1.0" encoding="UTF-8" standalone="yes"?>
<Relationships xmlns="http://schemas.openxmlformats.org/package/2006/relationships"><Relationship Id="rId3" Type="http://schemas.openxmlformats.org/officeDocument/2006/relationships/oleObject" Target="file:///\\Users\ahwemple\Desktop\XanthineInterferentTemplate_C6_2.xlsx" TargetMode="External"/><Relationship Id="rId2" Type="http://schemas.microsoft.com/office/2011/relationships/chartColorStyle" Target="colors13.xml"/><Relationship Id="rId1" Type="http://schemas.microsoft.com/office/2011/relationships/chartStyle" Target="style13.xml"/></Relationships>
</file>

<file path=ppt/charts/_rels/chart14.xml.rels><?xml version="1.0" encoding="UTF-8" standalone="yes"?>
<Relationships xmlns="http://schemas.openxmlformats.org/package/2006/relationships"><Relationship Id="rId3" Type="http://schemas.openxmlformats.org/officeDocument/2006/relationships/oleObject" Target="file:///\\Users\ahwemple\Desktop\XanthineInterferentC4_2.xlsx" TargetMode="External"/><Relationship Id="rId2" Type="http://schemas.microsoft.com/office/2011/relationships/chartColorStyle" Target="colors14.xml"/><Relationship Id="rId1" Type="http://schemas.microsoft.com/office/2011/relationships/chartStyle" Target="style14.xml"/></Relationships>
</file>

<file path=ppt/charts/_rels/chart2.xml.rels><?xml version="1.0" encoding="UTF-8" standalone="yes"?>
<Relationships xmlns="http://schemas.openxmlformats.org/package/2006/relationships"><Relationship Id="rId3" Type="http://schemas.openxmlformats.org/officeDocument/2006/relationships/oleObject" Target="file:///\\Users\ahwemple\Desktop\DataAnalysis_CalibrationCurve_Xanthine_TEES_MPCSize.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oleObject" Target="../embeddings/oleObject1.bin"/></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oleObject" Target="../embeddings/oleObject2.bin"/></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oleObject" Target="../embeddings/oleObject3.bin"/></Relationships>
</file>

<file path=ppt/charts/_rels/chart6.xml.rels><?xml version="1.0" encoding="UTF-8" standalone="yes"?>
<Relationships xmlns="http://schemas.openxmlformats.org/package/2006/relationships"><Relationship Id="rId3" Type="http://schemas.openxmlformats.org/officeDocument/2006/relationships/oleObject" Target="file:///\\Users\ahwemple\Downloads\DataAnalysis_CalibrationCurve_Xanthine_TEES_LongevitySensivity_C6_2.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Users\ahwemple\Downloads\CalibrationCurve_Xanthine_TEES_LongevitySensivity_C3.xlsx"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Users\ahwemple\Desktop\CalibrationCurve_Xanthine_TEES_LongevitySensivity_C4_2.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file:///C:\Users\mleopold\Documents\UR_Research\MANUSCRIPTS\XANTHINE\2023\TEES_C6_Hypoxanthine.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3375834030035236"/>
          <c:y val="2.4950124565118255E-2"/>
          <c:w val="0.82291189149413857"/>
          <c:h val="0.80190592701575403"/>
        </c:manualLayout>
      </c:layout>
      <c:scatterChart>
        <c:scatterStyle val="lineMarker"/>
        <c:varyColors val="0"/>
        <c:ser>
          <c:idx val="0"/>
          <c:order val="0"/>
          <c:tx>
            <c:strRef>
              <c:f>'Cal Curves'!$D$46</c:f>
              <c:strCache>
                <c:ptCount val="1"/>
                <c:pt idx="0">
                  <c:v>12mg</c:v>
                </c:pt>
              </c:strCache>
            </c:strRef>
          </c:tx>
          <c:spPr>
            <a:ln w="28575" cap="rnd">
              <a:noFill/>
              <a:round/>
            </a:ln>
            <a:effectLst/>
          </c:spPr>
          <c:marker>
            <c:symbol val="triangle"/>
            <c:size val="7"/>
            <c:spPr>
              <a:solidFill>
                <a:schemeClr val="accent1"/>
              </a:solidFill>
              <a:ln w="9525">
                <a:solidFill>
                  <a:schemeClr val="accent1"/>
                </a:solidFill>
              </a:ln>
              <a:effectLst/>
            </c:spPr>
          </c:marker>
          <c:errBars>
            <c:errDir val="y"/>
            <c:errBarType val="both"/>
            <c:errValType val="cust"/>
            <c:noEndCap val="0"/>
            <c:plus>
              <c:numRef>
                <c:f>'Cal Curves'!$E$26:$E$41</c:f>
                <c:numCache>
                  <c:formatCode>General</c:formatCode>
                  <c:ptCount val="16"/>
                  <c:pt idx="0">
                    <c:v>5.2104796499999996E-3</c:v>
                  </c:pt>
                  <c:pt idx="1">
                    <c:v>3.0950195739999999E-2</c:v>
                  </c:pt>
                  <c:pt idx="2">
                    <c:v>5.9048173789999998E-2</c:v>
                  </c:pt>
                  <c:pt idx="3">
                    <c:v>8.6827713649999999E-2</c:v>
                  </c:pt>
                  <c:pt idx="4">
                    <c:v>0.12567033720000001</c:v>
                  </c:pt>
                  <c:pt idx="5">
                    <c:v>0.14947186909999999</c:v>
                  </c:pt>
                  <c:pt idx="6">
                    <c:v>0.1979880188</c:v>
                  </c:pt>
                  <c:pt idx="7">
                    <c:v>0.2393127562</c:v>
                  </c:pt>
                  <c:pt idx="8">
                    <c:v>0.28005503980000002</c:v>
                  </c:pt>
                  <c:pt idx="9">
                    <c:v>0.3224665216</c:v>
                  </c:pt>
                  <c:pt idx="10">
                    <c:v>0.36374523780000001</c:v>
                  </c:pt>
                  <c:pt idx="11">
                    <c:v>0.37278113569999999</c:v>
                  </c:pt>
                  <c:pt idx="12">
                    <c:v>0.41992176799999997</c:v>
                  </c:pt>
                  <c:pt idx="13">
                    <c:v>0.44182961120000003</c:v>
                  </c:pt>
                  <c:pt idx="14">
                    <c:v>0.4136456288</c:v>
                  </c:pt>
                  <c:pt idx="15">
                    <c:v>0.46171295369999998</c:v>
                  </c:pt>
                </c:numCache>
              </c:numRef>
            </c:plus>
            <c:minus>
              <c:numRef>
                <c:f>'Cal Curves'!$E$26:$E$41</c:f>
                <c:numCache>
                  <c:formatCode>General</c:formatCode>
                  <c:ptCount val="16"/>
                  <c:pt idx="0">
                    <c:v>5.2104796499999996E-3</c:v>
                  </c:pt>
                  <c:pt idx="1">
                    <c:v>3.0950195739999999E-2</c:v>
                  </c:pt>
                  <c:pt idx="2">
                    <c:v>5.9048173789999998E-2</c:v>
                  </c:pt>
                  <c:pt idx="3">
                    <c:v>8.6827713649999999E-2</c:v>
                  </c:pt>
                  <c:pt idx="4">
                    <c:v>0.12567033720000001</c:v>
                  </c:pt>
                  <c:pt idx="5">
                    <c:v>0.14947186909999999</c:v>
                  </c:pt>
                  <c:pt idx="6">
                    <c:v>0.1979880188</c:v>
                  </c:pt>
                  <c:pt idx="7">
                    <c:v>0.2393127562</c:v>
                  </c:pt>
                  <c:pt idx="8">
                    <c:v>0.28005503980000002</c:v>
                  </c:pt>
                  <c:pt idx="9">
                    <c:v>0.3224665216</c:v>
                  </c:pt>
                  <c:pt idx="10">
                    <c:v>0.36374523780000001</c:v>
                  </c:pt>
                  <c:pt idx="11">
                    <c:v>0.37278113569999999</c:v>
                  </c:pt>
                  <c:pt idx="12">
                    <c:v>0.41992176799999997</c:v>
                  </c:pt>
                  <c:pt idx="13">
                    <c:v>0.44182961120000003</c:v>
                  </c:pt>
                  <c:pt idx="14">
                    <c:v>0.4136456288</c:v>
                  </c:pt>
                  <c:pt idx="15">
                    <c:v>0.46171295369999998</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Cal Curves'!$C$47:$C$62</c:f>
              <c:numCache>
                <c:formatCode>General</c:formatCode>
                <c:ptCount val="16"/>
                <c:pt idx="0">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c:v>599.99999999999977</c:v>
                </c:pt>
              </c:numCache>
            </c:numRef>
          </c:xVal>
          <c:yVal>
            <c:numRef>
              <c:f>'Cal Curves'!$D$47:$D$62</c:f>
              <c:numCache>
                <c:formatCode>General</c:formatCode>
                <c:ptCount val="16"/>
                <c:pt idx="0">
                  <c:v>1.3899999999999999E-2</c:v>
                </c:pt>
                <c:pt idx="1">
                  <c:v>0.16400000000000001</c:v>
                </c:pt>
                <c:pt idx="2">
                  <c:v>0.27360000000000001</c:v>
                </c:pt>
                <c:pt idx="3">
                  <c:v>0.40110000000000001</c:v>
                </c:pt>
                <c:pt idx="4">
                  <c:v>0.52390000000000003</c:v>
                </c:pt>
                <c:pt idx="5">
                  <c:v>0.60880000000000001</c:v>
                </c:pt>
                <c:pt idx="6">
                  <c:v>0.71330000000000005</c:v>
                </c:pt>
                <c:pt idx="7">
                  <c:v>0.80310000000000004</c:v>
                </c:pt>
                <c:pt idx="8">
                  <c:v>0.876</c:v>
                </c:pt>
                <c:pt idx="9">
                  <c:v>0.98340000000000005</c:v>
                </c:pt>
                <c:pt idx="10">
                  <c:v>1.0754999999999999</c:v>
                </c:pt>
                <c:pt idx="11">
                  <c:v>1.131</c:v>
                </c:pt>
                <c:pt idx="12">
                  <c:v>1.2294</c:v>
                </c:pt>
                <c:pt idx="13">
                  <c:v>1.2984</c:v>
                </c:pt>
                <c:pt idx="14">
                  <c:v>1.3412999999999999</c:v>
                </c:pt>
                <c:pt idx="15">
                  <c:v>1.4444999999999999</c:v>
                </c:pt>
              </c:numCache>
            </c:numRef>
          </c:yVal>
          <c:smooth val="0"/>
          <c:extLst>
            <c:ext xmlns:c16="http://schemas.microsoft.com/office/drawing/2014/chart" uri="{C3380CC4-5D6E-409C-BE32-E72D297353CC}">
              <c16:uniqueId val="{00000000-AEC6-4B23-9CAD-DE3432AAD81E}"/>
            </c:ext>
          </c:extLst>
        </c:ser>
        <c:ser>
          <c:idx val="1"/>
          <c:order val="1"/>
          <c:tx>
            <c:strRef>
              <c:f>'Cal Curves'!$E$46</c:f>
              <c:strCache>
                <c:ptCount val="1"/>
                <c:pt idx="0">
                  <c:v>8mg</c:v>
                </c:pt>
              </c:strCache>
            </c:strRef>
          </c:tx>
          <c:spPr>
            <a:ln w="28575" cap="rnd">
              <a:noFill/>
              <a:round/>
            </a:ln>
            <a:effectLst/>
          </c:spPr>
          <c:marker>
            <c:symbol val="diamond"/>
            <c:size val="7"/>
            <c:spPr>
              <a:solidFill>
                <a:schemeClr val="accent2"/>
              </a:solidFill>
              <a:ln w="9525">
                <a:solidFill>
                  <a:schemeClr val="accent2"/>
                </a:solidFill>
              </a:ln>
              <a:effectLst/>
            </c:spPr>
          </c:marker>
          <c:errBars>
            <c:errDir val="y"/>
            <c:errBarType val="both"/>
            <c:errValType val="cust"/>
            <c:noEndCap val="0"/>
            <c:plus>
              <c:numRef>
                <c:f>'Cal Curves'!$G$26:$G$41</c:f>
                <c:numCache>
                  <c:formatCode>General</c:formatCode>
                  <c:ptCount val="16"/>
                  <c:pt idx="0">
                    <c:v>3.7752779610000001E-3</c:v>
                  </c:pt>
                  <c:pt idx="1">
                    <c:v>1.5482144369999999E-2</c:v>
                  </c:pt>
                  <c:pt idx="2">
                    <c:v>2.975389254E-2</c:v>
                  </c:pt>
                  <c:pt idx="3">
                    <c:v>4.6695101879999999E-2</c:v>
                  </c:pt>
                  <c:pt idx="4">
                    <c:v>6.3159635019999993E-2</c:v>
                  </c:pt>
                  <c:pt idx="5">
                    <c:v>8.9301449310000003E-2</c:v>
                  </c:pt>
                  <c:pt idx="6">
                    <c:v>0.1036091421</c:v>
                  </c:pt>
                  <c:pt idx="7">
                    <c:v>0.1254205524</c:v>
                  </c:pt>
                  <c:pt idx="8">
                    <c:v>0.124093008</c:v>
                  </c:pt>
                  <c:pt idx="9">
                    <c:v>9.4474782150000006E-2</c:v>
                  </c:pt>
                  <c:pt idx="10">
                    <c:v>0.11204585810000001</c:v>
                  </c:pt>
                  <c:pt idx="11">
                    <c:v>0.1065868413</c:v>
                  </c:pt>
                  <c:pt idx="12">
                    <c:v>0.1232303075</c:v>
                  </c:pt>
                  <c:pt idx="13">
                    <c:v>0.1143205174</c:v>
                  </c:pt>
                  <c:pt idx="14">
                    <c:v>0.1318851248</c:v>
                  </c:pt>
                  <c:pt idx="15">
                    <c:v>0.13786928609999999</c:v>
                  </c:pt>
                </c:numCache>
              </c:numRef>
            </c:plus>
            <c:minus>
              <c:numRef>
                <c:f>'Cal Curves'!$G$26:$G$41</c:f>
                <c:numCache>
                  <c:formatCode>General</c:formatCode>
                  <c:ptCount val="16"/>
                  <c:pt idx="0">
                    <c:v>3.7752779610000001E-3</c:v>
                  </c:pt>
                  <c:pt idx="1">
                    <c:v>1.5482144369999999E-2</c:v>
                  </c:pt>
                  <c:pt idx="2">
                    <c:v>2.975389254E-2</c:v>
                  </c:pt>
                  <c:pt idx="3">
                    <c:v>4.6695101879999999E-2</c:v>
                  </c:pt>
                  <c:pt idx="4">
                    <c:v>6.3159635019999993E-2</c:v>
                  </c:pt>
                  <c:pt idx="5">
                    <c:v>8.9301449310000003E-2</c:v>
                  </c:pt>
                  <c:pt idx="6">
                    <c:v>0.1036091421</c:v>
                  </c:pt>
                  <c:pt idx="7">
                    <c:v>0.1254205524</c:v>
                  </c:pt>
                  <c:pt idx="8">
                    <c:v>0.124093008</c:v>
                  </c:pt>
                  <c:pt idx="9">
                    <c:v>9.4474782150000006E-2</c:v>
                  </c:pt>
                  <c:pt idx="10">
                    <c:v>0.11204585810000001</c:v>
                  </c:pt>
                  <c:pt idx="11">
                    <c:v>0.1065868413</c:v>
                  </c:pt>
                  <c:pt idx="12">
                    <c:v>0.1232303075</c:v>
                  </c:pt>
                  <c:pt idx="13">
                    <c:v>0.1143205174</c:v>
                  </c:pt>
                  <c:pt idx="14">
                    <c:v>0.1318851248</c:v>
                  </c:pt>
                  <c:pt idx="15">
                    <c:v>0.13786928609999999</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Cal Curves'!$C$47:$C$62</c:f>
              <c:numCache>
                <c:formatCode>General</c:formatCode>
                <c:ptCount val="16"/>
                <c:pt idx="0">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c:v>599.99999999999977</c:v>
                </c:pt>
              </c:numCache>
            </c:numRef>
          </c:xVal>
          <c:yVal>
            <c:numRef>
              <c:f>'Cal Curves'!$E$47:$E$62</c:f>
              <c:numCache>
                <c:formatCode>General</c:formatCode>
                <c:ptCount val="16"/>
                <c:pt idx="0">
                  <c:v>1.3899999999999999E-2</c:v>
                </c:pt>
                <c:pt idx="1">
                  <c:v>0.13389999999999999</c:v>
                </c:pt>
                <c:pt idx="2">
                  <c:v>0.21479999999999999</c:v>
                </c:pt>
                <c:pt idx="3">
                  <c:v>0.29070000000000001</c:v>
                </c:pt>
                <c:pt idx="4">
                  <c:v>0.35060000000000002</c:v>
                </c:pt>
                <c:pt idx="5">
                  <c:v>0.42920000000000003</c:v>
                </c:pt>
                <c:pt idx="6">
                  <c:v>0.49909999999999999</c:v>
                </c:pt>
                <c:pt idx="7">
                  <c:v>0.56369999999999998</c:v>
                </c:pt>
                <c:pt idx="8">
                  <c:v>0.61360000000000003</c:v>
                </c:pt>
                <c:pt idx="9">
                  <c:v>0.63570000000000004</c:v>
                </c:pt>
                <c:pt idx="10">
                  <c:v>0.69020000000000004</c:v>
                </c:pt>
                <c:pt idx="11">
                  <c:v>0.72650000000000003</c:v>
                </c:pt>
                <c:pt idx="12">
                  <c:v>0.77039999999999997</c:v>
                </c:pt>
                <c:pt idx="13">
                  <c:v>0.7651</c:v>
                </c:pt>
                <c:pt idx="14">
                  <c:v>0.83620000000000005</c:v>
                </c:pt>
                <c:pt idx="15">
                  <c:v>0.86609999999999998</c:v>
                </c:pt>
              </c:numCache>
            </c:numRef>
          </c:yVal>
          <c:smooth val="0"/>
          <c:extLst>
            <c:ext xmlns:c16="http://schemas.microsoft.com/office/drawing/2014/chart" uri="{C3380CC4-5D6E-409C-BE32-E72D297353CC}">
              <c16:uniqueId val="{00000001-AEC6-4B23-9CAD-DE3432AAD81E}"/>
            </c:ext>
          </c:extLst>
        </c:ser>
        <c:ser>
          <c:idx val="2"/>
          <c:order val="2"/>
          <c:tx>
            <c:strRef>
              <c:f>'Cal Curves'!$F$46</c:f>
              <c:strCache>
                <c:ptCount val="1"/>
                <c:pt idx="0">
                  <c:v>4mg</c:v>
                </c:pt>
              </c:strCache>
            </c:strRef>
          </c:tx>
          <c:spPr>
            <a:ln w="28575" cap="rnd">
              <a:noFill/>
              <a:round/>
            </a:ln>
            <a:effectLst/>
          </c:spPr>
          <c:marker>
            <c:symbol val="circle"/>
            <c:size val="7"/>
            <c:spPr>
              <a:solidFill>
                <a:schemeClr val="accent3"/>
              </a:solidFill>
              <a:ln w="9525">
                <a:solidFill>
                  <a:schemeClr val="accent3"/>
                </a:solidFill>
              </a:ln>
              <a:effectLst/>
            </c:spPr>
          </c:marker>
          <c:errBars>
            <c:errDir val="y"/>
            <c:errBarType val="both"/>
            <c:errValType val="cust"/>
            <c:noEndCap val="0"/>
            <c:plus>
              <c:numRef>
                <c:f>'Cal Curves'!$I$26:$I$41</c:f>
                <c:numCache>
                  <c:formatCode>General</c:formatCode>
                  <c:ptCount val="16"/>
                  <c:pt idx="0">
                    <c:v>4.383118347E-3</c:v>
                  </c:pt>
                  <c:pt idx="1">
                    <c:v>1.461396331E-2</c:v>
                  </c:pt>
                  <c:pt idx="2">
                    <c:v>2.9492553370000001E-2</c:v>
                  </c:pt>
                  <c:pt idx="3">
                    <c:v>4.1362017309999999E-2</c:v>
                  </c:pt>
                  <c:pt idx="4">
                    <c:v>4.8159253440000001E-2</c:v>
                  </c:pt>
                  <c:pt idx="5">
                    <c:v>5.357522319E-2</c:v>
                  </c:pt>
                  <c:pt idx="6">
                    <c:v>5.7332322120000001E-2</c:v>
                  </c:pt>
                  <c:pt idx="7">
                    <c:v>5.7700861360000001E-2</c:v>
                  </c:pt>
                  <c:pt idx="8">
                    <c:v>6.2725791150000001E-2</c:v>
                  </c:pt>
                  <c:pt idx="9">
                    <c:v>6.9464604439999994E-2</c:v>
                  </c:pt>
                  <c:pt idx="10">
                    <c:v>7.0836718709999996E-2</c:v>
                  </c:pt>
                  <c:pt idx="11">
                    <c:v>7.1986614249999997E-2</c:v>
                  </c:pt>
                  <c:pt idx="12">
                    <c:v>7.3878315200000003E-2</c:v>
                  </c:pt>
                  <c:pt idx="13">
                    <c:v>7.4848101959999996E-2</c:v>
                  </c:pt>
                  <c:pt idx="14">
                    <c:v>7.5504806980000005E-2</c:v>
                  </c:pt>
                  <c:pt idx="15">
                    <c:v>7.7103560380000005E-2</c:v>
                  </c:pt>
                </c:numCache>
              </c:numRef>
            </c:plus>
            <c:minus>
              <c:numRef>
                <c:f>'Cal Curves'!$I$26:$I$41</c:f>
                <c:numCache>
                  <c:formatCode>General</c:formatCode>
                  <c:ptCount val="16"/>
                  <c:pt idx="0">
                    <c:v>4.383118347E-3</c:v>
                  </c:pt>
                  <c:pt idx="1">
                    <c:v>1.461396331E-2</c:v>
                  </c:pt>
                  <c:pt idx="2">
                    <c:v>2.9492553370000001E-2</c:v>
                  </c:pt>
                  <c:pt idx="3">
                    <c:v>4.1362017309999999E-2</c:v>
                  </c:pt>
                  <c:pt idx="4">
                    <c:v>4.8159253440000001E-2</c:v>
                  </c:pt>
                  <c:pt idx="5">
                    <c:v>5.357522319E-2</c:v>
                  </c:pt>
                  <c:pt idx="6">
                    <c:v>5.7332322120000001E-2</c:v>
                  </c:pt>
                  <c:pt idx="7">
                    <c:v>5.7700861360000001E-2</c:v>
                  </c:pt>
                  <c:pt idx="8">
                    <c:v>6.2725791150000001E-2</c:v>
                  </c:pt>
                  <c:pt idx="9">
                    <c:v>6.9464604439999994E-2</c:v>
                  </c:pt>
                  <c:pt idx="10">
                    <c:v>7.0836718709999996E-2</c:v>
                  </c:pt>
                  <c:pt idx="11">
                    <c:v>7.1986614249999997E-2</c:v>
                  </c:pt>
                  <c:pt idx="12">
                    <c:v>7.3878315200000003E-2</c:v>
                  </c:pt>
                  <c:pt idx="13">
                    <c:v>7.4848101959999996E-2</c:v>
                  </c:pt>
                  <c:pt idx="14">
                    <c:v>7.5504806980000005E-2</c:v>
                  </c:pt>
                  <c:pt idx="15">
                    <c:v>7.7103560380000005E-2</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Cal Curves'!$C$47:$C$62</c:f>
              <c:numCache>
                <c:formatCode>General</c:formatCode>
                <c:ptCount val="16"/>
                <c:pt idx="0">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c:v>599.99999999999977</c:v>
                </c:pt>
              </c:numCache>
            </c:numRef>
          </c:xVal>
          <c:yVal>
            <c:numRef>
              <c:f>'Cal Curves'!$F$47:$F$62</c:f>
              <c:numCache>
                <c:formatCode>General</c:formatCode>
                <c:ptCount val="16"/>
                <c:pt idx="0">
                  <c:v>7.7000000000000002E-3</c:v>
                </c:pt>
                <c:pt idx="1">
                  <c:v>3.8199999999999998E-2</c:v>
                </c:pt>
                <c:pt idx="2">
                  <c:v>6.7500000000000004E-2</c:v>
                </c:pt>
                <c:pt idx="3">
                  <c:v>9.2999999999999999E-2</c:v>
                </c:pt>
                <c:pt idx="4">
                  <c:v>0.111</c:v>
                </c:pt>
                <c:pt idx="5">
                  <c:v>0.12609999999999999</c:v>
                </c:pt>
                <c:pt idx="6">
                  <c:v>0.13739999999999999</c:v>
                </c:pt>
                <c:pt idx="7">
                  <c:v>0.14050000000000001</c:v>
                </c:pt>
                <c:pt idx="8">
                  <c:v>0.154</c:v>
                </c:pt>
                <c:pt idx="9">
                  <c:v>0.17330000000000001</c:v>
                </c:pt>
                <c:pt idx="10">
                  <c:v>0.1799</c:v>
                </c:pt>
                <c:pt idx="11">
                  <c:v>0.186</c:v>
                </c:pt>
                <c:pt idx="12">
                  <c:v>0.19500000000000001</c:v>
                </c:pt>
                <c:pt idx="13">
                  <c:v>0.20399999999999999</c:v>
                </c:pt>
                <c:pt idx="14">
                  <c:v>0.21099999999999999</c:v>
                </c:pt>
                <c:pt idx="15">
                  <c:v>0.222</c:v>
                </c:pt>
              </c:numCache>
            </c:numRef>
          </c:yVal>
          <c:smooth val="0"/>
          <c:extLst>
            <c:ext xmlns:c16="http://schemas.microsoft.com/office/drawing/2014/chart" uri="{C3380CC4-5D6E-409C-BE32-E72D297353CC}">
              <c16:uniqueId val="{00000002-AEC6-4B23-9CAD-DE3432AAD81E}"/>
            </c:ext>
          </c:extLst>
        </c:ser>
        <c:dLbls>
          <c:showLegendKey val="0"/>
          <c:showVal val="0"/>
          <c:showCatName val="0"/>
          <c:showSerName val="0"/>
          <c:showPercent val="0"/>
          <c:showBubbleSize val="0"/>
        </c:dLbls>
        <c:axId val="1954269295"/>
        <c:axId val="1954355807"/>
      </c:scatterChart>
      <c:valAx>
        <c:axId val="1954269295"/>
        <c:scaling>
          <c:orientation val="minMax"/>
          <c:max val="625"/>
          <c:min val="0"/>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1000" b="1"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r>
                  <a:rPr lang="en-US" sz="2000" b="1">
                    <a:solidFill>
                      <a:schemeClr val="tx1"/>
                    </a:solidFill>
                    <a:latin typeface="Times New Roman" panose="02020603050405020304" pitchFamily="18" charset="0"/>
                    <a:cs typeface="Times New Roman" panose="02020603050405020304" pitchFamily="18" charset="0"/>
                  </a:rPr>
                  <a:t>Xanthine Concentration (</a:t>
                </a:r>
                <a:r>
                  <a:rPr lang="el-GR" sz="2000" b="1" i="0" u="none" strike="noStrike" baseline="0">
                    <a:solidFill>
                      <a:schemeClr val="tx1"/>
                    </a:solidFill>
                    <a:effectLst/>
                    <a:latin typeface="Times New Roman" panose="02020603050405020304" pitchFamily="18" charset="0"/>
                    <a:cs typeface="Times New Roman" panose="02020603050405020304" pitchFamily="18" charset="0"/>
                  </a:rPr>
                  <a:t>μ</a:t>
                </a:r>
                <a:r>
                  <a:rPr lang="en-US" sz="2000" b="1">
                    <a:solidFill>
                      <a:schemeClr val="tx1"/>
                    </a:solidFill>
                    <a:latin typeface="Times New Roman" panose="02020603050405020304" pitchFamily="18" charset="0"/>
                    <a:cs typeface="Times New Roman" panose="02020603050405020304" pitchFamily="18" charset="0"/>
                  </a:rPr>
                  <a:t>M)</a:t>
                </a:r>
              </a:p>
            </c:rich>
          </c:tx>
          <c:layout>
            <c:manualLayout>
              <c:xMode val="edge"/>
              <c:yMode val="edge"/>
              <c:x val="0.27436178620275975"/>
              <c:y val="0.91983769072339794"/>
            </c:manualLayout>
          </c:layout>
          <c:overlay val="0"/>
          <c:spPr>
            <a:noFill/>
            <a:ln>
              <a:noFill/>
            </a:ln>
            <a:effectLst/>
          </c:spPr>
          <c:txPr>
            <a:bodyPr rot="0" spcFirstLastPara="1" vertOverflow="ellipsis" vert="horz" wrap="square" anchor="ctr" anchorCtr="1"/>
            <a:lstStyle/>
            <a:p>
              <a:pPr>
                <a:defRPr sz="1000" b="1"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out"/>
        <c:minorTickMark val="none"/>
        <c:tickLblPos val="nextTo"/>
        <c:spPr>
          <a:noFill/>
          <a:ln w="9525" cap="flat" cmpd="sng" algn="ctr">
            <a:solidFill>
              <a:srgbClr val="000000"/>
            </a:solidFill>
            <a:round/>
          </a:ln>
          <a:effectLst/>
        </c:spPr>
        <c:txPr>
          <a:bodyPr rot="-60000000" spcFirstLastPara="1" vertOverflow="ellipsis" vert="horz" wrap="square" anchor="ctr" anchorCtr="1"/>
          <a:lstStyle/>
          <a:p>
            <a:pPr>
              <a:defRPr sz="16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1954355807"/>
        <c:crossesAt val="0"/>
        <c:crossBetween val="midCat"/>
      </c:valAx>
      <c:valAx>
        <c:axId val="1954355807"/>
        <c:scaling>
          <c:orientation val="minMax"/>
          <c:max val="2"/>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r>
                  <a:rPr lang="en-US" sz="2000" b="1">
                    <a:solidFill>
                      <a:schemeClr val="tx1"/>
                    </a:solidFill>
                    <a:latin typeface="Times New Roman" panose="02020603050405020304" pitchFamily="18" charset="0"/>
                    <a:cs typeface="Times New Roman" panose="02020603050405020304" pitchFamily="18" charset="0"/>
                  </a:rPr>
                  <a:t>Current (</a:t>
                </a:r>
                <a:r>
                  <a:rPr lang="el-GR" sz="2000" b="1">
                    <a:solidFill>
                      <a:schemeClr val="tx1"/>
                    </a:solidFill>
                    <a:latin typeface="Times New Roman" panose="02020603050405020304" pitchFamily="18" charset="0"/>
                    <a:cs typeface="Times New Roman" panose="02020603050405020304" pitchFamily="18" charset="0"/>
                  </a:rPr>
                  <a:t>μ</a:t>
                </a:r>
                <a:r>
                  <a:rPr lang="en-US" sz="2000" b="1">
                    <a:solidFill>
                      <a:schemeClr val="tx1"/>
                    </a:solidFill>
                    <a:latin typeface="Times New Roman" panose="02020603050405020304" pitchFamily="18" charset="0"/>
                    <a:cs typeface="Times New Roman" panose="02020603050405020304" pitchFamily="18" charset="0"/>
                  </a:rPr>
                  <a:t>A)</a:t>
                </a:r>
              </a:p>
            </c:rich>
          </c:tx>
          <c:layout>
            <c:manualLayout>
              <c:xMode val="edge"/>
              <c:yMode val="edge"/>
              <c:x val="0"/>
              <c:y val="0.23860080402983394"/>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out"/>
        <c:minorTickMark val="none"/>
        <c:tickLblPos val="nextTo"/>
        <c:spPr>
          <a:noFill/>
          <a:ln w="9525" cap="flat" cmpd="sng" algn="ctr">
            <a:solidFill>
              <a:srgbClr val="000000"/>
            </a:solidFill>
            <a:round/>
          </a:ln>
          <a:effectLst/>
        </c:spPr>
        <c:txPr>
          <a:bodyPr rot="-60000000" spcFirstLastPara="1" vertOverflow="ellipsis" vert="horz" wrap="square" anchor="ctr" anchorCtr="1"/>
          <a:lstStyle/>
          <a:p>
            <a:pPr>
              <a:defRPr sz="16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1954269295"/>
        <c:crossesAt val="0"/>
        <c:crossBetween val="midCat"/>
      </c:valAx>
      <c:spPr>
        <a:noFill/>
        <a:ln w="25400">
          <a:noFill/>
        </a:ln>
        <a:effectLst/>
      </c:spPr>
    </c:plotArea>
    <c:legend>
      <c:legendPos val="t"/>
      <c:layout>
        <c:manualLayout>
          <c:xMode val="edge"/>
          <c:yMode val="edge"/>
          <c:x val="0.20551264346580372"/>
          <c:y val="0.15024304713189449"/>
          <c:w val="0.12993815212840235"/>
          <c:h val="0.25162322526928882"/>
        </c:manualLayout>
      </c:layout>
      <c:overlay val="0"/>
      <c:spPr>
        <a:noFill/>
        <a:ln>
          <a:noFill/>
        </a:ln>
        <a:effectLst/>
      </c:spPr>
      <c:txPr>
        <a:bodyPr rot="0" spcFirstLastPara="1" vertOverflow="ellipsis" vert="horz" wrap="square" anchor="ctr" anchorCtr="1"/>
        <a:lstStyle/>
        <a:p>
          <a:pPr>
            <a:defRPr sz="18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4">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9.0580195488951562E-2"/>
          <c:y val="1.7917267563042044E-2"/>
          <c:w val="0.55926452454816256"/>
          <c:h val="0.63972813322835276"/>
        </c:manualLayout>
      </c:layout>
      <c:barChart>
        <c:barDir val="col"/>
        <c:grouping val="clustered"/>
        <c:varyColors val="0"/>
        <c:ser>
          <c:idx val="0"/>
          <c:order val="0"/>
          <c:tx>
            <c:strRef>
              <c:f>'/Users/ahwemple/Desktop/[XanthineInterferentTemplate_C6_2.xlsx]Graph Day 1'!$B$3</c:f>
              <c:strCache>
                <c:ptCount val="1"/>
                <c:pt idx="0">
                  <c:v>Ascobic Acid</c:v>
                </c:pt>
              </c:strCache>
            </c:strRef>
          </c:tx>
          <c:spPr>
            <a:pattFill prst="pct60">
              <a:fgClr>
                <a:schemeClr val="accent1"/>
              </a:fgClr>
              <a:bgClr>
                <a:schemeClr val="bg1"/>
              </a:bgClr>
            </a:pattFill>
            <a:ln>
              <a:noFill/>
            </a:ln>
            <a:effectLst/>
          </c:spPr>
          <c:invertIfNegative val="0"/>
          <c:errBars>
            <c:errBarType val="both"/>
            <c:errValType val="cust"/>
            <c:noEndCap val="0"/>
            <c:plus>
              <c:numRef>
                <c:f>'Graph Day 3'!$C$13</c:f>
                <c:numCache>
                  <c:formatCode>General</c:formatCode>
                  <c:ptCount val="1"/>
                  <c:pt idx="0">
                    <c:v>0.15408192800000001</c:v>
                  </c:pt>
                </c:numCache>
              </c:numRef>
            </c:plus>
            <c:minus>
              <c:numRef>
                <c:f>'Graph Day 3'!$C$13</c:f>
                <c:numCache>
                  <c:formatCode>General</c:formatCode>
                  <c:ptCount val="1"/>
                  <c:pt idx="0">
                    <c:v>0.15408192800000001</c:v>
                  </c:pt>
                </c:numCache>
              </c:numRef>
            </c:minus>
            <c:spPr>
              <a:noFill/>
              <a:ln w="9525" cap="flat" cmpd="sng" algn="ctr">
                <a:solidFill>
                  <a:schemeClr val="tx1">
                    <a:lumMod val="65000"/>
                    <a:lumOff val="35000"/>
                  </a:schemeClr>
                </a:solidFill>
                <a:round/>
              </a:ln>
              <a:effectLst/>
            </c:spPr>
          </c:errBars>
          <c:val>
            <c:numRef>
              <c:f>'Graph Day 3'!$C$3</c:f>
              <c:numCache>
                <c:formatCode>General</c:formatCode>
                <c:ptCount val="1"/>
                <c:pt idx="0">
                  <c:v>-1.082915933</c:v>
                </c:pt>
              </c:numCache>
            </c:numRef>
          </c:val>
          <c:extLst>
            <c:ext xmlns:c16="http://schemas.microsoft.com/office/drawing/2014/chart" uri="{C3380CC4-5D6E-409C-BE32-E72D297353CC}">
              <c16:uniqueId val="{00000000-EDB9-4E32-8447-A8C131EF7E8D}"/>
            </c:ext>
          </c:extLst>
        </c:ser>
        <c:ser>
          <c:idx val="1"/>
          <c:order val="1"/>
          <c:tx>
            <c:strRef>
              <c:f>'/Users/ahwemple/Desktop/[XanthineInterferentTemplate_C6_2.xlsx]Graph Day 1'!$B$4</c:f>
              <c:strCache>
                <c:ptCount val="1"/>
                <c:pt idx="0">
                  <c:v>Glucose</c:v>
                </c:pt>
              </c:strCache>
            </c:strRef>
          </c:tx>
          <c:spPr>
            <a:pattFill prst="dkDnDiag">
              <a:fgClr>
                <a:schemeClr val="accent2"/>
              </a:fgClr>
              <a:bgClr>
                <a:schemeClr val="bg1"/>
              </a:bgClr>
            </a:pattFill>
            <a:ln>
              <a:noFill/>
            </a:ln>
            <a:effectLst/>
          </c:spPr>
          <c:invertIfNegative val="0"/>
          <c:errBars>
            <c:errBarType val="both"/>
            <c:errValType val="cust"/>
            <c:noEndCap val="0"/>
            <c:plus>
              <c:numRef>
                <c:f>'Graph Day 3'!$C$14</c:f>
                <c:numCache>
                  <c:formatCode>General</c:formatCode>
                  <c:ptCount val="1"/>
                  <c:pt idx="0">
                    <c:v>8.3692209599999998E-2</c:v>
                  </c:pt>
                </c:numCache>
              </c:numRef>
            </c:plus>
            <c:minus>
              <c:numRef>
                <c:f>'Graph Day 3'!$C$14</c:f>
                <c:numCache>
                  <c:formatCode>General</c:formatCode>
                  <c:ptCount val="1"/>
                  <c:pt idx="0">
                    <c:v>8.3692209599999998E-2</c:v>
                  </c:pt>
                </c:numCache>
              </c:numRef>
            </c:minus>
            <c:spPr>
              <a:noFill/>
              <a:ln w="9525" cap="flat" cmpd="sng" algn="ctr">
                <a:solidFill>
                  <a:schemeClr val="tx1">
                    <a:lumMod val="65000"/>
                    <a:lumOff val="35000"/>
                  </a:schemeClr>
                </a:solidFill>
                <a:round/>
              </a:ln>
              <a:effectLst/>
            </c:spPr>
          </c:errBars>
          <c:val>
            <c:numRef>
              <c:f>'Graph Day 3'!$C$4</c:f>
              <c:numCache>
                <c:formatCode>General</c:formatCode>
                <c:ptCount val="1"/>
                <c:pt idx="0">
                  <c:v>-2.4868664649999999</c:v>
                </c:pt>
              </c:numCache>
            </c:numRef>
          </c:val>
          <c:extLst>
            <c:ext xmlns:c16="http://schemas.microsoft.com/office/drawing/2014/chart" uri="{C3380CC4-5D6E-409C-BE32-E72D297353CC}">
              <c16:uniqueId val="{00000001-EDB9-4E32-8447-A8C131EF7E8D}"/>
            </c:ext>
          </c:extLst>
        </c:ser>
        <c:ser>
          <c:idx val="2"/>
          <c:order val="2"/>
          <c:tx>
            <c:strRef>
              <c:f>'/Users/ahwemple/Desktop/[XanthineInterferentTemplate_C6_2.xlsx]Graph Day 1'!$B$5</c:f>
              <c:strCache>
                <c:ptCount val="1"/>
                <c:pt idx="0">
                  <c:v>Sodium Benzoate</c:v>
                </c:pt>
              </c:strCache>
            </c:strRef>
          </c:tx>
          <c:spPr>
            <a:pattFill prst="horzBrick">
              <a:fgClr>
                <a:schemeClr val="accent3"/>
              </a:fgClr>
              <a:bgClr>
                <a:schemeClr val="bg1"/>
              </a:bgClr>
            </a:pattFill>
            <a:ln>
              <a:noFill/>
            </a:ln>
            <a:effectLst/>
          </c:spPr>
          <c:invertIfNegative val="0"/>
          <c:dPt>
            <c:idx val="0"/>
            <c:invertIfNegative val="0"/>
            <c:bubble3D val="0"/>
            <c:spPr>
              <a:pattFill prst="horzBrick">
                <a:fgClr>
                  <a:schemeClr val="tx1"/>
                </a:fgClr>
                <a:bgClr>
                  <a:schemeClr val="bg1"/>
                </a:bgClr>
              </a:pattFill>
              <a:ln>
                <a:noFill/>
              </a:ln>
              <a:effectLst/>
            </c:spPr>
            <c:extLst>
              <c:ext xmlns:c16="http://schemas.microsoft.com/office/drawing/2014/chart" uri="{C3380CC4-5D6E-409C-BE32-E72D297353CC}">
                <c16:uniqueId val="{00000003-EDB9-4E32-8447-A8C131EF7E8D}"/>
              </c:ext>
            </c:extLst>
          </c:dPt>
          <c:errBars>
            <c:errBarType val="both"/>
            <c:errValType val="cust"/>
            <c:noEndCap val="0"/>
            <c:plus>
              <c:numRef>
                <c:f>'Graph Day 3'!$C$15</c:f>
                <c:numCache>
                  <c:formatCode>General</c:formatCode>
                  <c:ptCount val="1"/>
                  <c:pt idx="0">
                    <c:v>1.584316015E-3</c:v>
                  </c:pt>
                </c:numCache>
              </c:numRef>
            </c:plus>
            <c:minus>
              <c:numRef>
                <c:f>'Graph Day 3'!$C$15</c:f>
                <c:numCache>
                  <c:formatCode>General</c:formatCode>
                  <c:ptCount val="1"/>
                  <c:pt idx="0">
                    <c:v>1.584316015E-3</c:v>
                  </c:pt>
                </c:numCache>
              </c:numRef>
            </c:minus>
            <c:spPr>
              <a:noFill/>
              <a:ln w="9525" cap="flat" cmpd="sng" algn="ctr">
                <a:solidFill>
                  <a:schemeClr val="tx1">
                    <a:lumMod val="65000"/>
                    <a:lumOff val="35000"/>
                  </a:schemeClr>
                </a:solidFill>
                <a:round/>
              </a:ln>
              <a:effectLst/>
            </c:spPr>
          </c:errBars>
          <c:val>
            <c:numRef>
              <c:f>'Graph Day 3'!$C$5</c:f>
              <c:numCache>
                <c:formatCode>General</c:formatCode>
                <c:ptCount val="1"/>
                <c:pt idx="0">
                  <c:v>-2.8761782330000001</c:v>
                </c:pt>
              </c:numCache>
            </c:numRef>
          </c:val>
          <c:extLst>
            <c:ext xmlns:c16="http://schemas.microsoft.com/office/drawing/2014/chart" uri="{C3380CC4-5D6E-409C-BE32-E72D297353CC}">
              <c16:uniqueId val="{00000004-EDB9-4E32-8447-A8C131EF7E8D}"/>
            </c:ext>
          </c:extLst>
        </c:ser>
        <c:ser>
          <c:idx val="3"/>
          <c:order val="3"/>
          <c:tx>
            <c:strRef>
              <c:f>'/Users/ahwemple/Desktop/[XanthineInterferentTemplate_C6_2.xlsx]Graph Day 1'!$B$6</c:f>
              <c:strCache>
                <c:ptCount val="1"/>
                <c:pt idx="0">
                  <c:v>Uric Acid</c:v>
                </c:pt>
              </c:strCache>
            </c:strRef>
          </c:tx>
          <c:spPr>
            <a:pattFill prst="trellis">
              <a:fgClr>
                <a:schemeClr val="accent4"/>
              </a:fgClr>
              <a:bgClr>
                <a:schemeClr val="bg1"/>
              </a:bgClr>
            </a:pattFill>
            <a:ln>
              <a:noFill/>
            </a:ln>
            <a:effectLst/>
          </c:spPr>
          <c:invertIfNegative val="0"/>
          <c:errBars>
            <c:errBarType val="both"/>
            <c:errValType val="cust"/>
            <c:noEndCap val="0"/>
            <c:plus>
              <c:numRef>
                <c:f>'Graph Day 3'!$C$16</c:f>
                <c:numCache>
                  <c:formatCode>General</c:formatCode>
                  <c:ptCount val="1"/>
                  <c:pt idx="0">
                    <c:v>9.7875080439999998E-2</c:v>
                  </c:pt>
                </c:numCache>
              </c:numRef>
            </c:plus>
            <c:minus>
              <c:numRef>
                <c:f>'Graph Day 3'!$C$16</c:f>
                <c:numCache>
                  <c:formatCode>General</c:formatCode>
                  <c:ptCount val="1"/>
                  <c:pt idx="0">
                    <c:v>9.7875080439999998E-2</c:v>
                  </c:pt>
                </c:numCache>
              </c:numRef>
            </c:minus>
            <c:spPr>
              <a:noFill/>
              <a:ln w="9525" cap="flat" cmpd="sng" algn="ctr">
                <a:solidFill>
                  <a:schemeClr val="tx1">
                    <a:lumMod val="65000"/>
                    <a:lumOff val="35000"/>
                  </a:schemeClr>
                </a:solidFill>
                <a:round/>
              </a:ln>
              <a:effectLst/>
            </c:spPr>
          </c:errBars>
          <c:val>
            <c:numRef>
              <c:f>'Graph Day 3'!$C$6</c:f>
              <c:numCache>
                <c:formatCode>General</c:formatCode>
                <c:ptCount val="1"/>
                <c:pt idx="0">
                  <c:v>-0.69544994429999996</c:v>
                </c:pt>
              </c:numCache>
            </c:numRef>
          </c:val>
          <c:extLst>
            <c:ext xmlns:c16="http://schemas.microsoft.com/office/drawing/2014/chart" uri="{C3380CC4-5D6E-409C-BE32-E72D297353CC}">
              <c16:uniqueId val="{00000005-EDB9-4E32-8447-A8C131EF7E8D}"/>
            </c:ext>
          </c:extLst>
        </c:ser>
        <c:ser>
          <c:idx val="4"/>
          <c:order val="4"/>
          <c:tx>
            <c:strRef>
              <c:f>'/Users/ahwemple/Desktop/[XanthineInterferentTemplate_C6_2.xlsx]Graph Day 1'!$B$7</c:f>
              <c:strCache>
                <c:ptCount val="1"/>
                <c:pt idx="0">
                  <c:v>Creatinine</c:v>
                </c:pt>
              </c:strCache>
            </c:strRef>
          </c:tx>
          <c:spPr>
            <a:pattFill prst="narVert">
              <a:fgClr>
                <a:schemeClr val="accent5"/>
              </a:fgClr>
              <a:bgClr>
                <a:schemeClr val="bg1"/>
              </a:bgClr>
            </a:pattFill>
            <a:ln>
              <a:noFill/>
            </a:ln>
            <a:effectLst/>
          </c:spPr>
          <c:invertIfNegative val="0"/>
          <c:errBars>
            <c:errBarType val="both"/>
            <c:errValType val="cust"/>
            <c:noEndCap val="0"/>
            <c:plus>
              <c:numRef>
                <c:f>'Graph Day 3'!$C$17</c:f>
                <c:numCache>
                  <c:formatCode>General</c:formatCode>
                  <c:ptCount val="1"/>
                  <c:pt idx="0">
                    <c:v>0.18115553949999999</c:v>
                  </c:pt>
                </c:numCache>
              </c:numRef>
            </c:plus>
            <c:minus>
              <c:numRef>
                <c:f>'Graph Day 3'!$C$17</c:f>
                <c:numCache>
                  <c:formatCode>General</c:formatCode>
                  <c:ptCount val="1"/>
                  <c:pt idx="0">
                    <c:v>0.18115553949999999</c:v>
                  </c:pt>
                </c:numCache>
              </c:numRef>
            </c:minus>
            <c:spPr>
              <a:noFill/>
              <a:ln w="9525" cap="flat" cmpd="sng" algn="ctr">
                <a:solidFill>
                  <a:schemeClr val="tx1">
                    <a:lumMod val="65000"/>
                    <a:lumOff val="35000"/>
                  </a:schemeClr>
                </a:solidFill>
                <a:round/>
              </a:ln>
              <a:effectLst/>
            </c:spPr>
          </c:errBars>
          <c:val>
            <c:numRef>
              <c:f>'Graph Day 3'!$C$7</c:f>
              <c:numCache>
                <c:formatCode>General</c:formatCode>
                <c:ptCount val="1"/>
                <c:pt idx="0">
                  <c:v>-3.1078283980000001</c:v>
                </c:pt>
              </c:numCache>
            </c:numRef>
          </c:val>
          <c:extLst>
            <c:ext xmlns:c16="http://schemas.microsoft.com/office/drawing/2014/chart" uri="{C3380CC4-5D6E-409C-BE32-E72D297353CC}">
              <c16:uniqueId val="{00000006-EDB9-4E32-8447-A8C131EF7E8D}"/>
            </c:ext>
          </c:extLst>
        </c:ser>
        <c:ser>
          <c:idx val="5"/>
          <c:order val="5"/>
          <c:tx>
            <c:strRef>
              <c:f>'/Users/ahwemple/Desktop/[XanthineInterferentTemplate_C6_2.xlsx]Graph Day 1'!$B$8</c:f>
              <c:strCache>
                <c:ptCount val="1"/>
                <c:pt idx="0">
                  <c:v>Urea</c:v>
                </c:pt>
              </c:strCache>
            </c:strRef>
          </c:tx>
          <c:spPr>
            <a:solidFill>
              <a:schemeClr val="accent6"/>
            </a:solidFill>
            <a:ln>
              <a:noFill/>
            </a:ln>
            <a:effectLst/>
          </c:spPr>
          <c:invertIfNegative val="0"/>
          <c:dPt>
            <c:idx val="0"/>
            <c:invertIfNegative val="0"/>
            <c:bubble3D val="0"/>
            <c:spPr>
              <a:pattFill prst="pct50">
                <a:fgClr>
                  <a:schemeClr val="accent6"/>
                </a:fgClr>
                <a:bgClr>
                  <a:schemeClr val="bg1"/>
                </a:bgClr>
              </a:pattFill>
              <a:ln>
                <a:noFill/>
              </a:ln>
              <a:effectLst/>
            </c:spPr>
            <c:extLst>
              <c:ext xmlns:c16="http://schemas.microsoft.com/office/drawing/2014/chart" uri="{C3380CC4-5D6E-409C-BE32-E72D297353CC}">
                <c16:uniqueId val="{00000008-EDB9-4E32-8447-A8C131EF7E8D}"/>
              </c:ext>
            </c:extLst>
          </c:dPt>
          <c:errBars>
            <c:errBarType val="both"/>
            <c:errValType val="cust"/>
            <c:noEndCap val="0"/>
            <c:plus>
              <c:numRef>
                <c:f>'Graph Day 3'!$C$18</c:f>
                <c:numCache>
                  <c:formatCode>General</c:formatCode>
                  <c:ptCount val="1"/>
                  <c:pt idx="0">
                    <c:v>0.1958088026</c:v>
                  </c:pt>
                </c:numCache>
              </c:numRef>
            </c:plus>
            <c:minus>
              <c:numRef>
                <c:f>'Graph Day 3'!$C$18</c:f>
                <c:numCache>
                  <c:formatCode>General</c:formatCode>
                  <c:ptCount val="1"/>
                  <c:pt idx="0">
                    <c:v>0.1958088026</c:v>
                  </c:pt>
                </c:numCache>
              </c:numRef>
            </c:minus>
            <c:spPr>
              <a:noFill/>
              <a:ln w="9525" cap="flat" cmpd="sng" algn="ctr">
                <a:solidFill>
                  <a:schemeClr val="tx1">
                    <a:lumMod val="65000"/>
                    <a:lumOff val="35000"/>
                  </a:schemeClr>
                </a:solidFill>
                <a:round/>
              </a:ln>
              <a:effectLst/>
            </c:spPr>
          </c:errBars>
          <c:val>
            <c:numRef>
              <c:f>'Graph Day 3'!$C$8</c:f>
              <c:numCache>
                <c:formatCode>General</c:formatCode>
                <c:ptCount val="1"/>
                <c:pt idx="0">
                  <c:v>-4.4364949219999996</c:v>
                </c:pt>
              </c:numCache>
            </c:numRef>
          </c:val>
          <c:extLst>
            <c:ext xmlns:c16="http://schemas.microsoft.com/office/drawing/2014/chart" uri="{C3380CC4-5D6E-409C-BE32-E72D297353CC}">
              <c16:uniqueId val="{00000009-EDB9-4E32-8447-A8C131EF7E8D}"/>
            </c:ext>
          </c:extLst>
        </c:ser>
        <c:ser>
          <c:idx val="6"/>
          <c:order val="6"/>
          <c:tx>
            <c:strRef>
              <c:f>'/Users/ahwemple/Desktop/[XanthineInterferentTemplate_C6_2.xlsx]Graph Day 1'!$B$9</c:f>
              <c:strCache>
                <c:ptCount val="1"/>
                <c:pt idx="0">
                  <c:v>Xanthine (30µM)</c:v>
                </c:pt>
              </c:strCache>
            </c:strRef>
          </c:tx>
          <c:spPr>
            <a:solidFill>
              <a:schemeClr val="tx1"/>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B-EDB9-4E32-8447-A8C131EF7E8D}"/>
              </c:ext>
            </c:extLst>
          </c:dPt>
          <c:errBars>
            <c:errBarType val="both"/>
            <c:errValType val="cust"/>
            <c:noEndCap val="0"/>
            <c:plus>
              <c:numRef>
                <c:f>'Graph Day 3'!$C$19</c:f>
                <c:numCache>
                  <c:formatCode>General</c:formatCode>
                  <c:ptCount val="1"/>
                  <c:pt idx="0">
                    <c:v>3.5388746989999997E-2</c:v>
                  </c:pt>
                </c:numCache>
              </c:numRef>
            </c:plus>
            <c:minus>
              <c:numRef>
                <c:f>'Graph Day 3'!$C$19</c:f>
                <c:numCache>
                  <c:formatCode>General</c:formatCode>
                  <c:ptCount val="1"/>
                  <c:pt idx="0">
                    <c:v>3.5388746989999997E-2</c:v>
                  </c:pt>
                </c:numCache>
              </c:numRef>
            </c:minus>
            <c:spPr>
              <a:noFill/>
              <a:ln w="9525" cap="flat" cmpd="sng" algn="ctr">
                <a:solidFill>
                  <a:schemeClr val="tx1">
                    <a:lumMod val="65000"/>
                    <a:lumOff val="35000"/>
                  </a:schemeClr>
                </a:solidFill>
                <a:round/>
              </a:ln>
              <a:effectLst/>
            </c:spPr>
          </c:errBars>
          <c:val>
            <c:numRef>
              <c:f>'Graph Day 3'!$C$9</c:f>
              <c:numCache>
                <c:formatCode>General</c:formatCode>
                <c:ptCount val="1"/>
                <c:pt idx="0">
                  <c:v>-0.27804399330000001</c:v>
                </c:pt>
              </c:numCache>
            </c:numRef>
          </c:val>
          <c:extLst>
            <c:ext xmlns:c16="http://schemas.microsoft.com/office/drawing/2014/chart" uri="{C3380CC4-5D6E-409C-BE32-E72D297353CC}">
              <c16:uniqueId val="{0000000C-EDB9-4E32-8447-A8C131EF7E8D}"/>
            </c:ext>
          </c:extLst>
        </c:ser>
        <c:dLbls>
          <c:showLegendKey val="0"/>
          <c:showVal val="0"/>
          <c:showCatName val="0"/>
          <c:showSerName val="0"/>
          <c:showPercent val="0"/>
          <c:showBubbleSize val="0"/>
        </c:dLbls>
        <c:gapWidth val="500"/>
        <c:axId val="1100544015"/>
        <c:axId val="1216485199"/>
      </c:barChart>
      <c:catAx>
        <c:axId val="1100544015"/>
        <c:scaling>
          <c:orientation val="minMax"/>
        </c:scaling>
        <c:delete val="0"/>
        <c:axPos val="b"/>
        <c:title>
          <c:tx>
            <c:rich>
              <a:bodyPr rot="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r>
                  <a:rPr lang="en-US" sz="1600"/>
                  <a:t>Interferent</a:t>
                </a:r>
              </a:p>
            </c:rich>
          </c:tx>
          <c:layout>
            <c:manualLayout>
              <c:xMode val="edge"/>
              <c:yMode val="edge"/>
              <c:x val="0.28793977878127525"/>
              <c:y val="0.62208145314312824"/>
            </c:manualLayout>
          </c:layout>
          <c:overlay val="0"/>
          <c:spPr>
            <a:noFill/>
            <a:ln>
              <a:noFill/>
            </a:ln>
            <a:effectLst/>
          </c:spPr>
          <c:txPr>
            <a:bodyPr rot="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16485199"/>
        <c:crosses val="autoZero"/>
        <c:auto val="1"/>
        <c:lblAlgn val="ctr"/>
        <c:lblOffset val="100"/>
        <c:tickLblSkip val="1"/>
        <c:noMultiLvlLbl val="0"/>
      </c:catAx>
      <c:valAx>
        <c:axId val="1216485199"/>
        <c:scaling>
          <c:orientation val="minMax"/>
        </c:scaling>
        <c:delete val="0"/>
        <c:axPos val="l"/>
        <c:title>
          <c:tx>
            <c:rich>
              <a:bodyPr rot="-54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r>
                  <a:rPr lang="en-US" sz="1400"/>
                  <a:t>Selectivity Coefficient</a:t>
                </a:r>
              </a:p>
            </c:rich>
          </c:tx>
          <c:overlay val="0"/>
          <c:spPr>
            <a:noFill/>
            <a:ln>
              <a:noFill/>
            </a:ln>
            <a:effectLst/>
          </c:spPr>
          <c:txPr>
            <a:bodyPr rot="-54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100544015"/>
        <c:crosses val="autoZero"/>
        <c:crossBetween val="between"/>
      </c:valAx>
      <c:spPr>
        <a:noFill/>
        <a:ln>
          <a:noFill/>
        </a:ln>
        <a:effectLst/>
      </c:spPr>
    </c:plotArea>
    <c:legend>
      <c:legendPos val="l"/>
      <c:layout>
        <c:manualLayout>
          <c:xMode val="edge"/>
          <c:yMode val="edge"/>
          <c:x val="0.66401788813802265"/>
          <c:y val="2.1109821062983758E-2"/>
          <c:w val="0.18255577402107948"/>
          <c:h val="0.63419431427387551"/>
        </c:manualLayout>
      </c:layout>
      <c:overlay val="0"/>
      <c:spPr>
        <a:noFill/>
        <a:ln>
          <a:solidFill>
            <a:schemeClr val="bg1">
              <a:lumMod val="75000"/>
            </a:schemeClr>
          </a:solidFill>
        </a:ln>
        <a:effectLst/>
      </c:spPr>
      <c:txPr>
        <a:bodyPr rot="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708538358626085"/>
          <c:y val="0.15356689221208333"/>
          <c:w val="0.79167156790494386"/>
          <c:h val="0.77051709550589753"/>
        </c:manualLayout>
      </c:layout>
      <c:barChart>
        <c:barDir val="col"/>
        <c:grouping val="clustered"/>
        <c:varyColors val="0"/>
        <c:ser>
          <c:idx val="0"/>
          <c:order val="0"/>
          <c:tx>
            <c:strRef>
              <c:f>'/Users/ahwemple/Desktop/[XanthineInterferentTemplate_C6_2.xlsx]Graph Day 1'!$B$3</c:f>
              <c:strCache>
                <c:ptCount val="1"/>
                <c:pt idx="0">
                  <c:v>Ascobic Acid</c:v>
                </c:pt>
              </c:strCache>
            </c:strRef>
          </c:tx>
          <c:spPr>
            <a:pattFill prst="pct60">
              <a:fgClr>
                <a:schemeClr val="accent1"/>
              </a:fgClr>
              <a:bgClr>
                <a:schemeClr val="bg1"/>
              </a:bgClr>
            </a:pattFill>
            <a:ln>
              <a:noFill/>
            </a:ln>
            <a:effectLst/>
          </c:spPr>
          <c:invertIfNegative val="0"/>
          <c:errBars>
            <c:errBarType val="both"/>
            <c:errValType val="cust"/>
            <c:noEndCap val="0"/>
            <c:plus>
              <c:numRef>
                <c:f>'Graph Day 1'!$C$13</c:f>
                <c:numCache>
                  <c:formatCode>General</c:formatCode>
                  <c:ptCount val="1"/>
                  <c:pt idx="0">
                    <c:v>0.14513389087328513</c:v>
                  </c:pt>
                </c:numCache>
              </c:numRef>
            </c:plus>
            <c:minus>
              <c:numRef>
                <c:f>'Graph Day 1'!$C$13</c:f>
                <c:numCache>
                  <c:formatCode>General</c:formatCode>
                  <c:ptCount val="1"/>
                  <c:pt idx="0">
                    <c:v>0.14513389087328513</c:v>
                  </c:pt>
                </c:numCache>
              </c:numRef>
            </c:minus>
            <c:spPr>
              <a:noFill/>
              <a:ln w="9525" cap="flat" cmpd="sng" algn="ctr">
                <a:solidFill>
                  <a:schemeClr val="tx1">
                    <a:lumMod val="65000"/>
                    <a:lumOff val="35000"/>
                  </a:schemeClr>
                </a:solidFill>
                <a:round/>
              </a:ln>
              <a:effectLst/>
            </c:spPr>
          </c:errBars>
          <c:val>
            <c:numRef>
              <c:f>'Graph Day 1'!$C$3</c:f>
              <c:numCache>
                <c:formatCode>General</c:formatCode>
                <c:ptCount val="1"/>
                <c:pt idx="0">
                  <c:v>-0.98726870487075291</c:v>
                </c:pt>
              </c:numCache>
            </c:numRef>
          </c:val>
          <c:extLst>
            <c:ext xmlns:c16="http://schemas.microsoft.com/office/drawing/2014/chart" uri="{C3380CC4-5D6E-409C-BE32-E72D297353CC}">
              <c16:uniqueId val="{00000000-F3D8-4D00-ABFB-373991CA6DA7}"/>
            </c:ext>
          </c:extLst>
        </c:ser>
        <c:ser>
          <c:idx val="1"/>
          <c:order val="1"/>
          <c:tx>
            <c:strRef>
              <c:f>'/Users/ahwemple/Desktop/[XanthineInterferentTemplate_C6_2.xlsx]Graph Day 1'!$B$4</c:f>
              <c:strCache>
                <c:ptCount val="1"/>
                <c:pt idx="0">
                  <c:v>Glucose</c:v>
                </c:pt>
              </c:strCache>
            </c:strRef>
          </c:tx>
          <c:spPr>
            <a:pattFill prst="dkDnDiag">
              <a:fgClr>
                <a:schemeClr val="accent2"/>
              </a:fgClr>
              <a:bgClr>
                <a:schemeClr val="bg1"/>
              </a:bgClr>
            </a:pattFill>
            <a:ln>
              <a:noFill/>
            </a:ln>
            <a:effectLst/>
          </c:spPr>
          <c:invertIfNegative val="0"/>
          <c:errBars>
            <c:errBarType val="both"/>
            <c:errValType val="cust"/>
            <c:noEndCap val="0"/>
            <c:plus>
              <c:numRef>
                <c:f>'Graph Day 1'!$C$14</c:f>
                <c:numCache>
                  <c:formatCode>General</c:formatCode>
                  <c:ptCount val="1"/>
                  <c:pt idx="0">
                    <c:v>0.20599547306380589</c:v>
                  </c:pt>
                </c:numCache>
              </c:numRef>
            </c:plus>
            <c:minus>
              <c:numRef>
                <c:f>'Graph Day 1'!$C$14</c:f>
                <c:numCache>
                  <c:formatCode>General</c:formatCode>
                  <c:ptCount val="1"/>
                  <c:pt idx="0">
                    <c:v>0.20599547306380589</c:v>
                  </c:pt>
                </c:numCache>
              </c:numRef>
            </c:minus>
            <c:spPr>
              <a:noFill/>
              <a:ln w="9525" cap="flat" cmpd="sng" algn="ctr">
                <a:solidFill>
                  <a:schemeClr val="tx1">
                    <a:lumMod val="65000"/>
                    <a:lumOff val="35000"/>
                  </a:schemeClr>
                </a:solidFill>
                <a:round/>
              </a:ln>
              <a:effectLst/>
            </c:spPr>
          </c:errBars>
          <c:val>
            <c:numRef>
              <c:f>'Graph Day 1'!$C$4</c:f>
              <c:numCache>
                <c:formatCode>General</c:formatCode>
                <c:ptCount val="1"/>
                <c:pt idx="0">
                  <c:v>-1.8726417626921901</c:v>
                </c:pt>
              </c:numCache>
            </c:numRef>
          </c:val>
          <c:extLst>
            <c:ext xmlns:c16="http://schemas.microsoft.com/office/drawing/2014/chart" uri="{C3380CC4-5D6E-409C-BE32-E72D297353CC}">
              <c16:uniqueId val="{00000001-F3D8-4D00-ABFB-373991CA6DA7}"/>
            </c:ext>
          </c:extLst>
        </c:ser>
        <c:ser>
          <c:idx val="2"/>
          <c:order val="2"/>
          <c:tx>
            <c:strRef>
              <c:f>'/Users/ahwemple/Desktop/[XanthineInterferentTemplate_C6_2.xlsx]Graph Day 1'!$B$5</c:f>
              <c:strCache>
                <c:ptCount val="1"/>
                <c:pt idx="0">
                  <c:v>Sodium Benzoate</c:v>
                </c:pt>
              </c:strCache>
            </c:strRef>
          </c:tx>
          <c:spPr>
            <a:pattFill prst="horzBrick">
              <a:fgClr>
                <a:schemeClr val="accent3"/>
              </a:fgClr>
              <a:bgClr>
                <a:schemeClr val="bg1"/>
              </a:bgClr>
            </a:pattFill>
            <a:ln>
              <a:noFill/>
            </a:ln>
            <a:effectLst/>
          </c:spPr>
          <c:invertIfNegative val="0"/>
          <c:errBars>
            <c:errBarType val="both"/>
            <c:errValType val="cust"/>
            <c:noEndCap val="0"/>
            <c:plus>
              <c:numRef>
                <c:f>'Graph Day 1'!$C$15</c:f>
                <c:numCache>
                  <c:formatCode>General</c:formatCode>
                  <c:ptCount val="1"/>
                  <c:pt idx="0">
                    <c:v>7.4277087335477832E-2</c:v>
                  </c:pt>
                </c:numCache>
              </c:numRef>
            </c:plus>
            <c:minus>
              <c:numRef>
                <c:f>'Graph Day 1'!$C$15</c:f>
                <c:numCache>
                  <c:formatCode>General</c:formatCode>
                  <c:ptCount val="1"/>
                  <c:pt idx="0">
                    <c:v>7.4277087335477832E-2</c:v>
                  </c:pt>
                </c:numCache>
              </c:numRef>
            </c:minus>
            <c:spPr>
              <a:noFill/>
              <a:ln w="9525" cap="flat" cmpd="sng" algn="ctr">
                <a:solidFill>
                  <a:schemeClr val="tx1">
                    <a:lumMod val="65000"/>
                    <a:lumOff val="35000"/>
                  </a:schemeClr>
                </a:solidFill>
                <a:round/>
              </a:ln>
              <a:effectLst/>
            </c:spPr>
          </c:errBars>
          <c:val>
            <c:numRef>
              <c:f>'Graph Day 1'!$C$5</c:f>
              <c:numCache>
                <c:formatCode>General</c:formatCode>
                <c:ptCount val="1"/>
                <c:pt idx="0">
                  <c:v>-1.4872695978426091</c:v>
                </c:pt>
              </c:numCache>
            </c:numRef>
          </c:val>
          <c:extLst>
            <c:ext xmlns:c16="http://schemas.microsoft.com/office/drawing/2014/chart" uri="{C3380CC4-5D6E-409C-BE32-E72D297353CC}">
              <c16:uniqueId val="{00000002-F3D8-4D00-ABFB-373991CA6DA7}"/>
            </c:ext>
          </c:extLst>
        </c:ser>
        <c:ser>
          <c:idx val="3"/>
          <c:order val="3"/>
          <c:tx>
            <c:strRef>
              <c:f>'/Users/ahwemple/Desktop/[XanthineInterferentTemplate_C6_2.xlsx]Graph Day 1'!$B$6</c:f>
              <c:strCache>
                <c:ptCount val="1"/>
                <c:pt idx="0">
                  <c:v>Uric Acid</c:v>
                </c:pt>
              </c:strCache>
            </c:strRef>
          </c:tx>
          <c:spPr>
            <a:pattFill prst="trellis">
              <a:fgClr>
                <a:schemeClr val="accent4"/>
              </a:fgClr>
              <a:bgClr>
                <a:schemeClr val="bg1"/>
              </a:bgClr>
            </a:pattFill>
            <a:ln>
              <a:noFill/>
            </a:ln>
            <a:effectLst/>
          </c:spPr>
          <c:invertIfNegative val="0"/>
          <c:errBars>
            <c:errBarType val="both"/>
            <c:errValType val="cust"/>
            <c:noEndCap val="0"/>
            <c:plus>
              <c:numRef>
                <c:f>'Graph Day 1'!$C$16</c:f>
                <c:numCache>
                  <c:formatCode>General</c:formatCode>
                  <c:ptCount val="1"/>
                  <c:pt idx="0">
                    <c:v>0.26357671129933385</c:v>
                  </c:pt>
                </c:numCache>
              </c:numRef>
            </c:plus>
            <c:minus>
              <c:numRef>
                <c:f>'Graph Day 1'!$C$16</c:f>
                <c:numCache>
                  <c:formatCode>General</c:formatCode>
                  <c:ptCount val="1"/>
                  <c:pt idx="0">
                    <c:v>0.26357671129933385</c:v>
                  </c:pt>
                </c:numCache>
              </c:numRef>
            </c:minus>
            <c:spPr>
              <a:noFill/>
              <a:ln w="9525" cap="flat" cmpd="sng" algn="ctr">
                <a:solidFill>
                  <a:schemeClr val="tx1">
                    <a:lumMod val="65000"/>
                    <a:lumOff val="35000"/>
                  </a:schemeClr>
                </a:solidFill>
                <a:round/>
              </a:ln>
              <a:effectLst/>
            </c:spPr>
          </c:errBars>
          <c:val>
            <c:numRef>
              <c:f>'Graph Day 1'!$C$6</c:f>
              <c:numCache>
                <c:formatCode>General</c:formatCode>
                <c:ptCount val="1"/>
                <c:pt idx="0">
                  <c:v>-0.23955811014903011</c:v>
                </c:pt>
              </c:numCache>
            </c:numRef>
          </c:val>
          <c:extLst>
            <c:ext xmlns:c16="http://schemas.microsoft.com/office/drawing/2014/chart" uri="{C3380CC4-5D6E-409C-BE32-E72D297353CC}">
              <c16:uniqueId val="{00000003-F3D8-4D00-ABFB-373991CA6DA7}"/>
            </c:ext>
          </c:extLst>
        </c:ser>
        <c:ser>
          <c:idx val="4"/>
          <c:order val="4"/>
          <c:tx>
            <c:strRef>
              <c:f>'/Users/ahwemple/Desktop/[XanthineInterferentTemplate_C6_2.xlsx]Graph Day 1'!$B$7</c:f>
              <c:strCache>
                <c:ptCount val="1"/>
                <c:pt idx="0">
                  <c:v>Creatinine</c:v>
                </c:pt>
              </c:strCache>
            </c:strRef>
          </c:tx>
          <c:spPr>
            <a:pattFill prst="narVert">
              <a:fgClr>
                <a:schemeClr val="accent5"/>
              </a:fgClr>
              <a:bgClr>
                <a:schemeClr val="bg1"/>
              </a:bgClr>
            </a:pattFill>
            <a:ln>
              <a:noFill/>
            </a:ln>
            <a:effectLst/>
          </c:spPr>
          <c:invertIfNegative val="0"/>
          <c:errBars>
            <c:errBarType val="both"/>
            <c:errValType val="cust"/>
            <c:noEndCap val="0"/>
            <c:plus>
              <c:numRef>
                <c:f>'Graph Day 1'!$C$17</c:f>
                <c:numCache>
                  <c:formatCode>General</c:formatCode>
                  <c:ptCount val="1"/>
                  <c:pt idx="0">
                    <c:v>0.17733578053523263</c:v>
                  </c:pt>
                </c:numCache>
              </c:numRef>
            </c:plus>
            <c:minus>
              <c:numRef>
                <c:f>'Graph Day 1'!$C$17</c:f>
                <c:numCache>
                  <c:formatCode>General</c:formatCode>
                  <c:ptCount val="1"/>
                  <c:pt idx="0">
                    <c:v>0.17733578053523263</c:v>
                  </c:pt>
                </c:numCache>
              </c:numRef>
            </c:minus>
            <c:spPr>
              <a:noFill/>
              <a:ln w="9525" cap="flat" cmpd="sng" algn="ctr">
                <a:solidFill>
                  <a:schemeClr val="tx1">
                    <a:lumMod val="65000"/>
                    <a:lumOff val="35000"/>
                  </a:schemeClr>
                </a:solidFill>
                <a:round/>
              </a:ln>
              <a:effectLst/>
            </c:spPr>
          </c:errBars>
          <c:val>
            <c:numRef>
              <c:f>'Graph Day 1'!$C$7</c:f>
              <c:numCache>
                <c:formatCode>General</c:formatCode>
                <c:ptCount val="1"/>
                <c:pt idx="0">
                  <c:v>-2.843385057283407</c:v>
                </c:pt>
              </c:numCache>
            </c:numRef>
          </c:val>
          <c:extLst>
            <c:ext xmlns:c16="http://schemas.microsoft.com/office/drawing/2014/chart" uri="{C3380CC4-5D6E-409C-BE32-E72D297353CC}">
              <c16:uniqueId val="{00000004-F3D8-4D00-ABFB-373991CA6DA7}"/>
            </c:ext>
          </c:extLst>
        </c:ser>
        <c:ser>
          <c:idx val="5"/>
          <c:order val="5"/>
          <c:tx>
            <c:strRef>
              <c:f>'/Users/ahwemple/Desktop/[XanthineInterferentTemplate_C6_2.xlsx]Graph Day 1'!$B$8</c:f>
              <c:strCache>
                <c:ptCount val="1"/>
                <c:pt idx="0">
                  <c:v>Urea</c:v>
                </c:pt>
              </c:strCache>
            </c:strRef>
          </c:tx>
          <c:spPr>
            <a:solidFill>
              <a:schemeClr val="accent6"/>
            </a:solidFill>
            <a:ln>
              <a:noFill/>
            </a:ln>
            <a:effectLst/>
          </c:spPr>
          <c:invertIfNegative val="0"/>
          <c:dPt>
            <c:idx val="0"/>
            <c:invertIfNegative val="0"/>
            <c:bubble3D val="0"/>
            <c:spPr>
              <a:pattFill prst="pct50">
                <a:fgClr>
                  <a:schemeClr val="accent6"/>
                </a:fgClr>
                <a:bgClr>
                  <a:schemeClr val="bg1"/>
                </a:bgClr>
              </a:pattFill>
              <a:ln>
                <a:noFill/>
              </a:ln>
              <a:effectLst/>
            </c:spPr>
            <c:extLst>
              <c:ext xmlns:c16="http://schemas.microsoft.com/office/drawing/2014/chart" uri="{C3380CC4-5D6E-409C-BE32-E72D297353CC}">
                <c16:uniqueId val="{00000006-F3D8-4D00-ABFB-373991CA6DA7}"/>
              </c:ext>
            </c:extLst>
          </c:dPt>
          <c:errBars>
            <c:errBarType val="both"/>
            <c:errValType val="cust"/>
            <c:noEndCap val="0"/>
            <c:plus>
              <c:numRef>
                <c:f>'Graph Day 1'!$C$18</c:f>
                <c:numCache>
                  <c:formatCode>General</c:formatCode>
                  <c:ptCount val="1"/>
                  <c:pt idx="0">
                    <c:v>0.33480833185094239</c:v>
                  </c:pt>
                </c:numCache>
              </c:numRef>
            </c:plus>
            <c:minus>
              <c:numRef>
                <c:f>'Graph Day 1'!$C$18</c:f>
                <c:numCache>
                  <c:formatCode>General</c:formatCode>
                  <c:ptCount val="1"/>
                  <c:pt idx="0">
                    <c:v>0.33480833185094239</c:v>
                  </c:pt>
                </c:numCache>
              </c:numRef>
            </c:minus>
            <c:spPr>
              <a:noFill/>
              <a:ln w="9525" cap="flat" cmpd="sng" algn="ctr">
                <a:solidFill>
                  <a:schemeClr val="tx1">
                    <a:lumMod val="65000"/>
                    <a:lumOff val="35000"/>
                  </a:schemeClr>
                </a:solidFill>
                <a:round/>
              </a:ln>
              <a:effectLst/>
            </c:spPr>
          </c:errBars>
          <c:val>
            <c:numRef>
              <c:f>'Graph Day 1'!$C$8</c:f>
              <c:numCache>
                <c:formatCode>General</c:formatCode>
                <c:ptCount val="1"/>
                <c:pt idx="0">
                  <c:v>-4.3602974561442043</c:v>
                </c:pt>
              </c:numCache>
            </c:numRef>
          </c:val>
          <c:extLst>
            <c:ext xmlns:c16="http://schemas.microsoft.com/office/drawing/2014/chart" uri="{C3380CC4-5D6E-409C-BE32-E72D297353CC}">
              <c16:uniqueId val="{00000007-F3D8-4D00-ABFB-373991CA6DA7}"/>
            </c:ext>
          </c:extLst>
        </c:ser>
        <c:ser>
          <c:idx val="6"/>
          <c:order val="6"/>
          <c:tx>
            <c:strRef>
              <c:f>'/Users/ahwemple/Desktop/[XanthineInterferentTemplate_C6_2.xlsx]Graph Day 1'!$B$9</c:f>
              <c:strCache>
                <c:ptCount val="1"/>
                <c:pt idx="0">
                  <c:v>Xanthine (30µM)</c:v>
                </c:pt>
              </c:strCache>
            </c:strRef>
          </c:tx>
          <c:spPr>
            <a:pattFill prst="solidDmnd">
              <a:fgClr>
                <a:schemeClr val="tx1"/>
              </a:fgClr>
              <a:bgClr>
                <a:schemeClr val="bg1"/>
              </a:bgClr>
            </a:pattFill>
            <a:ln>
              <a:noFill/>
            </a:ln>
            <a:effectLst/>
          </c:spPr>
          <c:invertIfNegative val="0"/>
          <c:errBars>
            <c:errBarType val="both"/>
            <c:errValType val="cust"/>
            <c:noEndCap val="0"/>
            <c:plus>
              <c:numRef>
                <c:f>'Graph Day 1'!$C$19</c:f>
                <c:numCache>
                  <c:formatCode>General</c:formatCode>
                  <c:ptCount val="1"/>
                  <c:pt idx="0">
                    <c:v>0.14843147500117676</c:v>
                  </c:pt>
                </c:numCache>
              </c:numRef>
            </c:plus>
            <c:minus>
              <c:numRef>
                <c:f>'Graph Day 1'!$C$19</c:f>
                <c:numCache>
                  <c:formatCode>General</c:formatCode>
                  <c:ptCount val="1"/>
                  <c:pt idx="0">
                    <c:v>0.14843147500117676</c:v>
                  </c:pt>
                </c:numCache>
              </c:numRef>
            </c:minus>
            <c:spPr>
              <a:noFill/>
              <a:ln w="9525" cap="flat" cmpd="sng" algn="ctr">
                <a:solidFill>
                  <a:schemeClr val="tx1">
                    <a:lumMod val="65000"/>
                    <a:lumOff val="35000"/>
                  </a:schemeClr>
                </a:solidFill>
                <a:round/>
              </a:ln>
              <a:effectLst/>
            </c:spPr>
          </c:errBars>
          <c:val>
            <c:numRef>
              <c:f>'Graph Day 1'!$C$9</c:f>
              <c:numCache>
                <c:formatCode>General</c:formatCode>
                <c:ptCount val="1"/>
                <c:pt idx="0">
                  <c:v>2.4644617559589792E-2</c:v>
                </c:pt>
              </c:numCache>
            </c:numRef>
          </c:val>
          <c:extLst>
            <c:ext xmlns:c16="http://schemas.microsoft.com/office/drawing/2014/chart" uri="{C3380CC4-5D6E-409C-BE32-E72D297353CC}">
              <c16:uniqueId val="{00000008-F3D8-4D00-ABFB-373991CA6DA7}"/>
            </c:ext>
          </c:extLst>
        </c:ser>
        <c:dLbls>
          <c:showLegendKey val="0"/>
          <c:showVal val="0"/>
          <c:showCatName val="0"/>
          <c:showSerName val="0"/>
          <c:showPercent val="0"/>
          <c:showBubbleSize val="0"/>
        </c:dLbls>
        <c:gapWidth val="500"/>
        <c:axId val="1100544015"/>
        <c:axId val="1216485199"/>
      </c:barChart>
      <c:catAx>
        <c:axId val="1100544015"/>
        <c:scaling>
          <c:orientation val="minMax"/>
        </c:scaling>
        <c:delete val="0"/>
        <c:axPos val="b"/>
        <c:title>
          <c:tx>
            <c:rich>
              <a:bodyPr rot="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r>
                  <a:rPr lang="en-US" sz="1600"/>
                  <a:t>Interferent</a:t>
                </a:r>
              </a:p>
            </c:rich>
          </c:tx>
          <c:overlay val="0"/>
          <c:spPr>
            <a:noFill/>
            <a:ln>
              <a:noFill/>
            </a:ln>
            <a:effectLst/>
          </c:spPr>
          <c:txPr>
            <a:bodyPr rot="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16485199"/>
        <c:crosses val="autoZero"/>
        <c:auto val="1"/>
        <c:lblAlgn val="ctr"/>
        <c:lblOffset val="100"/>
        <c:tickLblSkip val="1"/>
        <c:noMultiLvlLbl val="0"/>
      </c:catAx>
      <c:valAx>
        <c:axId val="1216485199"/>
        <c:scaling>
          <c:orientation val="minMax"/>
        </c:scaling>
        <c:delete val="0"/>
        <c:axPos val="l"/>
        <c:title>
          <c:tx>
            <c:rich>
              <a:bodyPr rot="-54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r>
                  <a:rPr lang="en-US" sz="1400"/>
                  <a:t>Selectivity Coefficient</a:t>
                </a:r>
              </a:p>
            </c:rich>
          </c:tx>
          <c:layout>
            <c:manualLayout>
              <c:xMode val="edge"/>
              <c:yMode val="edge"/>
              <c:x val="0"/>
              <c:y val="0.30043720612196761"/>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100544015"/>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9.5190653951365486E-2"/>
          <c:y val="4.6617859716362481E-2"/>
          <c:w val="0.52093218673961339"/>
          <c:h val="0.67317106576644237"/>
        </c:manualLayout>
      </c:layout>
      <c:barChart>
        <c:barDir val="col"/>
        <c:grouping val="clustered"/>
        <c:varyColors val="0"/>
        <c:ser>
          <c:idx val="0"/>
          <c:order val="0"/>
          <c:tx>
            <c:strRef>
              <c:f>'Graph Day 1'!$B$3</c:f>
              <c:strCache>
                <c:ptCount val="1"/>
                <c:pt idx="0">
                  <c:v>Ascobic Acid</c:v>
                </c:pt>
              </c:strCache>
            </c:strRef>
          </c:tx>
          <c:spPr>
            <a:pattFill prst="pct60">
              <a:fgClr>
                <a:schemeClr val="accent1"/>
              </a:fgClr>
              <a:bgClr>
                <a:schemeClr val="bg1"/>
              </a:bgClr>
            </a:pattFill>
            <a:ln>
              <a:noFill/>
            </a:ln>
            <a:effectLst/>
          </c:spPr>
          <c:invertIfNegative val="0"/>
          <c:errBars>
            <c:errBarType val="both"/>
            <c:errValType val="cust"/>
            <c:noEndCap val="0"/>
            <c:plus>
              <c:numRef>
                <c:f>'Graph Day 1'!$C$13</c:f>
                <c:numCache>
                  <c:formatCode>General</c:formatCode>
                  <c:ptCount val="1"/>
                  <c:pt idx="0">
                    <c:v>0.11438821401773563</c:v>
                  </c:pt>
                </c:numCache>
              </c:numRef>
            </c:plus>
            <c:minus>
              <c:numRef>
                <c:f>'Graph Day 1'!$C$13</c:f>
                <c:numCache>
                  <c:formatCode>General</c:formatCode>
                  <c:ptCount val="1"/>
                  <c:pt idx="0">
                    <c:v>0.11438821401773563</c:v>
                  </c:pt>
                </c:numCache>
              </c:numRef>
            </c:minus>
            <c:spPr>
              <a:noFill/>
              <a:ln w="9525" cap="flat" cmpd="sng" algn="ctr">
                <a:solidFill>
                  <a:schemeClr val="tx1">
                    <a:lumMod val="65000"/>
                    <a:lumOff val="35000"/>
                  </a:schemeClr>
                </a:solidFill>
                <a:round/>
              </a:ln>
              <a:effectLst/>
            </c:spPr>
          </c:errBars>
          <c:val>
            <c:numRef>
              <c:f>'Graph Day 1'!$C$3</c:f>
              <c:numCache>
                <c:formatCode>General</c:formatCode>
                <c:ptCount val="1"/>
                <c:pt idx="0">
                  <c:v>-0.81767434048614573</c:v>
                </c:pt>
              </c:numCache>
            </c:numRef>
          </c:val>
          <c:extLst>
            <c:ext xmlns:c16="http://schemas.microsoft.com/office/drawing/2014/chart" uri="{C3380CC4-5D6E-409C-BE32-E72D297353CC}">
              <c16:uniqueId val="{00000000-C7ED-40A0-964E-155AA1DD0BA6}"/>
            </c:ext>
          </c:extLst>
        </c:ser>
        <c:ser>
          <c:idx val="1"/>
          <c:order val="1"/>
          <c:tx>
            <c:strRef>
              <c:f>'Graph Day 1'!$B$4</c:f>
              <c:strCache>
                <c:ptCount val="1"/>
                <c:pt idx="0">
                  <c:v>Glucose</c:v>
                </c:pt>
              </c:strCache>
            </c:strRef>
          </c:tx>
          <c:spPr>
            <a:pattFill prst="dkDnDiag">
              <a:fgClr>
                <a:schemeClr val="accent2"/>
              </a:fgClr>
              <a:bgClr>
                <a:schemeClr val="bg1"/>
              </a:bgClr>
            </a:pattFill>
            <a:ln>
              <a:noFill/>
            </a:ln>
            <a:effectLst/>
          </c:spPr>
          <c:invertIfNegative val="0"/>
          <c:errBars>
            <c:errBarType val="both"/>
            <c:errValType val="cust"/>
            <c:noEndCap val="0"/>
            <c:plus>
              <c:numRef>
                <c:f>'Graph Day 1'!$C$14</c:f>
                <c:numCache>
                  <c:formatCode>General</c:formatCode>
                  <c:ptCount val="1"/>
                  <c:pt idx="0">
                    <c:v>0.18132337612754815</c:v>
                  </c:pt>
                </c:numCache>
              </c:numRef>
            </c:plus>
            <c:minus>
              <c:numRef>
                <c:f>'Graph Day 1'!$C$14</c:f>
                <c:numCache>
                  <c:formatCode>General</c:formatCode>
                  <c:ptCount val="1"/>
                  <c:pt idx="0">
                    <c:v>0.18132337612754815</c:v>
                  </c:pt>
                </c:numCache>
              </c:numRef>
            </c:minus>
            <c:spPr>
              <a:noFill/>
              <a:ln w="9525" cap="flat" cmpd="sng" algn="ctr">
                <a:solidFill>
                  <a:schemeClr val="tx1">
                    <a:lumMod val="65000"/>
                    <a:lumOff val="35000"/>
                  </a:schemeClr>
                </a:solidFill>
                <a:round/>
              </a:ln>
              <a:effectLst/>
            </c:spPr>
          </c:errBars>
          <c:val>
            <c:numRef>
              <c:f>'Graph Day 1'!$C$4</c:f>
              <c:numCache>
                <c:formatCode>General</c:formatCode>
                <c:ptCount val="1"/>
                <c:pt idx="0">
                  <c:v>-1.8876778641662866</c:v>
                </c:pt>
              </c:numCache>
            </c:numRef>
          </c:val>
          <c:extLst>
            <c:ext xmlns:c16="http://schemas.microsoft.com/office/drawing/2014/chart" uri="{C3380CC4-5D6E-409C-BE32-E72D297353CC}">
              <c16:uniqueId val="{00000001-C7ED-40A0-964E-155AA1DD0BA6}"/>
            </c:ext>
          </c:extLst>
        </c:ser>
        <c:ser>
          <c:idx val="2"/>
          <c:order val="2"/>
          <c:tx>
            <c:strRef>
              <c:f>'Graph Day 1'!$B$5</c:f>
              <c:strCache>
                <c:ptCount val="1"/>
                <c:pt idx="0">
                  <c:v>Sodium Benzoate</c:v>
                </c:pt>
              </c:strCache>
            </c:strRef>
          </c:tx>
          <c:spPr>
            <a:pattFill prst="horzBrick">
              <a:fgClr>
                <a:schemeClr val="accent3"/>
              </a:fgClr>
              <a:bgClr>
                <a:schemeClr val="bg1"/>
              </a:bgClr>
            </a:pattFill>
            <a:ln>
              <a:noFill/>
            </a:ln>
            <a:effectLst/>
          </c:spPr>
          <c:invertIfNegative val="0"/>
          <c:errBars>
            <c:errBarType val="both"/>
            <c:errValType val="cust"/>
            <c:noEndCap val="0"/>
            <c:plus>
              <c:numRef>
                <c:f>'Graph Day 1'!$C$15</c:f>
                <c:numCache>
                  <c:formatCode>General</c:formatCode>
                  <c:ptCount val="1"/>
                  <c:pt idx="0">
                    <c:v>2.5433922435733794E-2</c:v>
                  </c:pt>
                </c:numCache>
              </c:numRef>
            </c:plus>
            <c:minus>
              <c:numRef>
                <c:f>'Graph Day 1'!$C$15</c:f>
                <c:numCache>
                  <c:formatCode>General</c:formatCode>
                  <c:ptCount val="1"/>
                  <c:pt idx="0">
                    <c:v>2.5433922435733794E-2</c:v>
                  </c:pt>
                </c:numCache>
              </c:numRef>
            </c:minus>
            <c:spPr>
              <a:noFill/>
              <a:ln w="9525" cap="flat" cmpd="sng" algn="ctr">
                <a:solidFill>
                  <a:schemeClr val="tx1">
                    <a:lumMod val="65000"/>
                    <a:lumOff val="35000"/>
                  </a:schemeClr>
                </a:solidFill>
                <a:round/>
              </a:ln>
              <a:effectLst/>
            </c:spPr>
          </c:errBars>
          <c:val>
            <c:numRef>
              <c:f>'Graph Day 1'!$C$5</c:f>
              <c:numCache>
                <c:formatCode>General</c:formatCode>
                <c:ptCount val="1"/>
                <c:pt idx="0">
                  <c:v>-1.3933168716818041</c:v>
                </c:pt>
              </c:numCache>
            </c:numRef>
          </c:val>
          <c:extLst>
            <c:ext xmlns:c16="http://schemas.microsoft.com/office/drawing/2014/chart" uri="{C3380CC4-5D6E-409C-BE32-E72D297353CC}">
              <c16:uniqueId val="{00000002-C7ED-40A0-964E-155AA1DD0BA6}"/>
            </c:ext>
          </c:extLst>
        </c:ser>
        <c:ser>
          <c:idx val="3"/>
          <c:order val="3"/>
          <c:tx>
            <c:strRef>
              <c:f>'Graph Day 1'!$B$6</c:f>
              <c:strCache>
                <c:ptCount val="1"/>
                <c:pt idx="0">
                  <c:v>Uric Acid</c:v>
                </c:pt>
              </c:strCache>
            </c:strRef>
          </c:tx>
          <c:spPr>
            <a:pattFill prst="trellis">
              <a:fgClr>
                <a:schemeClr val="accent4"/>
              </a:fgClr>
              <a:bgClr>
                <a:schemeClr val="bg1"/>
              </a:bgClr>
            </a:pattFill>
            <a:ln>
              <a:noFill/>
            </a:ln>
            <a:effectLst/>
          </c:spPr>
          <c:invertIfNegative val="0"/>
          <c:errBars>
            <c:errBarType val="both"/>
            <c:errValType val="cust"/>
            <c:noEndCap val="0"/>
            <c:plus>
              <c:numRef>
                <c:f>'Graph Day 1'!$C$16</c:f>
                <c:numCache>
                  <c:formatCode>General</c:formatCode>
                  <c:ptCount val="1"/>
                  <c:pt idx="0">
                    <c:v>7.7855158701853791E-2</c:v>
                  </c:pt>
                </c:numCache>
              </c:numRef>
            </c:plus>
            <c:minus>
              <c:numRef>
                <c:f>'Graph Day 1'!$C$16</c:f>
                <c:numCache>
                  <c:formatCode>General</c:formatCode>
                  <c:ptCount val="1"/>
                  <c:pt idx="0">
                    <c:v>7.7855158701853791E-2</c:v>
                  </c:pt>
                </c:numCache>
              </c:numRef>
            </c:minus>
            <c:spPr>
              <a:noFill/>
              <a:ln w="9525" cap="flat" cmpd="sng" algn="ctr">
                <a:solidFill>
                  <a:schemeClr val="tx1">
                    <a:lumMod val="65000"/>
                    <a:lumOff val="35000"/>
                  </a:schemeClr>
                </a:solidFill>
                <a:round/>
              </a:ln>
              <a:effectLst/>
            </c:spPr>
          </c:errBars>
          <c:val>
            <c:numRef>
              <c:f>'Graph Day 1'!$C$6</c:f>
              <c:numCache>
                <c:formatCode>General</c:formatCode>
                <c:ptCount val="1"/>
                <c:pt idx="0">
                  <c:v>-0.32420970609168021</c:v>
                </c:pt>
              </c:numCache>
            </c:numRef>
          </c:val>
          <c:extLst>
            <c:ext xmlns:c16="http://schemas.microsoft.com/office/drawing/2014/chart" uri="{C3380CC4-5D6E-409C-BE32-E72D297353CC}">
              <c16:uniqueId val="{00000003-C7ED-40A0-964E-155AA1DD0BA6}"/>
            </c:ext>
          </c:extLst>
        </c:ser>
        <c:ser>
          <c:idx val="4"/>
          <c:order val="4"/>
          <c:tx>
            <c:strRef>
              <c:f>'Graph Day 1'!$B$7</c:f>
              <c:strCache>
                <c:ptCount val="1"/>
                <c:pt idx="0">
                  <c:v>Creatinine</c:v>
                </c:pt>
              </c:strCache>
            </c:strRef>
          </c:tx>
          <c:spPr>
            <a:pattFill prst="narVert">
              <a:fgClr>
                <a:schemeClr val="accent5"/>
              </a:fgClr>
              <a:bgClr>
                <a:schemeClr val="bg1"/>
              </a:bgClr>
            </a:pattFill>
            <a:ln>
              <a:noFill/>
            </a:ln>
            <a:effectLst/>
          </c:spPr>
          <c:invertIfNegative val="0"/>
          <c:errBars>
            <c:errBarType val="both"/>
            <c:errValType val="cust"/>
            <c:noEndCap val="0"/>
            <c:plus>
              <c:numRef>
                <c:f>'Graph Day 1'!$C$17</c:f>
                <c:numCache>
                  <c:formatCode>General</c:formatCode>
                  <c:ptCount val="1"/>
                  <c:pt idx="0">
                    <c:v>0.19586806409735708</c:v>
                  </c:pt>
                </c:numCache>
              </c:numRef>
            </c:plus>
            <c:minus>
              <c:numRef>
                <c:f>'Graph Day 1'!$C$17</c:f>
                <c:numCache>
                  <c:formatCode>General</c:formatCode>
                  <c:ptCount val="1"/>
                  <c:pt idx="0">
                    <c:v>0.19586806409735708</c:v>
                  </c:pt>
                </c:numCache>
              </c:numRef>
            </c:minus>
            <c:spPr>
              <a:noFill/>
              <a:ln w="9525" cap="flat" cmpd="sng" algn="ctr">
                <a:solidFill>
                  <a:schemeClr val="tx1">
                    <a:lumMod val="65000"/>
                    <a:lumOff val="35000"/>
                  </a:schemeClr>
                </a:solidFill>
                <a:round/>
              </a:ln>
              <a:effectLst/>
            </c:spPr>
          </c:errBars>
          <c:val>
            <c:numRef>
              <c:f>'Graph Day 1'!$C$7</c:f>
              <c:numCache>
                <c:formatCode>General</c:formatCode>
                <c:ptCount val="1"/>
                <c:pt idx="0">
                  <c:v>-3.242986526182523</c:v>
                </c:pt>
              </c:numCache>
            </c:numRef>
          </c:val>
          <c:extLst>
            <c:ext xmlns:c16="http://schemas.microsoft.com/office/drawing/2014/chart" uri="{C3380CC4-5D6E-409C-BE32-E72D297353CC}">
              <c16:uniqueId val="{00000004-C7ED-40A0-964E-155AA1DD0BA6}"/>
            </c:ext>
          </c:extLst>
        </c:ser>
        <c:ser>
          <c:idx val="5"/>
          <c:order val="5"/>
          <c:tx>
            <c:strRef>
              <c:f>'Graph Day 1'!$B$8</c:f>
              <c:strCache>
                <c:ptCount val="1"/>
                <c:pt idx="0">
                  <c:v>Urea</c:v>
                </c:pt>
              </c:strCache>
            </c:strRef>
          </c:tx>
          <c:spPr>
            <a:solidFill>
              <a:schemeClr val="accent6"/>
            </a:solidFill>
            <a:ln>
              <a:noFill/>
            </a:ln>
            <a:effectLst/>
          </c:spPr>
          <c:invertIfNegative val="0"/>
          <c:dPt>
            <c:idx val="0"/>
            <c:invertIfNegative val="0"/>
            <c:bubble3D val="0"/>
            <c:spPr>
              <a:pattFill prst="pct50">
                <a:fgClr>
                  <a:schemeClr val="accent6"/>
                </a:fgClr>
                <a:bgClr>
                  <a:schemeClr val="bg1"/>
                </a:bgClr>
              </a:pattFill>
              <a:ln>
                <a:noFill/>
              </a:ln>
              <a:effectLst/>
            </c:spPr>
            <c:extLst>
              <c:ext xmlns:c16="http://schemas.microsoft.com/office/drawing/2014/chart" uri="{C3380CC4-5D6E-409C-BE32-E72D297353CC}">
                <c16:uniqueId val="{00000006-C7ED-40A0-964E-155AA1DD0BA6}"/>
              </c:ext>
            </c:extLst>
          </c:dPt>
          <c:errBars>
            <c:errBarType val="both"/>
            <c:errValType val="cust"/>
            <c:noEndCap val="0"/>
            <c:plus>
              <c:numRef>
                <c:f>'Graph Day 1'!$C$18</c:f>
                <c:numCache>
                  <c:formatCode>General</c:formatCode>
                  <c:ptCount val="1"/>
                  <c:pt idx="0">
                    <c:v>0.28715859228038654</c:v>
                  </c:pt>
                </c:numCache>
              </c:numRef>
            </c:plus>
            <c:minus>
              <c:numRef>
                <c:f>'Graph Day 1'!$C$18</c:f>
                <c:numCache>
                  <c:formatCode>General</c:formatCode>
                  <c:ptCount val="1"/>
                  <c:pt idx="0">
                    <c:v>0.28715859228038654</c:v>
                  </c:pt>
                </c:numCache>
              </c:numRef>
            </c:minus>
            <c:spPr>
              <a:noFill/>
              <a:ln w="9525" cap="flat" cmpd="sng" algn="ctr">
                <a:solidFill>
                  <a:schemeClr val="tx1">
                    <a:lumMod val="65000"/>
                    <a:lumOff val="35000"/>
                  </a:schemeClr>
                </a:solidFill>
                <a:round/>
              </a:ln>
              <a:effectLst/>
            </c:spPr>
          </c:errBars>
          <c:val>
            <c:numRef>
              <c:f>'Graph Day 1'!$C$8</c:f>
              <c:numCache>
                <c:formatCode>General</c:formatCode>
                <c:ptCount val="1"/>
                <c:pt idx="0">
                  <c:v>-3.9261328769730941</c:v>
                </c:pt>
              </c:numCache>
            </c:numRef>
          </c:val>
          <c:extLst>
            <c:ext xmlns:c16="http://schemas.microsoft.com/office/drawing/2014/chart" uri="{C3380CC4-5D6E-409C-BE32-E72D297353CC}">
              <c16:uniqueId val="{00000007-C7ED-40A0-964E-155AA1DD0BA6}"/>
            </c:ext>
          </c:extLst>
        </c:ser>
        <c:ser>
          <c:idx val="6"/>
          <c:order val="6"/>
          <c:tx>
            <c:strRef>
              <c:f>'Graph Day 1'!$B$9</c:f>
              <c:strCache>
                <c:ptCount val="1"/>
                <c:pt idx="0">
                  <c:v>Xanthine (30µM)</c:v>
                </c:pt>
              </c:strCache>
            </c:strRef>
          </c:tx>
          <c:spPr>
            <a:pattFill prst="solidDmnd">
              <a:fgClr>
                <a:schemeClr val="tx1"/>
              </a:fgClr>
              <a:bgClr>
                <a:schemeClr val="bg1"/>
              </a:bgClr>
            </a:pattFill>
            <a:ln>
              <a:noFill/>
            </a:ln>
            <a:effectLst/>
          </c:spPr>
          <c:invertIfNegative val="0"/>
          <c:errBars>
            <c:errBarType val="both"/>
            <c:errValType val="cust"/>
            <c:noEndCap val="0"/>
            <c:plus>
              <c:numRef>
                <c:f>'Graph Day 1'!$C$19</c:f>
                <c:numCache>
                  <c:formatCode>General</c:formatCode>
                  <c:ptCount val="1"/>
                  <c:pt idx="0">
                    <c:v>4.8634822141807851E-2</c:v>
                  </c:pt>
                </c:numCache>
              </c:numRef>
            </c:plus>
            <c:minus>
              <c:numRef>
                <c:f>'Graph Day 1'!$C$19</c:f>
                <c:numCache>
                  <c:formatCode>General</c:formatCode>
                  <c:ptCount val="1"/>
                  <c:pt idx="0">
                    <c:v>4.8634822141807851E-2</c:v>
                  </c:pt>
                </c:numCache>
              </c:numRef>
            </c:minus>
            <c:spPr>
              <a:noFill/>
              <a:ln w="9525" cap="flat" cmpd="sng" algn="ctr">
                <a:solidFill>
                  <a:schemeClr val="tx1">
                    <a:lumMod val="65000"/>
                    <a:lumOff val="35000"/>
                  </a:schemeClr>
                </a:solidFill>
                <a:round/>
              </a:ln>
              <a:effectLst/>
            </c:spPr>
          </c:errBars>
          <c:val>
            <c:numRef>
              <c:f>'Graph Day 1'!$C$9</c:f>
              <c:numCache>
                <c:formatCode>General</c:formatCode>
                <c:ptCount val="1"/>
                <c:pt idx="0">
                  <c:v>1.1493382629134767E-2</c:v>
                </c:pt>
              </c:numCache>
            </c:numRef>
          </c:val>
          <c:extLst>
            <c:ext xmlns:c16="http://schemas.microsoft.com/office/drawing/2014/chart" uri="{C3380CC4-5D6E-409C-BE32-E72D297353CC}">
              <c16:uniqueId val="{00000008-C7ED-40A0-964E-155AA1DD0BA6}"/>
            </c:ext>
          </c:extLst>
        </c:ser>
        <c:dLbls>
          <c:showLegendKey val="0"/>
          <c:showVal val="0"/>
          <c:showCatName val="0"/>
          <c:showSerName val="0"/>
          <c:showPercent val="0"/>
          <c:showBubbleSize val="0"/>
        </c:dLbls>
        <c:gapWidth val="500"/>
        <c:axId val="1100544015"/>
        <c:axId val="1216485199"/>
      </c:barChart>
      <c:catAx>
        <c:axId val="1100544015"/>
        <c:scaling>
          <c:orientation val="minMax"/>
        </c:scaling>
        <c:delete val="0"/>
        <c:axPos val="b"/>
        <c:title>
          <c:tx>
            <c:rich>
              <a:bodyPr rot="0" spcFirstLastPara="1" vertOverflow="ellipsis" vert="horz" wrap="square" anchor="ctr" anchorCtr="1"/>
              <a:lstStyle/>
              <a:p>
                <a:pPr>
                  <a:defRPr sz="1500" b="0" i="0" u="none" strike="noStrike" kern="1200" baseline="0">
                    <a:solidFill>
                      <a:schemeClr val="tx1"/>
                    </a:solidFill>
                    <a:latin typeface="Arial" panose="020B0604020202020204" pitchFamily="34" charset="0"/>
                    <a:ea typeface="+mn-ea"/>
                    <a:cs typeface="Arial" panose="020B0604020202020204" pitchFamily="34" charset="0"/>
                  </a:defRPr>
                </a:pPr>
                <a:r>
                  <a:rPr lang="en-US" sz="1500"/>
                  <a:t>Interferent</a:t>
                </a:r>
              </a:p>
            </c:rich>
          </c:tx>
          <c:layout>
            <c:manualLayout>
              <c:xMode val="edge"/>
              <c:yMode val="edge"/>
              <c:x val="0.34899647860716065"/>
              <c:y val="0.69901056190631783"/>
            </c:manualLayout>
          </c:layout>
          <c:overlay val="0"/>
          <c:spPr>
            <a:noFill/>
            <a:ln>
              <a:noFill/>
            </a:ln>
            <a:effectLst/>
          </c:spPr>
          <c:txPr>
            <a:bodyPr rot="0" spcFirstLastPara="1" vertOverflow="ellipsis" vert="horz" wrap="square" anchor="ctr" anchorCtr="1"/>
            <a:lstStyle/>
            <a:p>
              <a:pPr>
                <a:defRPr sz="15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16485199"/>
        <c:crosses val="autoZero"/>
        <c:auto val="1"/>
        <c:lblAlgn val="ctr"/>
        <c:lblOffset val="100"/>
        <c:tickLblSkip val="1"/>
        <c:noMultiLvlLbl val="0"/>
      </c:catAx>
      <c:valAx>
        <c:axId val="1216485199"/>
        <c:scaling>
          <c:orientation val="minMax"/>
        </c:scaling>
        <c:delete val="0"/>
        <c:axPos val="l"/>
        <c:title>
          <c:tx>
            <c:rich>
              <a:bodyPr rot="-54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r>
                  <a:rPr lang="en-US" sz="1400"/>
                  <a:t>Selectivity Coefficient</a:t>
                </a:r>
              </a:p>
            </c:rich>
          </c:tx>
          <c:overlay val="0"/>
          <c:spPr>
            <a:noFill/>
            <a:ln>
              <a:noFill/>
            </a:ln>
            <a:effectLst/>
          </c:spPr>
          <c:txPr>
            <a:bodyPr rot="-54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100544015"/>
        <c:crosses val="autoZero"/>
        <c:crossBetween val="between"/>
      </c:valAx>
      <c:spPr>
        <a:noFill/>
        <a:ln w="25400">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All!$B$2</c:f>
              <c:strCache>
                <c:ptCount val="1"/>
                <c:pt idx="0">
                  <c:v>Ascobic Acid</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strRef>
              <c:f>All!$C$1:$E$1</c:f>
              <c:strCache>
                <c:ptCount val="3"/>
                <c:pt idx="0">
                  <c:v>Day 1</c:v>
                </c:pt>
                <c:pt idx="1">
                  <c:v>Day 3</c:v>
                </c:pt>
                <c:pt idx="2">
                  <c:v>Day 5</c:v>
                </c:pt>
              </c:strCache>
            </c:strRef>
          </c:cat>
          <c:val>
            <c:numRef>
              <c:f>All!$C$2:$E$2</c:f>
              <c:numCache>
                <c:formatCode>General</c:formatCode>
                <c:ptCount val="3"/>
                <c:pt idx="0">
                  <c:v>-0.81767434000000006</c:v>
                </c:pt>
                <c:pt idx="1">
                  <c:v>-0.79292203289999996</c:v>
                </c:pt>
                <c:pt idx="2">
                  <c:v>-0.86583659499999999</c:v>
                </c:pt>
              </c:numCache>
            </c:numRef>
          </c:val>
          <c:smooth val="0"/>
          <c:extLst>
            <c:ext xmlns:c16="http://schemas.microsoft.com/office/drawing/2014/chart" uri="{C3380CC4-5D6E-409C-BE32-E72D297353CC}">
              <c16:uniqueId val="{00000000-9173-40BA-8252-4908C83C5F95}"/>
            </c:ext>
          </c:extLst>
        </c:ser>
        <c:ser>
          <c:idx val="1"/>
          <c:order val="1"/>
          <c:tx>
            <c:strRef>
              <c:f>All!$B$3</c:f>
              <c:strCache>
                <c:ptCount val="1"/>
                <c:pt idx="0">
                  <c:v>Glucose</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cat>
            <c:strRef>
              <c:f>All!$C$1:$E$1</c:f>
              <c:strCache>
                <c:ptCount val="3"/>
                <c:pt idx="0">
                  <c:v>Day 1</c:v>
                </c:pt>
                <c:pt idx="1">
                  <c:v>Day 3</c:v>
                </c:pt>
                <c:pt idx="2">
                  <c:v>Day 5</c:v>
                </c:pt>
              </c:strCache>
            </c:strRef>
          </c:cat>
          <c:val>
            <c:numRef>
              <c:f>All!$C$3:$E$3</c:f>
              <c:numCache>
                <c:formatCode>General</c:formatCode>
                <c:ptCount val="3"/>
                <c:pt idx="0">
                  <c:v>-1.887677864</c:v>
                </c:pt>
                <c:pt idx="1">
                  <c:v>-2.6654336729999999</c:v>
                </c:pt>
                <c:pt idx="2">
                  <c:v>-2.1089140880000001</c:v>
                </c:pt>
              </c:numCache>
            </c:numRef>
          </c:val>
          <c:smooth val="0"/>
          <c:extLst>
            <c:ext xmlns:c16="http://schemas.microsoft.com/office/drawing/2014/chart" uri="{C3380CC4-5D6E-409C-BE32-E72D297353CC}">
              <c16:uniqueId val="{00000001-9173-40BA-8252-4908C83C5F95}"/>
            </c:ext>
          </c:extLst>
        </c:ser>
        <c:ser>
          <c:idx val="2"/>
          <c:order val="2"/>
          <c:tx>
            <c:strRef>
              <c:f>All!$B$4</c:f>
              <c:strCache>
                <c:ptCount val="1"/>
                <c:pt idx="0">
                  <c:v>Sodium Benzoate</c:v>
                </c:pt>
              </c:strCache>
            </c:strRef>
          </c:tx>
          <c:spPr>
            <a:ln w="28575" cap="rnd">
              <a:solidFill>
                <a:srgbClr val="7030A0"/>
              </a:solidFill>
              <a:round/>
            </a:ln>
            <a:effectLst/>
          </c:spPr>
          <c:marker>
            <c:symbol val="circle"/>
            <c:size val="5"/>
            <c:spPr>
              <a:solidFill>
                <a:schemeClr val="accent3"/>
              </a:solidFill>
              <a:ln w="9525">
                <a:solidFill>
                  <a:schemeClr val="accent3"/>
                </a:solidFill>
              </a:ln>
              <a:effectLst/>
            </c:spPr>
          </c:marker>
          <c:cat>
            <c:strRef>
              <c:f>All!$C$1:$E$1</c:f>
              <c:strCache>
                <c:ptCount val="3"/>
                <c:pt idx="0">
                  <c:v>Day 1</c:v>
                </c:pt>
                <c:pt idx="1">
                  <c:v>Day 3</c:v>
                </c:pt>
                <c:pt idx="2">
                  <c:v>Day 5</c:v>
                </c:pt>
              </c:strCache>
            </c:strRef>
          </c:cat>
          <c:val>
            <c:numRef>
              <c:f>All!$C$4:$E$4</c:f>
              <c:numCache>
                <c:formatCode>General</c:formatCode>
                <c:ptCount val="3"/>
                <c:pt idx="0">
                  <c:v>-1.393316872</c:v>
                </c:pt>
                <c:pt idx="1">
                  <c:v>-2.8070026239999999</c:v>
                </c:pt>
                <c:pt idx="2">
                  <c:v>-2.3421989110000001</c:v>
                </c:pt>
              </c:numCache>
            </c:numRef>
          </c:val>
          <c:smooth val="0"/>
          <c:extLst>
            <c:ext xmlns:c16="http://schemas.microsoft.com/office/drawing/2014/chart" uri="{C3380CC4-5D6E-409C-BE32-E72D297353CC}">
              <c16:uniqueId val="{00000002-9173-40BA-8252-4908C83C5F95}"/>
            </c:ext>
          </c:extLst>
        </c:ser>
        <c:ser>
          <c:idx val="3"/>
          <c:order val="3"/>
          <c:tx>
            <c:strRef>
              <c:f>All!$B$5</c:f>
              <c:strCache>
                <c:ptCount val="1"/>
                <c:pt idx="0">
                  <c:v>Uric Acid</c:v>
                </c:pt>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cat>
            <c:strRef>
              <c:f>All!$C$1:$E$1</c:f>
              <c:strCache>
                <c:ptCount val="3"/>
                <c:pt idx="0">
                  <c:v>Day 1</c:v>
                </c:pt>
                <c:pt idx="1">
                  <c:v>Day 3</c:v>
                </c:pt>
                <c:pt idx="2">
                  <c:v>Day 5</c:v>
                </c:pt>
              </c:strCache>
            </c:strRef>
          </c:cat>
          <c:val>
            <c:numRef>
              <c:f>All!$C$5:$E$5</c:f>
              <c:numCache>
                <c:formatCode>General</c:formatCode>
                <c:ptCount val="3"/>
                <c:pt idx="0">
                  <c:v>-0.32420970599999999</c:v>
                </c:pt>
                <c:pt idx="1">
                  <c:v>-0.48760675380000001</c:v>
                </c:pt>
                <c:pt idx="2">
                  <c:v>-0.30990993979999998</c:v>
                </c:pt>
              </c:numCache>
            </c:numRef>
          </c:val>
          <c:smooth val="0"/>
          <c:extLst>
            <c:ext xmlns:c16="http://schemas.microsoft.com/office/drawing/2014/chart" uri="{C3380CC4-5D6E-409C-BE32-E72D297353CC}">
              <c16:uniqueId val="{00000003-9173-40BA-8252-4908C83C5F95}"/>
            </c:ext>
          </c:extLst>
        </c:ser>
        <c:ser>
          <c:idx val="4"/>
          <c:order val="4"/>
          <c:tx>
            <c:strRef>
              <c:f>All!$B$6</c:f>
              <c:strCache>
                <c:ptCount val="1"/>
                <c:pt idx="0">
                  <c:v>Creatinine</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cat>
            <c:strRef>
              <c:f>All!$C$1:$E$1</c:f>
              <c:strCache>
                <c:ptCount val="3"/>
                <c:pt idx="0">
                  <c:v>Day 1</c:v>
                </c:pt>
                <c:pt idx="1">
                  <c:v>Day 3</c:v>
                </c:pt>
                <c:pt idx="2">
                  <c:v>Day 5</c:v>
                </c:pt>
              </c:strCache>
            </c:strRef>
          </c:cat>
          <c:val>
            <c:numRef>
              <c:f>All!$C$6:$E$6</c:f>
              <c:numCache>
                <c:formatCode>General</c:formatCode>
                <c:ptCount val="3"/>
                <c:pt idx="0">
                  <c:v>-3.2429865260000001</c:v>
                </c:pt>
                <c:pt idx="1">
                  <c:v>-4.0270771889999999</c:v>
                </c:pt>
                <c:pt idx="2">
                  <c:v>-2.8583305229999998</c:v>
                </c:pt>
              </c:numCache>
            </c:numRef>
          </c:val>
          <c:smooth val="0"/>
          <c:extLst>
            <c:ext xmlns:c16="http://schemas.microsoft.com/office/drawing/2014/chart" uri="{C3380CC4-5D6E-409C-BE32-E72D297353CC}">
              <c16:uniqueId val="{00000004-9173-40BA-8252-4908C83C5F95}"/>
            </c:ext>
          </c:extLst>
        </c:ser>
        <c:ser>
          <c:idx val="5"/>
          <c:order val="5"/>
          <c:tx>
            <c:strRef>
              <c:f>All!$B$7</c:f>
              <c:strCache>
                <c:ptCount val="1"/>
                <c:pt idx="0">
                  <c:v>Urea</c:v>
                </c:pt>
              </c:strCache>
            </c:strRef>
          </c:tx>
          <c:spPr>
            <a:ln w="28575" cap="rnd">
              <a:solidFill>
                <a:schemeClr val="accent6"/>
              </a:solidFill>
              <a:round/>
            </a:ln>
            <a:effectLst/>
          </c:spPr>
          <c:marker>
            <c:symbol val="circle"/>
            <c:size val="5"/>
            <c:spPr>
              <a:solidFill>
                <a:schemeClr val="accent6"/>
              </a:solidFill>
              <a:ln w="9525">
                <a:solidFill>
                  <a:schemeClr val="accent6"/>
                </a:solidFill>
              </a:ln>
              <a:effectLst/>
            </c:spPr>
          </c:marker>
          <c:cat>
            <c:strRef>
              <c:f>All!$C$1:$E$1</c:f>
              <c:strCache>
                <c:ptCount val="3"/>
                <c:pt idx="0">
                  <c:v>Day 1</c:v>
                </c:pt>
                <c:pt idx="1">
                  <c:v>Day 3</c:v>
                </c:pt>
                <c:pt idx="2">
                  <c:v>Day 5</c:v>
                </c:pt>
              </c:strCache>
            </c:strRef>
          </c:cat>
          <c:val>
            <c:numRef>
              <c:f>All!$C$7:$E$7</c:f>
              <c:numCache>
                <c:formatCode>General</c:formatCode>
                <c:ptCount val="3"/>
                <c:pt idx="0">
                  <c:v>-3.9261328770000001</c:v>
                </c:pt>
                <c:pt idx="1">
                  <c:v>-3.7681927399999999</c:v>
                </c:pt>
                <c:pt idx="2">
                  <c:v>-4.2550346650000002</c:v>
                </c:pt>
              </c:numCache>
            </c:numRef>
          </c:val>
          <c:smooth val="0"/>
          <c:extLst>
            <c:ext xmlns:c16="http://schemas.microsoft.com/office/drawing/2014/chart" uri="{C3380CC4-5D6E-409C-BE32-E72D297353CC}">
              <c16:uniqueId val="{00000005-9173-40BA-8252-4908C83C5F95}"/>
            </c:ext>
          </c:extLst>
        </c:ser>
        <c:ser>
          <c:idx val="6"/>
          <c:order val="6"/>
          <c:tx>
            <c:strRef>
              <c:f>All!$B$8</c:f>
              <c:strCache>
                <c:ptCount val="1"/>
                <c:pt idx="0">
                  <c:v>Xanthine (30µM)</c:v>
                </c:pt>
              </c:strCache>
            </c:strRef>
          </c:tx>
          <c:spPr>
            <a:ln w="28575" cap="rnd">
              <a:solidFill>
                <a:schemeClr val="tx1"/>
              </a:solidFill>
              <a:round/>
            </a:ln>
            <a:effectLst/>
          </c:spPr>
          <c:marker>
            <c:symbol val="circle"/>
            <c:size val="5"/>
            <c:spPr>
              <a:solidFill>
                <a:schemeClr val="tx1"/>
              </a:solidFill>
              <a:ln w="9525">
                <a:solidFill>
                  <a:schemeClr val="accent1">
                    <a:lumMod val="60000"/>
                  </a:schemeClr>
                </a:solidFill>
              </a:ln>
              <a:effectLst/>
            </c:spPr>
          </c:marker>
          <c:cat>
            <c:strRef>
              <c:f>All!$C$1:$E$1</c:f>
              <c:strCache>
                <c:ptCount val="3"/>
                <c:pt idx="0">
                  <c:v>Day 1</c:v>
                </c:pt>
                <c:pt idx="1">
                  <c:v>Day 3</c:v>
                </c:pt>
                <c:pt idx="2">
                  <c:v>Day 5</c:v>
                </c:pt>
              </c:strCache>
            </c:strRef>
          </c:cat>
          <c:val>
            <c:numRef>
              <c:f>All!$C$8:$E$8</c:f>
              <c:numCache>
                <c:formatCode>General</c:formatCode>
                <c:ptCount val="3"/>
                <c:pt idx="0">
                  <c:v>1.1493382999999999E-2</c:v>
                </c:pt>
                <c:pt idx="1">
                  <c:v>5.4414158640000002E-2</c:v>
                </c:pt>
                <c:pt idx="2">
                  <c:v>-0.1060276112</c:v>
                </c:pt>
              </c:numCache>
            </c:numRef>
          </c:val>
          <c:smooth val="0"/>
          <c:extLst>
            <c:ext xmlns:c16="http://schemas.microsoft.com/office/drawing/2014/chart" uri="{C3380CC4-5D6E-409C-BE32-E72D297353CC}">
              <c16:uniqueId val="{00000006-9173-40BA-8252-4908C83C5F95}"/>
            </c:ext>
          </c:extLst>
        </c:ser>
        <c:dLbls>
          <c:showLegendKey val="0"/>
          <c:showVal val="0"/>
          <c:showCatName val="0"/>
          <c:showSerName val="0"/>
          <c:showPercent val="0"/>
          <c:showBubbleSize val="0"/>
        </c:dLbls>
        <c:marker val="1"/>
        <c:smooth val="0"/>
        <c:axId val="1029290783"/>
        <c:axId val="923765263"/>
      </c:lineChart>
      <c:catAx>
        <c:axId val="1029290783"/>
        <c:scaling>
          <c:orientation val="minMax"/>
        </c:scaling>
        <c:delete val="0"/>
        <c:axPos val="b"/>
        <c:numFmt formatCode="General" sourceLinked="1"/>
        <c:majorTickMark val="none"/>
        <c:minorTickMark val="none"/>
        <c:tickLblPos val="high"/>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923765263"/>
        <c:crosses val="autoZero"/>
        <c:auto val="1"/>
        <c:lblAlgn val="ctr"/>
        <c:lblOffset val="100"/>
        <c:noMultiLvlLbl val="0"/>
      </c:catAx>
      <c:valAx>
        <c:axId val="923765263"/>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sz="1400" dirty="0"/>
                  <a:t>Selectivity Coefficient</a:t>
                </a:r>
                <a:endParaRPr lang="en-US" dirty="0"/>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029290783"/>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640468679793794"/>
          <c:y val="8.9372178477690287E-2"/>
          <c:w val="0.86359531320206206"/>
          <c:h val="0.62082602232077444"/>
        </c:manualLayout>
      </c:layout>
      <c:lineChart>
        <c:grouping val="standard"/>
        <c:varyColors val="0"/>
        <c:ser>
          <c:idx val="0"/>
          <c:order val="0"/>
          <c:tx>
            <c:strRef>
              <c:f>All!$B$3</c:f>
              <c:strCache>
                <c:ptCount val="1"/>
                <c:pt idx="0">
                  <c:v>Ascobic Acid</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strRef>
              <c:f>All!$C$2:$F$2</c:f>
              <c:strCache>
                <c:ptCount val="4"/>
                <c:pt idx="0">
                  <c:v>Day 1</c:v>
                </c:pt>
                <c:pt idx="1">
                  <c:v>Day 3</c:v>
                </c:pt>
                <c:pt idx="2">
                  <c:v>Day 5</c:v>
                </c:pt>
                <c:pt idx="3">
                  <c:v>Day 7</c:v>
                </c:pt>
              </c:strCache>
            </c:strRef>
          </c:cat>
          <c:val>
            <c:numRef>
              <c:f>All!$C$3:$F$3</c:f>
              <c:numCache>
                <c:formatCode>General</c:formatCode>
                <c:ptCount val="4"/>
                <c:pt idx="0">
                  <c:v>-0.98726870487075291</c:v>
                </c:pt>
                <c:pt idx="1">
                  <c:v>-0.91203757959999998</c:v>
                </c:pt>
                <c:pt idx="2">
                  <c:v>-0.79520080199999998</c:v>
                </c:pt>
                <c:pt idx="3">
                  <c:v>-0.99149001329999997</c:v>
                </c:pt>
              </c:numCache>
            </c:numRef>
          </c:val>
          <c:smooth val="0"/>
          <c:extLst>
            <c:ext xmlns:c16="http://schemas.microsoft.com/office/drawing/2014/chart" uri="{C3380CC4-5D6E-409C-BE32-E72D297353CC}">
              <c16:uniqueId val="{00000000-370D-4E44-B660-F4D618837F6B}"/>
            </c:ext>
          </c:extLst>
        </c:ser>
        <c:ser>
          <c:idx val="1"/>
          <c:order val="1"/>
          <c:tx>
            <c:strRef>
              <c:f>All!$B$4</c:f>
              <c:strCache>
                <c:ptCount val="1"/>
                <c:pt idx="0">
                  <c:v>Glucose</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cat>
            <c:strRef>
              <c:f>All!$C$2:$F$2</c:f>
              <c:strCache>
                <c:ptCount val="4"/>
                <c:pt idx="0">
                  <c:v>Day 1</c:v>
                </c:pt>
                <c:pt idx="1">
                  <c:v>Day 3</c:v>
                </c:pt>
                <c:pt idx="2">
                  <c:v>Day 5</c:v>
                </c:pt>
                <c:pt idx="3">
                  <c:v>Day 7</c:v>
                </c:pt>
              </c:strCache>
            </c:strRef>
          </c:cat>
          <c:val>
            <c:numRef>
              <c:f>All!$C$4:$F$4</c:f>
              <c:numCache>
                <c:formatCode>General</c:formatCode>
                <c:ptCount val="4"/>
                <c:pt idx="0">
                  <c:v>-1.8726417626921901</c:v>
                </c:pt>
                <c:pt idx="1">
                  <c:v>-2.639385152</c:v>
                </c:pt>
                <c:pt idx="2">
                  <c:v>-2.3599081759999998</c:v>
                </c:pt>
                <c:pt idx="3">
                  <c:v>-2.1364645069999999</c:v>
                </c:pt>
              </c:numCache>
            </c:numRef>
          </c:val>
          <c:smooth val="0"/>
          <c:extLst>
            <c:ext xmlns:c16="http://schemas.microsoft.com/office/drawing/2014/chart" uri="{C3380CC4-5D6E-409C-BE32-E72D297353CC}">
              <c16:uniqueId val="{00000001-370D-4E44-B660-F4D618837F6B}"/>
            </c:ext>
          </c:extLst>
        </c:ser>
        <c:ser>
          <c:idx val="2"/>
          <c:order val="2"/>
          <c:tx>
            <c:strRef>
              <c:f>All!$B$5</c:f>
              <c:strCache>
                <c:ptCount val="1"/>
                <c:pt idx="0">
                  <c:v>Sodium Benzoate</c:v>
                </c:pt>
              </c:strCache>
            </c:strRef>
          </c:tx>
          <c:spPr>
            <a:ln w="28575" cap="rnd">
              <a:solidFill>
                <a:srgbClr val="7030A0"/>
              </a:solidFill>
              <a:round/>
            </a:ln>
            <a:effectLst/>
          </c:spPr>
          <c:marker>
            <c:symbol val="circle"/>
            <c:size val="5"/>
            <c:spPr>
              <a:solidFill>
                <a:schemeClr val="accent3"/>
              </a:solidFill>
              <a:ln w="9525">
                <a:solidFill>
                  <a:schemeClr val="accent3"/>
                </a:solidFill>
              </a:ln>
              <a:effectLst/>
            </c:spPr>
          </c:marker>
          <c:cat>
            <c:strRef>
              <c:f>All!$C$2:$F$2</c:f>
              <c:strCache>
                <c:ptCount val="4"/>
                <c:pt idx="0">
                  <c:v>Day 1</c:v>
                </c:pt>
                <c:pt idx="1">
                  <c:v>Day 3</c:v>
                </c:pt>
                <c:pt idx="2">
                  <c:v>Day 5</c:v>
                </c:pt>
                <c:pt idx="3">
                  <c:v>Day 7</c:v>
                </c:pt>
              </c:strCache>
            </c:strRef>
          </c:cat>
          <c:val>
            <c:numRef>
              <c:f>All!$C$5:$F$5</c:f>
              <c:numCache>
                <c:formatCode>General</c:formatCode>
                <c:ptCount val="4"/>
                <c:pt idx="0">
                  <c:v>-1.4872695978426091</c:v>
                </c:pt>
                <c:pt idx="1">
                  <c:v>-2.2451864229999998</c:v>
                </c:pt>
                <c:pt idx="2">
                  <c:v>-2.7281482750000001</c:v>
                </c:pt>
                <c:pt idx="3">
                  <c:v>-2.062004285</c:v>
                </c:pt>
              </c:numCache>
            </c:numRef>
          </c:val>
          <c:smooth val="0"/>
          <c:extLst>
            <c:ext xmlns:c16="http://schemas.microsoft.com/office/drawing/2014/chart" uri="{C3380CC4-5D6E-409C-BE32-E72D297353CC}">
              <c16:uniqueId val="{00000002-370D-4E44-B660-F4D618837F6B}"/>
            </c:ext>
          </c:extLst>
        </c:ser>
        <c:ser>
          <c:idx val="3"/>
          <c:order val="3"/>
          <c:tx>
            <c:strRef>
              <c:f>All!$B$6</c:f>
              <c:strCache>
                <c:ptCount val="1"/>
                <c:pt idx="0">
                  <c:v>Uric Acid</c:v>
                </c:pt>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cat>
            <c:strRef>
              <c:f>All!$C$2:$F$2</c:f>
              <c:strCache>
                <c:ptCount val="4"/>
                <c:pt idx="0">
                  <c:v>Day 1</c:v>
                </c:pt>
                <c:pt idx="1">
                  <c:v>Day 3</c:v>
                </c:pt>
                <c:pt idx="2">
                  <c:v>Day 5</c:v>
                </c:pt>
                <c:pt idx="3">
                  <c:v>Day 7</c:v>
                </c:pt>
              </c:strCache>
            </c:strRef>
          </c:cat>
          <c:val>
            <c:numRef>
              <c:f>All!$C$6:$F$6</c:f>
              <c:numCache>
                <c:formatCode>General</c:formatCode>
                <c:ptCount val="4"/>
                <c:pt idx="0">
                  <c:v>-0.23955811014903011</c:v>
                </c:pt>
                <c:pt idx="1">
                  <c:v>-0.46602187360000003</c:v>
                </c:pt>
                <c:pt idx="2">
                  <c:v>-0.38145852070000003</c:v>
                </c:pt>
                <c:pt idx="3">
                  <c:v>-0.67514822360000004</c:v>
                </c:pt>
              </c:numCache>
            </c:numRef>
          </c:val>
          <c:smooth val="0"/>
          <c:extLst>
            <c:ext xmlns:c16="http://schemas.microsoft.com/office/drawing/2014/chart" uri="{C3380CC4-5D6E-409C-BE32-E72D297353CC}">
              <c16:uniqueId val="{00000003-370D-4E44-B660-F4D618837F6B}"/>
            </c:ext>
          </c:extLst>
        </c:ser>
        <c:ser>
          <c:idx val="4"/>
          <c:order val="4"/>
          <c:tx>
            <c:strRef>
              <c:f>All!$B$7</c:f>
              <c:strCache>
                <c:ptCount val="1"/>
                <c:pt idx="0">
                  <c:v>Creatinine</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cat>
            <c:strRef>
              <c:f>All!$C$2:$F$2</c:f>
              <c:strCache>
                <c:ptCount val="4"/>
                <c:pt idx="0">
                  <c:v>Day 1</c:v>
                </c:pt>
                <c:pt idx="1">
                  <c:v>Day 3</c:v>
                </c:pt>
                <c:pt idx="2">
                  <c:v>Day 5</c:v>
                </c:pt>
                <c:pt idx="3">
                  <c:v>Day 7</c:v>
                </c:pt>
              </c:strCache>
            </c:strRef>
          </c:cat>
          <c:val>
            <c:numRef>
              <c:f>All!$C$7:$F$7</c:f>
              <c:numCache>
                <c:formatCode>General</c:formatCode>
                <c:ptCount val="4"/>
                <c:pt idx="0">
                  <c:v>-2.843385057283407</c:v>
                </c:pt>
                <c:pt idx="1">
                  <c:v>-2.9277138159999998</c:v>
                </c:pt>
                <c:pt idx="2">
                  <c:v>-2.8545174790000001</c:v>
                </c:pt>
                <c:pt idx="3">
                  <c:v>-2.830850533</c:v>
                </c:pt>
              </c:numCache>
            </c:numRef>
          </c:val>
          <c:smooth val="0"/>
          <c:extLst>
            <c:ext xmlns:c16="http://schemas.microsoft.com/office/drawing/2014/chart" uri="{C3380CC4-5D6E-409C-BE32-E72D297353CC}">
              <c16:uniqueId val="{00000004-370D-4E44-B660-F4D618837F6B}"/>
            </c:ext>
          </c:extLst>
        </c:ser>
        <c:ser>
          <c:idx val="5"/>
          <c:order val="5"/>
          <c:tx>
            <c:strRef>
              <c:f>All!$B$8</c:f>
              <c:strCache>
                <c:ptCount val="1"/>
                <c:pt idx="0">
                  <c:v>Urea</c:v>
                </c:pt>
              </c:strCache>
            </c:strRef>
          </c:tx>
          <c:spPr>
            <a:ln w="28575" cap="rnd">
              <a:solidFill>
                <a:schemeClr val="accent6"/>
              </a:solidFill>
              <a:round/>
            </a:ln>
            <a:effectLst/>
          </c:spPr>
          <c:marker>
            <c:symbol val="circle"/>
            <c:size val="5"/>
            <c:spPr>
              <a:solidFill>
                <a:schemeClr val="accent6"/>
              </a:solidFill>
              <a:ln w="9525">
                <a:solidFill>
                  <a:schemeClr val="accent6"/>
                </a:solidFill>
              </a:ln>
              <a:effectLst/>
            </c:spPr>
          </c:marker>
          <c:cat>
            <c:strRef>
              <c:f>All!$C$2:$F$2</c:f>
              <c:strCache>
                <c:ptCount val="4"/>
                <c:pt idx="0">
                  <c:v>Day 1</c:v>
                </c:pt>
                <c:pt idx="1">
                  <c:v>Day 3</c:v>
                </c:pt>
                <c:pt idx="2">
                  <c:v>Day 5</c:v>
                </c:pt>
                <c:pt idx="3">
                  <c:v>Day 7</c:v>
                </c:pt>
              </c:strCache>
            </c:strRef>
          </c:cat>
          <c:val>
            <c:numRef>
              <c:f>All!$C$8:$F$8</c:f>
              <c:numCache>
                <c:formatCode>General</c:formatCode>
                <c:ptCount val="4"/>
                <c:pt idx="0">
                  <c:v>-4.3602974561442043</c:v>
                </c:pt>
                <c:pt idx="1">
                  <c:v>-4.3192521880000001</c:v>
                </c:pt>
                <c:pt idx="2">
                  <c:v>-4.755068412</c:v>
                </c:pt>
                <c:pt idx="3">
                  <c:v>-3.7304327150000001</c:v>
                </c:pt>
              </c:numCache>
            </c:numRef>
          </c:val>
          <c:smooth val="0"/>
          <c:extLst>
            <c:ext xmlns:c16="http://schemas.microsoft.com/office/drawing/2014/chart" uri="{C3380CC4-5D6E-409C-BE32-E72D297353CC}">
              <c16:uniqueId val="{00000005-370D-4E44-B660-F4D618837F6B}"/>
            </c:ext>
          </c:extLst>
        </c:ser>
        <c:ser>
          <c:idx val="6"/>
          <c:order val="6"/>
          <c:tx>
            <c:strRef>
              <c:f>All!$B$9</c:f>
              <c:strCache>
                <c:ptCount val="1"/>
                <c:pt idx="0">
                  <c:v>Xanthine (30µM)</c:v>
                </c:pt>
              </c:strCache>
            </c:strRef>
          </c:tx>
          <c:spPr>
            <a:ln w="28575" cap="rnd">
              <a:solidFill>
                <a:schemeClr val="tx1"/>
              </a:solidFill>
              <a:round/>
            </a:ln>
            <a:effectLst/>
          </c:spPr>
          <c:marker>
            <c:symbol val="circle"/>
            <c:size val="5"/>
            <c:spPr>
              <a:solidFill>
                <a:schemeClr val="accent1">
                  <a:lumMod val="60000"/>
                </a:schemeClr>
              </a:solidFill>
              <a:ln w="9525">
                <a:solidFill>
                  <a:schemeClr val="accent1">
                    <a:lumMod val="60000"/>
                  </a:schemeClr>
                </a:solidFill>
              </a:ln>
              <a:effectLst/>
            </c:spPr>
          </c:marker>
          <c:cat>
            <c:strRef>
              <c:f>All!$C$2:$F$2</c:f>
              <c:strCache>
                <c:ptCount val="4"/>
                <c:pt idx="0">
                  <c:v>Day 1</c:v>
                </c:pt>
                <c:pt idx="1">
                  <c:v>Day 3</c:v>
                </c:pt>
                <c:pt idx="2">
                  <c:v>Day 5</c:v>
                </c:pt>
                <c:pt idx="3">
                  <c:v>Day 7</c:v>
                </c:pt>
              </c:strCache>
            </c:strRef>
          </c:cat>
          <c:val>
            <c:numRef>
              <c:f>All!$C$9:$F$9</c:f>
              <c:numCache>
                <c:formatCode>General</c:formatCode>
                <c:ptCount val="4"/>
                <c:pt idx="0">
                  <c:v>2.4644617559589792E-2</c:v>
                </c:pt>
                <c:pt idx="1">
                  <c:v>-4.1857873410000003E-2</c:v>
                </c:pt>
                <c:pt idx="2">
                  <c:v>1.63280999E-2</c:v>
                </c:pt>
                <c:pt idx="3">
                  <c:v>-3.186347808E-2</c:v>
                </c:pt>
              </c:numCache>
            </c:numRef>
          </c:val>
          <c:smooth val="0"/>
          <c:extLst>
            <c:ext xmlns:c16="http://schemas.microsoft.com/office/drawing/2014/chart" uri="{C3380CC4-5D6E-409C-BE32-E72D297353CC}">
              <c16:uniqueId val="{00000006-370D-4E44-B660-F4D618837F6B}"/>
            </c:ext>
          </c:extLst>
        </c:ser>
        <c:dLbls>
          <c:showLegendKey val="0"/>
          <c:showVal val="0"/>
          <c:showCatName val="0"/>
          <c:showSerName val="0"/>
          <c:showPercent val="0"/>
          <c:showBubbleSize val="0"/>
        </c:dLbls>
        <c:marker val="1"/>
        <c:smooth val="0"/>
        <c:axId val="1070950831"/>
        <c:axId val="1070717263"/>
      </c:lineChart>
      <c:catAx>
        <c:axId val="1070950831"/>
        <c:scaling>
          <c:orientation val="minMax"/>
        </c:scaling>
        <c:delete val="0"/>
        <c:axPos val="b"/>
        <c:numFmt formatCode="General" sourceLinked="1"/>
        <c:majorTickMark val="none"/>
        <c:minorTickMark val="none"/>
        <c:tickLblPos val="high"/>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070717263"/>
        <c:crosses val="autoZero"/>
        <c:auto val="1"/>
        <c:lblAlgn val="ctr"/>
        <c:lblOffset val="100"/>
        <c:noMultiLvlLbl val="0"/>
      </c:catAx>
      <c:valAx>
        <c:axId val="1070717263"/>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r>
                  <a:rPr lang="en-US" sz="1400"/>
                  <a:t>Selectivity Coefficient</a:t>
                </a:r>
              </a:p>
            </c:rich>
          </c:tx>
          <c:overlay val="0"/>
          <c:spPr>
            <a:noFill/>
            <a:ln>
              <a:noFill/>
            </a:ln>
            <a:effectLst/>
          </c:spPr>
          <c:txPr>
            <a:bodyPr rot="-54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070950831"/>
        <c:crosses val="autoZero"/>
        <c:crossBetween val="between"/>
      </c:valAx>
      <c:spPr>
        <a:noFill/>
        <a:ln>
          <a:noFill/>
        </a:ln>
        <a:effectLst/>
      </c:spPr>
    </c:plotArea>
    <c:legend>
      <c:legendPos val="b"/>
      <c:layout>
        <c:manualLayout>
          <c:xMode val="edge"/>
          <c:yMode val="edge"/>
          <c:x val="4.4914864313916503E-2"/>
          <c:y val="0.74587694627790535"/>
          <c:w val="0.88276392525107572"/>
          <c:h val="0.1973919786726894"/>
        </c:manualLayout>
      </c:layout>
      <c:overlay val="0"/>
      <c:spPr>
        <a:noFill/>
        <a:ln>
          <a:solidFill>
            <a:schemeClr val="tx1"/>
          </a:solidFill>
        </a:ln>
        <a:effectLst/>
      </c:spPr>
      <c:txPr>
        <a:bodyPr rot="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141043307086615"/>
          <c:y val="2.233965571188111E-2"/>
          <c:w val="0.82749750031246094"/>
          <c:h val="0.80794203849518809"/>
        </c:manualLayout>
      </c:layout>
      <c:scatterChart>
        <c:scatterStyle val="lineMarker"/>
        <c:varyColors val="0"/>
        <c:ser>
          <c:idx val="0"/>
          <c:order val="0"/>
          <c:tx>
            <c:strRef>
              <c:f>Sheet1!$C$1</c:f>
              <c:strCache>
                <c:ptCount val="1"/>
                <c:pt idx="0">
                  <c:v>TEES</c:v>
                </c:pt>
              </c:strCache>
            </c:strRef>
          </c:tx>
          <c:spPr>
            <a:ln w="19050" cap="rnd">
              <a:no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Sheet1!$S$4:$S$19</c:f>
                <c:numCache>
                  <c:formatCode>General</c:formatCode>
                  <c:ptCount val="16"/>
                  <c:pt idx="0">
                    <c:v>2.878979508E-3</c:v>
                  </c:pt>
                  <c:pt idx="1">
                    <c:v>8.0111705479999993E-3</c:v>
                  </c:pt>
                  <c:pt idx="2">
                    <c:v>8.6225215369999993E-3</c:v>
                  </c:pt>
                  <c:pt idx="3">
                    <c:v>9.755915863E-3</c:v>
                  </c:pt>
                  <c:pt idx="4">
                    <c:v>1.6362592039999999E-2</c:v>
                  </c:pt>
                  <c:pt idx="5">
                    <c:v>2.5640726169999999E-2</c:v>
                  </c:pt>
                  <c:pt idx="6">
                    <c:v>3.409966004E-2</c:v>
                  </c:pt>
                  <c:pt idx="7">
                    <c:v>4.0462316169999998E-2</c:v>
                  </c:pt>
                  <c:pt idx="8">
                    <c:v>4.3480338989999999E-2</c:v>
                  </c:pt>
                  <c:pt idx="9">
                    <c:v>4.4458198329999997E-2</c:v>
                  </c:pt>
                  <c:pt idx="10">
                    <c:v>4.4331439979999998E-2</c:v>
                  </c:pt>
                  <c:pt idx="11">
                    <c:v>4.2585943250000001E-2</c:v>
                  </c:pt>
                  <c:pt idx="12">
                    <c:v>4.0356057920000001E-2</c:v>
                  </c:pt>
                  <c:pt idx="13">
                    <c:v>3.7274481249999998E-2</c:v>
                  </c:pt>
                  <c:pt idx="14">
                    <c:v>3.571823079E-2</c:v>
                  </c:pt>
                  <c:pt idx="15">
                    <c:v>3.4650305659999998E-2</c:v>
                  </c:pt>
                </c:numCache>
              </c:numRef>
            </c:plus>
            <c:minus>
              <c:numRef>
                <c:f>Sheet1!$S$4:$S$19</c:f>
                <c:numCache>
                  <c:formatCode>General</c:formatCode>
                  <c:ptCount val="16"/>
                  <c:pt idx="0">
                    <c:v>2.878979508E-3</c:v>
                  </c:pt>
                  <c:pt idx="1">
                    <c:v>8.0111705479999993E-3</c:v>
                  </c:pt>
                  <c:pt idx="2">
                    <c:v>8.6225215369999993E-3</c:v>
                  </c:pt>
                  <c:pt idx="3">
                    <c:v>9.755915863E-3</c:v>
                  </c:pt>
                  <c:pt idx="4">
                    <c:v>1.6362592039999999E-2</c:v>
                  </c:pt>
                  <c:pt idx="5">
                    <c:v>2.5640726169999999E-2</c:v>
                  </c:pt>
                  <c:pt idx="6">
                    <c:v>3.409966004E-2</c:v>
                  </c:pt>
                  <c:pt idx="7">
                    <c:v>4.0462316169999998E-2</c:v>
                  </c:pt>
                  <c:pt idx="8">
                    <c:v>4.3480338989999999E-2</c:v>
                  </c:pt>
                  <c:pt idx="9">
                    <c:v>4.4458198329999997E-2</c:v>
                  </c:pt>
                  <c:pt idx="10">
                    <c:v>4.4331439979999998E-2</c:v>
                  </c:pt>
                  <c:pt idx="11">
                    <c:v>4.2585943250000001E-2</c:v>
                  </c:pt>
                  <c:pt idx="12">
                    <c:v>4.0356057920000001E-2</c:v>
                  </c:pt>
                  <c:pt idx="13">
                    <c:v>3.7274481249999998E-2</c:v>
                  </c:pt>
                  <c:pt idx="14">
                    <c:v>3.571823079E-2</c:v>
                  </c:pt>
                  <c:pt idx="15">
                    <c:v>3.4650305659999998E-2</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Sheet1!$B$2:$B$17</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Sheet1!$C$2:$C$17</c:f>
              <c:numCache>
                <c:formatCode>0.0000</c:formatCode>
                <c:ptCount val="16"/>
                <c:pt idx="0">
                  <c:v>5.7036401980198031E-3</c:v>
                </c:pt>
                <c:pt idx="1">
                  <c:v>9.2766336633663363E-2</c:v>
                </c:pt>
                <c:pt idx="2">
                  <c:v>0.19914059405940604</c:v>
                </c:pt>
                <c:pt idx="3">
                  <c:v>0.28995247524752477</c:v>
                </c:pt>
                <c:pt idx="4">
                  <c:v>0.3701524752475247</c:v>
                </c:pt>
                <c:pt idx="5">
                  <c:v>0.43942376237623754</c:v>
                </c:pt>
                <c:pt idx="6">
                  <c:v>0.4896079207920791</c:v>
                </c:pt>
                <c:pt idx="7">
                  <c:v>0.5286297029702971</c:v>
                </c:pt>
                <c:pt idx="8">
                  <c:v>0.5612039603960397</c:v>
                </c:pt>
                <c:pt idx="9">
                  <c:v>0.58810297029702985</c:v>
                </c:pt>
                <c:pt idx="10">
                  <c:v>0.61326138613861381</c:v>
                </c:pt>
                <c:pt idx="11">
                  <c:v>0.63645346534653446</c:v>
                </c:pt>
                <c:pt idx="12">
                  <c:v>0.65644554455445558</c:v>
                </c:pt>
                <c:pt idx="13">
                  <c:v>0.68002376237623774</c:v>
                </c:pt>
                <c:pt idx="14">
                  <c:v>0.70110495049504962</c:v>
                </c:pt>
                <c:pt idx="15">
                  <c:v>0.72045346534653476</c:v>
                </c:pt>
              </c:numCache>
            </c:numRef>
          </c:yVal>
          <c:smooth val="0"/>
          <c:extLst>
            <c:ext xmlns:c16="http://schemas.microsoft.com/office/drawing/2014/chart" uri="{C3380CC4-5D6E-409C-BE32-E72D297353CC}">
              <c16:uniqueId val="{00000000-D0E7-402D-83BC-B47CB1B577DA}"/>
            </c:ext>
          </c:extLst>
        </c:ser>
        <c:ser>
          <c:idx val="1"/>
          <c:order val="1"/>
          <c:tx>
            <c:strRef>
              <c:f>Sheet1!$D$1</c:f>
              <c:strCache>
                <c:ptCount val="1"/>
                <c:pt idx="0">
                  <c:v>C3</c:v>
                </c:pt>
              </c:strCache>
            </c:strRef>
          </c:tx>
          <c:spPr>
            <a:ln w="19050" cap="rnd">
              <a:no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Sheet1!$T$4:$T$19</c:f>
                <c:numCache>
                  <c:formatCode>General</c:formatCode>
                  <c:ptCount val="16"/>
                  <c:pt idx="0">
                    <c:v>1.433506759E-3</c:v>
                  </c:pt>
                  <c:pt idx="1">
                    <c:v>3.2274203000000001E-2</c:v>
                  </c:pt>
                  <c:pt idx="2">
                    <c:v>5.3986483840000002E-2</c:v>
                  </c:pt>
                  <c:pt idx="3">
                    <c:v>7.6437541390000002E-2</c:v>
                  </c:pt>
                  <c:pt idx="4">
                    <c:v>9.2494022649999993E-2</c:v>
                  </c:pt>
                  <c:pt idx="5">
                    <c:v>0.1082586631</c:v>
                  </c:pt>
                  <c:pt idx="6">
                    <c:v>0.1311502292</c:v>
                  </c:pt>
                  <c:pt idx="7">
                    <c:v>0.1531772186</c:v>
                  </c:pt>
                  <c:pt idx="8">
                    <c:v>0.1541830636</c:v>
                  </c:pt>
                  <c:pt idx="9">
                    <c:v>0.1587847181</c:v>
                  </c:pt>
                  <c:pt idx="10">
                    <c:v>0.1764827786</c:v>
                  </c:pt>
                  <c:pt idx="11">
                    <c:v>0.1845698764</c:v>
                  </c:pt>
                  <c:pt idx="12">
                    <c:v>0.19607184620000001</c:v>
                  </c:pt>
                  <c:pt idx="13">
                    <c:v>0.2058104815</c:v>
                  </c:pt>
                  <c:pt idx="14">
                    <c:v>0.21480111499999999</c:v>
                  </c:pt>
                  <c:pt idx="15">
                    <c:v>0.23171661169999999</c:v>
                  </c:pt>
                </c:numCache>
              </c:numRef>
            </c:plus>
            <c:minus>
              <c:numRef>
                <c:f>Sheet1!$T$4:$T$19</c:f>
                <c:numCache>
                  <c:formatCode>General</c:formatCode>
                  <c:ptCount val="16"/>
                  <c:pt idx="0">
                    <c:v>1.433506759E-3</c:v>
                  </c:pt>
                  <c:pt idx="1">
                    <c:v>3.2274203000000001E-2</c:v>
                  </c:pt>
                  <c:pt idx="2">
                    <c:v>5.3986483840000002E-2</c:v>
                  </c:pt>
                  <c:pt idx="3">
                    <c:v>7.6437541390000002E-2</c:v>
                  </c:pt>
                  <c:pt idx="4">
                    <c:v>9.2494022649999993E-2</c:v>
                  </c:pt>
                  <c:pt idx="5">
                    <c:v>0.1082586631</c:v>
                  </c:pt>
                  <c:pt idx="6">
                    <c:v>0.1311502292</c:v>
                  </c:pt>
                  <c:pt idx="7">
                    <c:v>0.1531772186</c:v>
                  </c:pt>
                  <c:pt idx="8">
                    <c:v>0.1541830636</c:v>
                  </c:pt>
                  <c:pt idx="9">
                    <c:v>0.1587847181</c:v>
                  </c:pt>
                  <c:pt idx="10">
                    <c:v>0.1764827786</c:v>
                  </c:pt>
                  <c:pt idx="11">
                    <c:v>0.1845698764</c:v>
                  </c:pt>
                  <c:pt idx="12">
                    <c:v>0.19607184620000001</c:v>
                  </c:pt>
                  <c:pt idx="13">
                    <c:v>0.2058104815</c:v>
                  </c:pt>
                  <c:pt idx="14">
                    <c:v>0.21480111499999999</c:v>
                  </c:pt>
                  <c:pt idx="15">
                    <c:v>0.23171661169999999</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Sheet1!$B$2:$B$17</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Sheet1!$D$2:$D$17</c:f>
              <c:numCache>
                <c:formatCode>General</c:formatCode>
                <c:ptCount val="16"/>
                <c:pt idx="0">
                  <c:v>4.4999999999999997E-3</c:v>
                </c:pt>
                <c:pt idx="1">
                  <c:v>0.17599999999999999</c:v>
                </c:pt>
                <c:pt idx="2">
                  <c:v>0.31900000000000001</c:v>
                </c:pt>
                <c:pt idx="3">
                  <c:v>0.45989999999999998</c:v>
                </c:pt>
                <c:pt idx="4">
                  <c:v>0.59319999999999995</c:v>
                </c:pt>
                <c:pt idx="5">
                  <c:v>0.73080000000000001</c:v>
                </c:pt>
                <c:pt idx="6">
                  <c:v>0.84019999999999995</c:v>
                </c:pt>
                <c:pt idx="7">
                  <c:v>0.90500000000000003</c:v>
                </c:pt>
                <c:pt idx="8">
                  <c:v>0.99750000000000005</c:v>
                </c:pt>
                <c:pt idx="9">
                  <c:v>1.0949</c:v>
                </c:pt>
                <c:pt idx="10">
                  <c:v>1.1922999999999999</c:v>
                </c:pt>
                <c:pt idx="11">
                  <c:v>1.2558</c:v>
                </c:pt>
                <c:pt idx="12">
                  <c:v>1.3065</c:v>
                </c:pt>
                <c:pt idx="13">
                  <c:v>1.351</c:v>
                </c:pt>
                <c:pt idx="14">
                  <c:v>1.395</c:v>
                </c:pt>
                <c:pt idx="15">
                  <c:v>1.4480999999999999</c:v>
                </c:pt>
              </c:numCache>
            </c:numRef>
          </c:yVal>
          <c:smooth val="0"/>
          <c:extLst>
            <c:ext xmlns:c16="http://schemas.microsoft.com/office/drawing/2014/chart" uri="{C3380CC4-5D6E-409C-BE32-E72D297353CC}">
              <c16:uniqueId val="{00000001-D0E7-402D-83BC-B47CB1B577DA}"/>
            </c:ext>
          </c:extLst>
        </c:ser>
        <c:ser>
          <c:idx val="3"/>
          <c:order val="2"/>
          <c:tx>
            <c:v>C4</c:v>
          </c:tx>
          <c:spPr>
            <a:ln w="25400" cap="rnd">
              <a:noFill/>
              <a:round/>
            </a:ln>
            <a:effectLst/>
          </c:spPr>
          <c:marker>
            <c:symbol val="circle"/>
            <c:size val="5"/>
            <c:spPr>
              <a:solidFill>
                <a:schemeClr val="accent4"/>
              </a:solidFill>
              <a:ln w="9525">
                <a:solidFill>
                  <a:schemeClr val="accent4"/>
                </a:solidFill>
              </a:ln>
              <a:effectLst/>
            </c:spPr>
          </c:marker>
          <c:errBars>
            <c:errDir val="x"/>
            <c:errBarType val="both"/>
            <c:errValType val="cust"/>
            <c:noEndCap val="0"/>
            <c:plus>
              <c:numRef>
                <c:f>Sheet1!$U$4:$U$19</c:f>
                <c:numCache>
                  <c:formatCode>General</c:formatCode>
                  <c:ptCount val="16"/>
                  <c:pt idx="0">
                    <c:v>2.8169459939999999E-3</c:v>
                  </c:pt>
                  <c:pt idx="1">
                    <c:v>7.2569853379999993E-2</c:v>
                  </c:pt>
                  <c:pt idx="2">
                    <c:v>0.1185359572</c:v>
                  </c:pt>
                  <c:pt idx="3">
                    <c:v>0.15472642189999999</c:v>
                  </c:pt>
                  <c:pt idx="4">
                    <c:v>0.17287830739999999</c:v>
                  </c:pt>
                  <c:pt idx="5">
                    <c:v>0.1959776104</c:v>
                  </c:pt>
                  <c:pt idx="6">
                    <c:v>0.215958551</c:v>
                  </c:pt>
                  <c:pt idx="7">
                    <c:v>0.2423248231</c:v>
                  </c:pt>
                  <c:pt idx="8">
                    <c:v>0.2485439415</c:v>
                  </c:pt>
                  <c:pt idx="9">
                    <c:v>0.26077177460000001</c:v>
                  </c:pt>
                  <c:pt idx="10">
                    <c:v>0.26335518289999998</c:v>
                  </c:pt>
                  <c:pt idx="11">
                    <c:v>0.26954869570000001</c:v>
                  </c:pt>
                  <c:pt idx="12">
                    <c:v>0.27274969269999999</c:v>
                  </c:pt>
                  <c:pt idx="13">
                    <c:v>0.27746028430000003</c:v>
                  </c:pt>
                  <c:pt idx="14">
                    <c:v>0.2753558854</c:v>
                  </c:pt>
                  <c:pt idx="15">
                    <c:v>0.27351109800000001</c:v>
                  </c:pt>
                </c:numCache>
              </c:numRef>
            </c:plus>
            <c:minus>
              <c:numRef>
                <c:f>Sheet1!$U$4:$U$19</c:f>
                <c:numCache>
                  <c:formatCode>General</c:formatCode>
                  <c:ptCount val="16"/>
                  <c:pt idx="0">
                    <c:v>2.8169459939999999E-3</c:v>
                  </c:pt>
                  <c:pt idx="1">
                    <c:v>7.2569853379999993E-2</c:v>
                  </c:pt>
                  <c:pt idx="2">
                    <c:v>0.1185359572</c:v>
                  </c:pt>
                  <c:pt idx="3">
                    <c:v>0.15472642189999999</c:v>
                  </c:pt>
                  <c:pt idx="4">
                    <c:v>0.17287830739999999</c:v>
                  </c:pt>
                  <c:pt idx="5">
                    <c:v>0.1959776104</c:v>
                  </c:pt>
                  <c:pt idx="6">
                    <c:v>0.215958551</c:v>
                  </c:pt>
                  <c:pt idx="7">
                    <c:v>0.2423248231</c:v>
                  </c:pt>
                  <c:pt idx="8">
                    <c:v>0.2485439415</c:v>
                  </c:pt>
                  <c:pt idx="9">
                    <c:v>0.26077177460000001</c:v>
                  </c:pt>
                  <c:pt idx="10">
                    <c:v>0.26335518289999998</c:v>
                  </c:pt>
                  <c:pt idx="11">
                    <c:v>0.26954869570000001</c:v>
                  </c:pt>
                  <c:pt idx="12">
                    <c:v>0.27274969269999999</c:v>
                  </c:pt>
                  <c:pt idx="13">
                    <c:v>0.27746028430000003</c:v>
                  </c:pt>
                  <c:pt idx="14">
                    <c:v>0.2753558854</c:v>
                  </c:pt>
                  <c:pt idx="15">
                    <c:v>0.27351109800000001</c:v>
                  </c:pt>
                </c:numCache>
              </c:numRef>
            </c:minus>
            <c:spPr>
              <a:noFill/>
              <a:ln w="9525" cap="flat" cmpd="sng" algn="ctr">
                <a:solidFill>
                  <a:schemeClr val="tx1">
                    <a:lumMod val="65000"/>
                    <a:lumOff val="35000"/>
                  </a:schemeClr>
                </a:solidFill>
                <a:round/>
              </a:ln>
              <a:effectLst/>
            </c:spPr>
          </c:errBars>
          <c:errBars>
            <c:errDir val="y"/>
            <c:errBarType val="both"/>
            <c:errValType val="cust"/>
            <c:noEndCap val="0"/>
            <c:plus>
              <c:numRef>
                <c:f>Sheet1!$U$4:$U$19</c:f>
                <c:numCache>
                  <c:formatCode>General</c:formatCode>
                  <c:ptCount val="16"/>
                  <c:pt idx="0">
                    <c:v>2.8169459939999999E-3</c:v>
                  </c:pt>
                  <c:pt idx="1">
                    <c:v>7.2569853379999993E-2</c:v>
                  </c:pt>
                  <c:pt idx="2">
                    <c:v>0.1185359572</c:v>
                  </c:pt>
                  <c:pt idx="3">
                    <c:v>0.15472642189999999</c:v>
                  </c:pt>
                  <c:pt idx="4">
                    <c:v>0.17287830739999999</c:v>
                  </c:pt>
                  <c:pt idx="5">
                    <c:v>0.1959776104</c:v>
                  </c:pt>
                  <c:pt idx="6">
                    <c:v>0.215958551</c:v>
                  </c:pt>
                  <c:pt idx="7">
                    <c:v>0.2423248231</c:v>
                  </c:pt>
                  <c:pt idx="8">
                    <c:v>0.2485439415</c:v>
                  </c:pt>
                  <c:pt idx="9">
                    <c:v>0.26077177460000001</c:v>
                  </c:pt>
                  <c:pt idx="10">
                    <c:v>0.26335518289999998</c:v>
                  </c:pt>
                  <c:pt idx="11">
                    <c:v>0.26954869570000001</c:v>
                  </c:pt>
                  <c:pt idx="12">
                    <c:v>0.27274969269999999</c:v>
                  </c:pt>
                  <c:pt idx="13">
                    <c:v>0.27746028430000003</c:v>
                  </c:pt>
                  <c:pt idx="14">
                    <c:v>0.2753558854</c:v>
                  </c:pt>
                  <c:pt idx="15">
                    <c:v>0.27351109800000001</c:v>
                  </c:pt>
                </c:numCache>
              </c:numRef>
            </c:plus>
            <c:minus>
              <c:numRef>
                <c:f>Sheet1!$U$4:$U$19</c:f>
                <c:numCache>
                  <c:formatCode>General</c:formatCode>
                  <c:ptCount val="16"/>
                  <c:pt idx="0">
                    <c:v>2.8169459939999999E-3</c:v>
                  </c:pt>
                  <c:pt idx="1">
                    <c:v>7.2569853379999993E-2</c:v>
                  </c:pt>
                  <c:pt idx="2">
                    <c:v>0.1185359572</c:v>
                  </c:pt>
                  <c:pt idx="3">
                    <c:v>0.15472642189999999</c:v>
                  </c:pt>
                  <c:pt idx="4">
                    <c:v>0.17287830739999999</c:v>
                  </c:pt>
                  <c:pt idx="5">
                    <c:v>0.1959776104</c:v>
                  </c:pt>
                  <c:pt idx="6">
                    <c:v>0.215958551</c:v>
                  </c:pt>
                  <c:pt idx="7">
                    <c:v>0.2423248231</c:v>
                  </c:pt>
                  <c:pt idx="8">
                    <c:v>0.2485439415</c:v>
                  </c:pt>
                  <c:pt idx="9">
                    <c:v>0.26077177460000001</c:v>
                  </c:pt>
                  <c:pt idx="10">
                    <c:v>0.26335518289999998</c:v>
                  </c:pt>
                  <c:pt idx="11">
                    <c:v>0.26954869570000001</c:v>
                  </c:pt>
                  <c:pt idx="12">
                    <c:v>0.27274969269999999</c:v>
                  </c:pt>
                  <c:pt idx="13">
                    <c:v>0.27746028430000003</c:v>
                  </c:pt>
                  <c:pt idx="14">
                    <c:v>0.2753558854</c:v>
                  </c:pt>
                  <c:pt idx="15">
                    <c:v>0.27351109800000001</c:v>
                  </c:pt>
                </c:numCache>
              </c:numRef>
            </c:minus>
            <c:spPr>
              <a:noFill/>
              <a:ln w="9525" cap="flat" cmpd="sng" algn="ctr">
                <a:solidFill>
                  <a:schemeClr val="tx1">
                    <a:lumMod val="65000"/>
                    <a:lumOff val="35000"/>
                  </a:schemeClr>
                </a:solidFill>
                <a:round/>
              </a:ln>
              <a:effectLst/>
            </c:spPr>
          </c:errBars>
          <c:xVal>
            <c:numRef>
              <c:f>Sheet1!$B$2:$B$17</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Sheet1!$E$2:$E$17</c:f>
              <c:numCache>
                <c:formatCode>General</c:formatCode>
                <c:ptCount val="16"/>
                <c:pt idx="0">
                  <c:v>3.7000000000000002E-3</c:v>
                </c:pt>
                <c:pt idx="1">
                  <c:v>0.21529999999999999</c:v>
                </c:pt>
                <c:pt idx="2">
                  <c:v>0.38790000000000002</c:v>
                </c:pt>
                <c:pt idx="3">
                  <c:v>0.53749999999999998</c:v>
                </c:pt>
                <c:pt idx="4">
                  <c:v>0.66890000000000005</c:v>
                </c:pt>
                <c:pt idx="5">
                  <c:v>0.80630000000000002</c:v>
                </c:pt>
                <c:pt idx="6">
                  <c:v>0.93</c:v>
                </c:pt>
                <c:pt idx="7">
                  <c:v>1.0630999999999999</c:v>
                </c:pt>
                <c:pt idx="8">
                  <c:v>1.1811</c:v>
                </c:pt>
                <c:pt idx="9">
                  <c:v>1.2895000000000001</c:v>
                </c:pt>
                <c:pt idx="10">
                  <c:v>1.4012</c:v>
                </c:pt>
                <c:pt idx="11">
                  <c:v>1.5092000000000001</c:v>
                </c:pt>
                <c:pt idx="12">
                  <c:v>1.6068</c:v>
                </c:pt>
                <c:pt idx="13">
                  <c:v>1.7055</c:v>
                </c:pt>
                <c:pt idx="14">
                  <c:v>1.7899</c:v>
                </c:pt>
                <c:pt idx="15">
                  <c:v>1.8724000000000001</c:v>
                </c:pt>
              </c:numCache>
            </c:numRef>
          </c:yVal>
          <c:smooth val="0"/>
          <c:extLst>
            <c:ext xmlns:c16="http://schemas.microsoft.com/office/drawing/2014/chart" uri="{C3380CC4-5D6E-409C-BE32-E72D297353CC}">
              <c16:uniqueId val="{00000002-D0E7-402D-83BC-B47CB1B577DA}"/>
            </c:ext>
          </c:extLst>
        </c:ser>
        <c:ser>
          <c:idx val="2"/>
          <c:order val="3"/>
          <c:tx>
            <c:strRef>
              <c:f>Sheet1!$F$1</c:f>
              <c:strCache>
                <c:ptCount val="1"/>
                <c:pt idx="0">
                  <c:v>C6</c:v>
                </c:pt>
              </c:strCache>
            </c:strRef>
          </c:tx>
          <c:spPr>
            <a:ln w="19050" cap="rnd">
              <a:noFill/>
              <a:round/>
            </a:ln>
            <a:effectLst/>
          </c:spPr>
          <c:marker>
            <c:symbol val="circle"/>
            <c:size val="5"/>
            <c:spPr>
              <a:solidFill>
                <a:schemeClr val="accent3"/>
              </a:solidFill>
              <a:ln w="9525">
                <a:solidFill>
                  <a:schemeClr val="accent3"/>
                </a:solidFill>
              </a:ln>
              <a:effectLst/>
            </c:spPr>
          </c:marker>
          <c:errBars>
            <c:errDir val="y"/>
            <c:errBarType val="both"/>
            <c:errValType val="cust"/>
            <c:noEndCap val="0"/>
            <c:plus>
              <c:numRef>
                <c:f>Sheet1!$V$4:$V$19</c:f>
                <c:numCache>
                  <c:formatCode>General</c:formatCode>
                  <c:ptCount val="16"/>
                  <c:pt idx="0">
                    <c:v>1.4639304130000001E-3</c:v>
                  </c:pt>
                  <c:pt idx="1">
                    <c:v>2.922462072E-2</c:v>
                  </c:pt>
                  <c:pt idx="2">
                    <c:v>4.6194188830000003E-2</c:v>
                  </c:pt>
                  <c:pt idx="3">
                    <c:v>6.7018819039999997E-2</c:v>
                  </c:pt>
                  <c:pt idx="4">
                    <c:v>8.3416739030000006E-2</c:v>
                  </c:pt>
                  <c:pt idx="5">
                    <c:v>9.1482046900000002E-2</c:v>
                  </c:pt>
                  <c:pt idx="6">
                    <c:v>0.11202335720000001</c:v>
                  </c:pt>
                  <c:pt idx="7">
                    <c:v>0.12666056479999999</c:v>
                  </c:pt>
                  <c:pt idx="8">
                    <c:v>0.14736345100000001</c:v>
                  </c:pt>
                  <c:pt idx="9">
                    <c:v>0.15744208470000001</c:v>
                  </c:pt>
                  <c:pt idx="10">
                    <c:v>0.16120302319999999</c:v>
                  </c:pt>
                  <c:pt idx="11">
                    <c:v>0.1776899727</c:v>
                  </c:pt>
                  <c:pt idx="12">
                    <c:v>0.1921503135</c:v>
                  </c:pt>
                  <c:pt idx="13">
                    <c:v>0.2017745588</c:v>
                  </c:pt>
                  <c:pt idx="14">
                    <c:v>0.21390686019999999</c:v>
                  </c:pt>
                  <c:pt idx="15">
                    <c:v>0.2058968045</c:v>
                  </c:pt>
                </c:numCache>
              </c:numRef>
            </c:plus>
            <c:minus>
              <c:numRef>
                <c:f>Sheet1!$V$4:$V$19</c:f>
                <c:numCache>
                  <c:formatCode>General</c:formatCode>
                  <c:ptCount val="16"/>
                  <c:pt idx="0">
                    <c:v>1.4639304130000001E-3</c:v>
                  </c:pt>
                  <c:pt idx="1">
                    <c:v>2.922462072E-2</c:v>
                  </c:pt>
                  <c:pt idx="2">
                    <c:v>4.6194188830000003E-2</c:v>
                  </c:pt>
                  <c:pt idx="3">
                    <c:v>6.7018819039999997E-2</c:v>
                  </c:pt>
                  <c:pt idx="4">
                    <c:v>8.3416739030000006E-2</c:v>
                  </c:pt>
                  <c:pt idx="5">
                    <c:v>9.1482046900000002E-2</c:v>
                  </c:pt>
                  <c:pt idx="6">
                    <c:v>0.11202335720000001</c:v>
                  </c:pt>
                  <c:pt idx="7">
                    <c:v>0.12666056479999999</c:v>
                  </c:pt>
                  <c:pt idx="8">
                    <c:v>0.14736345100000001</c:v>
                  </c:pt>
                  <c:pt idx="9">
                    <c:v>0.15744208470000001</c:v>
                  </c:pt>
                  <c:pt idx="10">
                    <c:v>0.16120302319999999</c:v>
                  </c:pt>
                  <c:pt idx="11">
                    <c:v>0.1776899727</c:v>
                  </c:pt>
                  <c:pt idx="12">
                    <c:v>0.1921503135</c:v>
                  </c:pt>
                  <c:pt idx="13">
                    <c:v>0.2017745588</c:v>
                  </c:pt>
                  <c:pt idx="14">
                    <c:v>0.21390686019999999</c:v>
                  </c:pt>
                  <c:pt idx="15">
                    <c:v>0.2058968045</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Sheet1!$B$2:$B$17</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Sheet1!$F$2:$F$17</c:f>
              <c:numCache>
                <c:formatCode>General</c:formatCode>
                <c:ptCount val="16"/>
                <c:pt idx="0">
                  <c:v>3.7000000000000002E-3</c:v>
                </c:pt>
                <c:pt idx="1">
                  <c:v>0.16789999999999999</c:v>
                </c:pt>
                <c:pt idx="2">
                  <c:v>0.27900000000000003</c:v>
                </c:pt>
                <c:pt idx="3">
                  <c:v>0.41049999999999998</c:v>
                </c:pt>
                <c:pt idx="4">
                  <c:v>0.53369999999999995</c:v>
                </c:pt>
                <c:pt idx="5">
                  <c:v>0.64680000000000004</c:v>
                </c:pt>
                <c:pt idx="6">
                  <c:v>0.76180000000000003</c:v>
                </c:pt>
                <c:pt idx="7">
                  <c:v>0.86750000000000005</c:v>
                </c:pt>
                <c:pt idx="8">
                  <c:v>0.95520000000000005</c:v>
                </c:pt>
                <c:pt idx="9">
                  <c:v>1.0006999999999999</c:v>
                </c:pt>
                <c:pt idx="10">
                  <c:v>1.0649999999999999</c:v>
                </c:pt>
                <c:pt idx="11" formatCode="0.00E+00">
                  <c:v>1.1599999999999999</c:v>
                </c:pt>
                <c:pt idx="12" formatCode="0.00E+00">
                  <c:v>1.27</c:v>
                </c:pt>
                <c:pt idx="13" formatCode="0.00E+00">
                  <c:v>1.38</c:v>
                </c:pt>
                <c:pt idx="14" formatCode="0.00E+00">
                  <c:v>1.49</c:v>
                </c:pt>
                <c:pt idx="15" formatCode="0.00E+00">
                  <c:v>1.58</c:v>
                </c:pt>
              </c:numCache>
            </c:numRef>
          </c:yVal>
          <c:smooth val="0"/>
          <c:extLst>
            <c:ext xmlns:c16="http://schemas.microsoft.com/office/drawing/2014/chart" uri="{C3380CC4-5D6E-409C-BE32-E72D297353CC}">
              <c16:uniqueId val="{00000003-D0E7-402D-83BC-B47CB1B577DA}"/>
            </c:ext>
          </c:extLst>
        </c:ser>
        <c:dLbls>
          <c:showLegendKey val="0"/>
          <c:showVal val="0"/>
          <c:showCatName val="0"/>
          <c:showSerName val="0"/>
          <c:showPercent val="0"/>
          <c:showBubbleSize val="0"/>
        </c:dLbls>
        <c:axId val="1212677088"/>
        <c:axId val="1213461952"/>
      </c:scatterChart>
      <c:valAx>
        <c:axId val="1212677088"/>
        <c:scaling>
          <c:orientation val="minMax"/>
          <c:max val="625"/>
          <c:min val="0"/>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2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sz="2000" b="1">
                    <a:solidFill>
                      <a:schemeClr val="tx1"/>
                    </a:solidFill>
                    <a:latin typeface="Times New Roman" panose="02020603050405020304" pitchFamily="18" charset="0"/>
                    <a:cs typeface="Times New Roman" panose="02020603050405020304" pitchFamily="18" charset="0"/>
                  </a:rPr>
                  <a:t>Xanthine Concentration (</a:t>
                </a:r>
                <a:r>
                  <a:rPr lang="el-GR" sz="2000" b="1">
                    <a:solidFill>
                      <a:schemeClr val="tx1"/>
                    </a:solidFill>
                    <a:latin typeface="Times New Roman" panose="02020603050405020304" pitchFamily="18" charset="0"/>
                    <a:cs typeface="Times New Roman" panose="02020603050405020304" pitchFamily="18" charset="0"/>
                  </a:rPr>
                  <a:t>μ</a:t>
                </a:r>
                <a:r>
                  <a:rPr lang="en-US" sz="2000" b="1">
                    <a:solidFill>
                      <a:schemeClr val="tx1"/>
                    </a:solidFill>
                    <a:latin typeface="Times New Roman" panose="02020603050405020304" pitchFamily="18" charset="0"/>
                    <a:cs typeface="Times New Roman" panose="02020603050405020304" pitchFamily="18" charset="0"/>
                  </a:rPr>
                  <a:t>M)</a:t>
                </a:r>
              </a:p>
            </c:rich>
          </c:tx>
          <c:layout>
            <c:manualLayout>
              <c:xMode val="edge"/>
              <c:yMode val="edge"/>
              <c:x val="0.30765429684551626"/>
              <c:y val="0.91225711860864922"/>
            </c:manualLayout>
          </c:layout>
          <c:overlay val="0"/>
          <c:spPr>
            <a:noFill/>
            <a:ln>
              <a:noFill/>
            </a:ln>
            <a:effectLst/>
          </c:spPr>
          <c:txPr>
            <a:bodyPr rot="0" spcFirstLastPara="1" vertOverflow="ellipsis" vert="horz" wrap="square" anchor="ctr" anchorCtr="1"/>
            <a:lstStyle/>
            <a:p>
              <a:pPr>
                <a:defRPr sz="2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13461952"/>
        <c:crosses val="autoZero"/>
        <c:crossBetween val="midCat"/>
      </c:valAx>
      <c:valAx>
        <c:axId val="1213461952"/>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2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sz="2000" b="1">
                    <a:solidFill>
                      <a:schemeClr val="tx1"/>
                    </a:solidFill>
                    <a:latin typeface="Times New Roman" panose="02020603050405020304" pitchFamily="18" charset="0"/>
                    <a:cs typeface="Times New Roman" panose="02020603050405020304" pitchFamily="18" charset="0"/>
                  </a:rPr>
                  <a:t>Current (</a:t>
                </a:r>
                <a:r>
                  <a:rPr lang="el-GR" sz="2000" b="1">
                    <a:solidFill>
                      <a:schemeClr val="tx1"/>
                    </a:solidFill>
                    <a:latin typeface="Times New Roman" panose="02020603050405020304" pitchFamily="18" charset="0"/>
                    <a:cs typeface="Times New Roman" panose="02020603050405020304" pitchFamily="18" charset="0"/>
                  </a:rPr>
                  <a:t>μ</a:t>
                </a:r>
                <a:r>
                  <a:rPr lang="en-US" sz="2000" b="1">
                    <a:solidFill>
                      <a:schemeClr val="tx1"/>
                    </a:solidFill>
                    <a:latin typeface="Times New Roman" panose="02020603050405020304" pitchFamily="18" charset="0"/>
                    <a:cs typeface="Times New Roman" panose="02020603050405020304" pitchFamily="18" charset="0"/>
                  </a:rPr>
                  <a:t>A)</a:t>
                </a:r>
              </a:p>
            </c:rich>
          </c:tx>
          <c:layout>
            <c:manualLayout>
              <c:xMode val="edge"/>
              <c:yMode val="edge"/>
              <c:x val="0"/>
              <c:y val="0.23037845870006929"/>
            </c:manualLayout>
          </c:layout>
          <c:overlay val="0"/>
          <c:spPr>
            <a:noFill/>
            <a:ln>
              <a:noFill/>
            </a:ln>
            <a:effectLst/>
          </c:spPr>
          <c:txPr>
            <a:bodyPr rot="-5400000" spcFirstLastPara="1" vertOverflow="ellipsis" vert="horz" wrap="square" anchor="ctr" anchorCtr="1"/>
            <a:lstStyle/>
            <a:p>
              <a:pPr>
                <a:defRPr sz="2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0.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6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1212677088"/>
        <c:crosses val="autoZero"/>
        <c:crossBetween val="midCat"/>
      </c:valAx>
      <c:spPr>
        <a:noFill/>
        <a:ln>
          <a:noFill/>
        </a:ln>
        <a:effectLst/>
      </c:spPr>
    </c:plotArea>
    <c:legend>
      <c:legendPos val="b"/>
      <c:layout>
        <c:manualLayout>
          <c:xMode val="edge"/>
          <c:yMode val="edge"/>
          <c:x val="0.18163061144218423"/>
          <c:y val="2.7937491721488811E-2"/>
          <c:w val="0.16516256391607975"/>
          <c:h val="0.37279984767539404"/>
        </c:manualLayout>
      </c:layout>
      <c:overlay val="0"/>
      <c:spPr>
        <a:noFill/>
        <a:ln>
          <a:noFill/>
        </a:ln>
        <a:effectLst/>
      </c:spPr>
      <c:txPr>
        <a:bodyPr rot="0" spcFirstLastPara="1" vertOverflow="ellipsis" vert="horz" wrap="square" anchor="ctr" anchorCtr="1"/>
        <a:lstStyle/>
        <a:p>
          <a:pPr>
            <a:defRPr sz="16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1981142982127234"/>
          <c:y val="2.515380850032381E-2"/>
          <c:w val="0.84745047494063241"/>
          <c:h val="0.60279420664774819"/>
        </c:manualLayout>
      </c:layout>
      <c:scatterChart>
        <c:scatterStyle val="lineMarker"/>
        <c:varyColors val="0"/>
        <c:ser>
          <c:idx val="0"/>
          <c:order val="0"/>
          <c:tx>
            <c:strRef>
              <c:f>'[DataAnalysis_CalibrationCurve_XanthineTest-All.xlsx]All'!$B$1</c:f>
              <c:strCache>
                <c:ptCount val="1"/>
                <c:pt idx="0">
                  <c:v>Pt / HMTES+Xox / 75.25PU (n=5)</c:v>
                </c:pt>
              </c:strCache>
            </c:strRef>
          </c:tx>
          <c:spPr>
            <a:ln w="28575" cap="rnd">
              <a:noFill/>
              <a:round/>
            </a:ln>
            <a:effectLst/>
          </c:spPr>
          <c:marker>
            <c:symbol val="circle"/>
            <c:size val="10"/>
            <c:spPr>
              <a:solidFill>
                <a:schemeClr val="tx1"/>
              </a:solidFill>
              <a:ln w="9525">
                <a:no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All'!$C$3:$C$18</c:f>
                <c:numCache>
                  <c:formatCode>General</c:formatCode>
                  <c:ptCount val="16"/>
                  <c:pt idx="0">
                    <c:v>1.6623427851989369E-3</c:v>
                  </c:pt>
                  <c:pt idx="1">
                    <c:v>7.3167215594621476E-3</c:v>
                  </c:pt>
                  <c:pt idx="2">
                    <c:v>1.1539800519744828E-2</c:v>
                  </c:pt>
                  <c:pt idx="3">
                    <c:v>1.8894561731295955E-2</c:v>
                  </c:pt>
                  <c:pt idx="4">
                    <c:v>2.6305902520089599E-2</c:v>
                  </c:pt>
                  <c:pt idx="5">
                    <c:v>3.4007339270521755E-2</c:v>
                  </c:pt>
                  <c:pt idx="6">
                    <c:v>4.1521267577503115E-2</c:v>
                  </c:pt>
                  <c:pt idx="7">
                    <c:v>4.8488174715884166E-2</c:v>
                  </c:pt>
                  <c:pt idx="8">
                    <c:v>5.3237301691766027E-2</c:v>
                  </c:pt>
                  <c:pt idx="9">
                    <c:v>5.6964637985062294E-2</c:v>
                  </c:pt>
                  <c:pt idx="10">
                    <c:v>5.9677138883540981E-2</c:v>
                  </c:pt>
                  <c:pt idx="11">
                    <c:v>6.1357867376997707E-2</c:v>
                  </c:pt>
                  <c:pt idx="12">
                    <c:v>6.258937757248631E-2</c:v>
                  </c:pt>
                  <c:pt idx="13">
                    <c:v>6.3978420652369777E-2</c:v>
                  </c:pt>
                  <c:pt idx="14">
                    <c:v>6.5940140709621842E-2</c:v>
                  </c:pt>
                  <c:pt idx="15">
                    <c:v>6.8125466580021193E-2</c:v>
                  </c:pt>
                </c:numCache>
              </c:numRef>
            </c:plus>
            <c:minus>
              <c:numRef>
                <c:f>'[DataAnalysis_CalibrationCurve_XanthineTest-All.xlsx]All'!$C$3:$C$18</c:f>
                <c:numCache>
                  <c:formatCode>General</c:formatCode>
                  <c:ptCount val="16"/>
                  <c:pt idx="0">
                    <c:v>1.6623427851989369E-3</c:v>
                  </c:pt>
                  <c:pt idx="1">
                    <c:v>7.3167215594621476E-3</c:v>
                  </c:pt>
                  <c:pt idx="2">
                    <c:v>1.1539800519744828E-2</c:v>
                  </c:pt>
                  <c:pt idx="3">
                    <c:v>1.8894561731295955E-2</c:v>
                  </c:pt>
                  <c:pt idx="4">
                    <c:v>2.6305902520089599E-2</c:v>
                  </c:pt>
                  <c:pt idx="5">
                    <c:v>3.4007339270521755E-2</c:v>
                  </c:pt>
                  <c:pt idx="6">
                    <c:v>4.1521267577503115E-2</c:v>
                  </c:pt>
                  <c:pt idx="7">
                    <c:v>4.8488174715884166E-2</c:v>
                  </c:pt>
                  <c:pt idx="8">
                    <c:v>5.3237301691766027E-2</c:v>
                  </c:pt>
                  <c:pt idx="9">
                    <c:v>5.6964637985062294E-2</c:v>
                  </c:pt>
                  <c:pt idx="10">
                    <c:v>5.9677138883540981E-2</c:v>
                  </c:pt>
                  <c:pt idx="11">
                    <c:v>6.1357867376997707E-2</c:v>
                  </c:pt>
                  <c:pt idx="12">
                    <c:v>6.258937757248631E-2</c:v>
                  </c:pt>
                  <c:pt idx="13">
                    <c:v>6.3978420652369777E-2</c:v>
                  </c:pt>
                  <c:pt idx="14">
                    <c:v>6.5940140709621842E-2</c:v>
                  </c:pt>
                  <c:pt idx="15">
                    <c:v>6.8125466580021193E-2</c:v>
                  </c:pt>
                </c:numCache>
              </c:numRef>
            </c:minus>
            <c:spPr>
              <a:noFill/>
              <a:ln w="9525" cap="flat" cmpd="sng" algn="ctr">
                <a:solidFill>
                  <a:schemeClr val="tx1">
                    <a:lumMod val="65000"/>
                    <a:lumOff val="35000"/>
                  </a:schemeClr>
                </a:solidFill>
                <a:round/>
              </a:ln>
              <a:effectLst/>
            </c:spPr>
          </c:errBars>
          <c:xVal>
            <c:numRef>
              <c:f>'[DataAnalysis_CalibrationCurve_XanthineTest-All.xlsx]All'!$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All'!$B$3:$B$18</c:f>
              <c:numCache>
                <c:formatCode>General</c:formatCode>
                <c:ptCount val="16"/>
                <c:pt idx="0">
                  <c:v>2.2816230769230766E-2</c:v>
                </c:pt>
                <c:pt idx="1">
                  <c:v>7.568046153846153E-2</c:v>
                </c:pt>
                <c:pt idx="2">
                  <c:v>0.10476584615384617</c:v>
                </c:pt>
                <c:pt idx="3">
                  <c:v>0.15662230769230767</c:v>
                </c:pt>
                <c:pt idx="4">
                  <c:v>0.20329076923076922</c:v>
                </c:pt>
                <c:pt idx="5">
                  <c:v>0.24429846153846152</c:v>
                </c:pt>
                <c:pt idx="6">
                  <c:v>0.27680076923076924</c:v>
                </c:pt>
                <c:pt idx="7">
                  <c:v>0.30225307692307696</c:v>
                </c:pt>
                <c:pt idx="8">
                  <c:v>0.31813153846153847</c:v>
                </c:pt>
                <c:pt idx="9">
                  <c:v>0.33138538461538464</c:v>
                </c:pt>
                <c:pt idx="10">
                  <c:v>0.34406461538461536</c:v>
                </c:pt>
                <c:pt idx="11">
                  <c:v>0.35308615384615383</c:v>
                </c:pt>
                <c:pt idx="12">
                  <c:v>0.36135384615384614</c:v>
                </c:pt>
                <c:pt idx="13">
                  <c:v>0.36958000000000002</c:v>
                </c:pt>
                <c:pt idx="14">
                  <c:v>0.37834384615384614</c:v>
                </c:pt>
                <c:pt idx="15">
                  <c:v>0.38859692307692312</c:v>
                </c:pt>
              </c:numCache>
            </c:numRef>
          </c:yVal>
          <c:smooth val="0"/>
          <c:extLst>
            <c:ext xmlns:c16="http://schemas.microsoft.com/office/drawing/2014/chart" uri="{C3380CC4-5D6E-409C-BE32-E72D297353CC}">
              <c16:uniqueId val="{00000000-8EC8-4903-BCDD-828979B9DE5C}"/>
            </c:ext>
          </c:extLst>
        </c:ser>
        <c:ser>
          <c:idx val="1"/>
          <c:order val="1"/>
          <c:tx>
            <c:strRef>
              <c:f>'[DataAnalysis_CalibrationCurve_XanthineTest-All.xlsx]All'!$D$1</c:f>
              <c:strCache>
                <c:ptCount val="1"/>
                <c:pt idx="0">
                  <c:v>Pt / HMTES 1+Xox / HMTES 2 / 75.25PU (n=6)</c:v>
                </c:pt>
              </c:strCache>
            </c:strRef>
          </c:tx>
          <c:spPr>
            <a:ln w="25400" cap="rnd">
              <a:noFill/>
              <a:round/>
            </a:ln>
            <a:effectLst/>
          </c:spPr>
          <c:marker>
            <c:symbol val="circle"/>
            <c:size val="10"/>
            <c:spPr>
              <a:noFill/>
              <a:ln w="19050">
                <a:solidFill>
                  <a:schemeClr val="tx1"/>
                </a:solid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All'!$E$3:$E$18</c:f>
                <c:numCache>
                  <c:formatCode>General</c:formatCode>
                  <c:ptCount val="16"/>
                  <c:pt idx="0">
                    <c:v>6.1760133414594867E-3</c:v>
                  </c:pt>
                  <c:pt idx="1">
                    <c:v>6.0787996246566434E-3</c:v>
                  </c:pt>
                  <c:pt idx="2">
                    <c:v>1.1218786379787463E-2</c:v>
                  </c:pt>
                  <c:pt idx="3">
                    <c:v>1.6541265498292601E-2</c:v>
                  </c:pt>
                  <c:pt idx="4">
                    <c:v>2.2412031111886273E-2</c:v>
                  </c:pt>
                  <c:pt idx="5">
                    <c:v>2.9124763824795216E-2</c:v>
                  </c:pt>
                  <c:pt idx="6">
                    <c:v>3.5420858814431189E-2</c:v>
                  </c:pt>
                  <c:pt idx="7">
                    <c:v>3.9441532940671362E-2</c:v>
                  </c:pt>
                  <c:pt idx="8">
                    <c:v>4.5345435462220154E-2</c:v>
                  </c:pt>
                  <c:pt idx="9">
                    <c:v>4.8212779473252518E-2</c:v>
                  </c:pt>
                  <c:pt idx="10">
                    <c:v>5.4808900211610924E-2</c:v>
                  </c:pt>
                  <c:pt idx="11">
                    <c:v>6.3656846025058306E-2</c:v>
                  </c:pt>
                  <c:pt idx="12">
                    <c:v>6.9431319281287152E-2</c:v>
                  </c:pt>
                  <c:pt idx="13">
                    <c:v>7.235589593821419E-2</c:v>
                  </c:pt>
                  <c:pt idx="14">
                    <c:v>7.6528936493385741E-2</c:v>
                  </c:pt>
                  <c:pt idx="15">
                    <c:v>7.8760297748797892E-2</c:v>
                  </c:pt>
                </c:numCache>
              </c:numRef>
            </c:plus>
            <c:minus>
              <c:numRef>
                <c:f>'[DataAnalysis_CalibrationCurve_XanthineTest-All.xlsx]All'!$E$3:$E$18</c:f>
                <c:numCache>
                  <c:formatCode>General</c:formatCode>
                  <c:ptCount val="16"/>
                  <c:pt idx="0">
                    <c:v>6.1760133414594867E-3</c:v>
                  </c:pt>
                  <c:pt idx="1">
                    <c:v>6.0787996246566434E-3</c:v>
                  </c:pt>
                  <c:pt idx="2">
                    <c:v>1.1218786379787463E-2</c:v>
                  </c:pt>
                  <c:pt idx="3">
                    <c:v>1.6541265498292601E-2</c:v>
                  </c:pt>
                  <c:pt idx="4">
                    <c:v>2.2412031111886273E-2</c:v>
                  </c:pt>
                  <c:pt idx="5">
                    <c:v>2.9124763824795216E-2</c:v>
                  </c:pt>
                  <c:pt idx="6">
                    <c:v>3.5420858814431189E-2</c:v>
                  </c:pt>
                  <c:pt idx="7">
                    <c:v>3.9441532940671362E-2</c:v>
                  </c:pt>
                  <c:pt idx="8">
                    <c:v>4.5345435462220154E-2</c:v>
                  </c:pt>
                  <c:pt idx="9">
                    <c:v>4.8212779473252518E-2</c:v>
                  </c:pt>
                  <c:pt idx="10">
                    <c:v>5.4808900211610924E-2</c:v>
                  </c:pt>
                  <c:pt idx="11">
                    <c:v>6.3656846025058306E-2</c:v>
                  </c:pt>
                  <c:pt idx="12">
                    <c:v>6.9431319281287152E-2</c:v>
                  </c:pt>
                  <c:pt idx="13">
                    <c:v>7.235589593821419E-2</c:v>
                  </c:pt>
                  <c:pt idx="14">
                    <c:v>7.6528936493385741E-2</c:v>
                  </c:pt>
                  <c:pt idx="15">
                    <c:v>7.8760297748797892E-2</c:v>
                  </c:pt>
                </c:numCache>
              </c:numRef>
            </c:minus>
            <c:spPr>
              <a:noFill/>
              <a:ln w="9525" cap="flat" cmpd="sng" algn="ctr">
                <a:solidFill>
                  <a:schemeClr val="tx1">
                    <a:lumMod val="65000"/>
                    <a:lumOff val="35000"/>
                  </a:schemeClr>
                </a:solidFill>
                <a:round/>
              </a:ln>
              <a:effectLst/>
            </c:spPr>
          </c:errBars>
          <c:xVal>
            <c:numRef>
              <c:f>'[DataAnalysis_CalibrationCurve_XanthineTest-All.xlsx]All'!$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All'!$D$3:$D$18</c:f>
              <c:numCache>
                <c:formatCode>General</c:formatCode>
                <c:ptCount val="16"/>
                <c:pt idx="0">
                  <c:v>5.3928910256410258E-2</c:v>
                </c:pt>
                <c:pt idx="1">
                  <c:v>7.185839743589742E-2</c:v>
                </c:pt>
                <c:pt idx="2">
                  <c:v>9.1011217948717957E-2</c:v>
                </c:pt>
                <c:pt idx="3">
                  <c:v>0.10723108974358975</c:v>
                </c:pt>
                <c:pt idx="4">
                  <c:v>0.12341551282051282</c:v>
                </c:pt>
                <c:pt idx="5">
                  <c:v>0.1400871794871795</c:v>
                </c:pt>
                <c:pt idx="6">
                  <c:v>0.15641858974358977</c:v>
                </c:pt>
                <c:pt idx="7">
                  <c:v>0.17164230769230771</c:v>
                </c:pt>
                <c:pt idx="8">
                  <c:v>0.18786474358974359</c:v>
                </c:pt>
                <c:pt idx="9">
                  <c:v>0.20236666666666669</c:v>
                </c:pt>
                <c:pt idx="10">
                  <c:v>0.21872179487179486</c:v>
                </c:pt>
                <c:pt idx="11">
                  <c:v>0.23579807692307689</c:v>
                </c:pt>
                <c:pt idx="12">
                  <c:v>0.25154294871794874</c:v>
                </c:pt>
                <c:pt idx="13">
                  <c:v>0.26605833333333334</c:v>
                </c:pt>
                <c:pt idx="14">
                  <c:v>0.28137628205128201</c:v>
                </c:pt>
                <c:pt idx="15">
                  <c:v>0.29625961538461537</c:v>
                </c:pt>
              </c:numCache>
            </c:numRef>
          </c:yVal>
          <c:smooth val="0"/>
          <c:extLst>
            <c:ext xmlns:c16="http://schemas.microsoft.com/office/drawing/2014/chart" uri="{C3380CC4-5D6E-409C-BE32-E72D297353CC}">
              <c16:uniqueId val="{00000001-8EC8-4903-BCDD-828979B9DE5C}"/>
            </c:ext>
          </c:extLst>
        </c:ser>
        <c:ser>
          <c:idx val="2"/>
          <c:order val="2"/>
          <c:tx>
            <c:strRef>
              <c:f>'[DataAnalysis_CalibrationCurve_XanthineTest-All.xlsx]All'!$F$1</c:f>
              <c:strCache>
                <c:ptCount val="1"/>
                <c:pt idx="0">
                  <c:v>Pt / HMTES-C3MPC+Xox / 75.25PU (n=5)</c:v>
                </c:pt>
              </c:strCache>
            </c:strRef>
          </c:tx>
          <c:spPr>
            <a:ln w="25400" cap="rnd">
              <a:noFill/>
              <a:round/>
            </a:ln>
            <a:effectLst/>
          </c:spPr>
          <c:marker>
            <c:symbol val="x"/>
            <c:size val="10"/>
            <c:spPr>
              <a:solidFill>
                <a:srgbClr val="FF0000"/>
              </a:solidFill>
              <a:ln w="9525">
                <a:no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All'!$G$3:$G$18</c:f>
                <c:numCache>
                  <c:formatCode>General</c:formatCode>
                  <c:ptCount val="16"/>
                  <c:pt idx="0">
                    <c:v>3.7297641389965105E-3</c:v>
                  </c:pt>
                  <c:pt idx="1">
                    <c:v>1.108509380673621E-2</c:v>
                  </c:pt>
                  <c:pt idx="2">
                    <c:v>1.6626072194815565E-2</c:v>
                  </c:pt>
                  <c:pt idx="3">
                    <c:v>2.2377721215636217E-2</c:v>
                  </c:pt>
                  <c:pt idx="4">
                    <c:v>2.985136792778122E-2</c:v>
                  </c:pt>
                  <c:pt idx="5">
                    <c:v>3.9837560273941128E-2</c:v>
                  </c:pt>
                  <c:pt idx="6">
                    <c:v>4.9987071775355905E-2</c:v>
                  </c:pt>
                  <c:pt idx="7">
                    <c:v>5.8431951457943138E-2</c:v>
                  </c:pt>
                  <c:pt idx="8">
                    <c:v>6.4357597458199897E-2</c:v>
                  </c:pt>
                  <c:pt idx="9">
                    <c:v>6.9294626820649116E-2</c:v>
                  </c:pt>
                  <c:pt idx="10">
                    <c:v>7.3896145268227437E-2</c:v>
                  </c:pt>
                  <c:pt idx="11">
                    <c:v>7.8446609316870614E-2</c:v>
                  </c:pt>
                  <c:pt idx="12">
                    <c:v>8.3311002251527114E-2</c:v>
                  </c:pt>
                  <c:pt idx="13">
                    <c:v>8.8318578781523438E-2</c:v>
                  </c:pt>
                  <c:pt idx="14">
                    <c:v>9.2609184417429935E-2</c:v>
                  </c:pt>
                  <c:pt idx="15">
                    <c:v>9.7640621548263806E-2</c:v>
                  </c:pt>
                </c:numCache>
              </c:numRef>
            </c:plus>
            <c:minus>
              <c:numRef>
                <c:f>'[DataAnalysis_CalibrationCurve_XanthineTest-All.xlsx]All'!$G$3:$G$18</c:f>
                <c:numCache>
                  <c:formatCode>General</c:formatCode>
                  <c:ptCount val="16"/>
                  <c:pt idx="0">
                    <c:v>3.7297641389965105E-3</c:v>
                  </c:pt>
                  <c:pt idx="1">
                    <c:v>1.108509380673621E-2</c:v>
                  </c:pt>
                  <c:pt idx="2">
                    <c:v>1.6626072194815565E-2</c:v>
                  </c:pt>
                  <c:pt idx="3">
                    <c:v>2.2377721215636217E-2</c:v>
                  </c:pt>
                  <c:pt idx="4">
                    <c:v>2.985136792778122E-2</c:v>
                  </c:pt>
                  <c:pt idx="5">
                    <c:v>3.9837560273941128E-2</c:v>
                  </c:pt>
                  <c:pt idx="6">
                    <c:v>4.9987071775355905E-2</c:v>
                  </c:pt>
                  <c:pt idx="7">
                    <c:v>5.8431951457943138E-2</c:v>
                  </c:pt>
                  <c:pt idx="8">
                    <c:v>6.4357597458199897E-2</c:v>
                  </c:pt>
                  <c:pt idx="9">
                    <c:v>6.9294626820649116E-2</c:v>
                  </c:pt>
                  <c:pt idx="10">
                    <c:v>7.3896145268227437E-2</c:v>
                  </c:pt>
                  <c:pt idx="11">
                    <c:v>7.8446609316870614E-2</c:v>
                  </c:pt>
                  <c:pt idx="12">
                    <c:v>8.3311002251527114E-2</c:v>
                  </c:pt>
                  <c:pt idx="13">
                    <c:v>8.8318578781523438E-2</c:v>
                  </c:pt>
                  <c:pt idx="14">
                    <c:v>9.2609184417429935E-2</c:v>
                  </c:pt>
                  <c:pt idx="15">
                    <c:v>9.7640621548263806E-2</c:v>
                  </c:pt>
                </c:numCache>
              </c:numRef>
            </c:minus>
            <c:spPr>
              <a:noFill/>
              <a:ln w="9525" cap="flat" cmpd="sng" algn="ctr">
                <a:solidFill>
                  <a:schemeClr val="tx1">
                    <a:lumMod val="65000"/>
                    <a:lumOff val="35000"/>
                  </a:schemeClr>
                </a:solidFill>
                <a:round/>
              </a:ln>
              <a:effectLst/>
            </c:spPr>
          </c:errBars>
          <c:xVal>
            <c:numRef>
              <c:f>'[DataAnalysis_CalibrationCurve_XanthineTest-All.xlsx]All'!$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All'!$F$3:$F$18</c:f>
              <c:numCache>
                <c:formatCode>General</c:formatCode>
                <c:ptCount val="16"/>
                <c:pt idx="0">
                  <c:v>1.6313461538461541E-2</c:v>
                </c:pt>
                <c:pt idx="1">
                  <c:v>9.1311769230769252E-2</c:v>
                </c:pt>
                <c:pt idx="2">
                  <c:v>0.15867538461538461</c:v>
                </c:pt>
                <c:pt idx="3">
                  <c:v>0.21985307692307696</c:v>
                </c:pt>
                <c:pt idx="4">
                  <c:v>0.27457999999999999</c:v>
                </c:pt>
                <c:pt idx="5">
                  <c:v>0.3215623076923077</c:v>
                </c:pt>
                <c:pt idx="6">
                  <c:v>0.36235384615384614</c:v>
                </c:pt>
                <c:pt idx="7">
                  <c:v>0.39691923076923075</c:v>
                </c:pt>
                <c:pt idx="8">
                  <c:v>0.42796615384615383</c:v>
                </c:pt>
                <c:pt idx="9">
                  <c:v>0.45706461538461535</c:v>
                </c:pt>
                <c:pt idx="10">
                  <c:v>0.48600538461538462</c:v>
                </c:pt>
                <c:pt idx="11">
                  <c:v>0.51259153846153838</c:v>
                </c:pt>
                <c:pt idx="12">
                  <c:v>0.54048999999999991</c:v>
                </c:pt>
                <c:pt idx="13">
                  <c:v>0.56781692307692311</c:v>
                </c:pt>
                <c:pt idx="14">
                  <c:v>0.59611999999999998</c:v>
                </c:pt>
                <c:pt idx="15">
                  <c:v>0.62543846153846161</c:v>
                </c:pt>
              </c:numCache>
            </c:numRef>
          </c:yVal>
          <c:smooth val="0"/>
          <c:extLst>
            <c:ext xmlns:c16="http://schemas.microsoft.com/office/drawing/2014/chart" uri="{C3380CC4-5D6E-409C-BE32-E72D297353CC}">
              <c16:uniqueId val="{00000002-8EC8-4903-BCDD-828979B9DE5C}"/>
            </c:ext>
          </c:extLst>
        </c:ser>
        <c:ser>
          <c:idx val="3"/>
          <c:order val="3"/>
          <c:tx>
            <c:strRef>
              <c:f>'[DataAnalysis_CalibrationCurve_XanthineTest-All.xlsx]All'!$H$1</c:f>
              <c:strCache>
                <c:ptCount val="1"/>
                <c:pt idx="0">
                  <c:v>Pt / HMTES 1-C3MPC+Xox/ HMTES 2 / 75.25PU (n=4)</c:v>
                </c:pt>
              </c:strCache>
            </c:strRef>
          </c:tx>
          <c:spPr>
            <a:ln w="25400" cap="rnd">
              <a:noFill/>
              <a:round/>
            </a:ln>
            <a:effectLst/>
          </c:spPr>
          <c:marker>
            <c:symbol val="square"/>
            <c:size val="10"/>
            <c:spPr>
              <a:noFill/>
              <a:ln w="19050">
                <a:solidFill>
                  <a:srgbClr val="FF0000">
                    <a:alpha val="99000"/>
                  </a:srgbClr>
                </a:solid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All'!$I$3:$I$18</c:f>
                <c:numCache>
                  <c:formatCode>General</c:formatCode>
                  <c:ptCount val="16"/>
                  <c:pt idx="0">
                    <c:v>1.4570282128420753E-3</c:v>
                  </c:pt>
                  <c:pt idx="1">
                    <c:v>5.9058635605605207E-3</c:v>
                  </c:pt>
                  <c:pt idx="2">
                    <c:v>1.2443266790205359E-2</c:v>
                  </c:pt>
                  <c:pt idx="3">
                    <c:v>1.8689577075797909E-2</c:v>
                  </c:pt>
                  <c:pt idx="4">
                    <c:v>2.4056807230229554E-2</c:v>
                  </c:pt>
                  <c:pt idx="5">
                    <c:v>2.8145500549526949E-2</c:v>
                  </c:pt>
                  <c:pt idx="6">
                    <c:v>3.1058334656372494E-2</c:v>
                  </c:pt>
                  <c:pt idx="7">
                    <c:v>3.3137045742528272E-2</c:v>
                  </c:pt>
                  <c:pt idx="8">
                    <c:v>3.5231873285662171E-2</c:v>
                  </c:pt>
                  <c:pt idx="9">
                    <c:v>3.6907062415799344E-2</c:v>
                  </c:pt>
                  <c:pt idx="10">
                    <c:v>3.8947362239238524E-2</c:v>
                  </c:pt>
                  <c:pt idx="11">
                    <c:v>4.0664381185373411E-2</c:v>
                  </c:pt>
                  <c:pt idx="12">
                    <c:v>4.2923699448660903E-2</c:v>
                  </c:pt>
                  <c:pt idx="13">
                    <c:v>4.4328944931362642E-2</c:v>
                  </c:pt>
                  <c:pt idx="14">
                    <c:v>4.5953638563114588E-2</c:v>
                  </c:pt>
                  <c:pt idx="15">
                    <c:v>4.7627688375047557E-2</c:v>
                  </c:pt>
                </c:numCache>
              </c:numRef>
            </c:plus>
            <c:minus>
              <c:numRef>
                <c:f>'[DataAnalysis_CalibrationCurve_XanthineTest-All.xlsx]All'!$I$3:$I$18</c:f>
                <c:numCache>
                  <c:formatCode>General</c:formatCode>
                  <c:ptCount val="16"/>
                  <c:pt idx="0">
                    <c:v>1.4570282128420753E-3</c:v>
                  </c:pt>
                  <c:pt idx="1">
                    <c:v>5.9058635605605207E-3</c:v>
                  </c:pt>
                  <c:pt idx="2">
                    <c:v>1.2443266790205359E-2</c:v>
                  </c:pt>
                  <c:pt idx="3">
                    <c:v>1.8689577075797909E-2</c:v>
                  </c:pt>
                  <c:pt idx="4">
                    <c:v>2.4056807230229554E-2</c:v>
                  </c:pt>
                  <c:pt idx="5">
                    <c:v>2.8145500549526949E-2</c:v>
                  </c:pt>
                  <c:pt idx="6">
                    <c:v>3.1058334656372494E-2</c:v>
                  </c:pt>
                  <c:pt idx="7">
                    <c:v>3.3137045742528272E-2</c:v>
                  </c:pt>
                  <c:pt idx="8">
                    <c:v>3.5231873285662171E-2</c:v>
                  </c:pt>
                  <c:pt idx="9">
                    <c:v>3.6907062415799344E-2</c:v>
                  </c:pt>
                  <c:pt idx="10">
                    <c:v>3.8947362239238524E-2</c:v>
                  </c:pt>
                  <c:pt idx="11">
                    <c:v>4.0664381185373411E-2</c:v>
                  </c:pt>
                  <c:pt idx="12">
                    <c:v>4.2923699448660903E-2</c:v>
                  </c:pt>
                  <c:pt idx="13">
                    <c:v>4.4328944931362642E-2</c:v>
                  </c:pt>
                  <c:pt idx="14">
                    <c:v>4.5953638563114588E-2</c:v>
                  </c:pt>
                  <c:pt idx="15">
                    <c:v>4.7627688375047557E-2</c:v>
                  </c:pt>
                </c:numCache>
              </c:numRef>
            </c:minus>
            <c:spPr>
              <a:noFill/>
              <a:ln w="9525" cap="flat" cmpd="sng" algn="ctr">
                <a:solidFill>
                  <a:schemeClr val="tx1">
                    <a:lumMod val="65000"/>
                    <a:lumOff val="35000"/>
                  </a:schemeClr>
                </a:solidFill>
                <a:round/>
              </a:ln>
              <a:effectLst/>
            </c:spPr>
          </c:errBars>
          <c:xVal>
            <c:numRef>
              <c:f>'[DataAnalysis_CalibrationCurve_XanthineTest-All.xlsx]All'!$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All'!$H$3:$H$18</c:f>
              <c:numCache>
                <c:formatCode>General</c:formatCode>
                <c:ptCount val="16"/>
                <c:pt idx="0">
                  <c:v>3.1685576923076927E-2</c:v>
                </c:pt>
                <c:pt idx="1">
                  <c:v>6.1997403846153841E-2</c:v>
                </c:pt>
                <c:pt idx="2">
                  <c:v>8.9240961538461547E-2</c:v>
                </c:pt>
                <c:pt idx="3">
                  <c:v>0.11741596153846154</c:v>
                </c:pt>
                <c:pt idx="4">
                  <c:v>0.14385673076923078</c:v>
                </c:pt>
                <c:pt idx="5">
                  <c:v>0.16806153846153848</c:v>
                </c:pt>
                <c:pt idx="6">
                  <c:v>0.18879711538461538</c:v>
                </c:pt>
                <c:pt idx="7">
                  <c:v>0.2068932692307692</c:v>
                </c:pt>
                <c:pt idx="8">
                  <c:v>0.22360865384615386</c:v>
                </c:pt>
                <c:pt idx="9">
                  <c:v>0.23844326923076922</c:v>
                </c:pt>
                <c:pt idx="10">
                  <c:v>0.25410288461538461</c:v>
                </c:pt>
                <c:pt idx="11">
                  <c:v>0.26795673076923077</c:v>
                </c:pt>
                <c:pt idx="12">
                  <c:v>0.28231923076923077</c:v>
                </c:pt>
                <c:pt idx="13">
                  <c:v>0.29610096153846155</c:v>
                </c:pt>
                <c:pt idx="14">
                  <c:v>0.3080298076923077</c:v>
                </c:pt>
                <c:pt idx="15">
                  <c:v>0.31980673076923083</c:v>
                </c:pt>
              </c:numCache>
            </c:numRef>
          </c:yVal>
          <c:smooth val="0"/>
          <c:extLst>
            <c:ext xmlns:c16="http://schemas.microsoft.com/office/drawing/2014/chart" uri="{C3380CC4-5D6E-409C-BE32-E72D297353CC}">
              <c16:uniqueId val="{00000003-8EC8-4903-BCDD-828979B9DE5C}"/>
            </c:ext>
          </c:extLst>
        </c:ser>
        <c:ser>
          <c:idx val="4"/>
          <c:order val="4"/>
          <c:tx>
            <c:strRef>
              <c:f>'[DataAnalysis_CalibrationCurve_XanthineTest-All.xlsx]All'!$J$1</c:f>
              <c:strCache>
                <c:ptCount val="1"/>
                <c:pt idx="0">
                  <c:v>Pt / HMTES-C4MPC+Xox / 75.25PU (n=5)</c:v>
                </c:pt>
              </c:strCache>
            </c:strRef>
          </c:tx>
          <c:spPr>
            <a:ln w="25400" cap="rnd">
              <a:noFill/>
              <a:round/>
            </a:ln>
            <a:effectLst/>
          </c:spPr>
          <c:marker>
            <c:symbol val="diamond"/>
            <c:size val="10"/>
            <c:spPr>
              <a:solidFill>
                <a:srgbClr val="00B050"/>
              </a:solidFill>
              <a:ln w="19050">
                <a:no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All'!$K$3:$K$18</c:f>
                <c:numCache>
                  <c:formatCode>General</c:formatCode>
                  <c:ptCount val="16"/>
                  <c:pt idx="0">
                    <c:v>3.2771142233886368E-3</c:v>
                  </c:pt>
                  <c:pt idx="1">
                    <c:v>1.0726487152242292E-2</c:v>
                  </c:pt>
                  <c:pt idx="2">
                    <c:v>2.0528018448455226E-2</c:v>
                  </c:pt>
                  <c:pt idx="3">
                    <c:v>2.9892500271560204E-2</c:v>
                  </c:pt>
                  <c:pt idx="4">
                    <c:v>4.0158288013233089E-2</c:v>
                  </c:pt>
                  <c:pt idx="5">
                    <c:v>4.9965773166895419E-2</c:v>
                  </c:pt>
                  <c:pt idx="6">
                    <c:v>5.951764751218401E-2</c:v>
                  </c:pt>
                  <c:pt idx="7">
                    <c:v>6.982694191047005E-2</c:v>
                  </c:pt>
                  <c:pt idx="8">
                    <c:v>7.9907370254601318E-2</c:v>
                  </c:pt>
                  <c:pt idx="9">
                    <c:v>9.0430087677699875E-2</c:v>
                  </c:pt>
                  <c:pt idx="10">
                    <c:v>0.10008840638752935</c:v>
                  </c:pt>
                  <c:pt idx="11">
                    <c:v>0.10952851245196711</c:v>
                  </c:pt>
                  <c:pt idx="12">
                    <c:v>0.11863558591570285</c:v>
                  </c:pt>
                  <c:pt idx="13">
                    <c:v>0.12717422576223977</c:v>
                  </c:pt>
                  <c:pt idx="14">
                    <c:v>0.13495972527115743</c:v>
                  </c:pt>
                  <c:pt idx="15">
                    <c:v>0.14274306318962793</c:v>
                  </c:pt>
                </c:numCache>
              </c:numRef>
            </c:plus>
            <c:minus>
              <c:numRef>
                <c:f>'[DataAnalysis_CalibrationCurve_XanthineTest-All.xlsx]All'!$K$3:$K$18</c:f>
                <c:numCache>
                  <c:formatCode>General</c:formatCode>
                  <c:ptCount val="16"/>
                  <c:pt idx="0">
                    <c:v>3.2771142233886368E-3</c:v>
                  </c:pt>
                  <c:pt idx="1">
                    <c:v>1.0726487152242292E-2</c:v>
                  </c:pt>
                  <c:pt idx="2">
                    <c:v>2.0528018448455226E-2</c:v>
                  </c:pt>
                  <c:pt idx="3">
                    <c:v>2.9892500271560204E-2</c:v>
                  </c:pt>
                  <c:pt idx="4">
                    <c:v>4.0158288013233089E-2</c:v>
                  </c:pt>
                  <c:pt idx="5">
                    <c:v>4.9965773166895419E-2</c:v>
                  </c:pt>
                  <c:pt idx="6">
                    <c:v>5.951764751218401E-2</c:v>
                  </c:pt>
                  <c:pt idx="7">
                    <c:v>6.982694191047005E-2</c:v>
                  </c:pt>
                  <c:pt idx="8">
                    <c:v>7.9907370254601318E-2</c:v>
                  </c:pt>
                  <c:pt idx="9">
                    <c:v>9.0430087677699875E-2</c:v>
                  </c:pt>
                  <c:pt idx="10">
                    <c:v>0.10008840638752935</c:v>
                  </c:pt>
                  <c:pt idx="11">
                    <c:v>0.10952851245196711</c:v>
                  </c:pt>
                  <c:pt idx="12">
                    <c:v>0.11863558591570285</c:v>
                  </c:pt>
                  <c:pt idx="13">
                    <c:v>0.12717422576223977</c:v>
                  </c:pt>
                  <c:pt idx="14">
                    <c:v>0.13495972527115743</c:v>
                  </c:pt>
                  <c:pt idx="15">
                    <c:v>0.14274306318962793</c:v>
                  </c:pt>
                </c:numCache>
              </c:numRef>
            </c:minus>
            <c:spPr>
              <a:noFill/>
              <a:ln w="9525" cap="flat" cmpd="sng" algn="ctr">
                <a:solidFill>
                  <a:schemeClr val="tx1">
                    <a:lumMod val="65000"/>
                    <a:lumOff val="35000"/>
                  </a:schemeClr>
                </a:solidFill>
                <a:round/>
              </a:ln>
              <a:effectLst/>
            </c:spPr>
          </c:errBars>
          <c:xVal>
            <c:numRef>
              <c:f>'[DataAnalysis_CalibrationCurve_XanthineTest-All.xlsx]All'!$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All'!$J$3:$J$18</c:f>
              <c:numCache>
                <c:formatCode>General</c:formatCode>
                <c:ptCount val="16"/>
                <c:pt idx="0">
                  <c:v>3.3920923076923085E-2</c:v>
                </c:pt>
                <c:pt idx="1">
                  <c:v>0.11874076923076923</c:v>
                </c:pt>
                <c:pt idx="2">
                  <c:v>0.19435769230769234</c:v>
                </c:pt>
                <c:pt idx="3">
                  <c:v>0.26480999999999999</c:v>
                </c:pt>
                <c:pt idx="4">
                  <c:v>0.34084000000000003</c:v>
                </c:pt>
                <c:pt idx="5">
                  <c:v>0.41537923076923083</c:v>
                </c:pt>
                <c:pt idx="6">
                  <c:v>0.48980692307692308</c:v>
                </c:pt>
                <c:pt idx="7">
                  <c:v>0.5649861538461538</c:v>
                </c:pt>
                <c:pt idx="8">
                  <c:v>0.64148538461538451</c:v>
                </c:pt>
                <c:pt idx="9">
                  <c:v>0.72003538461538452</c:v>
                </c:pt>
                <c:pt idx="10">
                  <c:v>0.79566615384615391</c:v>
                </c:pt>
                <c:pt idx="11">
                  <c:v>0.86993384615384617</c:v>
                </c:pt>
                <c:pt idx="12">
                  <c:v>0.94237153846153843</c:v>
                </c:pt>
                <c:pt idx="13">
                  <c:v>1.0119038461538459</c:v>
                </c:pt>
                <c:pt idx="14">
                  <c:v>1.077686153846154</c:v>
                </c:pt>
                <c:pt idx="15">
                  <c:v>1.1417992307692306</c:v>
                </c:pt>
              </c:numCache>
            </c:numRef>
          </c:yVal>
          <c:smooth val="0"/>
          <c:extLst>
            <c:ext xmlns:c16="http://schemas.microsoft.com/office/drawing/2014/chart" uri="{C3380CC4-5D6E-409C-BE32-E72D297353CC}">
              <c16:uniqueId val="{00000004-8EC8-4903-BCDD-828979B9DE5C}"/>
            </c:ext>
          </c:extLst>
        </c:ser>
        <c:ser>
          <c:idx val="5"/>
          <c:order val="5"/>
          <c:tx>
            <c:strRef>
              <c:f>'[DataAnalysis_CalibrationCurve_XanthineTest-All.xlsx]All'!$L$1</c:f>
              <c:strCache>
                <c:ptCount val="1"/>
                <c:pt idx="0">
                  <c:v>Pt / HMTES 1-C4MPC+Xox / HMTES 2 / 75.25PU (n=4)</c:v>
                </c:pt>
              </c:strCache>
            </c:strRef>
          </c:tx>
          <c:spPr>
            <a:ln w="25400" cap="rnd">
              <a:noFill/>
              <a:round/>
            </a:ln>
            <a:effectLst/>
          </c:spPr>
          <c:marker>
            <c:symbol val="diamond"/>
            <c:size val="10"/>
            <c:spPr>
              <a:noFill/>
              <a:ln w="19050">
                <a:solidFill>
                  <a:srgbClr val="00B050"/>
                </a:solid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All'!$M$3:$M$18</c:f>
                <c:numCache>
                  <c:formatCode>General</c:formatCode>
                  <c:ptCount val="16"/>
                  <c:pt idx="0">
                    <c:v>8.7958911562582495E-3</c:v>
                  </c:pt>
                  <c:pt idx="1">
                    <c:v>6.3014639199567603E-3</c:v>
                  </c:pt>
                  <c:pt idx="2">
                    <c:v>9.0018839798886845E-3</c:v>
                  </c:pt>
                  <c:pt idx="3">
                    <c:v>1.389712036317455E-2</c:v>
                  </c:pt>
                  <c:pt idx="4">
                    <c:v>1.8859831117564077E-2</c:v>
                  </c:pt>
                  <c:pt idx="5">
                    <c:v>2.4093659984111587E-2</c:v>
                  </c:pt>
                  <c:pt idx="6">
                    <c:v>3.0542327469568895E-2</c:v>
                  </c:pt>
                  <c:pt idx="7">
                    <c:v>3.5326958390892581E-2</c:v>
                  </c:pt>
                  <c:pt idx="8">
                    <c:v>4.1172308044414289E-2</c:v>
                  </c:pt>
                  <c:pt idx="9">
                    <c:v>4.6105134176531185E-2</c:v>
                  </c:pt>
                  <c:pt idx="10">
                    <c:v>5.1735655033311664E-2</c:v>
                  </c:pt>
                  <c:pt idx="11">
                    <c:v>5.6361670306019476E-2</c:v>
                  </c:pt>
                  <c:pt idx="12">
                    <c:v>5.9796705891737072E-2</c:v>
                  </c:pt>
                  <c:pt idx="13">
                    <c:v>6.485446208600805E-2</c:v>
                  </c:pt>
                  <c:pt idx="14">
                    <c:v>6.7936171386404745E-2</c:v>
                  </c:pt>
                  <c:pt idx="15">
                    <c:v>7.2151544233686776E-2</c:v>
                  </c:pt>
                </c:numCache>
              </c:numRef>
            </c:plus>
            <c:minus>
              <c:numRef>
                <c:f>'[DataAnalysis_CalibrationCurve_XanthineTest-All.xlsx]All'!$M$3:$M$18</c:f>
                <c:numCache>
                  <c:formatCode>General</c:formatCode>
                  <c:ptCount val="16"/>
                  <c:pt idx="0">
                    <c:v>8.7958911562582495E-3</c:v>
                  </c:pt>
                  <c:pt idx="1">
                    <c:v>6.3014639199567603E-3</c:v>
                  </c:pt>
                  <c:pt idx="2">
                    <c:v>9.0018839798886845E-3</c:v>
                  </c:pt>
                  <c:pt idx="3">
                    <c:v>1.389712036317455E-2</c:v>
                  </c:pt>
                  <c:pt idx="4">
                    <c:v>1.8859831117564077E-2</c:v>
                  </c:pt>
                  <c:pt idx="5">
                    <c:v>2.4093659984111587E-2</c:v>
                  </c:pt>
                  <c:pt idx="6">
                    <c:v>3.0542327469568895E-2</c:v>
                  </c:pt>
                  <c:pt idx="7">
                    <c:v>3.5326958390892581E-2</c:v>
                  </c:pt>
                  <c:pt idx="8">
                    <c:v>4.1172308044414289E-2</c:v>
                  </c:pt>
                  <c:pt idx="9">
                    <c:v>4.6105134176531185E-2</c:v>
                  </c:pt>
                  <c:pt idx="10">
                    <c:v>5.1735655033311664E-2</c:v>
                  </c:pt>
                  <c:pt idx="11">
                    <c:v>5.6361670306019476E-2</c:v>
                  </c:pt>
                  <c:pt idx="12">
                    <c:v>5.9796705891737072E-2</c:v>
                  </c:pt>
                  <c:pt idx="13">
                    <c:v>6.485446208600805E-2</c:v>
                  </c:pt>
                  <c:pt idx="14">
                    <c:v>6.7936171386404745E-2</c:v>
                  </c:pt>
                  <c:pt idx="15">
                    <c:v>7.2151544233686776E-2</c:v>
                  </c:pt>
                </c:numCache>
              </c:numRef>
            </c:minus>
            <c:spPr>
              <a:noFill/>
              <a:ln w="9525" cap="flat" cmpd="sng" algn="ctr">
                <a:solidFill>
                  <a:schemeClr val="tx1">
                    <a:lumMod val="65000"/>
                    <a:lumOff val="35000"/>
                  </a:schemeClr>
                </a:solidFill>
                <a:round/>
              </a:ln>
              <a:effectLst/>
            </c:spPr>
          </c:errBars>
          <c:xVal>
            <c:numRef>
              <c:f>'[DataAnalysis_CalibrationCurve_XanthineTest-All.xlsx]All'!$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All'!$L$3:$L$18</c:f>
              <c:numCache>
                <c:formatCode>General</c:formatCode>
                <c:ptCount val="16"/>
                <c:pt idx="0">
                  <c:v>6.0466346153846148E-2</c:v>
                </c:pt>
                <c:pt idx="1">
                  <c:v>9.7307307692307693E-2</c:v>
                </c:pt>
                <c:pt idx="2">
                  <c:v>0.13250384615384614</c:v>
                </c:pt>
                <c:pt idx="3">
                  <c:v>0.16365288461538458</c:v>
                </c:pt>
                <c:pt idx="4">
                  <c:v>0.19639038461538463</c:v>
                </c:pt>
                <c:pt idx="5">
                  <c:v>0.2289278846153846</c:v>
                </c:pt>
                <c:pt idx="6">
                  <c:v>0.26613846153846149</c:v>
                </c:pt>
                <c:pt idx="7">
                  <c:v>0.29458653846153848</c:v>
                </c:pt>
                <c:pt idx="8">
                  <c:v>0.32884038461538462</c:v>
                </c:pt>
                <c:pt idx="9">
                  <c:v>0.35989038461538458</c:v>
                </c:pt>
                <c:pt idx="10">
                  <c:v>0.39004903846153849</c:v>
                </c:pt>
                <c:pt idx="11">
                  <c:v>0.41887307692307696</c:v>
                </c:pt>
                <c:pt idx="12">
                  <c:v>0.44465769230769236</c:v>
                </c:pt>
                <c:pt idx="13">
                  <c:v>0.46691923076923081</c:v>
                </c:pt>
                <c:pt idx="14">
                  <c:v>0.49023846153846162</c:v>
                </c:pt>
                <c:pt idx="15">
                  <c:v>0.51235384615384616</c:v>
                </c:pt>
              </c:numCache>
            </c:numRef>
          </c:yVal>
          <c:smooth val="0"/>
          <c:extLst>
            <c:ext xmlns:c16="http://schemas.microsoft.com/office/drawing/2014/chart" uri="{C3380CC4-5D6E-409C-BE32-E72D297353CC}">
              <c16:uniqueId val="{00000005-8EC8-4903-BCDD-828979B9DE5C}"/>
            </c:ext>
          </c:extLst>
        </c:ser>
        <c:ser>
          <c:idx val="6"/>
          <c:order val="6"/>
          <c:tx>
            <c:strRef>
              <c:f>'[DataAnalysis_CalibrationCurve_XanthineTest-All.xlsx]All'!$N$1</c:f>
              <c:strCache>
                <c:ptCount val="1"/>
                <c:pt idx="0">
                  <c:v>Pt / HMTES-C6MPC+Xox / 75.25PU (n=6)</c:v>
                </c:pt>
              </c:strCache>
            </c:strRef>
          </c:tx>
          <c:spPr>
            <a:ln w="25400" cap="rnd">
              <a:noFill/>
              <a:round/>
            </a:ln>
            <a:effectLst/>
          </c:spPr>
          <c:marker>
            <c:symbol val="triangle"/>
            <c:size val="10"/>
            <c:spPr>
              <a:solidFill>
                <a:srgbClr val="7030A0"/>
              </a:solidFill>
              <a:ln w="9525">
                <a:no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All'!$O$3:$O$18</c:f>
                <c:numCache>
                  <c:formatCode>General</c:formatCode>
                  <c:ptCount val="16"/>
                  <c:pt idx="0">
                    <c:v>7.1305484677314131E-3</c:v>
                  </c:pt>
                  <c:pt idx="1">
                    <c:v>1.5503423725100225E-2</c:v>
                  </c:pt>
                  <c:pt idx="2">
                    <c:v>3.1284070102316548E-2</c:v>
                  </c:pt>
                  <c:pt idx="3">
                    <c:v>4.5576819396121286E-2</c:v>
                  </c:pt>
                  <c:pt idx="4">
                    <c:v>5.9812599701623545E-2</c:v>
                  </c:pt>
                  <c:pt idx="5">
                    <c:v>7.3276868499547607E-2</c:v>
                  </c:pt>
                  <c:pt idx="6">
                    <c:v>8.8726397807340762E-2</c:v>
                  </c:pt>
                  <c:pt idx="7">
                    <c:v>0.10251059962511179</c:v>
                  </c:pt>
                  <c:pt idx="8">
                    <c:v>0.11676341694454966</c:v>
                  </c:pt>
                  <c:pt idx="9">
                    <c:v>0.13131587064885616</c:v>
                  </c:pt>
                  <c:pt idx="10">
                    <c:v>0.14417792710594304</c:v>
                  </c:pt>
                  <c:pt idx="11">
                    <c:v>0.15646922740356731</c:v>
                  </c:pt>
                  <c:pt idx="12">
                    <c:v>0.16334005077343047</c:v>
                  </c:pt>
                  <c:pt idx="13">
                    <c:v>0.17050637869788696</c:v>
                  </c:pt>
                  <c:pt idx="14">
                    <c:v>0.17619971290177106</c:v>
                  </c:pt>
                  <c:pt idx="15">
                    <c:v>0.1830337532442235</c:v>
                  </c:pt>
                </c:numCache>
              </c:numRef>
            </c:plus>
            <c:minus>
              <c:numRef>
                <c:f>'[DataAnalysis_CalibrationCurve_XanthineTest-All.xlsx]All'!$O$3:$O$18</c:f>
                <c:numCache>
                  <c:formatCode>General</c:formatCode>
                  <c:ptCount val="16"/>
                  <c:pt idx="0">
                    <c:v>7.1305484677314131E-3</c:v>
                  </c:pt>
                  <c:pt idx="1">
                    <c:v>1.5503423725100225E-2</c:v>
                  </c:pt>
                  <c:pt idx="2">
                    <c:v>3.1284070102316548E-2</c:v>
                  </c:pt>
                  <c:pt idx="3">
                    <c:v>4.5576819396121286E-2</c:v>
                  </c:pt>
                  <c:pt idx="4">
                    <c:v>5.9812599701623545E-2</c:v>
                  </c:pt>
                  <c:pt idx="5">
                    <c:v>7.3276868499547607E-2</c:v>
                  </c:pt>
                  <c:pt idx="6">
                    <c:v>8.8726397807340762E-2</c:v>
                  </c:pt>
                  <c:pt idx="7">
                    <c:v>0.10251059962511179</c:v>
                  </c:pt>
                  <c:pt idx="8">
                    <c:v>0.11676341694454966</c:v>
                  </c:pt>
                  <c:pt idx="9">
                    <c:v>0.13131587064885616</c:v>
                  </c:pt>
                  <c:pt idx="10">
                    <c:v>0.14417792710594304</c:v>
                  </c:pt>
                  <c:pt idx="11">
                    <c:v>0.15646922740356731</c:v>
                  </c:pt>
                  <c:pt idx="12">
                    <c:v>0.16334005077343047</c:v>
                  </c:pt>
                  <c:pt idx="13">
                    <c:v>0.17050637869788696</c:v>
                  </c:pt>
                  <c:pt idx="14">
                    <c:v>0.17619971290177106</c:v>
                  </c:pt>
                  <c:pt idx="15">
                    <c:v>0.1830337532442235</c:v>
                  </c:pt>
                </c:numCache>
              </c:numRef>
            </c:minus>
            <c:spPr>
              <a:noFill/>
              <a:ln w="9525" cap="flat" cmpd="sng" algn="ctr">
                <a:solidFill>
                  <a:schemeClr val="tx1">
                    <a:lumMod val="65000"/>
                    <a:lumOff val="35000"/>
                  </a:schemeClr>
                </a:solidFill>
                <a:round/>
              </a:ln>
              <a:effectLst/>
            </c:spPr>
          </c:errBars>
          <c:xVal>
            <c:numRef>
              <c:f>'[DataAnalysis_CalibrationCurve_XanthineTest-All.xlsx]All'!$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All'!$N$3:$N$18</c:f>
              <c:numCache>
                <c:formatCode>General</c:formatCode>
                <c:ptCount val="16"/>
                <c:pt idx="0">
                  <c:v>4.7006733333333328E-2</c:v>
                </c:pt>
                <c:pt idx="1">
                  <c:v>0.15081799999999998</c:v>
                </c:pt>
                <c:pt idx="2">
                  <c:v>0.23995716666666669</c:v>
                </c:pt>
                <c:pt idx="3">
                  <c:v>0.32449033333333333</c:v>
                </c:pt>
                <c:pt idx="4">
                  <c:v>0.41524066666666665</c:v>
                </c:pt>
                <c:pt idx="5">
                  <c:v>0.50321450000000001</c:v>
                </c:pt>
                <c:pt idx="6">
                  <c:v>0.59559966666666664</c:v>
                </c:pt>
                <c:pt idx="7">
                  <c:v>0.68941750000000013</c:v>
                </c:pt>
                <c:pt idx="8">
                  <c:v>0.78668883333333317</c:v>
                </c:pt>
                <c:pt idx="9">
                  <c:v>0.88420166666666666</c:v>
                </c:pt>
                <c:pt idx="10">
                  <c:v>0.98353016666666659</c:v>
                </c:pt>
                <c:pt idx="11">
                  <c:v>1.0863488448844882</c:v>
                </c:pt>
                <c:pt idx="12">
                  <c:v>1.1837766666666665</c:v>
                </c:pt>
                <c:pt idx="13">
                  <c:v>1.2747916666666701</c:v>
                </c:pt>
                <c:pt idx="14">
                  <c:v>1.3587066666666667</c:v>
                </c:pt>
                <c:pt idx="15">
                  <c:v>1.4327866666666662</c:v>
                </c:pt>
              </c:numCache>
            </c:numRef>
          </c:yVal>
          <c:smooth val="0"/>
          <c:extLst>
            <c:ext xmlns:c16="http://schemas.microsoft.com/office/drawing/2014/chart" uri="{C3380CC4-5D6E-409C-BE32-E72D297353CC}">
              <c16:uniqueId val="{00000006-8EC8-4903-BCDD-828979B9DE5C}"/>
            </c:ext>
          </c:extLst>
        </c:ser>
        <c:ser>
          <c:idx val="7"/>
          <c:order val="7"/>
          <c:tx>
            <c:strRef>
              <c:f>'[DataAnalysis_CalibrationCurve_XanthineTest-All.xlsx]All'!$P$1</c:f>
              <c:strCache>
                <c:ptCount val="1"/>
                <c:pt idx="0">
                  <c:v>Pt / HMTES 1-C6MPC+Xox / HMTES 2 / 75.25PU (n=3)</c:v>
                </c:pt>
              </c:strCache>
            </c:strRef>
          </c:tx>
          <c:spPr>
            <a:ln w="25400" cap="rnd">
              <a:noFill/>
              <a:round/>
            </a:ln>
            <a:effectLst/>
          </c:spPr>
          <c:marker>
            <c:symbol val="triangle"/>
            <c:size val="10"/>
            <c:spPr>
              <a:noFill/>
              <a:ln w="19050">
                <a:solidFill>
                  <a:srgbClr val="7030A0"/>
                </a:solid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All'!$Q$3:$Q$18</c:f>
                <c:numCache>
                  <c:formatCode>General</c:formatCode>
                  <c:ptCount val="16"/>
                  <c:pt idx="0">
                    <c:v>6.0213082850268888E-3</c:v>
                  </c:pt>
                  <c:pt idx="1">
                    <c:v>4.3915776588070651E-3</c:v>
                  </c:pt>
                  <c:pt idx="2">
                    <c:v>1.1674995260527276E-2</c:v>
                  </c:pt>
                  <c:pt idx="3">
                    <c:v>1.889721901056695E-2</c:v>
                  </c:pt>
                  <c:pt idx="4">
                    <c:v>2.6813957192725852E-2</c:v>
                  </c:pt>
                  <c:pt idx="5">
                    <c:v>3.6944623916522867E-2</c:v>
                  </c:pt>
                  <c:pt idx="6">
                    <c:v>4.5341370737256491E-2</c:v>
                  </c:pt>
                  <c:pt idx="7">
                    <c:v>5.4146536291191774E-2</c:v>
                  </c:pt>
                  <c:pt idx="8">
                    <c:v>6.343687832010636E-2</c:v>
                  </c:pt>
                  <c:pt idx="9">
                    <c:v>7.289177047056361E-2</c:v>
                  </c:pt>
                  <c:pt idx="10">
                    <c:v>8.167392042139289E-2</c:v>
                  </c:pt>
                  <c:pt idx="11">
                    <c:v>9.2897209818168291E-2</c:v>
                  </c:pt>
                  <c:pt idx="12">
                    <c:v>0.10317909695928461</c:v>
                  </c:pt>
                  <c:pt idx="13">
                    <c:v>0.11356561209421358</c:v>
                  </c:pt>
                  <c:pt idx="14">
                    <c:v>0.12376732314037217</c:v>
                  </c:pt>
                  <c:pt idx="15">
                    <c:v>0.13417439326861105</c:v>
                  </c:pt>
                </c:numCache>
              </c:numRef>
            </c:plus>
            <c:minus>
              <c:numRef>
                <c:f>'[DataAnalysis_CalibrationCurve_XanthineTest-All.xlsx]All'!$Q$3:$Q$18</c:f>
                <c:numCache>
                  <c:formatCode>General</c:formatCode>
                  <c:ptCount val="16"/>
                  <c:pt idx="0">
                    <c:v>6.0213082850268888E-3</c:v>
                  </c:pt>
                  <c:pt idx="1">
                    <c:v>4.3915776588070651E-3</c:v>
                  </c:pt>
                  <c:pt idx="2">
                    <c:v>1.1674995260527276E-2</c:v>
                  </c:pt>
                  <c:pt idx="3">
                    <c:v>1.889721901056695E-2</c:v>
                  </c:pt>
                  <c:pt idx="4">
                    <c:v>2.6813957192725852E-2</c:v>
                  </c:pt>
                  <c:pt idx="5">
                    <c:v>3.6944623916522867E-2</c:v>
                  </c:pt>
                  <c:pt idx="6">
                    <c:v>4.5341370737256491E-2</c:v>
                  </c:pt>
                  <c:pt idx="7">
                    <c:v>5.4146536291191774E-2</c:v>
                  </c:pt>
                  <c:pt idx="8">
                    <c:v>6.343687832010636E-2</c:v>
                  </c:pt>
                  <c:pt idx="9">
                    <c:v>7.289177047056361E-2</c:v>
                  </c:pt>
                  <c:pt idx="10">
                    <c:v>8.167392042139289E-2</c:v>
                  </c:pt>
                  <c:pt idx="11">
                    <c:v>9.2897209818168291E-2</c:v>
                  </c:pt>
                  <c:pt idx="12">
                    <c:v>0.10317909695928461</c:v>
                  </c:pt>
                  <c:pt idx="13">
                    <c:v>0.11356561209421358</c:v>
                  </c:pt>
                  <c:pt idx="14">
                    <c:v>0.12376732314037217</c:v>
                  </c:pt>
                  <c:pt idx="15">
                    <c:v>0.13417439326861105</c:v>
                  </c:pt>
                </c:numCache>
              </c:numRef>
            </c:minus>
            <c:spPr>
              <a:noFill/>
              <a:ln w="9525" cap="flat" cmpd="sng" algn="ctr">
                <a:solidFill>
                  <a:schemeClr val="tx1">
                    <a:lumMod val="65000"/>
                    <a:lumOff val="35000"/>
                  </a:schemeClr>
                </a:solidFill>
                <a:round/>
              </a:ln>
              <a:effectLst/>
            </c:spPr>
          </c:errBars>
          <c:xVal>
            <c:numRef>
              <c:f>'[DataAnalysis_CalibrationCurve_XanthineTest-All.xlsx]All'!$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All'!$P$3:$P$18</c:f>
              <c:numCache>
                <c:formatCode>General</c:formatCode>
                <c:ptCount val="16"/>
                <c:pt idx="0">
                  <c:v>6.8012833333333342E-2</c:v>
                </c:pt>
                <c:pt idx="1">
                  <c:v>0.11858933333333331</c:v>
                </c:pt>
                <c:pt idx="2">
                  <c:v>0.16017166666666668</c:v>
                </c:pt>
                <c:pt idx="3">
                  <c:v>0.19868066666666664</c:v>
                </c:pt>
                <c:pt idx="4">
                  <c:v>0.2377006666666667</c:v>
                </c:pt>
                <c:pt idx="5">
                  <c:v>0.27632733333333337</c:v>
                </c:pt>
                <c:pt idx="6">
                  <c:v>0.31523233333333334</c:v>
                </c:pt>
                <c:pt idx="7">
                  <c:v>0.35497533333333336</c:v>
                </c:pt>
                <c:pt idx="8">
                  <c:v>0.395403</c:v>
                </c:pt>
                <c:pt idx="9">
                  <c:v>0.43571933333333335</c:v>
                </c:pt>
                <c:pt idx="10">
                  <c:v>0.47551500000000013</c:v>
                </c:pt>
                <c:pt idx="11">
                  <c:v>0.51044653465346534</c:v>
                </c:pt>
                <c:pt idx="12">
                  <c:v>0.55067133333333318</c:v>
                </c:pt>
                <c:pt idx="13">
                  <c:v>0.58905533333333326</c:v>
                </c:pt>
                <c:pt idx="14">
                  <c:v>0.62812833333333351</c:v>
                </c:pt>
                <c:pt idx="15">
                  <c:v>0.66651800000000005</c:v>
                </c:pt>
              </c:numCache>
            </c:numRef>
          </c:yVal>
          <c:smooth val="0"/>
          <c:extLst>
            <c:ext xmlns:c16="http://schemas.microsoft.com/office/drawing/2014/chart" uri="{C3380CC4-5D6E-409C-BE32-E72D297353CC}">
              <c16:uniqueId val="{00000007-8EC8-4903-BCDD-828979B9DE5C}"/>
            </c:ext>
          </c:extLst>
        </c:ser>
        <c:dLbls>
          <c:showLegendKey val="0"/>
          <c:showVal val="0"/>
          <c:showCatName val="0"/>
          <c:showSerName val="0"/>
          <c:showPercent val="0"/>
          <c:showBubbleSize val="0"/>
        </c:dLbls>
        <c:axId val="975122127"/>
        <c:axId val="298867487"/>
      </c:scatterChart>
      <c:valAx>
        <c:axId val="975122127"/>
        <c:scaling>
          <c:orientation val="minMax"/>
          <c:max val="620"/>
          <c:min val="0"/>
        </c:scaling>
        <c:delete val="0"/>
        <c:axPos val="b"/>
        <c:title>
          <c:tx>
            <c:rich>
              <a:bodyPr rot="0" spcFirstLastPara="1" vertOverflow="ellipsis" vert="horz" wrap="square" anchor="ctr" anchorCtr="1"/>
              <a:lstStyle/>
              <a:p>
                <a:pPr>
                  <a:defRPr sz="16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sz="1600" b="1" dirty="0">
                    <a:latin typeface="Times New Roman" panose="02020603050405020304" pitchFamily="18" charset="0"/>
                    <a:cs typeface="Times New Roman" panose="02020603050405020304" pitchFamily="18" charset="0"/>
                  </a:rPr>
                  <a:t>Xanthine</a:t>
                </a:r>
                <a:r>
                  <a:rPr lang="en-US" sz="1600" b="1" baseline="0" dirty="0">
                    <a:latin typeface="Times New Roman" panose="02020603050405020304" pitchFamily="18" charset="0"/>
                    <a:cs typeface="Times New Roman" panose="02020603050405020304" pitchFamily="18" charset="0"/>
                  </a:rPr>
                  <a:t> </a:t>
                </a:r>
                <a:r>
                  <a:rPr lang="en-US" sz="1600" b="1" dirty="0">
                    <a:latin typeface="Times New Roman" panose="02020603050405020304" pitchFamily="18" charset="0"/>
                    <a:cs typeface="Times New Roman" panose="02020603050405020304" pitchFamily="18" charset="0"/>
                  </a:rPr>
                  <a:t>Concentration (</a:t>
                </a:r>
                <a:r>
                  <a:rPr lang="el-GR" sz="1600" b="1" dirty="0">
                    <a:latin typeface="Times New Roman" panose="02020603050405020304" pitchFamily="18" charset="0"/>
                    <a:cs typeface="Times New Roman" panose="02020603050405020304" pitchFamily="18" charset="0"/>
                  </a:rPr>
                  <a:t>μ</a:t>
                </a:r>
                <a:r>
                  <a:rPr lang="en-US" sz="1600" b="1" dirty="0">
                    <a:latin typeface="Times New Roman" panose="02020603050405020304" pitchFamily="18" charset="0"/>
                    <a:cs typeface="Times New Roman" panose="02020603050405020304" pitchFamily="18" charset="0"/>
                  </a:rPr>
                  <a:t>M)</a:t>
                </a:r>
              </a:p>
            </c:rich>
          </c:tx>
          <c:layout>
            <c:manualLayout>
              <c:xMode val="edge"/>
              <c:yMode val="edge"/>
              <c:x val="0.36582645919260093"/>
              <c:y val="0.69370512766336756"/>
            </c:manualLayout>
          </c:layout>
          <c:overlay val="0"/>
          <c:spPr>
            <a:noFill/>
            <a:ln>
              <a:noFill/>
            </a:ln>
            <a:effectLst/>
          </c:spPr>
          <c:txPr>
            <a:bodyPr rot="0" spcFirstLastPara="1" vertOverflow="ellipsis" vert="horz" wrap="square" anchor="ctr" anchorCtr="1"/>
            <a:lstStyle/>
            <a:p>
              <a:pPr>
                <a:defRPr sz="16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298867487"/>
        <c:crosses val="autoZero"/>
        <c:crossBetween val="midCat"/>
        <c:majorUnit val="50"/>
      </c:valAx>
      <c:valAx>
        <c:axId val="298867487"/>
        <c:scaling>
          <c:orientation val="minMax"/>
          <c:max val="1.7000000000000002"/>
          <c:min val="0"/>
        </c:scaling>
        <c:delete val="0"/>
        <c:axPos val="l"/>
        <c:title>
          <c:tx>
            <c:rich>
              <a:bodyPr rot="-54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r>
                  <a:rPr lang="en-US" sz="1600" b="1"/>
                  <a:t>Current (</a:t>
                </a:r>
                <a:r>
                  <a:rPr lang="el-GR" sz="1600" b="1"/>
                  <a:t>μ</a:t>
                </a:r>
                <a:r>
                  <a:rPr lang="en-US" sz="1600" b="1"/>
                  <a:t>A)</a:t>
                </a:r>
              </a:p>
            </c:rich>
          </c:tx>
          <c:layout>
            <c:manualLayout>
              <c:xMode val="edge"/>
              <c:yMode val="edge"/>
              <c:x val="9.3574700221295878E-4"/>
              <c:y val="0.2356857846904071"/>
            </c:manualLayout>
          </c:layout>
          <c:overlay val="0"/>
          <c:spPr>
            <a:noFill/>
            <a:ln>
              <a:noFill/>
            </a:ln>
            <a:effectLst/>
          </c:spPr>
          <c:txPr>
            <a:bodyPr rot="-54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975122127"/>
        <c:crosses val="autoZero"/>
        <c:crossBetween val="midCat"/>
        <c:majorUnit val="0.4"/>
      </c:valAx>
      <c:spPr>
        <a:noFill/>
        <a:ln>
          <a:noFill/>
        </a:ln>
        <a:effectLst/>
      </c:spPr>
    </c:plotArea>
    <c:legend>
      <c:legendPos val="b"/>
      <c:layout>
        <c:manualLayout>
          <c:xMode val="edge"/>
          <c:yMode val="edge"/>
          <c:x val="0"/>
          <c:y val="0.74188808990907784"/>
          <c:w val="0.99523120271730725"/>
          <c:h val="0.25811191009092216"/>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1653630796150481"/>
          <c:y val="1.7420791739674285E-2"/>
          <c:w val="0.85072761738116065"/>
          <c:h val="0.79843118752027364"/>
        </c:manualLayout>
      </c:layout>
      <c:scatterChart>
        <c:scatterStyle val="lineMarker"/>
        <c:varyColors val="0"/>
        <c:ser>
          <c:idx val="1"/>
          <c:order val="1"/>
          <c:tx>
            <c:strRef>
              <c:f>'[DataAnalysis_CalibrationCurve_XanthineTest-All.xlsx]2 Xerogels'!$D$1</c:f>
              <c:strCache>
                <c:ptCount val="1"/>
                <c:pt idx="0">
                  <c:v>Pt / HMTES 1+Xox / HMTES 2 / 75.25PU (n=6)</c:v>
                </c:pt>
              </c:strCache>
            </c:strRef>
          </c:tx>
          <c:spPr>
            <a:ln w="25400" cap="rnd">
              <a:noFill/>
              <a:round/>
            </a:ln>
            <a:effectLst/>
          </c:spPr>
          <c:marker>
            <c:symbol val="circle"/>
            <c:size val="10"/>
            <c:spPr>
              <a:noFill/>
              <a:ln w="19050">
                <a:solidFill>
                  <a:schemeClr val="tx1"/>
                </a:solid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2 Xerogels'!$E$3:$E$18</c:f>
                <c:numCache>
                  <c:formatCode>General</c:formatCode>
                  <c:ptCount val="16"/>
                  <c:pt idx="0">
                    <c:v>6.1760133414594867E-3</c:v>
                  </c:pt>
                  <c:pt idx="1">
                    <c:v>6.0787996246566434E-3</c:v>
                  </c:pt>
                  <c:pt idx="2">
                    <c:v>1.1218786379787463E-2</c:v>
                  </c:pt>
                  <c:pt idx="3">
                    <c:v>1.6541265498292601E-2</c:v>
                  </c:pt>
                  <c:pt idx="4">
                    <c:v>2.2412031111886273E-2</c:v>
                  </c:pt>
                  <c:pt idx="5">
                    <c:v>2.9124763824795216E-2</c:v>
                  </c:pt>
                  <c:pt idx="6">
                    <c:v>3.5420858814431189E-2</c:v>
                  </c:pt>
                  <c:pt idx="7">
                    <c:v>3.9441532940671362E-2</c:v>
                  </c:pt>
                  <c:pt idx="8">
                    <c:v>4.5345435462220154E-2</c:v>
                  </c:pt>
                  <c:pt idx="9">
                    <c:v>4.8212779473252518E-2</c:v>
                  </c:pt>
                  <c:pt idx="10">
                    <c:v>5.4808900211610924E-2</c:v>
                  </c:pt>
                  <c:pt idx="11">
                    <c:v>6.3656846025058306E-2</c:v>
                  </c:pt>
                  <c:pt idx="12">
                    <c:v>6.9431319281287152E-2</c:v>
                  </c:pt>
                  <c:pt idx="13">
                    <c:v>7.235589593821419E-2</c:v>
                  </c:pt>
                  <c:pt idx="14">
                    <c:v>7.6528936493385741E-2</c:v>
                  </c:pt>
                  <c:pt idx="15">
                    <c:v>7.8760297748797892E-2</c:v>
                  </c:pt>
                </c:numCache>
              </c:numRef>
            </c:plus>
            <c:minus>
              <c:numRef>
                <c:f>'[DataAnalysis_CalibrationCurve_XanthineTest-All.xlsx]2 Xerogels'!$E$3:$E$18</c:f>
                <c:numCache>
                  <c:formatCode>General</c:formatCode>
                  <c:ptCount val="16"/>
                  <c:pt idx="0">
                    <c:v>6.1760133414594867E-3</c:v>
                  </c:pt>
                  <c:pt idx="1">
                    <c:v>6.0787996246566434E-3</c:v>
                  </c:pt>
                  <c:pt idx="2">
                    <c:v>1.1218786379787463E-2</c:v>
                  </c:pt>
                  <c:pt idx="3">
                    <c:v>1.6541265498292601E-2</c:v>
                  </c:pt>
                  <c:pt idx="4">
                    <c:v>2.2412031111886273E-2</c:v>
                  </c:pt>
                  <c:pt idx="5">
                    <c:v>2.9124763824795216E-2</c:v>
                  </c:pt>
                  <c:pt idx="6">
                    <c:v>3.5420858814431189E-2</c:v>
                  </c:pt>
                  <c:pt idx="7">
                    <c:v>3.9441532940671362E-2</c:v>
                  </c:pt>
                  <c:pt idx="8">
                    <c:v>4.5345435462220154E-2</c:v>
                  </c:pt>
                  <c:pt idx="9">
                    <c:v>4.8212779473252518E-2</c:v>
                  </c:pt>
                  <c:pt idx="10">
                    <c:v>5.4808900211610924E-2</c:v>
                  </c:pt>
                  <c:pt idx="11">
                    <c:v>6.3656846025058306E-2</c:v>
                  </c:pt>
                  <c:pt idx="12">
                    <c:v>6.9431319281287152E-2</c:v>
                  </c:pt>
                  <c:pt idx="13">
                    <c:v>7.235589593821419E-2</c:v>
                  </c:pt>
                  <c:pt idx="14">
                    <c:v>7.6528936493385741E-2</c:v>
                  </c:pt>
                  <c:pt idx="15">
                    <c:v>7.8760297748797892E-2</c:v>
                  </c:pt>
                </c:numCache>
              </c:numRef>
            </c:minus>
            <c:spPr>
              <a:noFill/>
              <a:ln w="9525" cap="flat" cmpd="sng" algn="ctr">
                <a:solidFill>
                  <a:schemeClr val="tx1">
                    <a:lumMod val="65000"/>
                    <a:lumOff val="35000"/>
                  </a:schemeClr>
                </a:solidFill>
                <a:round/>
              </a:ln>
              <a:effectLst/>
            </c:spPr>
          </c:errBars>
          <c:xVal>
            <c:numRef>
              <c:f>'[DataAnalysis_CalibrationCurve_XanthineTest-All.xlsx]2 Xerogels'!$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2 Xerogels'!$D$3:$D$18</c:f>
              <c:numCache>
                <c:formatCode>General</c:formatCode>
                <c:ptCount val="16"/>
                <c:pt idx="0">
                  <c:v>5.3928910256410258E-2</c:v>
                </c:pt>
                <c:pt idx="1">
                  <c:v>7.185839743589742E-2</c:v>
                </c:pt>
                <c:pt idx="2">
                  <c:v>9.1011217948717957E-2</c:v>
                </c:pt>
                <c:pt idx="3">
                  <c:v>0.10723108974358975</c:v>
                </c:pt>
                <c:pt idx="4">
                  <c:v>0.12341551282051282</c:v>
                </c:pt>
                <c:pt idx="5">
                  <c:v>0.1400871794871795</c:v>
                </c:pt>
                <c:pt idx="6">
                  <c:v>0.15641858974358977</c:v>
                </c:pt>
                <c:pt idx="7">
                  <c:v>0.17164230769230771</c:v>
                </c:pt>
                <c:pt idx="8">
                  <c:v>0.18786474358974359</c:v>
                </c:pt>
                <c:pt idx="9">
                  <c:v>0.20236666666666669</c:v>
                </c:pt>
                <c:pt idx="10">
                  <c:v>0.21872179487179486</c:v>
                </c:pt>
                <c:pt idx="11">
                  <c:v>0.23579807692307689</c:v>
                </c:pt>
                <c:pt idx="12">
                  <c:v>0.25154294871794874</c:v>
                </c:pt>
                <c:pt idx="13">
                  <c:v>0.26605833333333334</c:v>
                </c:pt>
                <c:pt idx="14">
                  <c:v>0.28137628205128201</c:v>
                </c:pt>
                <c:pt idx="15">
                  <c:v>0.29625961538461537</c:v>
                </c:pt>
              </c:numCache>
            </c:numRef>
          </c:yVal>
          <c:smooth val="0"/>
          <c:extLst xmlns:c15="http://schemas.microsoft.com/office/drawing/2012/chart">
            <c:ext xmlns:c16="http://schemas.microsoft.com/office/drawing/2014/chart" uri="{C3380CC4-5D6E-409C-BE32-E72D297353CC}">
              <c16:uniqueId val="{00000000-784F-4BE8-AD15-4AF885452C59}"/>
            </c:ext>
          </c:extLst>
        </c:ser>
        <c:ser>
          <c:idx val="3"/>
          <c:order val="3"/>
          <c:tx>
            <c:strRef>
              <c:f>'[DataAnalysis_CalibrationCurve_XanthineTest-All.xlsx]2 Xerogels'!$H$1</c:f>
              <c:strCache>
                <c:ptCount val="1"/>
                <c:pt idx="0">
                  <c:v>Pt / HMTES 1-C3MPC+Xox/ HMTES 2 / 75.25PU (n=4)</c:v>
                </c:pt>
              </c:strCache>
            </c:strRef>
          </c:tx>
          <c:spPr>
            <a:ln w="25400" cap="rnd">
              <a:noFill/>
              <a:round/>
            </a:ln>
            <a:effectLst/>
          </c:spPr>
          <c:marker>
            <c:symbol val="square"/>
            <c:size val="10"/>
            <c:spPr>
              <a:noFill/>
              <a:ln w="19050">
                <a:solidFill>
                  <a:srgbClr val="FF0000">
                    <a:alpha val="99000"/>
                  </a:srgbClr>
                </a:solid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2 Xerogels'!$I$3:$I$18</c:f>
                <c:numCache>
                  <c:formatCode>General</c:formatCode>
                  <c:ptCount val="16"/>
                  <c:pt idx="0">
                    <c:v>1.4570282128420753E-3</c:v>
                  </c:pt>
                  <c:pt idx="1">
                    <c:v>5.9058635605605207E-3</c:v>
                  </c:pt>
                  <c:pt idx="2">
                    <c:v>1.2443266790205359E-2</c:v>
                  </c:pt>
                  <c:pt idx="3">
                    <c:v>1.8689577075797909E-2</c:v>
                  </c:pt>
                  <c:pt idx="4">
                    <c:v>2.4056807230229554E-2</c:v>
                  </c:pt>
                  <c:pt idx="5">
                    <c:v>2.8145500549526949E-2</c:v>
                  </c:pt>
                  <c:pt idx="6">
                    <c:v>3.1058334656372494E-2</c:v>
                  </c:pt>
                  <c:pt idx="7">
                    <c:v>3.3137045742528272E-2</c:v>
                  </c:pt>
                  <c:pt idx="8">
                    <c:v>3.5231873285662171E-2</c:v>
                  </c:pt>
                  <c:pt idx="9">
                    <c:v>3.6907062415799344E-2</c:v>
                  </c:pt>
                  <c:pt idx="10">
                    <c:v>3.8947362239238524E-2</c:v>
                  </c:pt>
                  <c:pt idx="11">
                    <c:v>4.0664381185373411E-2</c:v>
                  </c:pt>
                  <c:pt idx="12">
                    <c:v>4.2923699448660903E-2</c:v>
                  </c:pt>
                  <c:pt idx="13">
                    <c:v>4.4328944931362642E-2</c:v>
                  </c:pt>
                  <c:pt idx="14">
                    <c:v>4.5953638563114588E-2</c:v>
                  </c:pt>
                  <c:pt idx="15">
                    <c:v>4.7627688375047557E-2</c:v>
                  </c:pt>
                </c:numCache>
              </c:numRef>
            </c:plus>
            <c:minus>
              <c:numRef>
                <c:f>'[DataAnalysis_CalibrationCurve_XanthineTest-All.xlsx]2 Xerogels'!$I$3:$I$18</c:f>
                <c:numCache>
                  <c:formatCode>General</c:formatCode>
                  <c:ptCount val="16"/>
                  <c:pt idx="0">
                    <c:v>1.4570282128420753E-3</c:v>
                  </c:pt>
                  <c:pt idx="1">
                    <c:v>5.9058635605605207E-3</c:v>
                  </c:pt>
                  <c:pt idx="2">
                    <c:v>1.2443266790205359E-2</c:v>
                  </c:pt>
                  <c:pt idx="3">
                    <c:v>1.8689577075797909E-2</c:v>
                  </c:pt>
                  <c:pt idx="4">
                    <c:v>2.4056807230229554E-2</c:v>
                  </c:pt>
                  <c:pt idx="5">
                    <c:v>2.8145500549526949E-2</c:v>
                  </c:pt>
                  <c:pt idx="6">
                    <c:v>3.1058334656372494E-2</c:v>
                  </c:pt>
                  <c:pt idx="7">
                    <c:v>3.3137045742528272E-2</c:v>
                  </c:pt>
                  <c:pt idx="8">
                    <c:v>3.5231873285662171E-2</c:v>
                  </c:pt>
                  <c:pt idx="9">
                    <c:v>3.6907062415799344E-2</c:v>
                  </c:pt>
                  <c:pt idx="10">
                    <c:v>3.8947362239238524E-2</c:v>
                  </c:pt>
                  <c:pt idx="11">
                    <c:v>4.0664381185373411E-2</c:v>
                  </c:pt>
                  <c:pt idx="12">
                    <c:v>4.2923699448660903E-2</c:v>
                  </c:pt>
                  <c:pt idx="13">
                    <c:v>4.4328944931362642E-2</c:v>
                  </c:pt>
                  <c:pt idx="14">
                    <c:v>4.5953638563114588E-2</c:v>
                  </c:pt>
                  <c:pt idx="15">
                    <c:v>4.7627688375047557E-2</c:v>
                  </c:pt>
                </c:numCache>
              </c:numRef>
            </c:minus>
            <c:spPr>
              <a:noFill/>
              <a:ln w="9525" cap="flat" cmpd="sng" algn="ctr">
                <a:solidFill>
                  <a:schemeClr val="tx1">
                    <a:lumMod val="65000"/>
                    <a:lumOff val="35000"/>
                  </a:schemeClr>
                </a:solidFill>
                <a:round/>
              </a:ln>
              <a:effectLst/>
            </c:spPr>
          </c:errBars>
          <c:xVal>
            <c:numRef>
              <c:f>'[DataAnalysis_CalibrationCurve_XanthineTest-All.xlsx]2 Xerogels'!$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2 Xerogels'!$H$3:$H$18</c:f>
              <c:numCache>
                <c:formatCode>General</c:formatCode>
                <c:ptCount val="16"/>
                <c:pt idx="0">
                  <c:v>3.1685576923076927E-2</c:v>
                </c:pt>
                <c:pt idx="1">
                  <c:v>6.1997403846153841E-2</c:v>
                </c:pt>
                <c:pt idx="2">
                  <c:v>8.9240961538461547E-2</c:v>
                </c:pt>
                <c:pt idx="3">
                  <c:v>0.11741596153846154</c:v>
                </c:pt>
                <c:pt idx="4">
                  <c:v>0.14385673076923078</c:v>
                </c:pt>
                <c:pt idx="5">
                  <c:v>0.16806153846153848</c:v>
                </c:pt>
                <c:pt idx="6">
                  <c:v>0.18879711538461538</c:v>
                </c:pt>
                <c:pt idx="7">
                  <c:v>0.2068932692307692</c:v>
                </c:pt>
                <c:pt idx="8">
                  <c:v>0.22360865384615386</c:v>
                </c:pt>
                <c:pt idx="9">
                  <c:v>0.23844326923076922</c:v>
                </c:pt>
                <c:pt idx="10">
                  <c:v>0.25410288461538461</c:v>
                </c:pt>
                <c:pt idx="11">
                  <c:v>0.26795673076923077</c:v>
                </c:pt>
                <c:pt idx="12">
                  <c:v>0.28231923076923077</c:v>
                </c:pt>
                <c:pt idx="13">
                  <c:v>0.29610096153846155</c:v>
                </c:pt>
                <c:pt idx="14">
                  <c:v>0.3080298076923077</c:v>
                </c:pt>
                <c:pt idx="15">
                  <c:v>0.31980673076923083</c:v>
                </c:pt>
              </c:numCache>
            </c:numRef>
          </c:yVal>
          <c:smooth val="0"/>
          <c:extLst xmlns:c15="http://schemas.microsoft.com/office/drawing/2012/chart">
            <c:ext xmlns:c16="http://schemas.microsoft.com/office/drawing/2014/chart" uri="{C3380CC4-5D6E-409C-BE32-E72D297353CC}">
              <c16:uniqueId val="{00000001-784F-4BE8-AD15-4AF885452C59}"/>
            </c:ext>
          </c:extLst>
        </c:ser>
        <c:ser>
          <c:idx val="5"/>
          <c:order val="5"/>
          <c:tx>
            <c:strRef>
              <c:f>'[DataAnalysis_CalibrationCurve_XanthineTest-All.xlsx]2 Xerogels'!$L$1</c:f>
              <c:strCache>
                <c:ptCount val="1"/>
                <c:pt idx="0">
                  <c:v>Pt / HMTES 1-C4MPC+Xox / HMTES 2 / 75.25PU (n=4)</c:v>
                </c:pt>
              </c:strCache>
            </c:strRef>
          </c:tx>
          <c:spPr>
            <a:ln w="25400" cap="rnd">
              <a:noFill/>
              <a:round/>
            </a:ln>
            <a:effectLst/>
          </c:spPr>
          <c:marker>
            <c:symbol val="diamond"/>
            <c:size val="10"/>
            <c:spPr>
              <a:noFill/>
              <a:ln w="19050">
                <a:solidFill>
                  <a:srgbClr val="00B050"/>
                </a:solid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2 Xerogels'!$M$3:$M$18</c:f>
                <c:numCache>
                  <c:formatCode>General</c:formatCode>
                  <c:ptCount val="16"/>
                  <c:pt idx="0">
                    <c:v>8.7958911562582495E-3</c:v>
                  </c:pt>
                  <c:pt idx="1">
                    <c:v>6.3014639199567603E-3</c:v>
                  </c:pt>
                  <c:pt idx="2">
                    <c:v>9.0018839798886845E-3</c:v>
                  </c:pt>
                  <c:pt idx="3">
                    <c:v>1.389712036317455E-2</c:v>
                  </c:pt>
                  <c:pt idx="4">
                    <c:v>1.8859831117564077E-2</c:v>
                  </c:pt>
                  <c:pt idx="5">
                    <c:v>2.4093659984111587E-2</c:v>
                  </c:pt>
                  <c:pt idx="6">
                    <c:v>3.0542327469568895E-2</c:v>
                  </c:pt>
                  <c:pt idx="7">
                    <c:v>3.5326958390892581E-2</c:v>
                  </c:pt>
                  <c:pt idx="8">
                    <c:v>4.1172308044414289E-2</c:v>
                  </c:pt>
                  <c:pt idx="9">
                    <c:v>4.6105134176531185E-2</c:v>
                  </c:pt>
                  <c:pt idx="10">
                    <c:v>5.1735655033311664E-2</c:v>
                  </c:pt>
                  <c:pt idx="11">
                    <c:v>5.6361670306019476E-2</c:v>
                  </c:pt>
                  <c:pt idx="12">
                    <c:v>5.9796705891737072E-2</c:v>
                  </c:pt>
                  <c:pt idx="13">
                    <c:v>6.485446208600805E-2</c:v>
                  </c:pt>
                  <c:pt idx="14">
                    <c:v>6.7936171386404745E-2</c:v>
                  </c:pt>
                  <c:pt idx="15">
                    <c:v>7.2151544233686776E-2</c:v>
                  </c:pt>
                </c:numCache>
              </c:numRef>
            </c:plus>
            <c:minus>
              <c:numRef>
                <c:f>'[DataAnalysis_CalibrationCurve_XanthineTest-All.xlsx]2 Xerogels'!$M$3:$M$18</c:f>
                <c:numCache>
                  <c:formatCode>General</c:formatCode>
                  <c:ptCount val="16"/>
                  <c:pt idx="0">
                    <c:v>8.7958911562582495E-3</c:v>
                  </c:pt>
                  <c:pt idx="1">
                    <c:v>6.3014639199567603E-3</c:v>
                  </c:pt>
                  <c:pt idx="2">
                    <c:v>9.0018839798886845E-3</c:v>
                  </c:pt>
                  <c:pt idx="3">
                    <c:v>1.389712036317455E-2</c:v>
                  </c:pt>
                  <c:pt idx="4">
                    <c:v>1.8859831117564077E-2</c:v>
                  </c:pt>
                  <c:pt idx="5">
                    <c:v>2.4093659984111587E-2</c:v>
                  </c:pt>
                  <c:pt idx="6">
                    <c:v>3.0542327469568895E-2</c:v>
                  </c:pt>
                  <c:pt idx="7">
                    <c:v>3.5326958390892581E-2</c:v>
                  </c:pt>
                  <c:pt idx="8">
                    <c:v>4.1172308044414289E-2</c:v>
                  </c:pt>
                  <c:pt idx="9">
                    <c:v>4.6105134176531185E-2</c:v>
                  </c:pt>
                  <c:pt idx="10">
                    <c:v>5.1735655033311664E-2</c:v>
                  </c:pt>
                  <c:pt idx="11">
                    <c:v>5.6361670306019476E-2</c:v>
                  </c:pt>
                  <c:pt idx="12">
                    <c:v>5.9796705891737072E-2</c:v>
                  </c:pt>
                  <c:pt idx="13">
                    <c:v>6.485446208600805E-2</c:v>
                  </c:pt>
                  <c:pt idx="14">
                    <c:v>6.7936171386404745E-2</c:v>
                  </c:pt>
                  <c:pt idx="15">
                    <c:v>7.2151544233686776E-2</c:v>
                  </c:pt>
                </c:numCache>
              </c:numRef>
            </c:minus>
            <c:spPr>
              <a:noFill/>
              <a:ln w="9525" cap="flat" cmpd="sng" algn="ctr">
                <a:solidFill>
                  <a:schemeClr val="tx1">
                    <a:lumMod val="65000"/>
                    <a:lumOff val="35000"/>
                  </a:schemeClr>
                </a:solidFill>
                <a:round/>
              </a:ln>
              <a:effectLst/>
            </c:spPr>
          </c:errBars>
          <c:xVal>
            <c:numRef>
              <c:f>'[DataAnalysis_CalibrationCurve_XanthineTest-All.xlsx]2 Xerogels'!$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2 Xerogels'!$L$3:$L$18</c:f>
              <c:numCache>
                <c:formatCode>General</c:formatCode>
                <c:ptCount val="16"/>
                <c:pt idx="0">
                  <c:v>6.0466346153846148E-2</c:v>
                </c:pt>
                <c:pt idx="1">
                  <c:v>9.7307307692307693E-2</c:v>
                </c:pt>
                <c:pt idx="2">
                  <c:v>0.13250384615384614</c:v>
                </c:pt>
                <c:pt idx="3">
                  <c:v>0.16365288461538458</c:v>
                </c:pt>
                <c:pt idx="4">
                  <c:v>0.19639038461538463</c:v>
                </c:pt>
                <c:pt idx="5">
                  <c:v>0.2289278846153846</c:v>
                </c:pt>
                <c:pt idx="6">
                  <c:v>0.26613846153846149</c:v>
                </c:pt>
                <c:pt idx="7">
                  <c:v>0.29458653846153848</c:v>
                </c:pt>
                <c:pt idx="8">
                  <c:v>0.32884038461538462</c:v>
                </c:pt>
                <c:pt idx="9">
                  <c:v>0.35989038461538458</c:v>
                </c:pt>
                <c:pt idx="10">
                  <c:v>0.39004903846153849</c:v>
                </c:pt>
                <c:pt idx="11">
                  <c:v>0.41887307692307696</c:v>
                </c:pt>
                <c:pt idx="12">
                  <c:v>0.44465769230769236</c:v>
                </c:pt>
                <c:pt idx="13">
                  <c:v>0.46691923076923081</c:v>
                </c:pt>
                <c:pt idx="14">
                  <c:v>0.49023846153846162</c:v>
                </c:pt>
                <c:pt idx="15">
                  <c:v>0.51235384615384616</c:v>
                </c:pt>
              </c:numCache>
            </c:numRef>
          </c:yVal>
          <c:smooth val="0"/>
          <c:extLst xmlns:c15="http://schemas.microsoft.com/office/drawing/2012/chart">
            <c:ext xmlns:c16="http://schemas.microsoft.com/office/drawing/2014/chart" uri="{C3380CC4-5D6E-409C-BE32-E72D297353CC}">
              <c16:uniqueId val="{00000002-784F-4BE8-AD15-4AF885452C59}"/>
            </c:ext>
          </c:extLst>
        </c:ser>
        <c:ser>
          <c:idx val="7"/>
          <c:order val="7"/>
          <c:tx>
            <c:strRef>
              <c:f>'[DataAnalysis_CalibrationCurve_XanthineTest-All.xlsx]2 Xerogels'!$P$1</c:f>
              <c:strCache>
                <c:ptCount val="1"/>
                <c:pt idx="0">
                  <c:v>Pt / HMTES 1-C6MPC+Xox / HMTES 2 / 75.25PU (n=3)</c:v>
                </c:pt>
              </c:strCache>
            </c:strRef>
          </c:tx>
          <c:spPr>
            <a:ln w="25400" cap="rnd">
              <a:noFill/>
              <a:round/>
            </a:ln>
            <a:effectLst/>
          </c:spPr>
          <c:marker>
            <c:symbol val="triangle"/>
            <c:size val="10"/>
            <c:spPr>
              <a:noFill/>
              <a:ln w="19050">
                <a:solidFill>
                  <a:srgbClr val="7030A0"/>
                </a:solid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2 Xerogels'!$Q$3:$Q$18</c:f>
                <c:numCache>
                  <c:formatCode>General</c:formatCode>
                  <c:ptCount val="16"/>
                  <c:pt idx="0">
                    <c:v>6.0213082850268888E-3</c:v>
                  </c:pt>
                  <c:pt idx="1">
                    <c:v>4.3915776588070651E-3</c:v>
                  </c:pt>
                  <c:pt idx="2">
                    <c:v>1.1674995260527276E-2</c:v>
                  </c:pt>
                  <c:pt idx="3">
                    <c:v>1.889721901056695E-2</c:v>
                  </c:pt>
                  <c:pt idx="4">
                    <c:v>2.6813957192725852E-2</c:v>
                  </c:pt>
                  <c:pt idx="5">
                    <c:v>3.6944623916522867E-2</c:v>
                  </c:pt>
                  <c:pt idx="6">
                    <c:v>4.5341370737256491E-2</c:v>
                  </c:pt>
                  <c:pt idx="7">
                    <c:v>5.4146536291191774E-2</c:v>
                  </c:pt>
                  <c:pt idx="8">
                    <c:v>6.343687832010636E-2</c:v>
                  </c:pt>
                  <c:pt idx="9">
                    <c:v>7.289177047056361E-2</c:v>
                  </c:pt>
                  <c:pt idx="10">
                    <c:v>8.167392042139289E-2</c:v>
                  </c:pt>
                  <c:pt idx="11">
                    <c:v>9.2897209818168291E-2</c:v>
                  </c:pt>
                  <c:pt idx="12">
                    <c:v>0.10317909695928461</c:v>
                  </c:pt>
                  <c:pt idx="13">
                    <c:v>0.11356561209421358</c:v>
                  </c:pt>
                  <c:pt idx="14">
                    <c:v>0.12376732314037217</c:v>
                  </c:pt>
                  <c:pt idx="15">
                    <c:v>0.13417439326861105</c:v>
                  </c:pt>
                </c:numCache>
              </c:numRef>
            </c:plus>
            <c:minus>
              <c:numRef>
                <c:f>'[DataAnalysis_CalibrationCurve_XanthineTest-All.xlsx]2 Xerogels'!$Q$3:$Q$18</c:f>
                <c:numCache>
                  <c:formatCode>General</c:formatCode>
                  <c:ptCount val="16"/>
                  <c:pt idx="0">
                    <c:v>6.0213082850268888E-3</c:v>
                  </c:pt>
                  <c:pt idx="1">
                    <c:v>4.3915776588070651E-3</c:v>
                  </c:pt>
                  <c:pt idx="2">
                    <c:v>1.1674995260527276E-2</c:v>
                  </c:pt>
                  <c:pt idx="3">
                    <c:v>1.889721901056695E-2</c:v>
                  </c:pt>
                  <c:pt idx="4">
                    <c:v>2.6813957192725852E-2</c:v>
                  </c:pt>
                  <c:pt idx="5">
                    <c:v>3.6944623916522867E-2</c:v>
                  </c:pt>
                  <c:pt idx="6">
                    <c:v>4.5341370737256491E-2</c:v>
                  </c:pt>
                  <c:pt idx="7">
                    <c:v>5.4146536291191774E-2</c:v>
                  </c:pt>
                  <c:pt idx="8">
                    <c:v>6.343687832010636E-2</c:v>
                  </c:pt>
                  <c:pt idx="9">
                    <c:v>7.289177047056361E-2</c:v>
                  </c:pt>
                  <c:pt idx="10">
                    <c:v>8.167392042139289E-2</c:v>
                  </c:pt>
                  <c:pt idx="11">
                    <c:v>9.2897209818168291E-2</c:v>
                  </c:pt>
                  <c:pt idx="12">
                    <c:v>0.10317909695928461</c:v>
                  </c:pt>
                  <c:pt idx="13">
                    <c:v>0.11356561209421358</c:v>
                  </c:pt>
                  <c:pt idx="14">
                    <c:v>0.12376732314037217</c:v>
                  </c:pt>
                  <c:pt idx="15">
                    <c:v>0.13417439326861105</c:v>
                  </c:pt>
                </c:numCache>
              </c:numRef>
            </c:minus>
            <c:spPr>
              <a:noFill/>
              <a:ln w="9525" cap="flat" cmpd="sng" algn="ctr">
                <a:solidFill>
                  <a:schemeClr val="tx1">
                    <a:lumMod val="65000"/>
                    <a:lumOff val="35000"/>
                  </a:schemeClr>
                </a:solidFill>
                <a:round/>
              </a:ln>
              <a:effectLst/>
            </c:spPr>
          </c:errBars>
          <c:xVal>
            <c:numRef>
              <c:f>'[DataAnalysis_CalibrationCurve_XanthineTest-All.xlsx]2 Xerogels'!$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2 Xerogels'!$P$3:$P$18</c:f>
              <c:numCache>
                <c:formatCode>General</c:formatCode>
                <c:ptCount val="16"/>
                <c:pt idx="0">
                  <c:v>6.8012833333333342E-2</c:v>
                </c:pt>
                <c:pt idx="1">
                  <c:v>0.11858933333333331</c:v>
                </c:pt>
                <c:pt idx="2">
                  <c:v>0.16017166666666668</c:v>
                </c:pt>
                <c:pt idx="3">
                  <c:v>0.19868066666666664</c:v>
                </c:pt>
                <c:pt idx="4">
                  <c:v>0.2377006666666667</c:v>
                </c:pt>
                <c:pt idx="5">
                  <c:v>0.27632733333333337</c:v>
                </c:pt>
                <c:pt idx="6">
                  <c:v>0.31523233333333334</c:v>
                </c:pt>
                <c:pt idx="7">
                  <c:v>0.35497533333333336</c:v>
                </c:pt>
                <c:pt idx="8">
                  <c:v>0.395403</c:v>
                </c:pt>
                <c:pt idx="9">
                  <c:v>0.43571933333333335</c:v>
                </c:pt>
                <c:pt idx="10">
                  <c:v>0.47551500000000013</c:v>
                </c:pt>
                <c:pt idx="11">
                  <c:v>0.51044653465346534</c:v>
                </c:pt>
                <c:pt idx="12">
                  <c:v>0.55067133333333318</c:v>
                </c:pt>
                <c:pt idx="13">
                  <c:v>0.58905533333333326</c:v>
                </c:pt>
                <c:pt idx="14">
                  <c:v>0.62812833333333351</c:v>
                </c:pt>
                <c:pt idx="15">
                  <c:v>0.66651800000000005</c:v>
                </c:pt>
              </c:numCache>
            </c:numRef>
          </c:yVal>
          <c:smooth val="0"/>
          <c:extLst xmlns:c15="http://schemas.microsoft.com/office/drawing/2012/chart">
            <c:ext xmlns:c16="http://schemas.microsoft.com/office/drawing/2014/chart" uri="{C3380CC4-5D6E-409C-BE32-E72D297353CC}">
              <c16:uniqueId val="{00000003-784F-4BE8-AD15-4AF885452C59}"/>
            </c:ext>
          </c:extLst>
        </c:ser>
        <c:dLbls>
          <c:showLegendKey val="0"/>
          <c:showVal val="0"/>
          <c:showCatName val="0"/>
          <c:showSerName val="0"/>
          <c:showPercent val="0"/>
          <c:showBubbleSize val="0"/>
        </c:dLbls>
        <c:axId val="975122127"/>
        <c:axId val="298867487"/>
        <c:extLst>
          <c:ext xmlns:c15="http://schemas.microsoft.com/office/drawing/2012/chart" uri="{02D57815-91ED-43cb-92C2-25804820EDAC}">
            <c15:filteredScatterSeries>
              <c15:ser>
                <c:idx val="0"/>
                <c:order val="0"/>
                <c:tx>
                  <c:strRef>
                    <c:extLst>
                      <c:ext uri="{02D57815-91ED-43cb-92C2-25804820EDAC}">
                        <c15:formulaRef>
                          <c15:sqref>'[DataAnalysis_CalibrationCurve_XanthineTest-All.xlsx]2 Xerogels'!$B$1</c15:sqref>
                        </c15:formulaRef>
                      </c:ext>
                    </c:extLst>
                    <c:strCache>
                      <c:ptCount val="1"/>
                      <c:pt idx="0">
                        <c:v>Pt / HMTES+Xox / 75.25PU (n=5)</c:v>
                      </c:pt>
                    </c:strCache>
                  </c:strRef>
                </c:tx>
                <c:spPr>
                  <a:ln w="28575" cap="rnd">
                    <a:noFill/>
                    <a:round/>
                  </a:ln>
                  <a:effectLst/>
                </c:spPr>
                <c:marker>
                  <c:symbol val="circle"/>
                  <c:size val="10"/>
                  <c:spPr>
                    <a:solidFill>
                      <a:schemeClr val="tx1"/>
                    </a:solidFill>
                    <a:ln w="9525">
                      <a:no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extLst>
                        <c:ext uri="{02D57815-91ED-43cb-92C2-25804820EDAC}">
                          <c15:formulaRef>
                            <c15:sqref>'[DataAnalysis_CalibrationCurve_XanthineTest-All.xlsx]2 Xerogels'!$C$3:$C$18</c15:sqref>
                          </c15:formulaRef>
                        </c:ext>
                      </c:extLst>
                      <c:numCache>
                        <c:formatCode>General</c:formatCode>
                        <c:ptCount val="16"/>
                        <c:pt idx="0">
                          <c:v>1.6623427851989369E-3</c:v>
                        </c:pt>
                        <c:pt idx="1">
                          <c:v>7.3167215594621476E-3</c:v>
                        </c:pt>
                        <c:pt idx="2">
                          <c:v>1.1539800519744828E-2</c:v>
                        </c:pt>
                        <c:pt idx="3">
                          <c:v>1.8894561731295955E-2</c:v>
                        </c:pt>
                        <c:pt idx="4">
                          <c:v>2.6305902520089599E-2</c:v>
                        </c:pt>
                        <c:pt idx="5">
                          <c:v>3.4007339270521755E-2</c:v>
                        </c:pt>
                        <c:pt idx="6">
                          <c:v>4.1521267577503115E-2</c:v>
                        </c:pt>
                        <c:pt idx="7">
                          <c:v>4.8488174715884166E-2</c:v>
                        </c:pt>
                        <c:pt idx="8">
                          <c:v>5.3237301691766027E-2</c:v>
                        </c:pt>
                        <c:pt idx="9">
                          <c:v>5.6964637985062294E-2</c:v>
                        </c:pt>
                        <c:pt idx="10">
                          <c:v>5.9677138883540981E-2</c:v>
                        </c:pt>
                        <c:pt idx="11">
                          <c:v>6.1357867376997707E-2</c:v>
                        </c:pt>
                        <c:pt idx="12">
                          <c:v>6.258937757248631E-2</c:v>
                        </c:pt>
                        <c:pt idx="13">
                          <c:v>6.3978420652369777E-2</c:v>
                        </c:pt>
                        <c:pt idx="14">
                          <c:v>6.5940140709621842E-2</c:v>
                        </c:pt>
                        <c:pt idx="15">
                          <c:v>6.8125466580021193E-2</c:v>
                        </c:pt>
                      </c:numCache>
                    </c:numRef>
                  </c:plus>
                  <c:minus>
                    <c:numRef>
                      <c:extLst>
                        <c:ext uri="{02D57815-91ED-43cb-92C2-25804820EDAC}">
                          <c15:formulaRef>
                            <c15:sqref>'[DataAnalysis_CalibrationCurve_XanthineTest-All.xlsx]2 Xerogels'!$C$3:$C$18</c15:sqref>
                          </c15:formulaRef>
                        </c:ext>
                      </c:extLst>
                      <c:numCache>
                        <c:formatCode>General</c:formatCode>
                        <c:ptCount val="16"/>
                        <c:pt idx="0">
                          <c:v>1.6623427851989369E-3</c:v>
                        </c:pt>
                        <c:pt idx="1">
                          <c:v>7.3167215594621476E-3</c:v>
                        </c:pt>
                        <c:pt idx="2">
                          <c:v>1.1539800519744828E-2</c:v>
                        </c:pt>
                        <c:pt idx="3">
                          <c:v>1.8894561731295955E-2</c:v>
                        </c:pt>
                        <c:pt idx="4">
                          <c:v>2.6305902520089599E-2</c:v>
                        </c:pt>
                        <c:pt idx="5">
                          <c:v>3.4007339270521755E-2</c:v>
                        </c:pt>
                        <c:pt idx="6">
                          <c:v>4.1521267577503115E-2</c:v>
                        </c:pt>
                        <c:pt idx="7">
                          <c:v>4.8488174715884166E-2</c:v>
                        </c:pt>
                        <c:pt idx="8">
                          <c:v>5.3237301691766027E-2</c:v>
                        </c:pt>
                        <c:pt idx="9">
                          <c:v>5.6964637985062294E-2</c:v>
                        </c:pt>
                        <c:pt idx="10">
                          <c:v>5.9677138883540981E-2</c:v>
                        </c:pt>
                        <c:pt idx="11">
                          <c:v>6.1357867376997707E-2</c:v>
                        </c:pt>
                        <c:pt idx="12">
                          <c:v>6.258937757248631E-2</c:v>
                        </c:pt>
                        <c:pt idx="13">
                          <c:v>6.3978420652369777E-2</c:v>
                        </c:pt>
                        <c:pt idx="14">
                          <c:v>6.5940140709621842E-2</c:v>
                        </c:pt>
                        <c:pt idx="15">
                          <c:v>6.8125466580021193E-2</c:v>
                        </c:pt>
                      </c:numCache>
                    </c:numRef>
                  </c:minus>
                  <c:spPr>
                    <a:noFill/>
                    <a:ln w="9525" cap="flat" cmpd="sng" algn="ctr">
                      <a:solidFill>
                        <a:schemeClr val="tx1">
                          <a:lumMod val="65000"/>
                          <a:lumOff val="35000"/>
                        </a:schemeClr>
                      </a:solidFill>
                      <a:round/>
                    </a:ln>
                    <a:effectLst/>
                  </c:spPr>
                </c:errBars>
                <c:xVal>
                  <c:numRef>
                    <c:extLst>
                      <c:ext uri="{02D57815-91ED-43cb-92C2-25804820EDAC}">
                        <c15:formulaRef>
                          <c15:sqref>'[DataAnalysis_CalibrationCurve_XanthineTest-All.xlsx]2 Xerogels'!$A$3:$A$18</c15:sqref>
                        </c15:formulaRef>
                      </c:ext>
                    </c:extLst>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extLst>
                      <c:ext uri="{02D57815-91ED-43cb-92C2-25804820EDAC}">
                        <c15:formulaRef>
                          <c15:sqref>'[DataAnalysis_CalibrationCurve_XanthineTest-All.xlsx]2 Xerogels'!$B$3:$B$18</c15:sqref>
                        </c15:formulaRef>
                      </c:ext>
                    </c:extLst>
                    <c:numCache>
                      <c:formatCode>General</c:formatCode>
                      <c:ptCount val="16"/>
                      <c:pt idx="0">
                        <c:v>2.2816230769230766E-2</c:v>
                      </c:pt>
                      <c:pt idx="1">
                        <c:v>7.568046153846153E-2</c:v>
                      </c:pt>
                      <c:pt idx="2">
                        <c:v>0.10476584615384617</c:v>
                      </c:pt>
                      <c:pt idx="3">
                        <c:v>0.15662230769230767</c:v>
                      </c:pt>
                      <c:pt idx="4">
                        <c:v>0.20329076923076922</c:v>
                      </c:pt>
                      <c:pt idx="5">
                        <c:v>0.24429846153846152</c:v>
                      </c:pt>
                      <c:pt idx="6">
                        <c:v>0.27680076923076924</c:v>
                      </c:pt>
                      <c:pt idx="7">
                        <c:v>0.30225307692307696</c:v>
                      </c:pt>
                      <c:pt idx="8">
                        <c:v>0.31813153846153847</c:v>
                      </c:pt>
                      <c:pt idx="9">
                        <c:v>0.33138538461538464</c:v>
                      </c:pt>
                      <c:pt idx="10">
                        <c:v>0.34406461538461536</c:v>
                      </c:pt>
                      <c:pt idx="11">
                        <c:v>0.35308615384615383</c:v>
                      </c:pt>
                      <c:pt idx="12">
                        <c:v>0.36135384615384614</c:v>
                      </c:pt>
                      <c:pt idx="13">
                        <c:v>0.36958000000000002</c:v>
                      </c:pt>
                      <c:pt idx="14">
                        <c:v>0.37834384615384614</c:v>
                      </c:pt>
                      <c:pt idx="15">
                        <c:v>0.38859692307692312</c:v>
                      </c:pt>
                    </c:numCache>
                  </c:numRef>
                </c:yVal>
                <c:smooth val="0"/>
                <c:extLst>
                  <c:ext xmlns:c16="http://schemas.microsoft.com/office/drawing/2014/chart" uri="{C3380CC4-5D6E-409C-BE32-E72D297353CC}">
                    <c16:uniqueId val="{00000004-784F-4BE8-AD15-4AF885452C59}"/>
                  </c:ext>
                </c:extLst>
              </c15:ser>
            </c15:filteredScatterSeries>
            <c15:filteredScatterSeries>
              <c15:ser>
                <c:idx val="2"/>
                <c:order val="2"/>
                <c:tx>
                  <c:strRef>
                    <c:extLst xmlns:c15="http://schemas.microsoft.com/office/drawing/2012/chart">
                      <c:ext xmlns:c15="http://schemas.microsoft.com/office/drawing/2012/chart" uri="{02D57815-91ED-43cb-92C2-25804820EDAC}">
                        <c15:formulaRef>
                          <c15:sqref>'[DataAnalysis_CalibrationCurve_XanthineTest-All.xlsx]2 Xerogels'!$F$1</c15:sqref>
                        </c15:formulaRef>
                      </c:ext>
                    </c:extLst>
                    <c:strCache>
                      <c:ptCount val="1"/>
                      <c:pt idx="0">
                        <c:v>Pt / HMTES-C3MPC+Xox / 75.25PU (n=5)</c:v>
                      </c:pt>
                    </c:strCache>
                  </c:strRef>
                </c:tx>
                <c:spPr>
                  <a:ln w="25400" cap="rnd">
                    <a:noFill/>
                    <a:round/>
                  </a:ln>
                  <a:effectLst/>
                </c:spPr>
                <c:marker>
                  <c:symbol val="x"/>
                  <c:size val="10"/>
                  <c:spPr>
                    <a:solidFill>
                      <a:srgbClr val="FF0000"/>
                    </a:solidFill>
                    <a:ln w="9525">
                      <a:no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extLst xmlns:c15="http://schemas.microsoft.com/office/drawing/2012/chart">
                        <c:ext xmlns:c15="http://schemas.microsoft.com/office/drawing/2012/chart" uri="{02D57815-91ED-43cb-92C2-25804820EDAC}">
                          <c15:formulaRef>
                            <c15:sqref>'[DataAnalysis_CalibrationCurve_XanthineTest-All.xlsx]2 Xerogels'!$G$3:$G$18</c15:sqref>
                          </c15:formulaRef>
                        </c:ext>
                      </c:extLst>
                      <c:numCache>
                        <c:formatCode>General</c:formatCode>
                        <c:ptCount val="16"/>
                        <c:pt idx="0">
                          <c:v>3.7297641389965105E-3</c:v>
                        </c:pt>
                        <c:pt idx="1">
                          <c:v>1.108509380673621E-2</c:v>
                        </c:pt>
                        <c:pt idx="2">
                          <c:v>1.6626072194815565E-2</c:v>
                        </c:pt>
                        <c:pt idx="3">
                          <c:v>2.2377721215636217E-2</c:v>
                        </c:pt>
                        <c:pt idx="4">
                          <c:v>2.985136792778122E-2</c:v>
                        </c:pt>
                        <c:pt idx="5">
                          <c:v>3.9837560273941128E-2</c:v>
                        </c:pt>
                        <c:pt idx="6">
                          <c:v>4.9987071775355905E-2</c:v>
                        </c:pt>
                        <c:pt idx="7">
                          <c:v>5.8431951457943138E-2</c:v>
                        </c:pt>
                        <c:pt idx="8">
                          <c:v>6.4357597458199897E-2</c:v>
                        </c:pt>
                        <c:pt idx="9">
                          <c:v>6.9294626820649116E-2</c:v>
                        </c:pt>
                        <c:pt idx="10">
                          <c:v>7.3896145268227437E-2</c:v>
                        </c:pt>
                        <c:pt idx="11">
                          <c:v>7.8446609316870614E-2</c:v>
                        </c:pt>
                        <c:pt idx="12">
                          <c:v>8.3311002251527114E-2</c:v>
                        </c:pt>
                        <c:pt idx="13">
                          <c:v>8.8318578781523438E-2</c:v>
                        </c:pt>
                        <c:pt idx="14">
                          <c:v>9.2609184417429935E-2</c:v>
                        </c:pt>
                        <c:pt idx="15">
                          <c:v>9.7640621548263806E-2</c:v>
                        </c:pt>
                      </c:numCache>
                    </c:numRef>
                  </c:plus>
                  <c:minus>
                    <c:numRef>
                      <c:extLst xmlns:c15="http://schemas.microsoft.com/office/drawing/2012/chart">
                        <c:ext xmlns:c15="http://schemas.microsoft.com/office/drawing/2012/chart" uri="{02D57815-91ED-43cb-92C2-25804820EDAC}">
                          <c15:formulaRef>
                            <c15:sqref>'[DataAnalysis_CalibrationCurve_XanthineTest-All.xlsx]2 Xerogels'!$G$3:$G$18</c15:sqref>
                          </c15:formulaRef>
                        </c:ext>
                      </c:extLst>
                      <c:numCache>
                        <c:formatCode>General</c:formatCode>
                        <c:ptCount val="16"/>
                        <c:pt idx="0">
                          <c:v>3.7297641389965105E-3</c:v>
                        </c:pt>
                        <c:pt idx="1">
                          <c:v>1.108509380673621E-2</c:v>
                        </c:pt>
                        <c:pt idx="2">
                          <c:v>1.6626072194815565E-2</c:v>
                        </c:pt>
                        <c:pt idx="3">
                          <c:v>2.2377721215636217E-2</c:v>
                        </c:pt>
                        <c:pt idx="4">
                          <c:v>2.985136792778122E-2</c:v>
                        </c:pt>
                        <c:pt idx="5">
                          <c:v>3.9837560273941128E-2</c:v>
                        </c:pt>
                        <c:pt idx="6">
                          <c:v>4.9987071775355905E-2</c:v>
                        </c:pt>
                        <c:pt idx="7">
                          <c:v>5.8431951457943138E-2</c:v>
                        </c:pt>
                        <c:pt idx="8">
                          <c:v>6.4357597458199897E-2</c:v>
                        </c:pt>
                        <c:pt idx="9">
                          <c:v>6.9294626820649116E-2</c:v>
                        </c:pt>
                        <c:pt idx="10">
                          <c:v>7.3896145268227437E-2</c:v>
                        </c:pt>
                        <c:pt idx="11">
                          <c:v>7.8446609316870614E-2</c:v>
                        </c:pt>
                        <c:pt idx="12">
                          <c:v>8.3311002251527114E-2</c:v>
                        </c:pt>
                        <c:pt idx="13">
                          <c:v>8.8318578781523438E-2</c:v>
                        </c:pt>
                        <c:pt idx="14">
                          <c:v>9.2609184417429935E-2</c:v>
                        </c:pt>
                        <c:pt idx="15">
                          <c:v>9.7640621548263806E-2</c:v>
                        </c:pt>
                      </c:numCache>
                    </c:numRef>
                  </c:minus>
                  <c:spPr>
                    <a:noFill/>
                    <a:ln w="9525" cap="flat" cmpd="sng" algn="ctr">
                      <a:solidFill>
                        <a:schemeClr val="tx1">
                          <a:lumMod val="65000"/>
                          <a:lumOff val="35000"/>
                        </a:schemeClr>
                      </a:solidFill>
                      <a:round/>
                    </a:ln>
                    <a:effectLst/>
                  </c:spPr>
                </c:errBars>
                <c:xVal>
                  <c:numRef>
                    <c:extLst xmlns:c15="http://schemas.microsoft.com/office/drawing/2012/chart">
                      <c:ext xmlns:c15="http://schemas.microsoft.com/office/drawing/2012/chart" uri="{02D57815-91ED-43cb-92C2-25804820EDAC}">
                        <c15:formulaRef>
                          <c15:sqref>'[DataAnalysis_CalibrationCurve_XanthineTest-All.xlsx]2 Xerogels'!$A$3:$A$18</c15:sqref>
                        </c15:formulaRef>
                      </c:ext>
                    </c:extLst>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extLst xmlns:c15="http://schemas.microsoft.com/office/drawing/2012/chart">
                      <c:ext xmlns:c15="http://schemas.microsoft.com/office/drawing/2012/chart" uri="{02D57815-91ED-43cb-92C2-25804820EDAC}">
                        <c15:formulaRef>
                          <c15:sqref>'[DataAnalysis_CalibrationCurve_XanthineTest-All.xlsx]2 Xerogels'!$F$3:$F$18</c15:sqref>
                        </c15:formulaRef>
                      </c:ext>
                    </c:extLst>
                    <c:numCache>
                      <c:formatCode>General</c:formatCode>
                      <c:ptCount val="16"/>
                      <c:pt idx="0">
                        <c:v>1.6313461538461541E-2</c:v>
                      </c:pt>
                      <c:pt idx="1">
                        <c:v>9.1311769230769252E-2</c:v>
                      </c:pt>
                      <c:pt idx="2">
                        <c:v>0.15867538461538461</c:v>
                      </c:pt>
                      <c:pt idx="3">
                        <c:v>0.21985307692307696</c:v>
                      </c:pt>
                      <c:pt idx="4">
                        <c:v>0.27457999999999999</c:v>
                      </c:pt>
                      <c:pt idx="5">
                        <c:v>0.3215623076923077</c:v>
                      </c:pt>
                      <c:pt idx="6">
                        <c:v>0.36235384615384614</c:v>
                      </c:pt>
                      <c:pt idx="7">
                        <c:v>0.39691923076923075</c:v>
                      </c:pt>
                      <c:pt idx="8">
                        <c:v>0.42796615384615383</c:v>
                      </c:pt>
                      <c:pt idx="9">
                        <c:v>0.45706461538461535</c:v>
                      </c:pt>
                      <c:pt idx="10">
                        <c:v>0.48600538461538462</c:v>
                      </c:pt>
                      <c:pt idx="11">
                        <c:v>0.51259153846153838</c:v>
                      </c:pt>
                      <c:pt idx="12">
                        <c:v>0.54048999999999991</c:v>
                      </c:pt>
                      <c:pt idx="13">
                        <c:v>0.56781692307692311</c:v>
                      </c:pt>
                      <c:pt idx="14">
                        <c:v>0.59611999999999998</c:v>
                      </c:pt>
                      <c:pt idx="15">
                        <c:v>0.62543846153846161</c:v>
                      </c:pt>
                    </c:numCache>
                  </c:numRef>
                </c:yVal>
                <c:smooth val="0"/>
                <c:extLst xmlns:c15="http://schemas.microsoft.com/office/drawing/2012/chart">
                  <c:ext xmlns:c16="http://schemas.microsoft.com/office/drawing/2014/chart" uri="{C3380CC4-5D6E-409C-BE32-E72D297353CC}">
                    <c16:uniqueId val="{00000005-784F-4BE8-AD15-4AF885452C59}"/>
                  </c:ext>
                </c:extLst>
              </c15:ser>
            </c15:filteredScatterSeries>
            <c15:filteredScatterSeries>
              <c15:ser>
                <c:idx val="4"/>
                <c:order val="4"/>
                <c:tx>
                  <c:strRef>
                    <c:extLst xmlns:c15="http://schemas.microsoft.com/office/drawing/2012/chart">
                      <c:ext xmlns:c15="http://schemas.microsoft.com/office/drawing/2012/chart" uri="{02D57815-91ED-43cb-92C2-25804820EDAC}">
                        <c15:formulaRef>
                          <c15:sqref>'[DataAnalysis_CalibrationCurve_XanthineTest-All.xlsx]2 Xerogels'!$J$1</c15:sqref>
                        </c15:formulaRef>
                      </c:ext>
                    </c:extLst>
                    <c:strCache>
                      <c:ptCount val="1"/>
                      <c:pt idx="0">
                        <c:v>Pt / HMTES-C4MPC+Xox / 75.25PU (n=5)</c:v>
                      </c:pt>
                    </c:strCache>
                  </c:strRef>
                </c:tx>
                <c:spPr>
                  <a:ln w="25400" cap="rnd">
                    <a:noFill/>
                    <a:round/>
                  </a:ln>
                  <a:effectLst/>
                </c:spPr>
                <c:marker>
                  <c:symbol val="diamond"/>
                  <c:size val="10"/>
                  <c:spPr>
                    <a:solidFill>
                      <a:srgbClr val="00B050"/>
                    </a:solidFill>
                    <a:ln w="19050">
                      <a:no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extLst xmlns:c15="http://schemas.microsoft.com/office/drawing/2012/chart">
                        <c:ext xmlns:c15="http://schemas.microsoft.com/office/drawing/2012/chart" uri="{02D57815-91ED-43cb-92C2-25804820EDAC}">
                          <c15:formulaRef>
                            <c15:sqref>'[DataAnalysis_CalibrationCurve_XanthineTest-All.xlsx]2 Xerogels'!$K$3:$K$18</c15:sqref>
                          </c15:formulaRef>
                        </c:ext>
                      </c:extLst>
                      <c:numCache>
                        <c:formatCode>General</c:formatCode>
                        <c:ptCount val="16"/>
                        <c:pt idx="0">
                          <c:v>3.2771142233886368E-3</c:v>
                        </c:pt>
                        <c:pt idx="1">
                          <c:v>1.0726487152242292E-2</c:v>
                        </c:pt>
                        <c:pt idx="2">
                          <c:v>2.0528018448455226E-2</c:v>
                        </c:pt>
                        <c:pt idx="3">
                          <c:v>2.9892500271560204E-2</c:v>
                        </c:pt>
                        <c:pt idx="4">
                          <c:v>4.0158288013233089E-2</c:v>
                        </c:pt>
                        <c:pt idx="5">
                          <c:v>4.9965773166895419E-2</c:v>
                        </c:pt>
                        <c:pt idx="6">
                          <c:v>5.951764751218401E-2</c:v>
                        </c:pt>
                        <c:pt idx="7">
                          <c:v>6.982694191047005E-2</c:v>
                        </c:pt>
                        <c:pt idx="8">
                          <c:v>7.9907370254601318E-2</c:v>
                        </c:pt>
                        <c:pt idx="9">
                          <c:v>9.0430087677699875E-2</c:v>
                        </c:pt>
                        <c:pt idx="10">
                          <c:v>0.10008840638752935</c:v>
                        </c:pt>
                        <c:pt idx="11">
                          <c:v>0.10952851245196711</c:v>
                        </c:pt>
                        <c:pt idx="12">
                          <c:v>0.11863558591570285</c:v>
                        </c:pt>
                        <c:pt idx="13">
                          <c:v>0.12717422576223977</c:v>
                        </c:pt>
                        <c:pt idx="14">
                          <c:v>0.13495972527115743</c:v>
                        </c:pt>
                        <c:pt idx="15">
                          <c:v>0.14274306318962793</c:v>
                        </c:pt>
                      </c:numCache>
                    </c:numRef>
                  </c:plus>
                  <c:minus>
                    <c:numRef>
                      <c:extLst xmlns:c15="http://schemas.microsoft.com/office/drawing/2012/chart">
                        <c:ext xmlns:c15="http://schemas.microsoft.com/office/drawing/2012/chart" uri="{02D57815-91ED-43cb-92C2-25804820EDAC}">
                          <c15:formulaRef>
                            <c15:sqref>'[DataAnalysis_CalibrationCurve_XanthineTest-All.xlsx]2 Xerogels'!$K$3:$K$18</c15:sqref>
                          </c15:formulaRef>
                        </c:ext>
                      </c:extLst>
                      <c:numCache>
                        <c:formatCode>General</c:formatCode>
                        <c:ptCount val="16"/>
                        <c:pt idx="0">
                          <c:v>3.2771142233886368E-3</c:v>
                        </c:pt>
                        <c:pt idx="1">
                          <c:v>1.0726487152242292E-2</c:v>
                        </c:pt>
                        <c:pt idx="2">
                          <c:v>2.0528018448455226E-2</c:v>
                        </c:pt>
                        <c:pt idx="3">
                          <c:v>2.9892500271560204E-2</c:v>
                        </c:pt>
                        <c:pt idx="4">
                          <c:v>4.0158288013233089E-2</c:v>
                        </c:pt>
                        <c:pt idx="5">
                          <c:v>4.9965773166895419E-2</c:v>
                        </c:pt>
                        <c:pt idx="6">
                          <c:v>5.951764751218401E-2</c:v>
                        </c:pt>
                        <c:pt idx="7">
                          <c:v>6.982694191047005E-2</c:v>
                        </c:pt>
                        <c:pt idx="8">
                          <c:v>7.9907370254601318E-2</c:v>
                        </c:pt>
                        <c:pt idx="9">
                          <c:v>9.0430087677699875E-2</c:v>
                        </c:pt>
                        <c:pt idx="10">
                          <c:v>0.10008840638752935</c:v>
                        </c:pt>
                        <c:pt idx="11">
                          <c:v>0.10952851245196711</c:v>
                        </c:pt>
                        <c:pt idx="12">
                          <c:v>0.11863558591570285</c:v>
                        </c:pt>
                        <c:pt idx="13">
                          <c:v>0.12717422576223977</c:v>
                        </c:pt>
                        <c:pt idx="14">
                          <c:v>0.13495972527115743</c:v>
                        </c:pt>
                        <c:pt idx="15">
                          <c:v>0.14274306318962793</c:v>
                        </c:pt>
                      </c:numCache>
                    </c:numRef>
                  </c:minus>
                  <c:spPr>
                    <a:noFill/>
                    <a:ln w="9525" cap="flat" cmpd="sng" algn="ctr">
                      <a:solidFill>
                        <a:schemeClr val="tx1">
                          <a:lumMod val="65000"/>
                          <a:lumOff val="35000"/>
                        </a:schemeClr>
                      </a:solidFill>
                      <a:round/>
                    </a:ln>
                    <a:effectLst/>
                  </c:spPr>
                </c:errBars>
                <c:xVal>
                  <c:numRef>
                    <c:extLst xmlns:c15="http://schemas.microsoft.com/office/drawing/2012/chart">
                      <c:ext xmlns:c15="http://schemas.microsoft.com/office/drawing/2012/chart" uri="{02D57815-91ED-43cb-92C2-25804820EDAC}">
                        <c15:formulaRef>
                          <c15:sqref>'[DataAnalysis_CalibrationCurve_XanthineTest-All.xlsx]2 Xerogels'!$A$3:$A$18</c15:sqref>
                        </c15:formulaRef>
                      </c:ext>
                    </c:extLst>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extLst xmlns:c15="http://schemas.microsoft.com/office/drawing/2012/chart">
                      <c:ext xmlns:c15="http://schemas.microsoft.com/office/drawing/2012/chart" uri="{02D57815-91ED-43cb-92C2-25804820EDAC}">
                        <c15:formulaRef>
                          <c15:sqref>'[DataAnalysis_CalibrationCurve_XanthineTest-All.xlsx]2 Xerogels'!$J$3:$J$18</c15:sqref>
                        </c15:formulaRef>
                      </c:ext>
                    </c:extLst>
                    <c:numCache>
                      <c:formatCode>General</c:formatCode>
                      <c:ptCount val="16"/>
                      <c:pt idx="0">
                        <c:v>3.3920923076923085E-2</c:v>
                      </c:pt>
                      <c:pt idx="1">
                        <c:v>0.11874076923076923</c:v>
                      </c:pt>
                      <c:pt idx="2">
                        <c:v>0.19435769230769234</c:v>
                      </c:pt>
                      <c:pt idx="3">
                        <c:v>0.26480999999999999</c:v>
                      </c:pt>
                      <c:pt idx="4">
                        <c:v>0.34084000000000003</c:v>
                      </c:pt>
                      <c:pt idx="5">
                        <c:v>0.41537923076923083</c:v>
                      </c:pt>
                      <c:pt idx="6">
                        <c:v>0.48980692307692308</c:v>
                      </c:pt>
                      <c:pt idx="7">
                        <c:v>0.5649861538461538</c:v>
                      </c:pt>
                      <c:pt idx="8">
                        <c:v>0.64148538461538451</c:v>
                      </c:pt>
                      <c:pt idx="9">
                        <c:v>0.72003538461538452</c:v>
                      </c:pt>
                      <c:pt idx="10">
                        <c:v>0.79566615384615391</c:v>
                      </c:pt>
                      <c:pt idx="11">
                        <c:v>0.86993384615384617</c:v>
                      </c:pt>
                      <c:pt idx="12">
                        <c:v>0.94237153846153843</c:v>
                      </c:pt>
                      <c:pt idx="13">
                        <c:v>1.0119038461538459</c:v>
                      </c:pt>
                      <c:pt idx="14">
                        <c:v>1.077686153846154</c:v>
                      </c:pt>
                      <c:pt idx="15">
                        <c:v>1.1417992307692306</c:v>
                      </c:pt>
                    </c:numCache>
                  </c:numRef>
                </c:yVal>
                <c:smooth val="0"/>
                <c:extLst xmlns:c15="http://schemas.microsoft.com/office/drawing/2012/chart">
                  <c:ext xmlns:c16="http://schemas.microsoft.com/office/drawing/2014/chart" uri="{C3380CC4-5D6E-409C-BE32-E72D297353CC}">
                    <c16:uniqueId val="{00000006-784F-4BE8-AD15-4AF885452C59}"/>
                  </c:ext>
                </c:extLst>
              </c15:ser>
            </c15:filteredScatterSeries>
            <c15:filteredScatterSeries>
              <c15:ser>
                <c:idx val="6"/>
                <c:order val="6"/>
                <c:tx>
                  <c:strRef>
                    <c:extLst xmlns:c15="http://schemas.microsoft.com/office/drawing/2012/chart">
                      <c:ext xmlns:c15="http://schemas.microsoft.com/office/drawing/2012/chart" uri="{02D57815-91ED-43cb-92C2-25804820EDAC}">
                        <c15:formulaRef>
                          <c15:sqref>'[DataAnalysis_CalibrationCurve_XanthineTest-All.xlsx]2 Xerogels'!$N$1</c15:sqref>
                        </c15:formulaRef>
                      </c:ext>
                    </c:extLst>
                    <c:strCache>
                      <c:ptCount val="1"/>
                      <c:pt idx="0">
                        <c:v>Pt / HMTES-C6MPC+Xox / 75.25PU (n=6)</c:v>
                      </c:pt>
                    </c:strCache>
                  </c:strRef>
                </c:tx>
                <c:spPr>
                  <a:ln w="25400" cap="rnd">
                    <a:noFill/>
                    <a:round/>
                  </a:ln>
                  <a:effectLst/>
                </c:spPr>
                <c:marker>
                  <c:symbol val="triangle"/>
                  <c:size val="10"/>
                  <c:spPr>
                    <a:solidFill>
                      <a:srgbClr val="7030A0"/>
                    </a:solidFill>
                    <a:ln w="9525">
                      <a:no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extLst xmlns:c15="http://schemas.microsoft.com/office/drawing/2012/chart">
                        <c:ext xmlns:c15="http://schemas.microsoft.com/office/drawing/2012/chart" uri="{02D57815-91ED-43cb-92C2-25804820EDAC}">
                          <c15:formulaRef>
                            <c15:sqref>'[DataAnalysis_CalibrationCurve_XanthineTest-All.xlsx]2 Xerogels'!$O$3:$O$18</c15:sqref>
                          </c15:formulaRef>
                        </c:ext>
                      </c:extLst>
                      <c:numCache>
                        <c:formatCode>General</c:formatCode>
                        <c:ptCount val="16"/>
                        <c:pt idx="0">
                          <c:v>7.1305484677314131E-3</c:v>
                        </c:pt>
                        <c:pt idx="1">
                          <c:v>1.5503423725100225E-2</c:v>
                        </c:pt>
                        <c:pt idx="2">
                          <c:v>3.1284070102316548E-2</c:v>
                        </c:pt>
                        <c:pt idx="3">
                          <c:v>4.5576819396121286E-2</c:v>
                        </c:pt>
                        <c:pt idx="4">
                          <c:v>5.9812599701623545E-2</c:v>
                        </c:pt>
                        <c:pt idx="5">
                          <c:v>7.3276868499547607E-2</c:v>
                        </c:pt>
                        <c:pt idx="6">
                          <c:v>8.8726397807340762E-2</c:v>
                        </c:pt>
                        <c:pt idx="7">
                          <c:v>0.10251059962511179</c:v>
                        </c:pt>
                        <c:pt idx="8">
                          <c:v>0.11676341694454966</c:v>
                        </c:pt>
                        <c:pt idx="9">
                          <c:v>0.13131587064885616</c:v>
                        </c:pt>
                        <c:pt idx="10">
                          <c:v>0.14417792710594304</c:v>
                        </c:pt>
                        <c:pt idx="11">
                          <c:v>0.15646922740356731</c:v>
                        </c:pt>
                        <c:pt idx="12">
                          <c:v>0.16334005077343047</c:v>
                        </c:pt>
                        <c:pt idx="13">
                          <c:v>0.17050637869788696</c:v>
                        </c:pt>
                        <c:pt idx="14">
                          <c:v>0.17619971290177106</c:v>
                        </c:pt>
                        <c:pt idx="15">
                          <c:v>0.1830337532442235</c:v>
                        </c:pt>
                      </c:numCache>
                    </c:numRef>
                  </c:plus>
                  <c:minus>
                    <c:numRef>
                      <c:extLst xmlns:c15="http://schemas.microsoft.com/office/drawing/2012/chart">
                        <c:ext xmlns:c15="http://schemas.microsoft.com/office/drawing/2012/chart" uri="{02D57815-91ED-43cb-92C2-25804820EDAC}">
                          <c15:formulaRef>
                            <c15:sqref>'[DataAnalysis_CalibrationCurve_XanthineTest-All.xlsx]2 Xerogels'!$O$3:$O$18</c15:sqref>
                          </c15:formulaRef>
                        </c:ext>
                      </c:extLst>
                      <c:numCache>
                        <c:formatCode>General</c:formatCode>
                        <c:ptCount val="16"/>
                        <c:pt idx="0">
                          <c:v>7.1305484677314131E-3</c:v>
                        </c:pt>
                        <c:pt idx="1">
                          <c:v>1.5503423725100225E-2</c:v>
                        </c:pt>
                        <c:pt idx="2">
                          <c:v>3.1284070102316548E-2</c:v>
                        </c:pt>
                        <c:pt idx="3">
                          <c:v>4.5576819396121286E-2</c:v>
                        </c:pt>
                        <c:pt idx="4">
                          <c:v>5.9812599701623545E-2</c:v>
                        </c:pt>
                        <c:pt idx="5">
                          <c:v>7.3276868499547607E-2</c:v>
                        </c:pt>
                        <c:pt idx="6">
                          <c:v>8.8726397807340762E-2</c:v>
                        </c:pt>
                        <c:pt idx="7">
                          <c:v>0.10251059962511179</c:v>
                        </c:pt>
                        <c:pt idx="8">
                          <c:v>0.11676341694454966</c:v>
                        </c:pt>
                        <c:pt idx="9">
                          <c:v>0.13131587064885616</c:v>
                        </c:pt>
                        <c:pt idx="10">
                          <c:v>0.14417792710594304</c:v>
                        </c:pt>
                        <c:pt idx="11">
                          <c:v>0.15646922740356731</c:v>
                        </c:pt>
                        <c:pt idx="12">
                          <c:v>0.16334005077343047</c:v>
                        </c:pt>
                        <c:pt idx="13">
                          <c:v>0.17050637869788696</c:v>
                        </c:pt>
                        <c:pt idx="14">
                          <c:v>0.17619971290177106</c:v>
                        </c:pt>
                        <c:pt idx="15">
                          <c:v>0.1830337532442235</c:v>
                        </c:pt>
                      </c:numCache>
                    </c:numRef>
                  </c:minus>
                  <c:spPr>
                    <a:noFill/>
                    <a:ln w="9525" cap="flat" cmpd="sng" algn="ctr">
                      <a:solidFill>
                        <a:schemeClr val="tx1">
                          <a:lumMod val="65000"/>
                          <a:lumOff val="35000"/>
                        </a:schemeClr>
                      </a:solidFill>
                      <a:round/>
                    </a:ln>
                    <a:effectLst/>
                  </c:spPr>
                </c:errBars>
                <c:xVal>
                  <c:numRef>
                    <c:extLst xmlns:c15="http://schemas.microsoft.com/office/drawing/2012/chart">
                      <c:ext xmlns:c15="http://schemas.microsoft.com/office/drawing/2012/chart" uri="{02D57815-91ED-43cb-92C2-25804820EDAC}">
                        <c15:formulaRef>
                          <c15:sqref>'[DataAnalysis_CalibrationCurve_XanthineTest-All.xlsx]2 Xerogels'!$A$3:$A$18</c15:sqref>
                        </c15:formulaRef>
                      </c:ext>
                    </c:extLst>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extLst xmlns:c15="http://schemas.microsoft.com/office/drawing/2012/chart">
                      <c:ext xmlns:c15="http://schemas.microsoft.com/office/drawing/2012/chart" uri="{02D57815-91ED-43cb-92C2-25804820EDAC}">
                        <c15:formulaRef>
                          <c15:sqref>'[DataAnalysis_CalibrationCurve_XanthineTest-All.xlsx]2 Xerogels'!$N$3:$N$18</c15:sqref>
                        </c15:formulaRef>
                      </c:ext>
                    </c:extLst>
                    <c:numCache>
                      <c:formatCode>General</c:formatCode>
                      <c:ptCount val="16"/>
                      <c:pt idx="0">
                        <c:v>4.7006733333333328E-2</c:v>
                      </c:pt>
                      <c:pt idx="1">
                        <c:v>0.15081799999999998</c:v>
                      </c:pt>
                      <c:pt idx="2">
                        <c:v>0.23995716666666669</c:v>
                      </c:pt>
                      <c:pt idx="3">
                        <c:v>0.32449033333333333</c:v>
                      </c:pt>
                      <c:pt idx="4">
                        <c:v>0.41524066666666665</c:v>
                      </c:pt>
                      <c:pt idx="5">
                        <c:v>0.50321450000000001</c:v>
                      </c:pt>
                      <c:pt idx="6">
                        <c:v>0.59559966666666664</c:v>
                      </c:pt>
                      <c:pt idx="7">
                        <c:v>0.68941750000000013</c:v>
                      </c:pt>
                      <c:pt idx="8">
                        <c:v>0.78668883333333317</c:v>
                      </c:pt>
                      <c:pt idx="9">
                        <c:v>0.88420166666666666</c:v>
                      </c:pt>
                      <c:pt idx="10">
                        <c:v>0.98353016666666659</c:v>
                      </c:pt>
                      <c:pt idx="11">
                        <c:v>1.0863488448844882</c:v>
                      </c:pt>
                      <c:pt idx="12">
                        <c:v>1.1837766666666665</c:v>
                      </c:pt>
                      <c:pt idx="13">
                        <c:v>1.2747916666666701</c:v>
                      </c:pt>
                      <c:pt idx="14">
                        <c:v>1.3587066666666667</c:v>
                      </c:pt>
                      <c:pt idx="15">
                        <c:v>1.4327866666666662</c:v>
                      </c:pt>
                    </c:numCache>
                  </c:numRef>
                </c:yVal>
                <c:smooth val="0"/>
                <c:extLst xmlns:c15="http://schemas.microsoft.com/office/drawing/2012/chart">
                  <c:ext xmlns:c16="http://schemas.microsoft.com/office/drawing/2014/chart" uri="{C3380CC4-5D6E-409C-BE32-E72D297353CC}">
                    <c16:uniqueId val="{00000007-784F-4BE8-AD15-4AF885452C59}"/>
                  </c:ext>
                </c:extLst>
              </c15:ser>
            </c15:filteredScatterSeries>
          </c:ext>
        </c:extLst>
      </c:scatterChart>
      <c:valAx>
        <c:axId val="975122127"/>
        <c:scaling>
          <c:orientation val="minMax"/>
          <c:max val="620"/>
          <c:min val="0"/>
        </c:scaling>
        <c:delete val="0"/>
        <c:axPos val="b"/>
        <c:title>
          <c:tx>
            <c:rich>
              <a:bodyPr rot="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r>
                  <a:rPr lang="en-US" sz="1600" b="1" dirty="0">
                    <a:solidFill>
                      <a:schemeClr val="tx1"/>
                    </a:solidFill>
                  </a:rPr>
                  <a:t>Xanthine Concentration (</a:t>
                </a:r>
                <a:r>
                  <a:rPr lang="el-GR" sz="1600" b="1" dirty="0">
                    <a:solidFill>
                      <a:schemeClr val="tx1"/>
                    </a:solidFill>
                  </a:rPr>
                  <a:t>μ</a:t>
                </a:r>
                <a:r>
                  <a:rPr lang="en-US" sz="1600" b="1" dirty="0">
                    <a:solidFill>
                      <a:schemeClr val="tx1"/>
                    </a:solidFill>
                  </a:rPr>
                  <a:t>M)</a:t>
                </a:r>
              </a:p>
            </c:rich>
          </c:tx>
          <c:layout>
            <c:manualLayout>
              <c:xMode val="edge"/>
              <c:yMode val="edge"/>
              <c:x val="0.34409011373578302"/>
              <c:y val="0.94301204601598099"/>
            </c:manualLayout>
          </c:layout>
          <c:overlay val="0"/>
          <c:spPr>
            <a:noFill/>
            <a:ln>
              <a:noFill/>
            </a:ln>
            <a:effectLst/>
          </c:spPr>
          <c:txPr>
            <a:bodyPr rot="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98867487"/>
        <c:crosses val="autoZero"/>
        <c:crossBetween val="midCat"/>
        <c:majorUnit val="50"/>
      </c:valAx>
      <c:valAx>
        <c:axId val="298867487"/>
        <c:scaling>
          <c:orientation val="minMax"/>
          <c:max val="0.82000000000000006"/>
          <c:min val="0"/>
        </c:scaling>
        <c:delete val="0"/>
        <c:axPos val="l"/>
        <c:title>
          <c:tx>
            <c:rich>
              <a:bodyPr rot="-54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r>
                  <a:rPr lang="en-US" sz="1600" b="1" dirty="0"/>
                  <a:t>Current (</a:t>
                </a:r>
                <a:r>
                  <a:rPr lang="el-GR" sz="1600" b="1" dirty="0"/>
                  <a:t>μ</a:t>
                </a:r>
                <a:r>
                  <a:rPr lang="en-US" sz="1600" b="1" dirty="0"/>
                  <a:t>A)</a:t>
                </a:r>
              </a:p>
            </c:rich>
          </c:tx>
          <c:layout>
            <c:manualLayout>
              <c:xMode val="edge"/>
              <c:yMode val="edge"/>
              <c:x val="2.1901428988043165E-3"/>
              <c:y val="0.27324735068535017"/>
            </c:manualLayout>
          </c:layout>
          <c:overlay val="0"/>
          <c:spPr>
            <a:noFill/>
            <a:ln>
              <a:noFill/>
            </a:ln>
            <a:effectLst/>
          </c:spPr>
          <c:txPr>
            <a:bodyPr rot="-54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75122127"/>
        <c:crosses val="autoZero"/>
        <c:crossBetween val="midCat"/>
        <c:majorUnit val="0.2"/>
      </c:valAx>
      <c:spPr>
        <a:noFill/>
        <a:ln>
          <a:noFill/>
        </a:ln>
        <a:effectLst/>
      </c:spPr>
    </c:plotArea>
    <c:legend>
      <c:legendPos val="b"/>
      <c:layout>
        <c:manualLayout>
          <c:xMode val="edge"/>
          <c:yMode val="edge"/>
          <c:x val="0.11268241469816273"/>
          <c:y val="2.6674101458094856E-4"/>
          <c:w val="0.59888641003207932"/>
          <c:h val="0.23596044190541549"/>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1043365412656751"/>
          <c:y val="1.641966733402209E-2"/>
          <c:w val="0.85683027121609801"/>
          <c:h val="0.81843570400258903"/>
        </c:manualLayout>
      </c:layout>
      <c:scatterChart>
        <c:scatterStyle val="lineMarker"/>
        <c:varyColors val="0"/>
        <c:ser>
          <c:idx val="0"/>
          <c:order val="0"/>
          <c:tx>
            <c:strRef>
              <c:f>'[DataAnalysis_CalibrationCurve_XanthineTest-All.xlsx]1 Xerogel'!$B$1</c:f>
              <c:strCache>
                <c:ptCount val="1"/>
                <c:pt idx="0">
                  <c:v>Pt / HMTES+Xox / 75.25PU (n=5)</c:v>
                </c:pt>
              </c:strCache>
            </c:strRef>
          </c:tx>
          <c:spPr>
            <a:ln w="28575" cap="rnd">
              <a:noFill/>
              <a:round/>
            </a:ln>
            <a:effectLst/>
          </c:spPr>
          <c:marker>
            <c:symbol val="circle"/>
            <c:size val="10"/>
            <c:spPr>
              <a:solidFill>
                <a:schemeClr val="tx1"/>
              </a:solidFill>
              <a:ln w="9525">
                <a:no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1 Xerogel'!$C$3:$C$18</c:f>
                <c:numCache>
                  <c:formatCode>General</c:formatCode>
                  <c:ptCount val="16"/>
                  <c:pt idx="0">
                    <c:v>1.6623427851989369E-3</c:v>
                  </c:pt>
                  <c:pt idx="1">
                    <c:v>7.3167215594621476E-3</c:v>
                  </c:pt>
                  <c:pt idx="2">
                    <c:v>1.1539800519744828E-2</c:v>
                  </c:pt>
                  <c:pt idx="3">
                    <c:v>1.8894561731295955E-2</c:v>
                  </c:pt>
                  <c:pt idx="4">
                    <c:v>2.6305902520089599E-2</c:v>
                  </c:pt>
                  <c:pt idx="5">
                    <c:v>3.4007339270521755E-2</c:v>
                  </c:pt>
                  <c:pt idx="6">
                    <c:v>4.1521267577503115E-2</c:v>
                  </c:pt>
                  <c:pt idx="7">
                    <c:v>4.8488174715884166E-2</c:v>
                  </c:pt>
                  <c:pt idx="8">
                    <c:v>5.3237301691766027E-2</c:v>
                  </c:pt>
                  <c:pt idx="9">
                    <c:v>5.6964637985062294E-2</c:v>
                  </c:pt>
                  <c:pt idx="10">
                    <c:v>5.9677138883540981E-2</c:v>
                  </c:pt>
                  <c:pt idx="11">
                    <c:v>6.1357867376997707E-2</c:v>
                  </c:pt>
                  <c:pt idx="12">
                    <c:v>6.258937757248631E-2</c:v>
                  </c:pt>
                  <c:pt idx="13">
                    <c:v>6.3978420652369777E-2</c:v>
                  </c:pt>
                  <c:pt idx="14">
                    <c:v>6.5940140709621842E-2</c:v>
                  </c:pt>
                  <c:pt idx="15">
                    <c:v>6.8125466580021193E-2</c:v>
                  </c:pt>
                </c:numCache>
              </c:numRef>
            </c:plus>
            <c:minus>
              <c:numRef>
                <c:f>'[DataAnalysis_CalibrationCurve_XanthineTest-All.xlsx]1 Xerogel'!$C$3:$C$18</c:f>
                <c:numCache>
                  <c:formatCode>General</c:formatCode>
                  <c:ptCount val="16"/>
                  <c:pt idx="0">
                    <c:v>1.6623427851989369E-3</c:v>
                  </c:pt>
                  <c:pt idx="1">
                    <c:v>7.3167215594621476E-3</c:v>
                  </c:pt>
                  <c:pt idx="2">
                    <c:v>1.1539800519744828E-2</c:v>
                  </c:pt>
                  <c:pt idx="3">
                    <c:v>1.8894561731295955E-2</c:v>
                  </c:pt>
                  <c:pt idx="4">
                    <c:v>2.6305902520089599E-2</c:v>
                  </c:pt>
                  <c:pt idx="5">
                    <c:v>3.4007339270521755E-2</c:v>
                  </c:pt>
                  <c:pt idx="6">
                    <c:v>4.1521267577503115E-2</c:v>
                  </c:pt>
                  <c:pt idx="7">
                    <c:v>4.8488174715884166E-2</c:v>
                  </c:pt>
                  <c:pt idx="8">
                    <c:v>5.3237301691766027E-2</c:v>
                  </c:pt>
                  <c:pt idx="9">
                    <c:v>5.6964637985062294E-2</c:v>
                  </c:pt>
                  <c:pt idx="10">
                    <c:v>5.9677138883540981E-2</c:v>
                  </c:pt>
                  <c:pt idx="11">
                    <c:v>6.1357867376997707E-2</c:v>
                  </c:pt>
                  <c:pt idx="12">
                    <c:v>6.258937757248631E-2</c:v>
                  </c:pt>
                  <c:pt idx="13">
                    <c:v>6.3978420652369777E-2</c:v>
                  </c:pt>
                  <c:pt idx="14">
                    <c:v>6.5940140709621842E-2</c:v>
                  </c:pt>
                  <c:pt idx="15">
                    <c:v>6.8125466580021193E-2</c:v>
                  </c:pt>
                </c:numCache>
              </c:numRef>
            </c:minus>
            <c:spPr>
              <a:noFill/>
              <a:ln w="9525" cap="flat" cmpd="sng" algn="ctr">
                <a:solidFill>
                  <a:schemeClr val="tx1">
                    <a:lumMod val="65000"/>
                    <a:lumOff val="35000"/>
                  </a:schemeClr>
                </a:solidFill>
                <a:round/>
              </a:ln>
              <a:effectLst/>
            </c:spPr>
          </c:errBars>
          <c:xVal>
            <c:numRef>
              <c:f>'[DataAnalysis_CalibrationCurve_XanthineTest-All.xlsx]1 Xerogel'!$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1 Xerogel'!$B$3:$B$18</c:f>
              <c:numCache>
                <c:formatCode>General</c:formatCode>
                <c:ptCount val="16"/>
                <c:pt idx="0">
                  <c:v>2.2816230769230766E-2</c:v>
                </c:pt>
                <c:pt idx="1">
                  <c:v>7.568046153846153E-2</c:v>
                </c:pt>
                <c:pt idx="2">
                  <c:v>0.10476584615384617</c:v>
                </c:pt>
                <c:pt idx="3">
                  <c:v>0.15662230769230767</c:v>
                </c:pt>
                <c:pt idx="4">
                  <c:v>0.20329076923076922</c:v>
                </c:pt>
                <c:pt idx="5">
                  <c:v>0.24429846153846152</c:v>
                </c:pt>
                <c:pt idx="6">
                  <c:v>0.27680076923076924</c:v>
                </c:pt>
                <c:pt idx="7">
                  <c:v>0.30225307692307696</c:v>
                </c:pt>
                <c:pt idx="8">
                  <c:v>0.31813153846153847</c:v>
                </c:pt>
                <c:pt idx="9">
                  <c:v>0.33138538461538464</c:v>
                </c:pt>
                <c:pt idx="10">
                  <c:v>0.34406461538461536</c:v>
                </c:pt>
                <c:pt idx="11">
                  <c:v>0.35308615384615383</c:v>
                </c:pt>
                <c:pt idx="12">
                  <c:v>0.36135384615384614</c:v>
                </c:pt>
                <c:pt idx="13">
                  <c:v>0.36958000000000002</c:v>
                </c:pt>
                <c:pt idx="14">
                  <c:v>0.37834384615384614</c:v>
                </c:pt>
                <c:pt idx="15">
                  <c:v>0.38859692307692312</c:v>
                </c:pt>
              </c:numCache>
            </c:numRef>
          </c:yVal>
          <c:smooth val="0"/>
          <c:extLst>
            <c:ext xmlns:c16="http://schemas.microsoft.com/office/drawing/2014/chart" uri="{C3380CC4-5D6E-409C-BE32-E72D297353CC}">
              <c16:uniqueId val="{00000000-3C08-447B-81EF-68ADB3A125B1}"/>
            </c:ext>
          </c:extLst>
        </c:ser>
        <c:ser>
          <c:idx val="2"/>
          <c:order val="2"/>
          <c:tx>
            <c:strRef>
              <c:f>'[DataAnalysis_CalibrationCurve_XanthineTest-All.xlsx]1 Xerogel'!$F$1</c:f>
              <c:strCache>
                <c:ptCount val="1"/>
                <c:pt idx="0">
                  <c:v>Pt / HMTES-C3MPC+Xox / 75.25PU (n=5)</c:v>
                </c:pt>
              </c:strCache>
            </c:strRef>
          </c:tx>
          <c:spPr>
            <a:ln w="25400" cap="rnd">
              <a:noFill/>
              <a:round/>
            </a:ln>
            <a:effectLst/>
          </c:spPr>
          <c:marker>
            <c:symbol val="x"/>
            <c:size val="10"/>
            <c:spPr>
              <a:solidFill>
                <a:srgbClr val="FF0000"/>
              </a:solidFill>
              <a:ln w="9525">
                <a:no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1 Xerogel'!$G$3:$G$18</c:f>
                <c:numCache>
                  <c:formatCode>General</c:formatCode>
                  <c:ptCount val="16"/>
                  <c:pt idx="0">
                    <c:v>3.7297641389965105E-3</c:v>
                  </c:pt>
                  <c:pt idx="1">
                    <c:v>1.108509380673621E-2</c:v>
                  </c:pt>
                  <c:pt idx="2">
                    <c:v>1.6626072194815565E-2</c:v>
                  </c:pt>
                  <c:pt idx="3">
                    <c:v>2.2377721215636217E-2</c:v>
                  </c:pt>
                  <c:pt idx="4">
                    <c:v>2.985136792778122E-2</c:v>
                  </c:pt>
                  <c:pt idx="5">
                    <c:v>3.9837560273941128E-2</c:v>
                  </c:pt>
                  <c:pt idx="6">
                    <c:v>4.9987071775355905E-2</c:v>
                  </c:pt>
                  <c:pt idx="7">
                    <c:v>5.8431951457943138E-2</c:v>
                  </c:pt>
                  <c:pt idx="8">
                    <c:v>6.4357597458199897E-2</c:v>
                  </c:pt>
                  <c:pt idx="9">
                    <c:v>6.9294626820649116E-2</c:v>
                  </c:pt>
                  <c:pt idx="10">
                    <c:v>7.3896145268227437E-2</c:v>
                  </c:pt>
                  <c:pt idx="11">
                    <c:v>7.8446609316870614E-2</c:v>
                  </c:pt>
                  <c:pt idx="12">
                    <c:v>8.3311002251527114E-2</c:v>
                  </c:pt>
                  <c:pt idx="13">
                    <c:v>8.8318578781523438E-2</c:v>
                  </c:pt>
                  <c:pt idx="14">
                    <c:v>9.2609184417429935E-2</c:v>
                  </c:pt>
                  <c:pt idx="15">
                    <c:v>9.7640621548263806E-2</c:v>
                  </c:pt>
                </c:numCache>
              </c:numRef>
            </c:plus>
            <c:minus>
              <c:numRef>
                <c:f>'[DataAnalysis_CalibrationCurve_XanthineTest-All.xlsx]1 Xerogel'!$G$3:$G$18</c:f>
                <c:numCache>
                  <c:formatCode>General</c:formatCode>
                  <c:ptCount val="16"/>
                  <c:pt idx="0">
                    <c:v>3.7297641389965105E-3</c:v>
                  </c:pt>
                  <c:pt idx="1">
                    <c:v>1.108509380673621E-2</c:v>
                  </c:pt>
                  <c:pt idx="2">
                    <c:v>1.6626072194815565E-2</c:v>
                  </c:pt>
                  <c:pt idx="3">
                    <c:v>2.2377721215636217E-2</c:v>
                  </c:pt>
                  <c:pt idx="4">
                    <c:v>2.985136792778122E-2</c:v>
                  </c:pt>
                  <c:pt idx="5">
                    <c:v>3.9837560273941128E-2</c:v>
                  </c:pt>
                  <c:pt idx="6">
                    <c:v>4.9987071775355905E-2</c:v>
                  </c:pt>
                  <c:pt idx="7">
                    <c:v>5.8431951457943138E-2</c:v>
                  </c:pt>
                  <c:pt idx="8">
                    <c:v>6.4357597458199897E-2</c:v>
                  </c:pt>
                  <c:pt idx="9">
                    <c:v>6.9294626820649116E-2</c:v>
                  </c:pt>
                  <c:pt idx="10">
                    <c:v>7.3896145268227437E-2</c:v>
                  </c:pt>
                  <c:pt idx="11">
                    <c:v>7.8446609316870614E-2</c:v>
                  </c:pt>
                  <c:pt idx="12">
                    <c:v>8.3311002251527114E-2</c:v>
                  </c:pt>
                  <c:pt idx="13">
                    <c:v>8.8318578781523438E-2</c:v>
                  </c:pt>
                  <c:pt idx="14">
                    <c:v>9.2609184417429935E-2</c:v>
                  </c:pt>
                  <c:pt idx="15">
                    <c:v>9.7640621548263806E-2</c:v>
                  </c:pt>
                </c:numCache>
              </c:numRef>
            </c:minus>
            <c:spPr>
              <a:noFill/>
              <a:ln w="9525" cap="flat" cmpd="sng" algn="ctr">
                <a:solidFill>
                  <a:schemeClr val="tx1">
                    <a:lumMod val="65000"/>
                    <a:lumOff val="35000"/>
                  </a:schemeClr>
                </a:solidFill>
                <a:round/>
              </a:ln>
              <a:effectLst/>
            </c:spPr>
          </c:errBars>
          <c:xVal>
            <c:numRef>
              <c:f>'[DataAnalysis_CalibrationCurve_XanthineTest-All.xlsx]1 Xerogel'!$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1 Xerogel'!$F$3:$F$18</c:f>
              <c:numCache>
                <c:formatCode>General</c:formatCode>
                <c:ptCount val="16"/>
                <c:pt idx="0">
                  <c:v>1.6313461538461541E-2</c:v>
                </c:pt>
                <c:pt idx="1">
                  <c:v>9.1311769230769252E-2</c:v>
                </c:pt>
                <c:pt idx="2">
                  <c:v>0.15867538461538461</c:v>
                </c:pt>
                <c:pt idx="3">
                  <c:v>0.21985307692307696</c:v>
                </c:pt>
                <c:pt idx="4">
                  <c:v>0.27457999999999999</c:v>
                </c:pt>
                <c:pt idx="5">
                  <c:v>0.3215623076923077</c:v>
                </c:pt>
                <c:pt idx="6">
                  <c:v>0.36235384615384614</c:v>
                </c:pt>
                <c:pt idx="7">
                  <c:v>0.39691923076923075</c:v>
                </c:pt>
                <c:pt idx="8">
                  <c:v>0.42796615384615383</c:v>
                </c:pt>
                <c:pt idx="9">
                  <c:v>0.45706461538461535</c:v>
                </c:pt>
                <c:pt idx="10">
                  <c:v>0.48600538461538462</c:v>
                </c:pt>
                <c:pt idx="11">
                  <c:v>0.51259153846153838</c:v>
                </c:pt>
                <c:pt idx="12">
                  <c:v>0.54048999999999991</c:v>
                </c:pt>
                <c:pt idx="13">
                  <c:v>0.56781692307692311</c:v>
                </c:pt>
                <c:pt idx="14">
                  <c:v>0.59611999999999998</c:v>
                </c:pt>
                <c:pt idx="15">
                  <c:v>0.62543846153846161</c:v>
                </c:pt>
              </c:numCache>
            </c:numRef>
          </c:yVal>
          <c:smooth val="0"/>
          <c:extLst>
            <c:ext xmlns:c16="http://schemas.microsoft.com/office/drawing/2014/chart" uri="{C3380CC4-5D6E-409C-BE32-E72D297353CC}">
              <c16:uniqueId val="{00000001-3C08-447B-81EF-68ADB3A125B1}"/>
            </c:ext>
          </c:extLst>
        </c:ser>
        <c:ser>
          <c:idx val="4"/>
          <c:order val="4"/>
          <c:tx>
            <c:strRef>
              <c:f>'[DataAnalysis_CalibrationCurve_XanthineTest-All.xlsx]1 Xerogel'!$J$1</c:f>
              <c:strCache>
                <c:ptCount val="1"/>
                <c:pt idx="0">
                  <c:v>Pt / HMTES-C4MPC+Xox / 75.25PU (n=5)</c:v>
                </c:pt>
              </c:strCache>
            </c:strRef>
          </c:tx>
          <c:spPr>
            <a:ln w="25400" cap="rnd">
              <a:noFill/>
              <a:round/>
            </a:ln>
            <a:effectLst/>
          </c:spPr>
          <c:marker>
            <c:symbol val="diamond"/>
            <c:size val="10"/>
            <c:spPr>
              <a:solidFill>
                <a:srgbClr val="00B050"/>
              </a:solidFill>
              <a:ln w="19050">
                <a:no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1 Xerogel'!$K$3:$K$18</c:f>
                <c:numCache>
                  <c:formatCode>General</c:formatCode>
                  <c:ptCount val="16"/>
                  <c:pt idx="0">
                    <c:v>3.2771142233886368E-3</c:v>
                  </c:pt>
                  <c:pt idx="1">
                    <c:v>1.0726487152242292E-2</c:v>
                  </c:pt>
                  <c:pt idx="2">
                    <c:v>2.0528018448455226E-2</c:v>
                  </c:pt>
                  <c:pt idx="3">
                    <c:v>2.9892500271560204E-2</c:v>
                  </c:pt>
                  <c:pt idx="4">
                    <c:v>4.0158288013233089E-2</c:v>
                  </c:pt>
                  <c:pt idx="5">
                    <c:v>4.9965773166895419E-2</c:v>
                  </c:pt>
                  <c:pt idx="6">
                    <c:v>5.951764751218401E-2</c:v>
                  </c:pt>
                  <c:pt idx="7">
                    <c:v>6.982694191047005E-2</c:v>
                  </c:pt>
                  <c:pt idx="8">
                    <c:v>7.9907370254601318E-2</c:v>
                  </c:pt>
                  <c:pt idx="9">
                    <c:v>9.0430087677699875E-2</c:v>
                  </c:pt>
                  <c:pt idx="10">
                    <c:v>0.10008840638752935</c:v>
                  </c:pt>
                  <c:pt idx="11">
                    <c:v>0.10952851245196711</c:v>
                  </c:pt>
                  <c:pt idx="12">
                    <c:v>0.11863558591570285</c:v>
                  </c:pt>
                  <c:pt idx="13">
                    <c:v>0.12717422576223977</c:v>
                  </c:pt>
                  <c:pt idx="14">
                    <c:v>0.13495972527115743</c:v>
                  </c:pt>
                  <c:pt idx="15">
                    <c:v>0.14274306318962793</c:v>
                  </c:pt>
                </c:numCache>
              </c:numRef>
            </c:plus>
            <c:minus>
              <c:numRef>
                <c:f>'[DataAnalysis_CalibrationCurve_XanthineTest-All.xlsx]1 Xerogel'!$K$3:$K$18</c:f>
                <c:numCache>
                  <c:formatCode>General</c:formatCode>
                  <c:ptCount val="16"/>
                  <c:pt idx="0">
                    <c:v>3.2771142233886368E-3</c:v>
                  </c:pt>
                  <c:pt idx="1">
                    <c:v>1.0726487152242292E-2</c:v>
                  </c:pt>
                  <c:pt idx="2">
                    <c:v>2.0528018448455226E-2</c:v>
                  </c:pt>
                  <c:pt idx="3">
                    <c:v>2.9892500271560204E-2</c:v>
                  </c:pt>
                  <c:pt idx="4">
                    <c:v>4.0158288013233089E-2</c:v>
                  </c:pt>
                  <c:pt idx="5">
                    <c:v>4.9965773166895419E-2</c:v>
                  </c:pt>
                  <c:pt idx="6">
                    <c:v>5.951764751218401E-2</c:v>
                  </c:pt>
                  <c:pt idx="7">
                    <c:v>6.982694191047005E-2</c:v>
                  </c:pt>
                  <c:pt idx="8">
                    <c:v>7.9907370254601318E-2</c:v>
                  </c:pt>
                  <c:pt idx="9">
                    <c:v>9.0430087677699875E-2</c:v>
                  </c:pt>
                  <c:pt idx="10">
                    <c:v>0.10008840638752935</c:v>
                  </c:pt>
                  <c:pt idx="11">
                    <c:v>0.10952851245196711</c:v>
                  </c:pt>
                  <c:pt idx="12">
                    <c:v>0.11863558591570285</c:v>
                  </c:pt>
                  <c:pt idx="13">
                    <c:v>0.12717422576223977</c:v>
                  </c:pt>
                  <c:pt idx="14">
                    <c:v>0.13495972527115743</c:v>
                  </c:pt>
                  <c:pt idx="15">
                    <c:v>0.14274306318962793</c:v>
                  </c:pt>
                </c:numCache>
              </c:numRef>
            </c:minus>
            <c:spPr>
              <a:noFill/>
              <a:ln w="9525" cap="flat" cmpd="sng" algn="ctr">
                <a:solidFill>
                  <a:schemeClr val="tx1">
                    <a:lumMod val="65000"/>
                    <a:lumOff val="35000"/>
                  </a:schemeClr>
                </a:solidFill>
                <a:round/>
              </a:ln>
              <a:effectLst/>
            </c:spPr>
          </c:errBars>
          <c:xVal>
            <c:numRef>
              <c:f>'[DataAnalysis_CalibrationCurve_XanthineTest-All.xlsx]1 Xerogel'!$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1 Xerogel'!$J$3:$J$18</c:f>
              <c:numCache>
                <c:formatCode>General</c:formatCode>
                <c:ptCount val="16"/>
                <c:pt idx="0">
                  <c:v>3.3920923076923085E-2</c:v>
                </c:pt>
                <c:pt idx="1">
                  <c:v>0.11874076923076923</c:v>
                </c:pt>
                <c:pt idx="2">
                  <c:v>0.19435769230769234</c:v>
                </c:pt>
                <c:pt idx="3">
                  <c:v>0.26480999999999999</c:v>
                </c:pt>
                <c:pt idx="4">
                  <c:v>0.34084000000000003</c:v>
                </c:pt>
                <c:pt idx="5">
                  <c:v>0.41537923076923083</c:v>
                </c:pt>
                <c:pt idx="6">
                  <c:v>0.48980692307692308</c:v>
                </c:pt>
                <c:pt idx="7">
                  <c:v>0.5649861538461538</c:v>
                </c:pt>
                <c:pt idx="8">
                  <c:v>0.64148538461538451</c:v>
                </c:pt>
                <c:pt idx="9">
                  <c:v>0.72003538461538452</c:v>
                </c:pt>
                <c:pt idx="10">
                  <c:v>0.79566615384615391</c:v>
                </c:pt>
                <c:pt idx="11">
                  <c:v>0.86993384615384617</c:v>
                </c:pt>
                <c:pt idx="12">
                  <c:v>0.94237153846153843</c:v>
                </c:pt>
                <c:pt idx="13">
                  <c:v>1.0119038461538459</c:v>
                </c:pt>
                <c:pt idx="14">
                  <c:v>1.077686153846154</c:v>
                </c:pt>
                <c:pt idx="15">
                  <c:v>1.1417992307692306</c:v>
                </c:pt>
              </c:numCache>
            </c:numRef>
          </c:yVal>
          <c:smooth val="0"/>
          <c:extLst>
            <c:ext xmlns:c16="http://schemas.microsoft.com/office/drawing/2014/chart" uri="{C3380CC4-5D6E-409C-BE32-E72D297353CC}">
              <c16:uniqueId val="{00000002-3C08-447B-81EF-68ADB3A125B1}"/>
            </c:ext>
          </c:extLst>
        </c:ser>
        <c:ser>
          <c:idx val="6"/>
          <c:order val="6"/>
          <c:tx>
            <c:strRef>
              <c:f>'[DataAnalysis_CalibrationCurve_XanthineTest-All.xlsx]1 Xerogel'!$N$1</c:f>
              <c:strCache>
                <c:ptCount val="1"/>
                <c:pt idx="0">
                  <c:v>Pt / HMTES-C6MPC+Xox / 75.25PU (n=6)</c:v>
                </c:pt>
              </c:strCache>
            </c:strRef>
          </c:tx>
          <c:spPr>
            <a:ln w="25400" cap="rnd">
              <a:noFill/>
              <a:round/>
            </a:ln>
            <a:effectLst/>
          </c:spPr>
          <c:marker>
            <c:symbol val="triangle"/>
            <c:size val="10"/>
            <c:spPr>
              <a:solidFill>
                <a:srgbClr val="7030A0"/>
              </a:solidFill>
              <a:ln w="9525">
                <a:no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f>'[DataAnalysis_CalibrationCurve_XanthineTest-All.xlsx]1 Xerogel'!$O$3:$O$18</c:f>
                <c:numCache>
                  <c:formatCode>General</c:formatCode>
                  <c:ptCount val="16"/>
                  <c:pt idx="0">
                    <c:v>7.1305484677314131E-3</c:v>
                  </c:pt>
                  <c:pt idx="1">
                    <c:v>1.5503423725100225E-2</c:v>
                  </c:pt>
                  <c:pt idx="2">
                    <c:v>3.1284070102316548E-2</c:v>
                  </c:pt>
                  <c:pt idx="3">
                    <c:v>4.5576819396121286E-2</c:v>
                  </c:pt>
                  <c:pt idx="4">
                    <c:v>5.9812599701623545E-2</c:v>
                  </c:pt>
                  <c:pt idx="5">
                    <c:v>7.3276868499547607E-2</c:v>
                  </c:pt>
                  <c:pt idx="6">
                    <c:v>8.8726397807340762E-2</c:v>
                  </c:pt>
                  <c:pt idx="7">
                    <c:v>0.10251059962511179</c:v>
                  </c:pt>
                  <c:pt idx="8">
                    <c:v>0.11676341694454966</c:v>
                  </c:pt>
                  <c:pt idx="9">
                    <c:v>0.13131587064885616</c:v>
                  </c:pt>
                  <c:pt idx="10">
                    <c:v>0.14417792710594304</c:v>
                  </c:pt>
                  <c:pt idx="11">
                    <c:v>0.15646922740356731</c:v>
                  </c:pt>
                  <c:pt idx="12">
                    <c:v>0.16334005077343047</c:v>
                  </c:pt>
                  <c:pt idx="13">
                    <c:v>0.17050637869788696</c:v>
                  </c:pt>
                  <c:pt idx="14">
                    <c:v>0.17619971290177106</c:v>
                  </c:pt>
                  <c:pt idx="15">
                    <c:v>0.1830337532442235</c:v>
                  </c:pt>
                </c:numCache>
              </c:numRef>
            </c:plus>
            <c:minus>
              <c:numRef>
                <c:f>'[DataAnalysis_CalibrationCurve_XanthineTest-All.xlsx]1 Xerogel'!$O$3:$O$18</c:f>
                <c:numCache>
                  <c:formatCode>General</c:formatCode>
                  <c:ptCount val="16"/>
                  <c:pt idx="0">
                    <c:v>7.1305484677314131E-3</c:v>
                  </c:pt>
                  <c:pt idx="1">
                    <c:v>1.5503423725100225E-2</c:v>
                  </c:pt>
                  <c:pt idx="2">
                    <c:v>3.1284070102316548E-2</c:v>
                  </c:pt>
                  <c:pt idx="3">
                    <c:v>4.5576819396121286E-2</c:v>
                  </c:pt>
                  <c:pt idx="4">
                    <c:v>5.9812599701623545E-2</c:v>
                  </c:pt>
                  <c:pt idx="5">
                    <c:v>7.3276868499547607E-2</c:v>
                  </c:pt>
                  <c:pt idx="6">
                    <c:v>8.8726397807340762E-2</c:v>
                  </c:pt>
                  <c:pt idx="7">
                    <c:v>0.10251059962511179</c:v>
                  </c:pt>
                  <c:pt idx="8">
                    <c:v>0.11676341694454966</c:v>
                  </c:pt>
                  <c:pt idx="9">
                    <c:v>0.13131587064885616</c:v>
                  </c:pt>
                  <c:pt idx="10">
                    <c:v>0.14417792710594304</c:v>
                  </c:pt>
                  <c:pt idx="11">
                    <c:v>0.15646922740356731</c:v>
                  </c:pt>
                  <c:pt idx="12">
                    <c:v>0.16334005077343047</c:v>
                  </c:pt>
                  <c:pt idx="13">
                    <c:v>0.17050637869788696</c:v>
                  </c:pt>
                  <c:pt idx="14">
                    <c:v>0.17619971290177106</c:v>
                  </c:pt>
                  <c:pt idx="15">
                    <c:v>0.1830337532442235</c:v>
                  </c:pt>
                </c:numCache>
              </c:numRef>
            </c:minus>
            <c:spPr>
              <a:noFill/>
              <a:ln w="9525" cap="flat" cmpd="sng" algn="ctr">
                <a:solidFill>
                  <a:schemeClr val="tx1">
                    <a:lumMod val="65000"/>
                    <a:lumOff val="35000"/>
                  </a:schemeClr>
                </a:solidFill>
                <a:round/>
              </a:ln>
              <a:effectLst/>
            </c:spPr>
          </c:errBars>
          <c:xVal>
            <c:numRef>
              <c:f>'[DataAnalysis_CalibrationCurve_XanthineTest-All.xlsx]1 Xerogel'!$A$3:$A$18</c:f>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f>'[DataAnalysis_CalibrationCurve_XanthineTest-All.xlsx]1 Xerogel'!$N$3:$N$18</c:f>
              <c:numCache>
                <c:formatCode>General</c:formatCode>
                <c:ptCount val="16"/>
                <c:pt idx="0">
                  <c:v>4.7006733333333328E-2</c:v>
                </c:pt>
                <c:pt idx="1">
                  <c:v>0.15081799999999998</c:v>
                </c:pt>
                <c:pt idx="2">
                  <c:v>0.23995716666666669</c:v>
                </c:pt>
                <c:pt idx="3">
                  <c:v>0.32449033333333333</c:v>
                </c:pt>
                <c:pt idx="4">
                  <c:v>0.41524066666666665</c:v>
                </c:pt>
                <c:pt idx="5">
                  <c:v>0.50321450000000001</c:v>
                </c:pt>
                <c:pt idx="6">
                  <c:v>0.59559966666666664</c:v>
                </c:pt>
                <c:pt idx="7">
                  <c:v>0.68941750000000013</c:v>
                </c:pt>
                <c:pt idx="8">
                  <c:v>0.78668883333333317</c:v>
                </c:pt>
                <c:pt idx="9">
                  <c:v>0.88420166666666666</c:v>
                </c:pt>
                <c:pt idx="10">
                  <c:v>0.98353016666666659</c:v>
                </c:pt>
                <c:pt idx="11">
                  <c:v>1.0863488448844882</c:v>
                </c:pt>
                <c:pt idx="12">
                  <c:v>1.1837766666666665</c:v>
                </c:pt>
                <c:pt idx="13">
                  <c:v>1.2747916666666701</c:v>
                </c:pt>
                <c:pt idx="14">
                  <c:v>1.3587066666666667</c:v>
                </c:pt>
                <c:pt idx="15">
                  <c:v>1.4327866666666662</c:v>
                </c:pt>
              </c:numCache>
            </c:numRef>
          </c:yVal>
          <c:smooth val="0"/>
          <c:extLst>
            <c:ext xmlns:c16="http://schemas.microsoft.com/office/drawing/2014/chart" uri="{C3380CC4-5D6E-409C-BE32-E72D297353CC}">
              <c16:uniqueId val="{00000003-3C08-447B-81EF-68ADB3A125B1}"/>
            </c:ext>
          </c:extLst>
        </c:ser>
        <c:dLbls>
          <c:showLegendKey val="0"/>
          <c:showVal val="0"/>
          <c:showCatName val="0"/>
          <c:showSerName val="0"/>
          <c:showPercent val="0"/>
          <c:showBubbleSize val="0"/>
        </c:dLbls>
        <c:axId val="975122127"/>
        <c:axId val="298867487"/>
        <c:extLst>
          <c:ext xmlns:c15="http://schemas.microsoft.com/office/drawing/2012/chart" uri="{02D57815-91ED-43cb-92C2-25804820EDAC}">
            <c15:filteredScatterSeries>
              <c15:ser>
                <c:idx val="1"/>
                <c:order val="1"/>
                <c:tx>
                  <c:strRef>
                    <c:extLst>
                      <c:ext uri="{02D57815-91ED-43cb-92C2-25804820EDAC}">
                        <c15:formulaRef>
                          <c15:sqref>'[DataAnalysis_CalibrationCurve_XanthineTest-All.xlsx]1 Xerogel'!$D$1</c15:sqref>
                        </c15:formulaRef>
                      </c:ext>
                    </c:extLst>
                    <c:strCache>
                      <c:ptCount val="1"/>
                      <c:pt idx="0">
                        <c:v>Pt / HMTES 1+Xox / HMTES 2 / 75.25PU (n=6)</c:v>
                      </c:pt>
                    </c:strCache>
                  </c:strRef>
                </c:tx>
                <c:spPr>
                  <a:ln w="25400" cap="rnd">
                    <a:noFill/>
                    <a:round/>
                  </a:ln>
                  <a:effectLst/>
                </c:spPr>
                <c:marker>
                  <c:symbol val="circle"/>
                  <c:size val="10"/>
                  <c:spPr>
                    <a:noFill/>
                    <a:ln w="19050">
                      <a:solidFill>
                        <a:schemeClr val="tx1"/>
                      </a:solid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extLst>
                        <c:ext uri="{02D57815-91ED-43cb-92C2-25804820EDAC}">
                          <c15:formulaRef>
                            <c15:sqref>'[DataAnalysis_CalibrationCurve_XanthineTest-All.xlsx]1 Xerogel'!$E$3:$E$18</c15:sqref>
                          </c15:formulaRef>
                        </c:ext>
                      </c:extLst>
                      <c:numCache>
                        <c:formatCode>General</c:formatCode>
                        <c:ptCount val="16"/>
                        <c:pt idx="0">
                          <c:v>6.1760133414594867E-3</c:v>
                        </c:pt>
                        <c:pt idx="1">
                          <c:v>6.0787996246566434E-3</c:v>
                        </c:pt>
                        <c:pt idx="2">
                          <c:v>1.1218786379787463E-2</c:v>
                        </c:pt>
                        <c:pt idx="3">
                          <c:v>1.6541265498292601E-2</c:v>
                        </c:pt>
                        <c:pt idx="4">
                          <c:v>2.2412031111886273E-2</c:v>
                        </c:pt>
                        <c:pt idx="5">
                          <c:v>2.9124763824795216E-2</c:v>
                        </c:pt>
                        <c:pt idx="6">
                          <c:v>3.5420858814431189E-2</c:v>
                        </c:pt>
                        <c:pt idx="7">
                          <c:v>3.9441532940671362E-2</c:v>
                        </c:pt>
                        <c:pt idx="8">
                          <c:v>4.5345435462220154E-2</c:v>
                        </c:pt>
                        <c:pt idx="9">
                          <c:v>4.8212779473252518E-2</c:v>
                        </c:pt>
                        <c:pt idx="10">
                          <c:v>5.4808900211610924E-2</c:v>
                        </c:pt>
                        <c:pt idx="11">
                          <c:v>6.3656846025058306E-2</c:v>
                        </c:pt>
                        <c:pt idx="12">
                          <c:v>6.9431319281287152E-2</c:v>
                        </c:pt>
                        <c:pt idx="13">
                          <c:v>7.235589593821419E-2</c:v>
                        </c:pt>
                        <c:pt idx="14">
                          <c:v>7.6528936493385741E-2</c:v>
                        </c:pt>
                        <c:pt idx="15">
                          <c:v>7.8760297748797892E-2</c:v>
                        </c:pt>
                      </c:numCache>
                    </c:numRef>
                  </c:plus>
                  <c:minus>
                    <c:numRef>
                      <c:extLst>
                        <c:ext uri="{02D57815-91ED-43cb-92C2-25804820EDAC}">
                          <c15:formulaRef>
                            <c15:sqref>'[DataAnalysis_CalibrationCurve_XanthineTest-All.xlsx]1 Xerogel'!$E$3:$E$18</c15:sqref>
                          </c15:formulaRef>
                        </c:ext>
                      </c:extLst>
                      <c:numCache>
                        <c:formatCode>General</c:formatCode>
                        <c:ptCount val="16"/>
                        <c:pt idx="0">
                          <c:v>6.1760133414594867E-3</c:v>
                        </c:pt>
                        <c:pt idx="1">
                          <c:v>6.0787996246566434E-3</c:v>
                        </c:pt>
                        <c:pt idx="2">
                          <c:v>1.1218786379787463E-2</c:v>
                        </c:pt>
                        <c:pt idx="3">
                          <c:v>1.6541265498292601E-2</c:v>
                        </c:pt>
                        <c:pt idx="4">
                          <c:v>2.2412031111886273E-2</c:v>
                        </c:pt>
                        <c:pt idx="5">
                          <c:v>2.9124763824795216E-2</c:v>
                        </c:pt>
                        <c:pt idx="6">
                          <c:v>3.5420858814431189E-2</c:v>
                        </c:pt>
                        <c:pt idx="7">
                          <c:v>3.9441532940671362E-2</c:v>
                        </c:pt>
                        <c:pt idx="8">
                          <c:v>4.5345435462220154E-2</c:v>
                        </c:pt>
                        <c:pt idx="9">
                          <c:v>4.8212779473252518E-2</c:v>
                        </c:pt>
                        <c:pt idx="10">
                          <c:v>5.4808900211610924E-2</c:v>
                        </c:pt>
                        <c:pt idx="11">
                          <c:v>6.3656846025058306E-2</c:v>
                        </c:pt>
                        <c:pt idx="12">
                          <c:v>6.9431319281287152E-2</c:v>
                        </c:pt>
                        <c:pt idx="13">
                          <c:v>7.235589593821419E-2</c:v>
                        </c:pt>
                        <c:pt idx="14">
                          <c:v>7.6528936493385741E-2</c:v>
                        </c:pt>
                        <c:pt idx="15">
                          <c:v>7.8760297748797892E-2</c:v>
                        </c:pt>
                      </c:numCache>
                    </c:numRef>
                  </c:minus>
                  <c:spPr>
                    <a:noFill/>
                    <a:ln w="9525" cap="flat" cmpd="sng" algn="ctr">
                      <a:solidFill>
                        <a:schemeClr val="tx1">
                          <a:lumMod val="65000"/>
                          <a:lumOff val="35000"/>
                        </a:schemeClr>
                      </a:solidFill>
                      <a:round/>
                    </a:ln>
                    <a:effectLst/>
                  </c:spPr>
                </c:errBars>
                <c:xVal>
                  <c:numRef>
                    <c:extLst>
                      <c:ext uri="{02D57815-91ED-43cb-92C2-25804820EDAC}">
                        <c15:formulaRef>
                          <c15:sqref>'[DataAnalysis_CalibrationCurve_XanthineTest-All.xlsx]1 Xerogel'!$A$3:$A$18</c15:sqref>
                        </c15:formulaRef>
                      </c:ext>
                    </c:extLst>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extLst>
                      <c:ext uri="{02D57815-91ED-43cb-92C2-25804820EDAC}">
                        <c15:formulaRef>
                          <c15:sqref>'[DataAnalysis_CalibrationCurve_XanthineTest-All.xlsx]1 Xerogel'!$D$3:$D$18</c15:sqref>
                        </c15:formulaRef>
                      </c:ext>
                    </c:extLst>
                    <c:numCache>
                      <c:formatCode>General</c:formatCode>
                      <c:ptCount val="16"/>
                      <c:pt idx="0">
                        <c:v>5.3928910256410258E-2</c:v>
                      </c:pt>
                      <c:pt idx="1">
                        <c:v>7.185839743589742E-2</c:v>
                      </c:pt>
                      <c:pt idx="2">
                        <c:v>9.1011217948717957E-2</c:v>
                      </c:pt>
                      <c:pt idx="3">
                        <c:v>0.10723108974358975</c:v>
                      </c:pt>
                      <c:pt idx="4">
                        <c:v>0.12341551282051282</c:v>
                      </c:pt>
                      <c:pt idx="5">
                        <c:v>0.1400871794871795</c:v>
                      </c:pt>
                      <c:pt idx="6">
                        <c:v>0.15641858974358977</c:v>
                      </c:pt>
                      <c:pt idx="7">
                        <c:v>0.17164230769230771</c:v>
                      </c:pt>
                      <c:pt idx="8">
                        <c:v>0.18786474358974359</c:v>
                      </c:pt>
                      <c:pt idx="9">
                        <c:v>0.20236666666666669</c:v>
                      </c:pt>
                      <c:pt idx="10">
                        <c:v>0.21872179487179486</c:v>
                      </c:pt>
                      <c:pt idx="11">
                        <c:v>0.23579807692307689</c:v>
                      </c:pt>
                      <c:pt idx="12">
                        <c:v>0.25154294871794874</c:v>
                      </c:pt>
                      <c:pt idx="13">
                        <c:v>0.26605833333333334</c:v>
                      </c:pt>
                      <c:pt idx="14">
                        <c:v>0.28137628205128201</c:v>
                      </c:pt>
                      <c:pt idx="15">
                        <c:v>0.29625961538461537</c:v>
                      </c:pt>
                    </c:numCache>
                  </c:numRef>
                </c:yVal>
                <c:smooth val="0"/>
                <c:extLst>
                  <c:ext xmlns:c16="http://schemas.microsoft.com/office/drawing/2014/chart" uri="{C3380CC4-5D6E-409C-BE32-E72D297353CC}">
                    <c16:uniqueId val="{00000004-3C08-447B-81EF-68ADB3A125B1}"/>
                  </c:ext>
                </c:extLst>
              </c15:ser>
            </c15:filteredScatterSeries>
            <c15:filteredScatterSeries>
              <c15:ser>
                <c:idx val="3"/>
                <c:order val="3"/>
                <c:tx>
                  <c:strRef>
                    <c:extLst xmlns:c15="http://schemas.microsoft.com/office/drawing/2012/chart">
                      <c:ext xmlns:c15="http://schemas.microsoft.com/office/drawing/2012/chart" uri="{02D57815-91ED-43cb-92C2-25804820EDAC}">
                        <c15:formulaRef>
                          <c15:sqref>'[DataAnalysis_CalibrationCurve_XanthineTest-All.xlsx]1 Xerogel'!$H$1</c15:sqref>
                        </c15:formulaRef>
                      </c:ext>
                    </c:extLst>
                    <c:strCache>
                      <c:ptCount val="1"/>
                      <c:pt idx="0">
                        <c:v>Pt / HMTES 1-C3MPC+Xox/ HMTES 2 / 75.25PU (n=4)</c:v>
                      </c:pt>
                    </c:strCache>
                  </c:strRef>
                </c:tx>
                <c:spPr>
                  <a:ln w="25400" cap="rnd">
                    <a:noFill/>
                    <a:round/>
                  </a:ln>
                  <a:effectLst/>
                </c:spPr>
                <c:marker>
                  <c:symbol val="square"/>
                  <c:size val="10"/>
                  <c:spPr>
                    <a:noFill/>
                    <a:ln w="19050">
                      <a:solidFill>
                        <a:srgbClr val="FF0000">
                          <a:alpha val="99000"/>
                        </a:srgbClr>
                      </a:solid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extLst xmlns:c15="http://schemas.microsoft.com/office/drawing/2012/chart">
                        <c:ext xmlns:c15="http://schemas.microsoft.com/office/drawing/2012/chart" uri="{02D57815-91ED-43cb-92C2-25804820EDAC}">
                          <c15:formulaRef>
                            <c15:sqref>'[DataAnalysis_CalibrationCurve_XanthineTest-All.xlsx]1 Xerogel'!$I$3:$I$18</c15:sqref>
                          </c15:formulaRef>
                        </c:ext>
                      </c:extLst>
                      <c:numCache>
                        <c:formatCode>General</c:formatCode>
                        <c:ptCount val="16"/>
                        <c:pt idx="0">
                          <c:v>1.4570282128420753E-3</c:v>
                        </c:pt>
                        <c:pt idx="1">
                          <c:v>5.9058635605605207E-3</c:v>
                        </c:pt>
                        <c:pt idx="2">
                          <c:v>1.2443266790205359E-2</c:v>
                        </c:pt>
                        <c:pt idx="3">
                          <c:v>1.8689577075797909E-2</c:v>
                        </c:pt>
                        <c:pt idx="4">
                          <c:v>2.4056807230229554E-2</c:v>
                        </c:pt>
                        <c:pt idx="5">
                          <c:v>2.8145500549526949E-2</c:v>
                        </c:pt>
                        <c:pt idx="6">
                          <c:v>3.1058334656372494E-2</c:v>
                        </c:pt>
                        <c:pt idx="7">
                          <c:v>3.3137045742528272E-2</c:v>
                        </c:pt>
                        <c:pt idx="8">
                          <c:v>3.5231873285662171E-2</c:v>
                        </c:pt>
                        <c:pt idx="9">
                          <c:v>3.6907062415799344E-2</c:v>
                        </c:pt>
                        <c:pt idx="10">
                          <c:v>3.8947362239238524E-2</c:v>
                        </c:pt>
                        <c:pt idx="11">
                          <c:v>4.0664381185373411E-2</c:v>
                        </c:pt>
                        <c:pt idx="12">
                          <c:v>4.2923699448660903E-2</c:v>
                        </c:pt>
                        <c:pt idx="13">
                          <c:v>4.4328944931362642E-2</c:v>
                        </c:pt>
                        <c:pt idx="14">
                          <c:v>4.5953638563114588E-2</c:v>
                        </c:pt>
                        <c:pt idx="15">
                          <c:v>4.7627688375047557E-2</c:v>
                        </c:pt>
                      </c:numCache>
                    </c:numRef>
                  </c:plus>
                  <c:minus>
                    <c:numRef>
                      <c:extLst xmlns:c15="http://schemas.microsoft.com/office/drawing/2012/chart">
                        <c:ext xmlns:c15="http://schemas.microsoft.com/office/drawing/2012/chart" uri="{02D57815-91ED-43cb-92C2-25804820EDAC}">
                          <c15:formulaRef>
                            <c15:sqref>'[DataAnalysis_CalibrationCurve_XanthineTest-All.xlsx]1 Xerogel'!$I$3:$I$18</c15:sqref>
                          </c15:formulaRef>
                        </c:ext>
                      </c:extLst>
                      <c:numCache>
                        <c:formatCode>General</c:formatCode>
                        <c:ptCount val="16"/>
                        <c:pt idx="0">
                          <c:v>1.4570282128420753E-3</c:v>
                        </c:pt>
                        <c:pt idx="1">
                          <c:v>5.9058635605605207E-3</c:v>
                        </c:pt>
                        <c:pt idx="2">
                          <c:v>1.2443266790205359E-2</c:v>
                        </c:pt>
                        <c:pt idx="3">
                          <c:v>1.8689577075797909E-2</c:v>
                        </c:pt>
                        <c:pt idx="4">
                          <c:v>2.4056807230229554E-2</c:v>
                        </c:pt>
                        <c:pt idx="5">
                          <c:v>2.8145500549526949E-2</c:v>
                        </c:pt>
                        <c:pt idx="6">
                          <c:v>3.1058334656372494E-2</c:v>
                        </c:pt>
                        <c:pt idx="7">
                          <c:v>3.3137045742528272E-2</c:v>
                        </c:pt>
                        <c:pt idx="8">
                          <c:v>3.5231873285662171E-2</c:v>
                        </c:pt>
                        <c:pt idx="9">
                          <c:v>3.6907062415799344E-2</c:v>
                        </c:pt>
                        <c:pt idx="10">
                          <c:v>3.8947362239238524E-2</c:v>
                        </c:pt>
                        <c:pt idx="11">
                          <c:v>4.0664381185373411E-2</c:v>
                        </c:pt>
                        <c:pt idx="12">
                          <c:v>4.2923699448660903E-2</c:v>
                        </c:pt>
                        <c:pt idx="13">
                          <c:v>4.4328944931362642E-2</c:v>
                        </c:pt>
                        <c:pt idx="14">
                          <c:v>4.5953638563114588E-2</c:v>
                        </c:pt>
                        <c:pt idx="15">
                          <c:v>4.7627688375047557E-2</c:v>
                        </c:pt>
                      </c:numCache>
                    </c:numRef>
                  </c:minus>
                  <c:spPr>
                    <a:noFill/>
                    <a:ln w="9525" cap="flat" cmpd="sng" algn="ctr">
                      <a:solidFill>
                        <a:schemeClr val="tx1">
                          <a:lumMod val="65000"/>
                          <a:lumOff val="35000"/>
                        </a:schemeClr>
                      </a:solidFill>
                      <a:round/>
                    </a:ln>
                    <a:effectLst/>
                  </c:spPr>
                </c:errBars>
                <c:xVal>
                  <c:numRef>
                    <c:extLst xmlns:c15="http://schemas.microsoft.com/office/drawing/2012/chart">
                      <c:ext xmlns:c15="http://schemas.microsoft.com/office/drawing/2012/chart" uri="{02D57815-91ED-43cb-92C2-25804820EDAC}">
                        <c15:formulaRef>
                          <c15:sqref>'[DataAnalysis_CalibrationCurve_XanthineTest-All.xlsx]1 Xerogel'!$A$3:$A$18</c15:sqref>
                        </c15:formulaRef>
                      </c:ext>
                    </c:extLst>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extLst xmlns:c15="http://schemas.microsoft.com/office/drawing/2012/chart">
                      <c:ext xmlns:c15="http://schemas.microsoft.com/office/drawing/2012/chart" uri="{02D57815-91ED-43cb-92C2-25804820EDAC}">
                        <c15:formulaRef>
                          <c15:sqref>'[DataAnalysis_CalibrationCurve_XanthineTest-All.xlsx]1 Xerogel'!$H$3:$H$18</c15:sqref>
                        </c15:formulaRef>
                      </c:ext>
                    </c:extLst>
                    <c:numCache>
                      <c:formatCode>General</c:formatCode>
                      <c:ptCount val="16"/>
                      <c:pt idx="0">
                        <c:v>3.1685576923076927E-2</c:v>
                      </c:pt>
                      <c:pt idx="1">
                        <c:v>6.1997403846153841E-2</c:v>
                      </c:pt>
                      <c:pt idx="2">
                        <c:v>8.9240961538461547E-2</c:v>
                      </c:pt>
                      <c:pt idx="3">
                        <c:v>0.11741596153846154</c:v>
                      </c:pt>
                      <c:pt idx="4">
                        <c:v>0.14385673076923078</c:v>
                      </c:pt>
                      <c:pt idx="5">
                        <c:v>0.16806153846153848</c:v>
                      </c:pt>
                      <c:pt idx="6">
                        <c:v>0.18879711538461538</c:v>
                      </c:pt>
                      <c:pt idx="7">
                        <c:v>0.2068932692307692</c:v>
                      </c:pt>
                      <c:pt idx="8">
                        <c:v>0.22360865384615386</c:v>
                      </c:pt>
                      <c:pt idx="9">
                        <c:v>0.23844326923076922</c:v>
                      </c:pt>
                      <c:pt idx="10">
                        <c:v>0.25410288461538461</c:v>
                      </c:pt>
                      <c:pt idx="11">
                        <c:v>0.26795673076923077</c:v>
                      </c:pt>
                      <c:pt idx="12">
                        <c:v>0.28231923076923077</c:v>
                      </c:pt>
                      <c:pt idx="13">
                        <c:v>0.29610096153846155</c:v>
                      </c:pt>
                      <c:pt idx="14">
                        <c:v>0.3080298076923077</c:v>
                      </c:pt>
                      <c:pt idx="15">
                        <c:v>0.31980673076923083</c:v>
                      </c:pt>
                    </c:numCache>
                  </c:numRef>
                </c:yVal>
                <c:smooth val="0"/>
                <c:extLst xmlns:c15="http://schemas.microsoft.com/office/drawing/2012/chart">
                  <c:ext xmlns:c16="http://schemas.microsoft.com/office/drawing/2014/chart" uri="{C3380CC4-5D6E-409C-BE32-E72D297353CC}">
                    <c16:uniqueId val="{00000005-3C08-447B-81EF-68ADB3A125B1}"/>
                  </c:ext>
                </c:extLst>
              </c15:ser>
            </c15:filteredScatterSeries>
            <c15:filteredScatterSeries>
              <c15:ser>
                <c:idx val="5"/>
                <c:order val="5"/>
                <c:tx>
                  <c:strRef>
                    <c:extLst xmlns:c15="http://schemas.microsoft.com/office/drawing/2012/chart">
                      <c:ext xmlns:c15="http://schemas.microsoft.com/office/drawing/2012/chart" uri="{02D57815-91ED-43cb-92C2-25804820EDAC}">
                        <c15:formulaRef>
                          <c15:sqref>'[DataAnalysis_CalibrationCurve_XanthineTest-All.xlsx]1 Xerogel'!$L$1</c15:sqref>
                        </c15:formulaRef>
                      </c:ext>
                    </c:extLst>
                    <c:strCache>
                      <c:ptCount val="1"/>
                      <c:pt idx="0">
                        <c:v>Pt / HMTES 1-C4MPC+Xox / HMTES 2 / 75.25PU (n=4)</c:v>
                      </c:pt>
                    </c:strCache>
                  </c:strRef>
                </c:tx>
                <c:spPr>
                  <a:ln w="25400" cap="rnd">
                    <a:noFill/>
                    <a:round/>
                  </a:ln>
                  <a:effectLst/>
                </c:spPr>
                <c:marker>
                  <c:symbol val="diamond"/>
                  <c:size val="10"/>
                  <c:spPr>
                    <a:noFill/>
                    <a:ln w="19050">
                      <a:solidFill>
                        <a:srgbClr val="00B050"/>
                      </a:solid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extLst xmlns:c15="http://schemas.microsoft.com/office/drawing/2012/chart">
                        <c:ext xmlns:c15="http://schemas.microsoft.com/office/drawing/2012/chart" uri="{02D57815-91ED-43cb-92C2-25804820EDAC}">
                          <c15:formulaRef>
                            <c15:sqref>'[DataAnalysis_CalibrationCurve_XanthineTest-All.xlsx]1 Xerogel'!$M$3:$M$18</c15:sqref>
                          </c15:formulaRef>
                        </c:ext>
                      </c:extLst>
                      <c:numCache>
                        <c:formatCode>General</c:formatCode>
                        <c:ptCount val="16"/>
                        <c:pt idx="0">
                          <c:v>8.7958911562582495E-3</c:v>
                        </c:pt>
                        <c:pt idx="1">
                          <c:v>6.3014639199567603E-3</c:v>
                        </c:pt>
                        <c:pt idx="2">
                          <c:v>9.0018839798886845E-3</c:v>
                        </c:pt>
                        <c:pt idx="3">
                          <c:v>1.389712036317455E-2</c:v>
                        </c:pt>
                        <c:pt idx="4">
                          <c:v>1.8859831117564077E-2</c:v>
                        </c:pt>
                        <c:pt idx="5">
                          <c:v>2.4093659984111587E-2</c:v>
                        </c:pt>
                        <c:pt idx="6">
                          <c:v>3.0542327469568895E-2</c:v>
                        </c:pt>
                        <c:pt idx="7">
                          <c:v>3.5326958390892581E-2</c:v>
                        </c:pt>
                        <c:pt idx="8">
                          <c:v>4.1172308044414289E-2</c:v>
                        </c:pt>
                        <c:pt idx="9">
                          <c:v>4.6105134176531185E-2</c:v>
                        </c:pt>
                        <c:pt idx="10">
                          <c:v>5.1735655033311664E-2</c:v>
                        </c:pt>
                        <c:pt idx="11">
                          <c:v>5.6361670306019476E-2</c:v>
                        </c:pt>
                        <c:pt idx="12">
                          <c:v>5.9796705891737072E-2</c:v>
                        </c:pt>
                        <c:pt idx="13">
                          <c:v>6.485446208600805E-2</c:v>
                        </c:pt>
                        <c:pt idx="14">
                          <c:v>6.7936171386404745E-2</c:v>
                        </c:pt>
                        <c:pt idx="15">
                          <c:v>7.2151544233686776E-2</c:v>
                        </c:pt>
                      </c:numCache>
                    </c:numRef>
                  </c:plus>
                  <c:minus>
                    <c:numRef>
                      <c:extLst xmlns:c15="http://schemas.microsoft.com/office/drawing/2012/chart">
                        <c:ext xmlns:c15="http://schemas.microsoft.com/office/drawing/2012/chart" uri="{02D57815-91ED-43cb-92C2-25804820EDAC}">
                          <c15:formulaRef>
                            <c15:sqref>'[DataAnalysis_CalibrationCurve_XanthineTest-All.xlsx]1 Xerogel'!$M$3:$M$18</c15:sqref>
                          </c15:formulaRef>
                        </c:ext>
                      </c:extLst>
                      <c:numCache>
                        <c:formatCode>General</c:formatCode>
                        <c:ptCount val="16"/>
                        <c:pt idx="0">
                          <c:v>8.7958911562582495E-3</c:v>
                        </c:pt>
                        <c:pt idx="1">
                          <c:v>6.3014639199567603E-3</c:v>
                        </c:pt>
                        <c:pt idx="2">
                          <c:v>9.0018839798886845E-3</c:v>
                        </c:pt>
                        <c:pt idx="3">
                          <c:v>1.389712036317455E-2</c:v>
                        </c:pt>
                        <c:pt idx="4">
                          <c:v>1.8859831117564077E-2</c:v>
                        </c:pt>
                        <c:pt idx="5">
                          <c:v>2.4093659984111587E-2</c:v>
                        </c:pt>
                        <c:pt idx="6">
                          <c:v>3.0542327469568895E-2</c:v>
                        </c:pt>
                        <c:pt idx="7">
                          <c:v>3.5326958390892581E-2</c:v>
                        </c:pt>
                        <c:pt idx="8">
                          <c:v>4.1172308044414289E-2</c:v>
                        </c:pt>
                        <c:pt idx="9">
                          <c:v>4.6105134176531185E-2</c:v>
                        </c:pt>
                        <c:pt idx="10">
                          <c:v>5.1735655033311664E-2</c:v>
                        </c:pt>
                        <c:pt idx="11">
                          <c:v>5.6361670306019476E-2</c:v>
                        </c:pt>
                        <c:pt idx="12">
                          <c:v>5.9796705891737072E-2</c:v>
                        </c:pt>
                        <c:pt idx="13">
                          <c:v>6.485446208600805E-2</c:v>
                        </c:pt>
                        <c:pt idx="14">
                          <c:v>6.7936171386404745E-2</c:v>
                        </c:pt>
                        <c:pt idx="15">
                          <c:v>7.2151544233686776E-2</c:v>
                        </c:pt>
                      </c:numCache>
                    </c:numRef>
                  </c:minus>
                  <c:spPr>
                    <a:noFill/>
                    <a:ln w="9525" cap="flat" cmpd="sng" algn="ctr">
                      <a:solidFill>
                        <a:schemeClr val="tx1">
                          <a:lumMod val="65000"/>
                          <a:lumOff val="35000"/>
                        </a:schemeClr>
                      </a:solidFill>
                      <a:round/>
                    </a:ln>
                    <a:effectLst/>
                  </c:spPr>
                </c:errBars>
                <c:xVal>
                  <c:numRef>
                    <c:extLst xmlns:c15="http://schemas.microsoft.com/office/drawing/2012/chart">
                      <c:ext xmlns:c15="http://schemas.microsoft.com/office/drawing/2012/chart" uri="{02D57815-91ED-43cb-92C2-25804820EDAC}">
                        <c15:formulaRef>
                          <c15:sqref>'[DataAnalysis_CalibrationCurve_XanthineTest-All.xlsx]1 Xerogel'!$A$3:$A$18</c15:sqref>
                        </c15:formulaRef>
                      </c:ext>
                    </c:extLst>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extLst xmlns:c15="http://schemas.microsoft.com/office/drawing/2012/chart">
                      <c:ext xmlns:c15="http://schemas.microsoft.com/office/drawing/2012/chart" uri="{02D57815-91ED-43cb-92C2-25804820EDAC}">
                        <c15:formulaRef>
                          <c15:sqref>'[DataAnalysis_CalibrationCurve_XanthineTest-All.xlsx]1 Xerogel'!$L$3:$L$18</c15:sqref>
                        </c15:formulaRef>
                      </c:ext>
                    </c:extLst>
                    <c:numCache>
                      <c:formatCode>General</c:formatCode>
                      <c:ptCount val="16"/>
                      <c:pt idx="0">
                        <c:v>6.0466346153846148E-2</c:v>
                      </c:pt>
                      <c:pt idx="1">
                        <c:v>9.7307307692307693E-2</c:v>
                      </c:pt>
                      <c:pt idx="2">
                        <c:v>0.13250384615384614</c:v>
                      </c:pt>
                      <c:pt idx="3">
                        <c:v>0.16365288461538458</c:v>
                      </c:pt>
                      <c:pt idx="4">
                        <c:v>0.19639038461538463</c:v>
                      </c:pt>
                      <c:pt idx="5">
                        <c:v>0.2289278846153846</c:v>
                      </c:pt>
                      <c:pt idx="6">
                        <c:v>0.26613846153846149</c:v>
                      </c:pt>
                      <c:pt idx="7">
                        <c:v>0.29458653846153848</c:v>
                      </c:pt>
                      <c:pt idx="8">
                        <c:v>0.32884038461538462</c:v>
                      </c:pt>
                      <c:pt idx="9">
                        <c:v>0.35989038461538458</c:v>
                      </c:pt>
                      <c:pt idx="10">
                        <c:v>0.39004903846153849</c:v>
                      </c:pt>
                      <c:pt idx="11">
                        <c:v>0.41887307692307696</c:v>
                      </c:pt>
                      <c:pt idx="12">
                        <c:v>0.44465769230769236</c:v>
                      </c:pt>
                      <c:pt idx="13">
                        <c:v>0.46691923076923081</c:v>
                      </c:pt>
                      <c:pt idx="14">
                        <c:v>0.49023846153846162</c:v>
                      </c:pt>
                      <c:pt idx="15">
                        <c:v>0.51235384615384616</c:v>
                      </c:pt>
                    </c:numCache>
                  </c:numRef>
                </c:yVal>
                <c:smooth val="0"/>
                <c:extLst xmlns:c15="http://schemas.microsoft.com/office/drawing/2012/chart">
                  <c:ext xmlns:c16="http://schemas.microsoft.com/office/drawing/2014/chart" uri="{C3380CC4-5D6E-409C-BE32-E72D297353CC}">
                    <c16:uniqueId val="{00000006-3C08-447B-81EF-68ADB3A125B1}"/>
                  </c:ext>
                </c:extLst>
              </c15:ser>
            </c15:filteredScatterSeries>
            <c15:filteredScatterSeries>
              <c15:ser>
                <c:idx val="7"/>
                <c:order val="7"/>
                <c:tx>
                  <c:strRef>
                    <c:extLst xmlns:c15="http://schemas.microsoft.com/office/drawing/2012/chart">
                      <c:ext xmlns:c15="http://schemas.microsoft.com/office/drawing/2012/chart" uri="{02D57815-91ED-43cb-92C2-25804820EDAC}">
                        <c15:formulaRef>
                          <c15:sqref>'[DataAnalysis_CalibrationCurve_XanthineTest-All.xlsx]1 Xerogel'!$P$1</c15:sqref>
                        </c15:formulaRef>
                      </c:ext>
                    </c:extLst>
                    <c:strCache>
                      <c:ptCount val="1"/>
                      <c:pt idx="0">
                        <c:v>Pt / HMTES 1-C6MPC+Xox / HMTES 2 / 75.25PU (n=3)</c:v>
                      </c:pt>
                    </c:strCache>
                  </c:strRef>
                </c:tx>
                <c:spPr>
                  <a:ln w="25400" cap="rnd">
                    <a:noFill/>
                    <a:round/>
                  </a:ln>
                  <a:effectLst/>
                </c:spPr>
                <c:marker>
                  <c:symbol val="triangle"/>
                  <c:size val="10"/>
                  <c:spPr>
                    <a:noFill/>
                    <a:ln w="19050">
                      <a:solidFill>
                        <a:srgbClr val="7030A0"/>
                      </a:solidFill>
                    </a:ln>
                    <a:effectLst/>
                  </c:spPr>
                </c:marker>
                <c:errBars>
                  <c:errDir val="x"/>
                  <c:errBarType val="both"/>
                  <c:errValType val="fixedVal"/>
                  <c:noEndCap val="0"/>
                  <c:val val="0"/>
                  <c:spPr>
                    <a:noFill/>
                    <a:ln w="9525" cap="flat" cmpd="sng" algn="ctr">
                      <a:solidFill>
                        <a:schemeClr val="tx1">
                          <a:lumMod val="65000"/>
                          <a:lumOff val="35000"/>
                        </a:schemeClr>
                      </a:solidFill>
                      <a:round/>
                    </a:ln>
                    <a:effectLst/>
                  </c:spPr>
                </c:errBars>
                <c:errBars>
                  <c:errDir val="y"/>
                  <c:errBarType val="both"/>
                  <c:errValType val="cust"/>
                  <c:noEndCap val="0"/>
                  <c:plus>
                    <c:numRef>
                      <c:extLst xmlns:c15="http://schemas.microsoft.com/office/drawing/2012/chart">
                        <c:ext xmlns:c15="http://schemas.microsoft.com/office/drawing/2012/chart" uri="{02D57815-91ED-43cb-92C2-25804820EDAC}">
                          <c15:formulaRef>
                            <c15:sqref>'[DataAnalysis_CalibrationCurve_XanthineTest-All.xlsx]1 Xerogel'!$Q$3:$Q$18</c15:sqref>
                          </c15:formulaRef>
                        </c:ext>
                      </c:extLst>
                      <c:numCache>
                        <c:formatCode>General</c:formatCode>
                        <c:ptCount val="16"/>
                        <c:pt idx="0">
                          <c:v>6.0213082850268888E-3</c:v>
                        </c:pt>
                        <c:pt idx="1">
                          <c:v>4.3915776588070651E-3</c:v>
                        </c:pt>
                        <c:pt idx="2">
                          <c:v>1.1674995260527276E-2</c:v>
                        </c:pt>
                        <c:pt idx="3">
                          <c:v>1.889721901056695E-2</c:v>
                        </c:pt>
                        <c:pt idx="4">
                          <c:v>2.6813957192725852E-2</c:v>
                        </c:pt>
                        <c:pt idx="5">
                          <c:v>3.6944623916522867E-2</c:v>
                        </c:pt>
                        <c:pt idx="6">
                          <c:v>4.5341370737256491E-2</c:v>
                        </c:pt>
                        <c:pt idx="7">
                          <c:v>5.4146536291191774E-2</c:v>
                        </c:pt>
                        <c:pt idx="8">
                          <c:v>6.343687832010636E-2</c:v>
                        </c:pt>
                        <c:pt idx="9">
                          <c:v>7.289177047056361E-2</c:v>
                        </c:pt>
                        <c:pt idx="10">
                          <c:v>8.167392042139289E-2</c:v>
                        </c:pt>
                        <c:pt idx="11">
                          <c:v>9.2897209818168291E-2</c:v>
                        </c:pt>
                        <c:pt idx="12">
                          <c:v>0.10317909695928461</c:v>
                        </c:pt>
                        <c:pt idx="13">
                          <c:v>0.11356561209421358</c:v>
                        </c:pt>
                        <c:pt idx="14">
                          <c:v>0.12376732314037217</c:v>
                        </c:pt>
                        <c:pt idx="15">
                          <c:v>0.13417439326861105</c:v>
                        </c:pt>
                      </c:numCache>
                    </c:numRef>
                  </c:plus>
                  <c:minus>
                    <c:numRef>
                      <c:extLst xmlns:c15="http://schemas.microsoft.com/office/drawing/2012/chart">
                        <c:ext xmlns:c15="http://schemas.microsoft.com/office/drawing/2012/chart" uri="{02D57815-91ED-43cb-92C2-25804820EDAC}">
                          <c15:formulaRef>
                            <c15:sqref>'[DataAnalysis_CalibrationCurve_XanthineTest-All.xlsx]1 Xerogel'!$Q$3:$Q$18</c15:sqref>
                          </c15:formulaRef>
                        </c:ext>
                      </c:extLst>
                      <c:numCache>
                        <c:formatCode>General</c:formatCode>
                        <c:ptCount val="16"/>
                        <c:pt idx="0">
                          <c:v>6.0213082850268888E-3</c:v>
                        </c:pt>
                        <c:pt idx="1">
                          <c:v>4.3915776588070651E-3</c:v>
                        </c:pt>
                        <c:pt idx="2">
                          <c:v>1.1674995260527276E-2</c:v>
                        </c:pt>
                        <c:pt idx="3">
                          <c:v>1.889721901056695E-2</c:v>
                        </c:pt>
                        <c:pt idx="4">
                          <c:v>2.6813957192725852E-2</c:v>
                        </c:pt>
                        <c:pt idx="5">
                          <c:v>3.6944623916522867E-2</c:v>
                        </c:pt>
                        <c:pt idx="6">
                          <c:v>4.5341370737256491E-2</c:v>
                        </c:pt>
                        <c:pt idx="7">
                          <c:v>5.4146536291191774E-2</c:v>
                        </c:pt>
                        <c:pt idx="8">
                          <c:v>6.343687832010636E-2</c:v>
                        </c:pt>
                        <c:pt idx="9">
                          <c:v>7.289177047056361E-2</c:v>
                        </c:pt>
                        <c:pt idx="10">
                          <c:v>8.167392042139289E-2</c:v>
                        </c:pt>
                        <c:pt idx="11">
                          <c:v>9.2897209818168291E-2</c:v>
                        </c:pt>
                        <c:pt idx="12">
                          <c:v>0.10317909695928461</c:v>
                        </c:pt>
                        <c:pt idx="13">
                          <c:v>0.11356561209421358</c:v>
                        </c:pt>
                        <c:pt idx="14">
                          <c:v>0.12376732314037217</c:v>
                        </c:pt>
                        <c:pt idx="15">
                          <c:v>0.13417439326861105</c:v>
                        </c:pt>
                      </c:numCache>
                    </c:numRef>
                  </c:minus>
                  <c:spPr>
                    <a:noFill/>
                    <a:ln w="9525" cap="flat" cmpd="sng" algn="ctr">
                      <a:solidFill>
                        <a:schemeClr val="tx1">
                          <a:lumMod val="65000"/>
                          <a:lumOff val="35000"/>
                        </a:schemeClr>
                      </a:solidFill>
                      <a:round/>
                    </a:ln>
                    <a:effectLst/>
                  </c:spPr>
                </c:errBars>
                <c:xVal>
                  <c:numRef>
                    <c:extLst xmlns:c15="http://schemas.microsoft.com/office/drawing/2012/chart">
                      <c:ext xmlns:c15="http://schemas.microsoft.com/office/drawing/2012/chart" uri="{02D57815-91ED-43cb-92C2-25804820EDAC}">
                        <c15:formulaRef>
                          <c15:sqref>'[DataAnalysis_CalibrationCurve_XanthineTest-All.xlsx]1 Xerogel'!$A$3:$A$18</c15:sqref>
                        </c15:formulaRef>
                      </c:ext>
                    </c:extLst>
                    <c:numCache>
                      <c:formatCode>0.00</c:formatCode>
                      <c:ptCount val="16"/>
                      <c:pt idx="0" formatCode="General">
                        <c:v>0</c:v>
                      </c:pt>
                      <c:pt idx="1">
                        <c:v>40.278980268249661</c:v>
                      </c:pt>
                      <c:pt idx="2">
                        <c:v>80.517761953397269</c:v>
                      </c:pt>
                      <c:pt idx="3">
                        <c:v>120.71642521213894</c:v>
                      </c:pt>
                      <c:pt idx="4">
                        <c:v>160.87504996165876</c:v>
                      </c:pt>
                      <c:pt idx="5">
                        <c:v>200.99371588058204</c:v>
                      </c:pt>
                      <c:pt idx="6">
                        <c:v>241.07250240992391</c:v>
                      </c:pt>
                      <c:pt idx="7">
                        <c:v>281.11148875403308</c:v>
                      </c:pt>
                      <c:pt idx="8">
                        <c:v>321.11075388153097</c:v>
                      </c:pt>
                      <c:pt idx="9">
                        <c:v>361.07037652624643</c:v>
                      </c:pt>
                      <c:pt idx="10">
                        <c:v>400.99043518814534</c:v>
                      </c:pt>
                      <c:pt idx="11">
                        <c:v>440.87100813425604</c:v>
                      </c:pt>
                      <c:pt idx="12">
                        <c:v>480.71217339958991</c:v>
                      </c:pt>
                      <c:pt idx="13">
                        <c:v>520.51400878805771</c:v>
                      </c:pt>
                      <c:pt idx="14">
                        <c:v>560.27659187338111</c:v>
                      </c:pt>
                      <c:pt idx="15" formatCode="General">
                        <c:v>599.99999999999977</c:v>
                      </c:pt>
                    </c:numCache>
                  </c:numRef>
                </c:xVal>
                <c:yVal>
                  <c:numRef>
                    <c:extLst xmlns:c15="http://schemas.microsoft.com/office/drawing/2012/chart">
                      <c:ext xmlns:c15="http://schemas.microsoft.com/office/drawing/2012/chart" uri="{02D57815-91ED-43cb-92C2-25804820EDAC}">
                        <c15:formulaRef>
                          <c15:sqref>'[DataAnalysis_CalibrationCurve_XanthineTest-All.xlsx]1 Xerogel'!$P$3:$P$18</c15:sqref>
                        </c15:formulaRef>
                      </c:ext>
                    </c:extLst>
                    <c:numCache>
                      <c:formatCode>General</c:formatCode>
                      <c:ptCount val="16"/>
                      <c:pt idx="0">
                        <c:v>6.8012833333333342E-2</c:v>
                      </c:pt>
                      <c:pt idx="1">
                        <c:v>0.11858933333333331</c:v>
                      </c:pt>
                      <c:pt idx="2">
                        <c:v>0.16017166666666668</c:v>
                      </c:pt>
                      <c:pt idx="3">
                        <c:v>0.19868066666666664</c:v>
                      </c:pt>
                      <c:pt idx="4">
                        <c:v>0.2377006666666667</c:v>
                      </c:pt>
                      <c:pt idx="5">
                        <c:v>0.27632733333333337</c:v>
                      </c:pt>
                      <c:pt idx="6">
                        <c:v>0.31523233333333334</c:v>
                      </c:pt>
                      <c:pt idx="7">
                        <c:v>0.35497533333333336</c:v>
                      </c:pt>
                      <c:pt idx="8">
                        <c:v>0.395403</c:v>
                      </c:pt>
                      <c:pt idx="9">
                        <c:v>0.43571933333333335</c:v>
                      </c:pt>
                      <c:pt idx="10">
                        <c:v>0.47551500000000013</c:v>
                      </c:pt>
                      <c:pt idx="11">
                        <c:v>0.51044653465346534</c:v>
                      </c:pt>
                      <c:pt idx="12">
                        <c:v>0.55067133333333318</c:v>
                      </c:pt>
                      <c:pt idx="13">
                        <c:v>0.58905533333333326</c:v>
                      </c:pt>
                      <c:pt idx="14">
                        <c:v>0.62812833333333351</c:v>
                      </c:pt>
                      <c:pt idx="15">
                        <c:v>0.66651800000000005</c:v>
                      </c:pt>
                    </c:numCache>
                  </c:numRef>
                </c:yVal>
                <c:smooth val="0"/>
                <c:extLst xmlns:c15="http://schemas.microsoft.com/office/drawing/2012/chart">
                  <c:ext xmlns:c16="http://schemas.microsoft.com/office/drawing/2014/chart" uri="{C3380CC4-5D6E-409C-BE32-E72D297353CC}">
                    <c16:uniqueId val="{00000007-3C08-447B-81EF-68ADB3A125B1}"/>
                  </c:ext>
                </c:extLst>
              </c15:ser>
            </c15:filteredScatterSeries>
          </c:ext>
        </c:extLst>
      </c:scatterChart>
      <c:valAx>
        <c:axId val="975122127"/>
        <c:scaling>
          <c:orientation val="minMax"/>
          <c:max val="620"/>
          <c:min val="0"/>
        </c:scaling>
        <c:delete val="0"/>
        <c:axPos val="b"/>
        <c:title>
          <c:tx>
            <c:rich>
              <a:bodyPr rot="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r>
                  <a:rPr lang="en-US" sz="1600" b="1" dirty="0"/>
                  <a:t>Xanthine</a:t>
                </a:r>
                <a:r>
                  <a:rPr lang="en-US" sz="1600" b="1" baseline="0" dirty="0"/>
                  <a:t> </a:t>
                </a:r>
                <a:r>
                  <a:rPr lang="en-US" sz="1600" b="1" dirty="0"/>
                  <a:t>Concentration (</a:t>
                </a:r>
                <a:r>
                  <a:rPr lang="el-GR" sz="1600" b="1" dirty="0"/>
                  <a:t>μ</a:t>
                </a:r>
                <a:r>
                  <a:rPr lang="en-US" sz="1600" b="1" dirty="0"/>
                  <a:t>M)</a:t>
                </a:r>
              </a:p>
            </c:rich>
          </c:tx>
          <c:layout>
            <c:manualLayout>
              <c:xMode val="edge"/>
              <c:yMode val="edge"/>
              <c:x val="0.31871755613881597"/>
              <c:y val="0.93785395908587665"/>
            </c:manualLayout>
          </c:layout>
          <c:overlay val="0"/>
          <c:spPr>
            <a:noFill/>
            <a:ln>
              <a:noFill/>
            </a:ln>
            <a:effectLst/>
          </c:spPr>
          <c:txPr>
            <a:bodyPr rot="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98867487"/>
        <c:crosses val="autoZero"/>
        <c:crossBetween val="midCat"/>
        <c:majorUnit val="50"/>
      </c:valAx>
      <c:valAx>
        <c:axId val="298867487"/>
        <c:scaling>
          <c:orientation val="minMax"/>
          <c:max val="1.7000000000000002"/>
          <c:min val="0"/>
        </c:scaling>
        <c:delete val="0"/>
        <c:axPos val="l"/>
        <c:title>
          <c:tx>
            <c:rich>
              <a:bodyPr rot="-54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r>
                  <a:rPr lang="en-US" sz="1600" b="1"/>
                  <a:t>Current (</a:t>
                </a:r>
                <a:r>
                  <a:rPr lang="el-GR" sz="1600" b="1"/>
                  <a:t>μ</a:t>
                </a:r>
                <a:r>
                  <a:rPr lang="en-US" sz="1600" b="1"/>
                  <a:t>A)</a:t>
                </a:r>
              </a:p>
            </c:rich>
          </c:tx>
          <c:layout>
            <c:manualLayout>
              <c:xMode val="edge"/>
              <c:yMode val="edge"/>
              <c:x val="1.3072536429298036E-3"/>
              <c:y val="0.29311008177909548"/>
            </c:manualLayout>
          </c:layout>
          <c:overlay val="0"/>
          <c:spPr>
            <a:noFill/>
            <a:ln>
              <a:noFill/>
            </a:ln>
            <a:effectLst/>
          </c:spPr>
          <c:txPr>
            <a:bodyPr rot="-54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75122127"/>
        <c:crosses val="autoZero"/>
        <c:crossBetween val="midCat"/>
        <c:majorUnit val="0.30000000000000004"/>
      </c:valAx>
      <c:spPr>
        <a:noFill/>
        <a:ln>
          <a:noFill/>
        </a:ln>
        <a:effectLst/>
      </c:spPr>
    </c:plotArea>
    <c:legend>
      <c:legendPos val="b"/>
      <c:layout>
        <c:manualLayout>
          <c:xMode val="edge"/>
          <c:yMode val="edge"/>
          <c:x val="0.10285258092738407"/>
          <c:y val="1.8190112698982751E-3"/>
          <c:w val="0.56841119860017508"/>
          <c:h val="0.23846064725658281"/>
        </c:manualLayout>
      </c:layout>
      <c:overlay val="0"/>
      <c:spPr>
        <a:noFill/>
        <a:ln>
          <a:noFill/>
        </a:ln>
        <a:effectLst/>
      </c:spPr>
      <c:txPr>
        <a:bodyPr rot="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733958042006261"/>
          <c:y val="0.11321816857910463"/>
          <c:w val="0.81553552491215719"/>
          <c:h val="0.6454636302006177"/>
        </c:manualLayout>
      </c:layout>
      <c:scatterChart>
        <c:scatterStyle val="lineMarker"/>
        <c:varyColors val="0"/>
        <c:ser>
          <c:idx val="0"/>
          <c:order val="0"/>
          <c:tx>
            <c:v>Day 1</c:v>
          </c:tx>
          <c:spPr>
            <a:ln w="19050" cap="rnd">
              <a:noFill/>
              <a:round/>
            </a:ln>
            <a:effectLst/>
          </c:spPr>
          <c:marker>
            <c:symbol val="circle"/>
            <c:size val="5"/>
            <c:spPr>
              <a:solidFill>
                <a:schemeClr val="accent1"/>
              </a:solidFill>
              <a:ln w="9525">
                <a:solidFill>
                  <a:schemeClr val="accent1"/>
                </a:solidFill>
              </a:ln>
              <a:effectLst/>
            </c:spPr>
          </c:marker>
          <c:errBars>
            <c:errDir val="x"/>
            <c:errBarType val="both"/>
            <c:errValType val="cust"/>
            <c:noEndCap val="0"/>
            <c:plus>
              <c:numRef>
                <c:f>All!$C$23:$C$38</c:f>
                <c:numCache>
                  <c:formatCode>General</c:formatCode>
                  <c:ptCount val="16"/>
                  <c:pt idx="0">
                    <c:v>2.0969693059999998E-3</c:v>
                  </c:pt>
                  <c:pt idx="1">
                    <c:v>6.1181736769999997E-3</c:v>
                  </c:pt>
                  <c:pt idx="2">
                    <c:v>1.5926794349999999E-2</c:v>
                  </c:pt>
                  <c:pt idx="3">
                    <c:v>2.7879390810000002E-2</c:v>
                  </c:pt>
                  <c:pt idx="4">
                    <c:v>4.1567103209999998E-2</c:v>
                  </c:pt>
                  <c:pt idx="5">
                    <c:v>5.6047530310000003E-2</c:v>
                  </c:pt>
                  <c:pt idx="6">
                    <c:v>6.9217637200000001E-2</c:v>
                  </c:pt>
                  <c:pt idx="7">
                    <c:v>7.8117331109999993E-2</c:v>
                  </c:pt>
                  <c:pt idx="8">
                    <c:v>8.2325861449999996E-2</c:v>
                  </c:pt>
                  <c:pt idx="9">
                    <c:v>8.2717582780000007E-2</c:v>
                  </c:pt>
                  <c:pt idx="10">
                    <c:v>8.1867418959999994E-2</c:v>
                  </c:pt>
                  <c:pt idx="11">
                    <c:v>8.0252069960000005E-2</c:v>
                  </c:pt>
                  <c:pt idx="12">
                    <c:v>7.8603567959999995E-2</c:v>
                  </c:pt>
                  <c:pt idx="13">
                    <c:v>7.8404089529999998E-2</c:v>
                  </c:pt>
                  <c:pt idx="14">
                    <c:v>7.6291481549999998E-2</c:v>
                  </c:pt>
                  <c:pt idx="15">
                    <c:v>7.7305305029999993E-2</c:v>
                  </c:pt>
                </c:numCache>
              </c:numRef>
            </c:plus>
            <c:minus>
              <c:numRef>
                <c:f>All!$C$23:$C$38</c:f>
                <c:numCache>
                  <c:formatCode>General</c:formatCode>
                  <c:ptCount val="16"/>
                  <c:pt idx="0">
                    <c:v>2.0969693059999998E-3</c:v>
                  </c:pt>
                  <c:pt idx="1">
                    <c:v>6.1181736769999997E-3</c:v>
                  </c:pt>
                  <c:pt idx="2">
                    <c:v>1.5926794349999999E-2</c:v>
                  </c:pt>
                  <c:pt idx="3">
                    <c:v>2.7879390810000002E-2</c:v>
                  </c:pt>
                  <c:pt idx="4">
                    <c:v>4.1567103209999998E-2</c:v>
                  </c:pt>
                  <c:pt idx="5">
                    <c:v>5.6047530310000003E-2</c:v>
                  </c:pt>
                  <c:pt idx="6">
                    <c:v>6.9217637200000001E-2</c:v>
                  </c:pt>
                  <c:pt idx="7">
                    <c:v>7.8117331109999993E-2</c:v>
                  </c:pt>
                  <c:pt idx="8">
                    <c:v>8.2325861449999996E-2</c:v>
                  </c:pt>
                  <c:pt idx="9">
                    <c:v>8.2717582780000007E-2</c:v>
                  </c:pt>
                  <c:pt idx="10">
                    <c:v>8.1867418959999994E-2</c:v>
                  </c:pt>
                  <c:pt idx="11">
                    <c:v>8.0252069960000005E-2</c:v>
                  </c:pt>
                  <c:pt idx="12">
                    <c:v>7.8603567959999995E-2</c:v>
                  </c:pt>
                  <c:pt idx="13">
                    <c:v>7.8404089529999998E-2</c:v>
                  </c:pt>
                  <c:pt idx="14">
                    <c:v>7.6291481549999998E-2</c:v>
                  </c:pt>
                  <c:pt idx="15">
                    <c:v>7.7305305029999993E-2</c:v>
                  </c:pt>
                </c:numCache>
              </c:numRef>
            </c:minus>
            <c:spPr>
              <a:noFill/>
              <a:ln w="9525" cap="flat" cmpd="sng" algn="ctr">
                <a:solidFill>
                  <a:schemeClr val="tx1">
                    <a:lumMod val="65000"/>
                    <a:lumOff val="35000"/>
                  </a:schemeClr>
                </a:solidFill>
                <a:round/>
              </a:ln>
              <a:effectLst/>
            </c:spPr>
          </c:errBars>
          <c:errBars>
            <c:errDir val="y"/>
            <c:errBarType val="both"/>
            <c:errValType val="percentage"/>
            <c:noEndCap val="0"/>
            <c:val val="5"/>
            <c:spPr>
              <a:noFill/>
              <a:ln w="9525" cap="flat" cmpd="sng" algn="ctr">
                <a:solidFill>
                  <a:schemeClr val="tx1">
                    <a:lumMod val="65000"/>
                    <a:lumOff val="35000"/>
                  </a:schemeClr>
                </a:solidFill>
                <a:round/>
              </a:ln>
              <a:effectLst/>
            </c:spPr>
          </c:errBars>
          <c:xVal>
            <c:numRef>
              <c:f>All!$B$3:$B$18</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All!$C$3:$C$18</c:f>
              <c:numCache>
                <c:formatCode>General</c:formatCode>
                <c:ptCount val="16"/>
                <c:pt idx="0">
                  <c:v>5.1999999999999998E-3</c:v>
                </c:pt>
                <c:pt idx="1">
                  <c:v>0.15129999999999999</c:v>
                </c:pt>
                <c:pt idx="2">
                  <c:v>0.27950000000000003</c:v>
                </c:pt>
                <c:pt idx="3">
                  <c:v>0.40179999999999999</c:v>
                </c:pt>
                <c:pt idx="4">
                  <c:v>0.51949999999999996</c:v>
                </c:pt>
                <c:pt idx="5">
                  <c:v>0.63239999999999996</c:v>
                </c:pt>
                <c:pt idx="6">
                  <c:v>0.74180000000000001</c:v>
                </c:pt>
                <c:pt idx="7">
                  <c:v>0.85040000000000004</c:v>
                </c:pt>
                <c:pt idx="8">
                  <c:v>0.95209999999999995</c:v>
                </c:pt>
                <c:pt idx="9">
                  <c:v>1.0542</c:v>
                </c:pt>
                <c:pt idx="10">
                  <c:v>1.1499999999999999</c:v>
                </c:pt>
                <c:pt idx="11">
                  <c:v>1.2452000000000001</c:v>
                </c:pt>
                <c:pt idx="12">
                  <c:v>1.3363</c:v>
                </c:pt>
                <c:pt idx="13">
                  <c:v>1.4068000000000001</c:v>
                </c:pt>
                <c:pt idx="14">
                  <c:v>1.4752000000000001</c:v>
                </c:pt>
                <c:pt idx="15">
                  <c:v>1.5361</c:v>
                </c:pt>
              </c:numCache>
            </c:numRef>
          </c:yVal>
          <c:smooth val="0"/>
          <c:extLst>
            <c:ext xmlns:c16="http://schemas.microsoft.com/office/drawing/2014/chart" uri="{C3380CC4-5D6E-409C-BE32-E72D297353CC}">
              <c16:uniqueId val="{00000000-2235-49B2-9AF9-43D3EE72B007}"/>
            </c:ext>
          </c:extLst>
        </c:ser>
        <c:ser>
          <c:idx val="1"/>
          <c:order val="1"/>
          <c:tx>
            <c:v>Day 3</c:v>
          </c:tx>
          <c:spPr>
            <a:ln w="19050" cap="rnd">
              <a:noFill/>
              <a:round/>
            </a:ln>
            <a:effectLst/>
          </c:spPr>
          <c:marker>
            <c:symbol val="circle"/>
            <c:size val="5"/>
            <c:spPr>
              <a:solidFill>
                <a:schemeClr val="accent2"/>
              </a:solidFill>
              <a:ln w="9525">
                <a:solidFill>
                  <a:schemeClr val="accent2"/>
                </a:solidFill>
              </a:ln>
              <a:effectLst/>
            </c:spPr>
          </c:marker>
          <c:errBars>
            <c:errDir val="x"/>
            <c:errBarType val="both"/>
            <c:errValType val="cust"/>
            <c:noEndCap val="0"/>
            <c:plus>
              <c:numRef>
                <c:f>All!$D$23:$D$38</c:f>
                <c:numCache>
                  <c:formatCode>General</c:formatCode>
                  <c:ptCount val="16"/>
                  <c:pt idx="0">
                    <c:v>1.325609355E-3</c:v>
                  </c:pt>
                  <c:pt idx="1">
                    <c:v>1.240425327E-2</c:v>
                  </c:pt>
                  <c:pt idx="2">
                    <c:v>2.21459221E-2</c:v>
                  </c:pt>
                  <c:pt idx="3">
                    <c:v>3.1104013900000001E-2</c:v>
                  </c:pt>
                  <c:pt idx="4">
                    <c:v>3.8657816060000003E-2</c:v>
                  </c:pt>
                  <c:pt idx="5">
                    <c:v>4.6036266989999998E-2</c:v>
                  </c:pt>
                  <c:pt idx="6">
                    <c:v>5.1404330800000002E-2</c:v>
                  </c:pt>
                  <c:pt idx="7">
                    <c:v>5.5016794180000002E-2</c:v>
                  </c:pt>
                  <c:pt idx="8">
                    <c:v>5.9553627480000003E-2</c:v>
                  </c:pt>
                  <c:pt idx="9">
                    <c:v>6.4852803860000002E-2</c:v>
                  </c:pt>
                  <c:pt idx="10">
                    <c:v>7.2303610399999996E-2</c:v>
                  </c:pt>
                  <c:pt idx="11">
                    <c:v>7.7821745139999995E-2</c:v>
                  </c:pt>
                  <c:pt idx="12">
                    <c:v>8.2403295069999993E-2</c:v>
                  </c:pt>
                  <c:pt idx="13">
                    <c:v>8.6980212500000001E-2</c:v>
                  </c:pt>
                  <c:pt idx="14">
                    <c:v>8.9897892009999994E-2</c:v>
                  </c:pt>
                  <c:pt idx="15">
                    <c:v>9.1073196410000001E-2</c:v>
                  </c:pt>
                </c:numCache>
              </c:numRef>
            </c:plus>
            <c:minus>
              <c:numRef>
                <c:f>All!$D$23:$D$38</c:f>
                <c:numCache>
                  <c:formatCode>General</c:formatCode>
                  <c:ptCount val="16"/>
                  <c:pt idx="0">
                    <c:v>1.325609355E-3</c:v>
                  </c:pt>
                  <c:pt idx="1">
                    <c:v>1.240425327E-2</c:v>
                  </c:pt>
                  <c:pt idx="2">
                    <c:v>2.21459221E-2</c:v>
                  </c:pt>
                  <c:pt idx="3">
                    <c:v>3.1104013900000001E-2</c:v>
                  </c:pt>
                  <c:pt idx="4">
                    <c:v>3.8657816060000003E-2</c:v>
                  </c:pt>
                  <c:pt idx="5">
                    <c:v>4.6036266989999998E-2</c:v>
                  </c:pt>
                  <c:pt idx="6">
                    <c:v>5.1404330800000002E-2</c:v>
                  </c:pt>
                  <c:pt idx="7">
                    <c:v>5.5016794180000002E-2</c:v>
                  </c:pt>
                  <c:pt idx="8">
                    <c:v>5.9553627480000003E-2</c:v>
                  </c:pt>
                  <c:pt idx="9">
                    <c:v>6.4852803860000002E-2</c:v>
                  </c:pt>
                  <c:pt idx="10">
                    <c:v>7.2303610399999996E-2</c:v>
                  </c:pt>
                  <c:pt idx="11">
                    <c:v>7.7821745139999995E-2</c:v>
                  </c:pt>
                  <c:pt idx="12">
                    <c:v>8.2403295069999993E-2</c:v>
                  </c:pt>
                  <c:pt idx="13">
                    <c:v>8.6980212500000001E-2</c:v>
                  </c:pt>
                  <c:pt idx="14">
                    <c:v>8.9897892009999994E-2</c:v>
                  </c:pt>
                  <c:pt idx="15">
                    <c:v>9.1073196410000001E-2</c:v>
                  </c:pt>
                </c:numCache>
              </c:numRef>
            </c:minus>
            <c:spPr>
              <a:noFill/>
              <a:ln w="9525" cap="flat" cmpd="sng" algn="ctr">
                <a:solidFill>
                  <a:schemeClr val="tx1">
                    <a:lumMod val="65000"/>
                    <a:lumOff val="35000"/>
                  </a:schemeClr>
                </a:solidFill>
                <a:round/>
              </a:ln>
              <a:effectLst/>
            </c:spPr>
          </c:errBars>
          <c:errBars>
            <c:errDir val="y"/>
            <c:errBarType val="both"/>
            <c:errValType val="percentage"/>
            <c:noEndCap val="0"/>
            <c:val val="5"/>
            <c:spPr>
              <a:noFill/>
              <a:ln w="9525" cap="flat" cmpd="sng" algn="ctr">
                <a:solidFill>
                  <a:schemeClr val="tx1">
                    <a:lumMod val="65000"/>
                    <a:lumOff val="35000"/>
                  </a:schemeClr>
                </a:solidFill>
                <a:round/>
              </a:ln>
              <a:effectLst/>
            </c:spPr>
          </c:errBars>
          <c:xVal>
            <c:numRef>
              <c:f>All!$B$3:$B$18</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All!$D$3:$D$18</c:f>
              <c:numCache>
                <c:formatCode>General</c:formatCode>
                <c:ptCount val="16"/>
                <c:pt idx="0">
                  <c:v>-1.1000000000000001E-3</c:v>
                </c:pt>
                <c:pt idx="1">
                  <c:v>6.8599999999999994E-2</c:v>
                </c:pt>
                <c:pt idx="2">
                  <c:v>0.12559999999999999</c:v>
                </c:pt>
                <c:pt idx="3">
                  <c:v>0.17760000000000001</c:v>
                </c:pt>
                <c:pt idx="4">
                  <c:v>0.2248</c:v>
                </c:pt>
                <c:pt idx="5">
                  <c:v>0.26450000000000001</c:v>
                </c:pt>
                <c:pt idx="6">
                  <c:v>0.29709999999999998</c:v>
                </c:pt>
                <c:pt idx="7">
                  <c:v>0.32169999999999999</c:v>
                </c:pt>
                <c:pt idx="8">
                  <c:v>0.34100000000000003</c:v>
                </c:pt>
                <c:pt idx="9">
                  <c:v>0.35549999999999998</c:v>
                </c:pt>
                <c:pt idx="10">
                  <c:v>0.36770000000000003</c:v>
                </c:pt>
                <c:pt idx="11">
                  <c:v>0.377</c:v>
                </c:pt>
                <c:pt idx="12">
                  <c:v>0.38640000000000002</c:v>
                </c:pt>
                <c:pt idx="13">
                  <c:v>0.39319999999999999</c:v>
                </c:pt>
                <c:pt idx="14">
                  <c:v>0.3987</c:v>
                </c:pt>
                <c:pt idx="15">
                  <c:v>0.40339999999999998</c:v>
                </c:pt>
              </c:numCache>
            </c:numRef>
          </c:yVal>
          <c:smooth val="0"/>
          <c:extLst>
            <c:ext xmlns:c16="http://schemas.microsoft.com/office/drawing/2014/chart" uri="{C3380CC4-5D6E-409C-BE32-E72D297353CC}">
              <c16:uniqueId val="{00000001-2235-49B2-9AF9-43D3EE72B007}"/>
            </c:ext>
          </c:extLst>
        </c:ser>
        <c:ser>
          <c:idx val="2"/>
          <c:order val="2"/>
          <c:tx>
            <c:v>Day 5</c:v>
          </c:tx>
          <c:spPr>
            <a:ln w="25400" cap="rnd">
              <a:noFill/>
              <a:round/>
            </a:ln>
            <a:effectLst/>
          </c:spPr>
          <c:marker>
            <c:symbol val="circle"/>
            <c:size val="5"/>
            <c:spPr>
              <a:solidFill>
                <a:schemeClr val="accent3"/>
              </a:solidFill>
              <a:ln w="9525">
                <a:solidFill>
                  <a:schemeClr val="accent3"/>
                </a:solidFill>
              </a:ln>
              <a:effectLst/>
            </c:spPr>
          </c:marker>
          <c:errBars>
            <c:errDir val="x"/>
            <c:errBarType val="both"/>
            <c:errValType val="cust"/>
            <c:noEndCap val="0"/>
            <c:plus>
              <c:numRef>
                <c:f>All!$E$23:$E$38</c:f>
                <c:numCache>
                  <c:formatCode>General</c:formatCode>
                  <c:ptCount val="16"/>
                  <c:pt idx="0">
                    <c:v>8.2583291288250307E-4</c:v>
                  </c:pt>
                  <c:pt idx="1">
                    <c:v>1.1938299711432942E-2</c:v>
                  </c:pt>
                  <c:pt idx="2">
                    <c:v>2.5861805814753131E-2</c:v>
                  </c:pt>
                  <c:pt idx="3">
                    <c:v>4.1303050734782312E-2</c:v>
                  </c:pt>
                  <c:pt idx="4">
                    <c:v>5.6267601690493295E-2</c:v>
                  </c:pt>
                  <c:pt idx="5">
                    <c:v>6.9872333580609708E-2</c:v>
                  </c:pt>
                  <c:pt idx="6">
                    <c:v>8.1535495337920053E-2</c:v>
                  </c:pt>
                  <c:pt idx="7">
                    <c:v>9.1668626039665232E-2</c:v>
                  </c:pt>
                  <c:pt idx="8">
                    <c:v>9.9313428095096981E-2</c:v>
                  </c:pt>
                  <c:pt idx="9">
                    <c:v>0.10489672540170165</c:v>
                  </c:pt>
                  <c:pt idx="10">
                    <c:v>0.10854152661539275</c:v>
                  </c:pt>
                  <c:pt idx="11">
                    <c:v>0.1116736674422399</c:v>
                  </c:pt>
                  <c:pt idx="12">
                    <c:v>0.11336109561926437</c:v>
                  </c:pt>
                  <c:pt idx="13">
                    <c:v>0.11432817675446413</c:v>
                  </c:pt>
                  <c:pt idx="14">
                    <c:v>0.11474406302724335</c:v>
                  </c:pt>
                  <c:pt idx="15">
                    <c:v>0.11590815329389048</c:v>
                  </c:pt>
                </c:numCache>
              </c:numRef>
            </c:plus>
            <c:minus>
              <c:numRef>
                <c:f>All!$E$23:$E$38</c:f>
                <c:numCache>
                  <c:formatCode>General</c:formatCode>
                  <c:ptCount val="16"/>
                  <c:pt idx="0">
                    <c:v>8.2583291288250307E-4</c:v>
                  </c:pt>
                  <c:pt idx="1">
                    <c:v>1.1938299711432942E-2</c:v>
                  </c:pt>
                  <c:pt idx="2">
                    <c:v>2.5861805814753131E-2</c:v>
                  </c:pt>
                  <c:pt idx="3">
                    <c:v>4.1303050734782312E-2</c:v>
                  </c:pt>
                  <c:pt idx="4">
                    <c:v>5.6267601690493295E-2</c:v>
                  </c:pt>
                  <c:pt idx="5">
                    <c:v>6.9872333580609708E-2</c:v>
                  </c:pt>
                  <c:pt idx="6">
                    <c:v>8.1535495337920053E-2</c:v>
                  </c:pt>
                  <c:pt idx="7">
                    <c:v>9.1668626039665232E-2</c:v>
                  </c:pt>
                  <c:pt idx="8">
                    <c:v>9.9313428095096981E-2</c:v>
                  </c:pt>
                  <c:pt idx="9">
                    <c:v>0.10489672540170165</c:v>
                  </c:pt>
                  <c:pt idx="10">
                    <c:v>0.10854152661539275</c:v>
                  </c:pt>
                  <c:pt idx="11">
                    <c:v>0.1116736674422399</c:v>
                  </c:pt>
                  <c:pt idx="12">
                    <c:v>0.11336109561926437</c:v>
                  </c:pt>
                  <c:pt idx="13">
                    <c:v>0.11432817675446413</c:v>
                  </c:pt>
                  <c:pt idx="14">
                    <c:v>0.11474406302724335</c:v>
                  </c:pt>
                  <c:pt idx="15">
                    <c:v>0.11590815329389048</c:v>
                  </c:pt>
                </c:numCache>
              </c:numRef>
            </c:minus>
            <c:spPr>
              <a:noFill/>
              <a:ln w="9525" cap="flat" cmpd="sng" algn="ctr">
                <a:solidFill>
                  <a:schemeClr val="accent1"/>
                </a:solidFill>
                <a:round/>
              </a:ln>
              <a:effectLst/>
            </c:spPr>
          </c:errBars>
          <c:errBars>
            <c:errDir val="y"/>
            <c:errBarType val="both"/>
            <c:errValType val="percentage"/>
            <c:noEndCap val="0"/>
            <c:val val="5"/>
            <c:spPr>
              <a:noFill/>
              <a:ln w="9525" cap="flat" cmpd="sng" algn="ctr">
                <a:solidFill>
                  <a:schemeClr val="tx1">
                    <a:lumMod val="65000"/>
                    <a:lumOff val="35000"/>
                  </a:schemeClr>
                </a:solidFill>
                <a:round/>
              </a:ln>
              <a:effectLst/>
            </c:spPr>
          </c:errBars>
          <c:xVal>
            <c:numRef>
              <c:f>All!$B$3:$B$18</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All!$E$3:$E$18</c:f>
              <c:numCache>
                <c:formatCode>0.0000</c:formatCode>
                <c:ptCount val="16"/>
                <c:pt idx="0">
                  <c:v>-2.6199999999999999E-3</c:v>
                </c:pt>
                <c:pt idx="1">
                  <c:v>4.5740000000000003E-2</c:v>
                </c:pt>
                <c:pt idx="2">
                  <c:v>8.3740000000000009E-2</c:v>
                </c:pt>
                <c:pt idx="3">
                  <c:v>0.11481999999999999</c:v>
                </c:pt>
                <c:pt idx="4">
                  <c:v>0.13983999999999999</c:v>
                </c:pt>
                <c:pt idx="5">
                  <c:v>0.15966</c:v>
                </c:pt>
                <c:pt idx="6">
                  <c:v>0.17488000000000001</c:v>
                </c:pt>
                <c:pt idx="7">
                  <c:v>0.18692000000000003</c:v>
                </c:pt>
                <c:pt idx="8">
                  <c:v>0.19641999999999998</c:v>
                </c:pt>
                <c:pt idx="9">
                  <c:v>0.20363999999999999</c:v>
                </c:pt>
                <c:pt idx="10">
                  <c:v>0.20835999999999996</c:v>
                </c:pt>
                <c:pt idx="11">
                  <c:v>0.21146000000000004</c:v>
                </c:pt>
                <c:pt idx="12">
                  <c:v>0.21474000000000001</c:v>
                </c:pt>
                <c:pt idx="13">
                  <c:v>0.21642</c:v>
                </c:pt>
                <c:pt idx="14">
                  <c:v>0.21820000000000003</c:v>
                </c:pt>
                <c:pt idx="15">
                  <c:v>0.22020000000000001</c:v>
                </c:pt>
              </c:numCache>
            </c:numRef>
          </c:yVal>
          <c:smooth val="0"/>
          <c:extLst>
            <c:ext xmlns:c16="http://schemas.microsoft.com/office/drawing/2014/chart" uri="{C3380CC4-5D6E-409C-BE32-E72D297353CC}">
              <c16:uniqueId val="{00000002-2235-49B2-9AF9-43D3EE72B007}"/>
            </c:ext>
          </c:extLst>
        </c:ser>
        <c:dLbls>
          <c:showLegendKey val="0"/>
          <c:showVal val="0"/>
          <c:showCatName val="0"/>
          <c:showSerName val="0"/>
          <c:showPercent val="0"/>
          <c:showBubbleSize val="0"/>
        </c:dLbls>
        <c:axId val="1073938255"/>
        <c:axId val="1182074607"/>
      </c:scatterChart>
      <c:valAx>
        <c:axId val="1073938255"/>
        <c:scaling>
          <c:orientation val="minMax"/>
          <c:max val="650"/>
          <c:min val="0"/>
        </c:scaling>
        <c:delete val="0"/>
        <c:axPos val="b"/>
        <c:title>
          <c:tx>
            <c:rich>
              <a:bodyPr rot="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r>
                  <a:rPr lang="en-US" sz="1600" dirty="0">
                    <a:latin typeface="Arial" panose="020B0604020202020204" pitchFamily="34" charset="0"/>
                    <a:cs typeface="Arial" panose="020B0604020202020204" pitchFamily="34" charset="0"/>
                  </a:rPr>
                  <a:t>Xanthine Concentration (</a:t>
                </a:r>
                <a:r>
                  <a:rPr lang="el-GR" sz="1600" dirty="0">
                    <a:latin typeface="Arial" panose="020B0604020202020204" pitchFamily="34" charset="0"/>
                    <a:cs typeface="Arial" panose="020B0604020202020204" pitchFamily="34" charset="0"/>
                  </a:rPr>
                  <a:t>μ</a:t>
                </a:r>
                <a:r>
                  <a:rPr lang="en-US" sz="1600" dirty="0">
                    <a:latin typeface="Arial" panose="020B0604020202020204" pitchFamily="34" charset="0"/>
                    <a:cs typeface="Arial" panose="020B0604020202020204" pitchFamily="34" charset="0"/>
                  </a:rPr>
                  <a:t>M)</a:t>
                </a:r>
              </a:p>
            </c:rich>
          </c:tx>
          <c:layout>
            <c:manualLayout>
              <c:xMode val="edge"/>
              <c:yMode val="edge"/>
              <c:x val="0.28902152933502401"/>
              <c:y val="0.82951831305177759"/>
            </c:manualLayout>
          </c:layout>
          <c:overlay val="0"/>
          <c:spPr>
            <a:noFill/>
            <a:ln>
              <a:noFill/>
            </a:ln>
            <a:effectLst/>
          </c:spPr>
          <c:txPr>
            <a:bodyPr rot="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182074607"/>
        <c:crosses val="autoZero"/>
        <c:crossBetween val="midCat"/>
        <c:majorUnit val="100"/>
      </c:valAx>
      <c:valAx>
        <c:axId val="1182074607"/>
        <c:scaling>
          <c:orientation val="minMax"/>
          <c:min val="0"/>
        </c:scaling>
        <c:delete val="0"/>
        <c:axPos val="l"/>
        <c:title>
          <c:tx>
            <c:rich>
              <a:bodyPr rot="-540000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r>
                  <a:rPr lang="en-US" sz="1600" dirty="0">
                    <a:latin typeface="Arial" panose="020B0604020202020204" pitchFamily="34" charset="0"/>
                    <a:cs typeface="Arial" panose="020B0604020202020204" pitchFamily="34" charset="0"/>
                  </a:rPr>
                  <a:t>Current  (</a:t>
                </a:r>
                <a:r>
                  <a:rPr lang="el-GR" sz="1600" dirty="0">
                    <a:latin typeface="Arial" panose="020B0604020202020204" pitchFamily="34" charset="0"/>
                    <a:cs typeface="Arial" panose="020B0604020202020204" pitchFamily="34" charset="0"/>
                  </a:rPr>
                  <a:t>μ</a:t>
                </a:r>
                <a:r>
                  <a:rPr lang="en-US" sz="1600" dirty="0">
                    <a:latin typeface="Arial" panose="020B0604020202020204" pitchFamily="34" charset="0"/>
                    <a:cs typeface="Arial" panose="020B0604020202020204" pitchFamily="34" charset="0"/>
                  </a:rPr>
                  <a:t>A)</a:t>
                </a:r>
              </a:p>
            </c:rich>
          </c:tx>
          <c:overlay val="0"/>
          <c:spPr>
            <a:noFill/>
            <a:ln>
              <a:noFill/>
            </a:ln>
            <a:effectLst/>
          </c:spPr>
          <c:txPr>
            <a:bodyPr rot="-540000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073938255"/>
        <c:crosses val="autoZero"/>
        <c:crossBetween val="midCat"/>
      </c:valAx>
      <c:spPr>
        <a:noFill/>
        <a:ln>
          <a:noFill/>
        </a:ln>
        <a:effectLst/>
      </c:spPr>
    </c:plotArea>
    <c:legend>
      <c:legendPos val="b"/>
      <c:layout>
        <c:manualLayout>
          <c:xMode val="edge"/>
          <c:yMode val="edge"/>
          <c:x val="0.18235231654288514"/>
          <c:y val="0.13141821760916247"/>
          <c:w val="0.11533537915704806"/>
          <c:h val="0.22781099514276842"/>
        </c:manualLayout>
      </c:layout>
      <c:overlay val="0"/>
      <c:spPr>
        <a:noFill/>
        <a:ln>
          <a:solidFill>
            <a:schemeClr val="bg1">
              <a:lumMod val="75000"/>
            </a:schemeClr>
          </a:solidFill>
        </a:ln>
        <a:effectLst/>
      </c:spPr>
      <c:txPr>
        <a:bodyPr rot="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057942870805957"/>
          <c:y val="4.808977635748278E-2"/>
          <c:w val="0.80674982977460408"/>
          <c:h val="0.73582724886661899"/>
        </c:manualLayout>
      </c:layout>
      <c:scatterChart>
        <c:scatterStyle val="lineMarker"/>
        <c:varyColors val="0"/>
        <c:ser>
          <c:idx val="0"/>
          <c:order val="0"/>
          <c:tx>
            <c:strRef>
              <c:f>All!$C$1</c:f>
              <c:strCache>
                <c:ptCount val="1"/>
                <c:pt idx="0">
                  <c:v>Day 1</c:v>
                </c:pt>
              </c:strCache>
            </c:strRef>
          </c:tx>
          <c:spPr>
            <a:ln w="19050" cap="rnd">
              <a:no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All!$C$19:$C$34</c:f>
                <c:numCache>
                  <c:formatCode>General</c:formatCode>
                  <c:ptCount val="16"/>
                  <c:pt idx="0">
                    <c:v>1.5514145942597834E-3</c:v>
                  </c:pt>
                  <c:pt idx="1">
                    <c:v>3.2817653768205161E-3</c:v>
                  </c:pt>
                  <c:pt idx="2">
                    <c:v>5.7617244328337005E-3</c:v>
                  </c:pt>
                  <c:pt idx="3">
                    <c:v>1.1897079617976885E-2</c:v>
                  </c:pt>
                  <c:pt idx="4">
                    <c:v>2.0247597881416397E-2</c:v>
                  </c:pt>
                  <c:pt idx="5">
                    <c:v>2.9409451713353501E-2</c:v>
                  </c:pt>
                  <c:pt idx="6">
                    <c:v>3.6230680152564525E-2</c:v>
                  </c:pt>
                  <c:pt idx="7">
                    <c:v>4.2666233608477641E-2</c:v>
                  </c:pt>
                  <c:pt idx="8">
                    <c:v>4.7724471720650218E-2</c:v>
                  </c:pt>
                  <c:pt idx="9">
                    <c:v>5.0491104278674225E-2</c:v>
                  </c:pt>
                  <c:pt idx="10">
                    <c:v>5.1029536147754351E-2</c:v>
                  </c:pt>
                  <c:pt idx="11">
                    <c:v>5.2226087522302012E-2</c:v>
                  </c:pt>
                  <c:pt idx="12">
                    <c:v>5.1332462398682673E-2</c:v>
                  </c:pt>
                  <c:pt idx="13">
                    <c:v>5.1966842359861758E-2</c:v>
                  </c:pt>
                  <c:pt idx="14">
                    <c:v>5.0823740036275995E-2</c:v>
                  </c:pt>
                  <c:pt idx="15">
                    <c:v>5.2338956088504848E-2</c:v>
                  </c:pt>
                </c:numCache>
              </c:numRef>
            </c:plus>
            <c:minus>
              <c:numRef>
                <c:f>All!$C$19:$C$34</c:f>
                <c:numCache>
                  <c:formatCode>General</c:formatCode>
                  <c:ptCount val="16"/>
                  <c:pt idx="0">
                    <c:v>1.5514145942597834E-3</c:v>
                  </c:pt>
                  <c:pt idx="1">
                    <c:v>3.2817653768205161E-3</c:v>
                  </c:pt>
                  <c:pt idx="2">
                    <c:v>5.7617244328337005E-3</c:v>
                  </c:pt>
                  <c:pt idx="3">
                    <c:v>1.1897079617976885E-2</c:v>
                  </c:pt>
                  <c:pt idx="4">
                    <c:v>2.0247597881416397E-2</c:v>
                  </c:pt>
                  <c:pt idx="5">
                    <c:v>2.9409451713353501E-2</c:v>
                  </c:pt>
                  <c:pt idx="6">
                    <c:v>3.6230680152564525E-2</c:v>
                  </c:pt>
                  <c:pt idx="7">
                    <c:v>4.2666233608477641E-2</c:v>
                  </c:pt>
                  <c:pt idx="8">
                    <c:v>4.7724471720650218E-2</c:v>
                  </c:pt>
                  <c:pt idx="9">
                    <c:v>5.0491104278674225E-2</c:v>
                  </c:pt>
                  <c:pt idx="10">
                    <c:v>5.1029536147754351E-2</c:v>
                  </c:pt>
                  <c:pt idx="11">
                    <c:v>5.2226087522302012E-2</c:v>
                  </c:pt>
                  <c:pt idx="12">
                    <c:v>5.1332462398682673E-2</c:v>
                  </c:pt>
                  <c:pt idx="13">
                    <c:v>5.1966842359861758E-2</c:v>
                  </c:pt>
                  <c:pt idx="14">
                    <c:v>5.0823740036275995E-2</c:v>
                  </c:pt>
                  <c:pt idx="15">
                    <c:v>5.2338956088504848E-2</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All!$B$2:$B$17</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All!$C$2:$C$17</c:f>
              <c:numCache>
                <c:formatCode>0.0000</c:formatCode>
                <c:ptCount val="16"/>
                <c:pt idx="0">
                  <c:v>-1.7594224422442262E-4</c:v>
                </c:pt>
                <c:pt idx="1">
                  <c:v>4.2964356435643558E-2</c:v>
                </c:pt>
                <c:pt idx="2">
                  <c:v>9.5413201320132035E-2</c:v>
                </c:pt>
                <c:pt idx="3">
                  <c:v>0.14025016501650164</c:v>
                </c:pt>
                <c:pt idx="4">
                  <c:v>0.17972211221122114</c:v>
                </c:pt>
                <c:pt idx="5">
                  <c:v>0.21150099009900991</c:v>
                </c:pt>
                <c:pt idx="6">
                  <c:v>0.24010165016501647</c:v>
                </c:pt>
                <c:pt idx="7">
                  <c:v>0.26256699669966982</c:v>
                </c:pt>
                <c:pt idx="8">
                  <c:v>0.28202904290429048</c:v>
                </c:pt>
                <c:pt idx="9">
                  <c:v>0.2988673267326733</c:v>
                </c:pt>
                <c:pt idx="10">
                  <c:v>0.31397623762376242</c:v>
                </c:pt>
                <c:pt idx="11">
                  <c:v>0.32582772277227701</c:v>
                </c:pt>
                <c:pt idx="12">
                  <c:v>0.33759009900990095</c:v>
                </c:pt>
                <c:pt idx="13">
                  <c:v>0.3465537953795379</c:v>
                </c:pt>
                <c:pt idx="14">
                  <c:v>0.35893333333333305</c:v>
                </c:pt>
                <c:pt idx="15">
                  <c:v>0.386745214521452</c:v>
                </c:pt>
              </c:numCache>
            </c:numRef>
          </c:yVal>
          <c:smooth val="0"/>
          <c:extLst>
            <c:ext xmlns:c16="http://schemas.microsoft.com/office/drawing/2014/chart" uri="{C3380CC4-5D6E-409C-BE32-E72D297353CC}">
              <c16:uniqueId val="{00000000-3597-4953-B26F-919AEB519ACE}"/>
            </c:ext>
          </c:extLst>
        </c:ser>
        <c:ser>
          <c:idx val="1"/>
          <c:order val="1"/>
          <c:tx>
            <c:strRef>
              <c:f>All!$D$1</c:f>
              <c:strCache>
                <c:ptCount val="1"/>
                <c:pt idx="0">
                  <c:v>Day 3</c:v>
                </c:pt>
              </c:strCache>
            </c:strRef>
          </c:tx>
          <c:spPr>
            <a:ln w="19050" cap="rnd">
              <a:no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All!$D$19:$D$34</c:f>
                <c:numCache>
                  <c:formatCode>General</c:formatCode>
                  <c:ptCount val="16"/>
                  <c:pt idx="0">
                    <c:v>1.1756168593551216E-2</c:v>
                  </c:pt>
                  <c:pt idx="1">
                    <c:v>2.0950820389664945E-2</c:v>
                  </c:pt>
                  <c:pt idx="2">
                    <c:v>2.8005579801175372E-2</c:v>
                  </c:pt>
                  <c:pt idx="3">
                    <c:v>3.1907405096622946E-2</c:v>
                  </c:pt>
                  <c:pt idx="4">
                    <c:v>3.1939894724309865E-2</c:v>
                  </c:pt>
                  <c:pt idx="5">
                    <c:v>2.8194536261481738E-2</c:v>
                  </c:pt>
                  <c:pt idx="6">
                    <c:v>2.4628134318295268E-2</c:v>
                  </c:pt>
                  <c:pt idx="7">
                    <c:v>2.0813982679919768E-2</c:v>
                  </c:pt>
                  <c:pt idx="8">
                    <c:v>1.8606517675266381E-2</c:v>
                  </c:pt>
                  <c:pt idx="9">
                    <c:v>1.8340460735761236E-2</c:v>
                  </c:pt>
                  <c:pt idx="10">
                    <c:v>2.0155070701935028E-2</c:v>
                  </c:pt>
                  <c:pt idx="11">
                    <c:v>2.2792542640082958E-2</c:v>
                  </c:pt>
                  <c:pt idx="12">
                    <c:v>2.6442153845706293E-2</c:v>
                  </c:pt>
                  <c:pt idx="13">
                    <c:v>3.0490777294126175E-2</c:v>
                  </c:pt>
                  <c:pt idx="14">
                    <c:v>3.4336569426778797E-2</c:v>
                  </c:pt>
                  <c:pt idx="15">
                    <c:v>3.9251592324388587E-2</c:v>
                  </c:pt>
                </c:numCache>
              </c:numRef>
            </c:plus>
            <c:minus>
              <c:numRef>
                <c:f>All!$D$19:$D$34</c:f>
                <c:numCache>
                  <c:formatCode>General</c:formatCode>
                  <c:ptCount val="16"/>
                  <c:pt idx="0">
                    <c:v>1.1756168593551216E-2</c:v>
                  </c:pt>
                  <c:pt idx="1">
                    <c:v>2.0950820389664945E-2</c:v>
                  </c:pt>
                  <c:pt idx="2">
                    <c:v>2.8005579801175372E-2</c:v>
                  </c:pt>
                  <c:pt idx="3">
                    <c:v>3.1907405096622946E-2</c:v>
                  </c:pt>
                  <c:pt idx="4">
                    <c:v>3.1939894724309865E-2</c:v>
                  </c:pt>
                  <c:pt idx="5">
                    <c:v>2.8194536261481738E-2</c:v>
                  </c:pt>
                  <c:pt idx="6">
                    <c:v>2.4628134318295268E-2</c:v>
                  </c:pt>
                  <c:pt idx="7">
                    <c:v>2.0813982679919768E-2</c:v>
                  </c:pt>
                  <c:pt idx="8">
                    <c:v>1.8606517675266381E-2</c:v>
                  </c:pt>
                  <c:pt idx="9">
                    <c:v>1.8340460735761236E-2</c:v>
                  </c:pt>
                  <c:pt idx="10">
                    <c:v>2.0155070701935028E-2</c:v>
                  </c:pt>
                  <c:pt idx="11">
                    <c:v>2.2792542640082958E-2</c:v>
                  </c:pt>
                  <c:pt idx="12">
                    <c:v>2.6442153845706293E-2</c:v>
                  </c:pt>
                  <c:pt idx="13">
                    <c:v>3.0490777294126175E-2</c:v>
                  </c:pt>
                  <c:pt idx="14">
                    <c:v>3.4336569426778797E-2</c:v>
                  </c:pt>
                  <c:pt idx="15">
                    <c:v>3.9251592324388587E-2</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All!$B$2:$B$17</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All!$D$2:$D$17</c:f>
              <c:numCache>
                <c:formatCode>General</c:formatCode>
                <c:ptCount val="16"/>
                <c:pt idx="0">
                  <c:v>3.8500000000000006E-3</c:v>
                </c:pt>
                <c:pt idx="1">
                  <c:v>4.6224999999999995E-2</c:v>
                </c:pt>
                <c:pt idx="2">
                  <c:v>9.4750000000000001E-2</c:v>
                </c:pt>
                <c:pt idx="3">
                  <c:v>0.14075000000000001</c:v>
                </c:pt>
                <c:pt idx="4">
                  <c:v>0.181675</c:v>
                </c:pt>
                <c:pt idx="5">
                  <c:v>0.21392499999999998</c:v>
                </c:pt>
                <c:pt idx="6">
                  <c:v>0.24460000000000001</c:v>
                </c:pt>
                <c:pt idx="7">
                  <c:v>0.27287500000000003</c:v>
                </c:pt>
                <c:pt idx="8">
                  <c:v>0.29804999999999998</c:v>
                </c:pt>
                <c:pt idx="9">
                  <c:v>0.32135000000000002</c:v>
                </c:pt>
                <c:pt idx="10">
                  <c:v>0.34337499999999999</c:v>
                </c:pt>
                <c:pt idx="11">
                  <c:v>0.36299999999999999</c:v>
                </c:pt>
                <c:pt idx="12">
                  <c:v>0.38125000000000003</c:v>
                </c:pt>
                <c:pt idx="13">
                  <c:v>0.39675000000000005</c:v>
                </c:pt>
                <c:pt idx="14">
                  <c:v>0.40500000000000003</c:v>
                </c:pt>
                <c:pt idx="15">
                  <c:v>0.41825000000000001</c:v>
                </c:pt>
              </c:numCache>
            </c:numRef>
          </c:yVal>
          <c:smooth val="0"/>
          <c:extLst>
            <c:ext xmlns:c16="http://schemas.microsoft.com/office/drawing/2014/chart" uri="{C3380CC4-5D6E-409C-BE32-E72D297353CC}">
              <c16:uniqueId val="{00000001-3597-4953-B26F-919AEB519ACE}"/>
            </c:ext>
          </c:extLst>
        </c:ser>
        <c:ser>
          <c:idx val="2"/>
          <c:order val="2"/>
          <c:tx>
            <c:strRef>
              <c:f>All!$E$1</c:f>
              <c:strCache>
                <c:ptCount val="1"/>
                <c:pt idx="0">
                  <c:v>Day 5</c:v>
                </c:pt>
              </c:strCache>
            </c:strRef>
          </c:tx>
          <c:spPr>
            <a:ln w="19050" cap="rnd">
              <a:noFill/>
              <a:round/>
            </a:ln>
            <a:effectLst/>
          </c:spPr>
          <c:marker>
            <c:symbol val="circle"/>
            <c:size val="5"/>
            <c:spPr>
              <a:solidFill>
                <a:schemeClr val="accent3"/>
              </a:solidFill>
              <a:ln w="9525">
                <a:solidFill>
                  <a:schemeClr val="accent3"/>
                </a:solidFill>
              </a:ln>
              <a:effectLst/>
            </c:spPr>
          </c:marker>
          <c:errBars>
            <c:errDir val="y"/>
            <c:errBarType val="both"/>
            <c:errValType val="cust"/>
            <c:noEndCap val="0"/>
            <c:plus>
              <c:numRef>
                <c:f>All!$E$19:$E$34</c:f>
                <c:numCache>
                  <c:formatCode>General</c:formatCode>
                  <c:ptCount val="16"/>
                  <c:pt idx="0">
                    <c:v>2.3286262044390038E-3</c:v>
                  </c:pt>
                  <c:pt idx="1">
                    <c:v>1.2591068262859982E-2</c:v>
                  </c:pt>
                  <c:pt idx="2">
                    <c:v>1.9343910540529287E-2</c:v>
                  </c:pt>
                  <c:pt idx="3">
                    <c:v>2.290113261391237E-2</c:v>
                  </c:pt>
                  <c:pt idx="4">
                    <c:v>2.3495464987950337E-2</c:v>
                  </c:pt>
                  <c:pt idx="5">
                    <c:v>2.1607449525568704E-2</c:v>
                  </c:pt>
                  <c:pt idx="6">
                    <c:v>1.8514048719823529E-2</c:v>
                  </c:pt>
                  <c:pt idx="7">
                    <c:v>1.4692068438446611E-2</c:v>
                  </c:pt>
                  <c:pt idx="8">
                    <c:v>1.1221185320633462E-2</c:v>
                  </c:pt>
                  <c:pt idx="9">
                    <c:v>8.5502558441253665E-3</c:v>
                  </c:pt>
                  <c:pt idx="10">
                    <c:v>6.7165839531714367E-3</c:v>
                  </c:pt>
                  <c:pt idx="11">
                    <c:v>5.819793810780587E-3</c:v>
                  </c:pt>
                  <c:pt idx="12">
                    <c:v>5.6077513318619982E-3</c:v>
                  </c:pt>
                  <c:pt idx="13">
                    <c:v>5.8469543353783793E-3</c:v>
                  </c:pt>
                  <c:pt idx="14">
                    <c:v>6.3884172531230316E-3</c:v>
                  </c:pt>
                  <c:pt idx="15">
                    <c:v>7.0994718113392046E-3</c:v>
                  </c:pt>
                </c:numCache>
              </c:numRef>
            </c:plus>
            <c:minus>
              <c:numRef>
                <c:f>All!$E$19:$E$34</c:f>
                <c:numCache>
                  <c:formatCode>General</c:formatCode>
                  <c:ptCount val="16"/>
                  <c:pt idx="0">
                    <c:v>2.3286262044390038E-3</c:v>
                  </c:pt>
                  <c:pt idx="1">
                    <c:v>1.2591068262859982E-2</c:v>
                  </c:pt>
                  <c:pt idx="2">
                    <c:v>1.9343910540529287E-2</c:v>
                  </c:pt>
                  <c:pt idx="3">
                    <c:v>2.290113261391237E-2</c:v>
                  </c:pt>
                  <c:pt idx="4">
                    <c:v>2.3495464987950337E-2</c:v>
                  </c:pt>
                  <c:pt idx="5">
                    <c:v>2.1607449525568704E-2</c:v>
                  </c:pt>
                  <c:pt idx="6">
                    <c:v>1.8514048719823529E-2</c:v>
                  </c:pt>
                  <c:pt idx="7">
                    <c:v>1.4692068438446611E-2</c:v>
                  </c:pt>
                  <c:pt idx="8">
                    <c:v>1.1221185320633462E-2</c:v>
                  </c:pt>
                  <c:pt idx="9">
                    <c:v>8.5502558441253665E-3</c:v>
                  </c:pt>
                  <c:pt idx="10">
                    <c:v>6.7165839531714367E-3</c:v>
                  </c:pt>
                  <c:pt idx="11">
                    <c:v>5.819793810780587E-3</c:v>
                  </c:pt>
                  <c:pt idx="12">
                    <c:v>5.6077513318619982E-3</c:v>
                  </c:pt>
                  <c:pt idx="13">
                    <c:v>5.8469543353783793E-3</c:v>
                  </c:pt>
                  <c:pt idx="14">
                    <c:v>6.3884172531230316E-3</c:v>
                  </c:pt>
                  <c:pt idx="15">
                    <c:v>7.0994718113392046E-3</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All!$B$2:$B$17</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All!$E$2:$E$17</c:f>
              <c:numCache>
                <c:formatCode>General</c:formatCode>
                <c:ptCount val="16"/>
                <c:pt idx="0">
                  <c:v>-1.9499999999999999E-3</c:v>
                </c:pt>
                <c:pt idx="1">
                  <c:v>1.9200000000000002E-2</c:v>
                </c:pt>
                <c:pt idx="2">
                  <c:v>3.5325000000000002E-2</c:v>
                </c:pt>
                <c:pt idx="3">
                  <c:v>4.8324999999999993E-2</c:v>
                </c:pt>
                <c:pt idx="4">
                  <c:v>5.7075000000000001E-2</c:v>
                </c:pt>
                <c:pt idx="5">
                  <c:v>6.2674999999999995E-2</c:v>
                </c:pt>
                <c:pt idx="6">
                  <c:v>6.7000000000000004E-2</c:v>
                </c:pt>
                <c:pt idx="7">
                  <c:v>7.0175000000000001E-2</c:v>
                </c:pt>
                <c:pt idx="8">
                  <c:v>7.2599999999999998E-2</c:v>
                </c:pt>
                <c:pt idx="9">
                  <c:v>7.4825000000000003E-2</c:v>
                </c:pt>
                <c:pt idx="10">
                  <c:v>7.6949999999999991E-2</c:v>
                </c:pt>
                <c:pt idx="11">
                  <c:v>7.8600000000000003E-2</c:v>
                </c:pt>
                <c:pt idx="12">
                  <c:v>8.0274999999999999E-2</c:v>
                </c:pt>
                <c:pt idx="13">
                  <c:v>8.1424999999999997E-2</c:v>
                </c:pt>
                <c:pt idx="14">
                  <c:v>8.2824999999999996E-2</c:v>
                </c:pt>
                <c:pt idx="15">
                  <c:v>8.3350000000000007E-2</c:v>
                </c:pt>
              </c:numCache>
            </c:numRef>
          </c:yVal>
          <c:smooth val="0"/>
          <c:extLst>
            <c:ext xmlns:c16="http://schemas.microsoft.com/office/drawing/2014/chart" uri="{C3380CC4-5D6E-409C-BE32-E72D297353CC}">
              <c16:uniqueId val="{00000002-3597-4953-B26F-919AEB519ACE}"/>
            </c:ext>
          </c:extLst>
        </c:ser>
        <c:dLbls>
          <c:showLegendKey val="0"/>
          <c:showVal val="0"/>
          <c:showCatName val="0"/>
          <c:showSerName val="0"/>
          <c:showPercent val="0"/>
          <c:showBubbleSize val="0"/>
        </c:dLbls>
        <c:axId val="1976212576"/>
        <c:axId val="1918311488"/>
      </c:scatterChart>
      <c:valAx>
        <c:axId val="1976212576"/>
        <c:scaling>
          <c:orientation val="minMax"/>
          <c:max val="650"/>
          <c:min val="0"/>
        </c:scaling>
        <c:delete val="0"/>
        <c:axPos val="b"/>
        <c:title>
          <c:tx>
            <c:rich>
              <a:bodyPr rot="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r>
                  <a:rPr lang="en-US" sz="1600" dirty="0"/>
                  <a:t>Xanthine Concentration (µM)</a:t>
                </a:r>
              </a:p>
            </c:rich>
          </c:tx>
          <c:layout>
            <c:manualLayout>
              <c:xMode val="edge"/>
              <c:yMode val="edge"/>
              <c:x val="0.3086493973070929"/>
              <c:y val="0.86567450406254953"/>
            </c:manualLayout>
          </c:layout>
          <c:overlay val="0"/>
          <c:spPr>
            <a:noFill/>
            <a:ln>
              <a:noFill/>
            </a:ln>
            <a:effectLst/>
          </c:spPr>
          <c:txPr>
            <a:bodyPr rot="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918311488"/>
        <c:crosses val="autoZero"/>
        <c:crossBetween val="midCat"/>
        <c:majorUnit val="100"/>
      </c:valAx>
      <c:valAx>
        <c:axId val="1918311488"/>
        <c:scaling>
          <c:orientation val="minMax"/>
          <c:min val="0"/>
        </c:scaling>
        <c:delete val="0"/>
        <c:axPos val="l"/>
        <c:title>
          <c:tx>
            <c:rich>
              <a:bodyPr rot="-540000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r>
                  <a:rPr lang="en-US" sz="1600"/>
                  <a:t>Current (µA)</a:t>
                </a:r>
              </a:p>
            </c:rich>
          </c:tx>
          <c:overlay val="0"/>
          <c:spPr>
            <a:noFill/>
            <a:ln>
              <a:noFill/>
            </a:ln>
            <a:effectLst/>
          </c:spPr>
          <c:txPr>
            <a:bodyPr rot="-540000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0.0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976212576"/>
        <c:crosses val="autoZero"/>
        <c:crossBetween val="midCat"/>
      </c:valAx>
      <c:spPr>
        <a:noFill/>
        <a:ln>
          <a:noFill/>
        </a:ln>
        <a:effectLst/>
      </c:spPr>
    </c:plotArea>
    <c:legend>
      <c:legendPos val="b"/>
      <c:layout>
        <c:manualLayout>
          <c:xMode val="edge"/>
          <c:yMode val="edge"/>
          <c:x val="0.19091373372717749"/>
          <c:y val="0.1167450298366241"/>
          <c:w val="0.13115382254167837"/>
          <c:h val="0.172319255547602"/>
        </c:manualLayout>
      </c:layout>
      <c:overlay val="0"/>
      <c:spPr>
        <a:noFill/>
        <a:ln>
          <a:solidFill>
            <a:schemeClr val="bg1">
              <a:lumMod val="75000"/>
            </a:schemeClr>
          </a:solidFill>
        </a:ln>
        <a:effectLst/>
      </c:spPr>
      <c:txPr>
        <a:bodyPr rot="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v>Day 1</c:v>
          </c:tx>
          <c:spPr>
            <a:ln w="19050" cap="rnd">
              <a:no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All!$B$19:$B$34</c:f>
                <c:numCache>
                  <c:formatCode>General</c:formatCode>
                  <c:ptCount val="16"/>
                  <c:pt idx="0">
                    <c:v>5.4433625305404399E-3</c:v>
                  </c:pt>
                  <c:pt idx="1">
                    <c:v>6.4804759828138844E-3</c:v>
                  </c:pt>
                  <c:pt idx="2">
                    <c:v>1.4260024515629462E-2</c:v>
                  </c:pt>
                  <c:pt idx="3">
                    <c:v>2.2314082458976793E-2</c:v>
                  </c:pt>
                  <c:pt idx="4">
                    <c:v>3.6057378292029436E-2</c:v>
                  </c:pt>
                  <c:pt idx="5">
                    <c:v>4.6002070296046582E-2</c:v>
                  </c:pt>
                  <c:pt idx="6">
                    <c:v>5.5031324312219139E-2</c:v>
                  </c:pt>
                  <c:pt idx="7">
                    <c:v>6.5805324887757671E-2</c:v>
                  </c:pt>
                  <c:pt idx="8">
                    <c:v>7.2497477383951361E-2</c:v>
                  </c:pt>
                  <c:pt idx="9">
                    <c:v>8.438337222359614E-2</c:v>
                  </c:pt>
                  <c:pt idx="10">
                    <c:v>9.0272385866159197E-2</c:v>
                  </c:pt>
                  <c:pt idx="11">
                    <c:v>9.0985448981042591E-2</c:v>
                  </c:pt>
                  <c:pt idx="12">
                    <c:v>0.10339280859263475</c:v>
                  </c:pt>
                  <c:pt idx="13">
                    <c:v>0.11037659110310843</c:v>
                  </c:pt>
                  <c:pt idx="14">
                    <c:v>0.11529629637268929</c:v>
                  </c:pt>
                  <c:pt idx="15">
                    <c:v>0.12774435051943306</c:v>
                  </c:pt>
                </c:numCache>
              </c:numRef>
            </c:plus>
            <c:minus>
              <c:numRef>
                <c:f>All!$B$19:$B$34</c:f>
                <c:numCache>
                  <c:formatCode>General</c:formatCode>
                  <c:ptCount val="16"/>
                  <c:pt idx="0">
                    <c:v>5.4433625305404399E-3</c:v>
                  </c:pt>
                  <c:pt idx="1">
                    <c:v>6.4804759828138844E-3</c:v>
                  </c:pt>
                  <c:pt idx="2">
                    <c:v>1.4260024515629462E-2</c:v>
                  </c:pt>
                  <c:pt idx="3">
                    <c:v>2.2314082458976793E-2</c:v>
                  </c:pt>
                  <c:pt idx="4">
                    <c:v>3.6057378292029436E-2</c:v>
                  </c:pt>
                  <c:pt idx="5">
                    <c:v>4.6002070296046582E-2</c:v>
                  </c:pt>
                  <c:pt idx="6">
                    <c:v>5.5031324312219139E-2</c:v>
                  </c:pt>
                  <c:pt idx="7">
                    <c:v>6.5805324887757671E-2</c:v>
                  </c:pt>
                  <c:pt idx="8">
                    <c:v>7.2497477383951361E-2</c:v>
                  </c:pt>
                  <c:pt idx="9">
                    <c:v>8.438337222359614E-2</c:v>
                  </c:pt>
                  <c:pt idx="10">
                    <c:v>9.0272385866159197E-2</c:v>
                  </c:pt>
                  <c:pt idx="11">
                    <c:v>9.0985448981042591E-2</c:v>
                  </c:pt>
                  <c:pt idx="12">
                    <c:v>0.10339280859263475</c:v>
                  </c:pt>
                  <c:pt idx="13">
                    <c:v>0.11037659110310843</c:v>
                  </c:pt>
                  <c:pt idx="14">
                    <c:v>0.11529629637268929</c:v>
                  </c:pt>
                  <c:pt idx="15">
                    <c:v>0.12774435051943306</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All!$A$2:$A$17</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All!$B$2:$B$17</c:f>
              <c:numCache>
                <c:formatCode>0.0000</c:formatCode>
                <c:ptCount val="16"/>
                <c:pt idx="0">
                  <c:v>7.4989735973597371E-3</c:v>
                </c:pt>
                <c:pt idx="1">
                  <c:v>0.15095049504950495</c:v>
                </c:pt>
                <c:pt idx="2">
                  <c:v>0.25772277227722767</c:v>
                </c:pt>
                <c:pt idx="3">
                  <c:v>0.33452805280528058</c:v>
                </c:pt>
                <c:pt idx="4">
                  <c:v>0.46166006600660081</c:v>
                </c:pt>
                <c:pt idx="5">
                  <c:v>0.55087128712871292</c:v>
                </c:pt>
                <c:pt idx="6">
                  <c:v>0.6414224422442244</c:v>
                </c:pt>
                <c:pt idx="7">
                  <c:v>0.72027392739273921</c:v>
                </c:pt>
                <c:pt idx="8">
                  <c:v>0.81404950495049544</c:v>
                </c:pt>
                <c:pt idx="9">
                  <c:v>0.90792739273927348</c:v>
                </c:pt>
                <c:pt idx="10">
                  <c:v>0.9660825082508242</c:v>
                </c:pt>
                <c:pt idx="11">
                  <c:v>1.0473663366336634</c:v>
                </c:pt>
                <c:pt idx="12">
                  <c:v>1.1363036303630367</c:v>
                </c:pt>
                <c:pt idx="13">
                  <c:v>1.2131683168316827</c:v>
                </c:pt>
                <c:pt idx="14">
                  <c:v>1.293168316831683</c:v>
                </c:pt>
                <c:pt idx="15">
                  <c:v>1.3681848184818477</c:v>
                </c:pt>
              </c:numCache>
            </c:numRef>
          </c:yVal>
          <c:smooth val="0"/>
          <c:extLst>
            <c:ext xmlns:c16="http://schemas.microsoft.com/office/drawing/2014/chart" uri="{C3380CC4-5D6E-409C-BE32-E72D297353CC}">
              <c16:uniqueId val="{00000000-06EB-48AD-91FD-DE792FB6AC3C}"/>
            </c:ext>
          </c:extLst>
        </c:ser>
        <c:ser>
          <c:idx val="1"/>
          <c:order val="1"/>
          <c:tx>
            <c:v>Day 3</c:v>
          </c:tx>
          <c:spPr>
            <a:ln w="19050" cap="rnd">
              <a:no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All!$C$19:$C$34</c:f>
                <c:numCache>
                  <c:formatCode>General</c:formatCode>
                  <c:ptCount val="16"/>
                  <c:pt idx="0">
                    <c:v>3.0262324040605227E-3</c:v>
                  </c:pt>
                  <c:pt idx="1">
                    <c:v>8.4226576242157122E-3</c:v>
                  </c:pt>
                  <c:pt idx="2">
                    <c:v>1.5540208132994343E-2</c:v>
                  </c:pt>
                  <c:pt idx="3">
                    <c:v>2.2310222650222134E-2</c:v>
                  </c:pt>
                  <c:pt idx="4">
                    <c:v>2.8189237389429037E-2</c:v>
                  </c:pt>
                  <c:pt idx="5">
                    <c:v>3.3134406634927477E-2</c:v>
                  </c:pt>
                  <c:pt idx="6">
                    <c:v>3.4491346381353788E-2</c:v>
                  </c:pt>
                  <c:pt idx="7">
                    <c:v>3.6067464614595736E-2</c:v>
                  </c:pt>
                  <c:pt idx="8">
                    <c:v>3.6212523363447248E-2</c:v>
                  </c:pt>
                  <c:pt idx="9">
                    <c:v>3.9899966574102011E-2</c:v>
                  </c:pt>
                  <c:pt idx="10">
                    <c:v>3.4928041900019129E-2</c:v>
                  </c:pt>
                  <c:pt idx="11">
                    <c:v>3.4869553006735027E-2</c:v>
                  </c:pt>
                  <c:pt idx="12">
                    <c:v>3.4629856597224416E-2</c:v>
                  </c:pt>
                  <c:pt idx="13">
                    <c:v>2.6355424324685149E-2</c:v>
                  </c:pt>
                  <c:pt idx="14">
                    <c:v>1.7579151459126488E-2</c:v>
                  </c:pt>
                  <c:pt idx="15">
                    <c:v>2.064675759427988E-2</c:v>
                  </c:pt>
                </c:numCache>
              </c:numRef>
            </c:plus>
            <c:minus>
              <c:numRef>
                <c:f>All!$C$19:$C$34</c:f>
                <c:numCache>
                  <c:formatCode>General</c:formatCode>
                  <c:ptCount val="16"/>
                  <c:pt idx="0">
                    <c:v>3.0262324040605227E-3</c:v>
                  </c:pt>
                  <c:pt idx="1">
                    <c:v>8.4226576242157122E-3</c:v>
                  </c:pt>
                  <c:pt idx="2">
                    <c:v>1.5540208132994343E-2</c:v>
                  </c:pt>
                  <c:pt idx="3">
                    <c:v>2.2310222650222134E-2</c:v>
                  </c:pt>
                  <c:pt idx="4">
                    <c:v>2.8189237389429037E-2</c:v>
                  </c:pt>
                  <c:pt idx="5">
                    <c:v>3.3134406634927477E-2</c:v>
                  </c:pt>
                  <c:pt idx="6">
                    <c:v>3.4491346381353788E-2</c:v>
                  </c:pt>
                  <c:pt idx="7">
                    <c:v>3.6067464614595736E-2</c:v>
                  </c:pt>
                  <c:pt idx="8">
                    <c:v>3.6212523363447248E-2</c:v>
                  </c:pt>
                  <c:pt idx="9">
                    <c:v>3.9899966574102011E-2</c:v>
                  </c:pt>
                  <c:pt idx="10">
                    <c:v>3.4928041900019129E-2</c:v>
                  </c:pt>
                  <c:pt idx="11">
                    <c:v>3.4869553006735027E-2</c:v>
                  </c:pt>
                  <c:pt idx="12">
                    <c:v>3.4629856597224416E-2</c:v>
                  </c:pt>
                  <c:pt idx="13">
                    <c:v>2.6355424324685149E-2</c:v>
                  </c:pt>
                  <c:pt idx="14">
                    <c:v>1.7579151459126488E-2</c:v>
                  </c:pt>
                  <c:pt idx="15">
                    <c:v>2.064675759427988E-2</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All!$A$2:$A$17</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All!$C$2:$C$17</c:f>
              <c:numCache>
                <c:formatCode>0.0000</c:formatCode>
                <c:ptCount val="16"/>
                <c:pt idx="0">
                  <c:v>4.3080966336633684E-4</c:v>
                </c:pt>
                <c:pt idx="1">
                  <c:v>0.10515702970297032</c:v>
                </c:pt>
                <c:pt idx="2">
                  <c:v>0.20006534653465341</c:v>
                </c:pt>
                <c:pt idx="3">
                  <c:v>0.29145148514851482</c:v>
                </c:pt>
                <c:pt idx="4">
                  <c:v>0.37981584158415843</c:v>
                </c:pt>
                <c:pt idx="5">
                  <c:v>0.46254653465346529</c:v>
                </c:pt>
                <c:pt idx="6">
                  <c:v>0.53890099009901005</c:v>
                </c:pt>
                <c:pt idx="7">
                  <c:v>0.6149663366336634</c:v>
                </c:pt>
                <c:pt idx="8">
                  <c:v>0.68510693069306927</c:v>
                </c:pt>
                <c:pt idx="9">
                  <c:v>0.75041980198019798</c:v>
                </c:pt>
                <c:pt idx="10">
                  <c:v>0.81374059405940624</c:v>
                </c:pt>
                <c:pt idx="11">
                  <c:v>0.87352871287128731</c:v>
                </c:pt>
                <c:pt idx="12">
                  <c:v>0.9281128712871286</c:v>
                </c:pt>
                <c:pt idx="13">
                  <c:v>0.97483366336633703</c:v>
                </c:pt>
                <c:pt idx="14">
                  <c:v>1.0207524752475259</c:v>
                </c:pt>
                <c:pt idx="15">
                  <c:v>1.0651683168316821</c:v>
                </c:pt>
              </c:numCache>
            </c:numRef>
          </c:yVal>
          <c:smooth val="0"/>
          <c:extLst>
            <c:ext xmlns:c16="http://schemas.microsoft.com/office/drawing/2014/chart" uri="{C3380CC4-5D6E-409C-BE32-E72D297353CC}">
              <c16:uniqueId val="{00000001-06EB-48AD-91FD-DE792FB6AC3C}"/>
            </c:ext>
          </c:extLst>
        </c:ser>
        <c:ser>
          <c:idx val="2"/>
          <c:order val="2"/>
          <c:tx>
            <c:v>Day 5</c:v>
          </c:tx>
          <c:spPr>
            <a:ln w="25400" cap="rnd">
              <a:noFill/>
              <a:round/>
            </a:ln>
            <a:effectLst/>
          </c:spPr>
          <c:marker>
            <c:symbol val="circle"/>
            <c:size val="5"/>
            <c:spPr>
              <a:solidFill>
                <a:schemeClr val="accent3"/>
              </a:solidFill>
              <a:ln w="9525">
                <a:solidFill>
                  <a:schemeClr val="accent3"/>
                </a:solidFill>
              </a:ln>
              <a:effectLst/>
            </c:spPr>
          </c:marker>
          <c:errBars>
            <c:errDir val="y"/>
            <c:errBarType val="both"/>
            <c:errValType val="cust"/>
            <c:noEndCap val="0"/>
            <c:plus>
              <c:numRef>
                <c:f>All!$D$19:$D$34</c:f>
                <c:numCache>
                  <c:formatCode>General</c:formatCode>
                  <c:ptCount val="16"/>
                  <c:pt idx="0">
                    <c:v>1.6180234856144702E-3</c:v>
                  </c:pt>
                  <c:pt idx="1">
                    <c:v>6.2600319488002616E-3</c:v>
                  </c:pt>
                  <c:pt idx="2">
                    <c:v>1.0585272788171306E-2</c:v>
                  </c:pt>
                  <c:pt idx="3">
                    <c:v>1.4663492080674372E-2</c:v>
                  </c:pt>
                  <c:pt idx="4">
                    <c:v>1.5162288745436819E-2</c:v>
                  </c:pt>
                  <c:pt idx="5">
                    <c:v>1.3816584237791906E-2</c:v>
                  </c:pt>
                  <c:pt idx="6">
                    <c:v>1.2913674922344933E-2</c:v>
                  </c:pt>
                  <c:pt idx="7">
                    <c:v>1.5800379742272021E-2</c:v>
                  </c:pt>
                  <c:pt idx="8">
                    <c:v>2.2954345993732875E-2</c:v>
                  </c:pt>
                  <c:pt idx="9">
                    <c:v>3.3052564197048322E-2</c:v>
                  </c:pt>
                  <c:pt idx="10">
                    <c:v>4.2496199830102478E-2</c:v>
                  </c:pt>
                  <c:pt idx="11">
                    <c:v>5.3285082340182227E-2</c:v>
                  </c:pt>
                  <c:pt idx="12">
                    <c:v>6.3232112095042328E-2</c:v>
                  </c:pt>
                  <c:pt idx="13">
                    <c:v>7.5889393198259256E-2</c:v>
                  </c:pt>
                  <c:pt idx="14">
                    <c:v>8.4529876375161017E-2</c:v>
                  </c:pt>
                  <c:pt idx="15">
                    <c:v>9.2200867674876036E-2</c:v>
                  </c:pt>
                </c:numCache>
              </c:numRef>
            </c:plus>
            <c:minus>
              <c:numRef>
                <c:f>All!$D$19:$D$34</c:f>
                <c:numCache>
                  <c:formatCode>General</c:formatCode>
                  <c:ptCount val="16"/>
                  <c:pt idx="0">
                    <c:v>1.6180234856144702E-3</c:v>
                  </c:pt>
                  <c:pt idx="1">
                    <c:v>6.2600319488002616E-3</c:v>
                  </c:pt>
                  <c:pt idx="2">
                    <c:v>1.0585272788171306E-2</c:v>
                  </c:pt>
                  <c:pt idx="3">
                    <c:v>1.4663492080674372E-2</c:v>
                  </c:pt>
                  <c:pt idx="4">
                    <c:v>1.5162288745436819E-2</c:v>
                  </c:pt>
                  <c:pt idx="5">
                    <c:v>1.3816584237791906E-2</c:v>
                  </c:pt>
                  <c:pt idx="6">
                    <c:v>1.2913674922344933E-2</c:v>
                  </c:pt>
                  <c:pt idx="7">
                    <c:v>1.5800379742272021E-2</c:v>
                  </c:pt>
                  <c:pt idx="8">
                    <c:v>2.2954345993732875E-2</c:v>
                  </c:pt>
                  <c:pt idx="9">
                    <c:v>3.3052564197048322E-2</c:v>
                  </c:pt>
                  <c:pt idx="10">
                    <c:v>4.2496199830102478E-2</c:v>
                  </c:pt>
                  <c:pt idx="11">
                    <c:v>5.3285082340182227E-2</c:v>
                  </c:pt>
                  <c:pt idx="12">
                    <c:v>6.3232112095042328E-2</c:v>
                  </c:pt>
                  <c:pt idx="13">
                    <c:v>7.5889393198259256E-2</c:v>
                  </c:pt>
                  <c:pt idx="14">
                    <c:v>8.4529876375161017E-2</c:v>
                  </c:pt>
                  <c:pt idx="15">
                    <c:v>9.2200867674876036E-2</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All!$A$2:$A$17</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All!$D$2:$D$17</c:f>
              <c:numCache>
                <c:formatCode>0.0000</c:formatCode>
                <c:ptCount val="16"/>
                <c:pt idx="0">
                  <c:v>6.600000000000001E-4</c:v>
                </c:pt>
                <c:pt idx="1">
                  <c:v>8.796000000000001E-2</c:v>
                </c:pt>
                <c:pt idx="2">
                  <c:v>0.16675999999999996</c:v>
                </c:pt>
                <c:pt idx="3">
                  <c:v>0.25363999999999998</c:v>
                </c:pt>
                <c:pt idx="4">
                  <c:v>0.33179999999999998</c:v>
                </c:pt>
                <c:pt idx="5">
                  <c:v>0.40903999999999996</c:v>
                </c:pt>
                <c:pt idx="6">
                  <c:v>0.47683999999999999</c:v>
                </c:pt>
                <c:pt idx="7">
                  <c:v>0.53471999999999997</c:v>
                </c:pt>
                <c:pt idx="8">
                  <c:v>0.59101999999999999</c:v>
                </c:pt>
                <c:pt idx="9">
                  <c:v>0.64662000000000008</c:v>
                </c:pt>
                <c:pt idx="10">
                  <c:v>0.68957999999999997</c:v>
                </c:pt>
                <c:pt idx="11">
                  <c:v>0.72560000000000002</c:v>
                </c:pt>
                <c:pt idx="12">
                  <c:v>0.76559999999999995</c:v>
                </c:pt>
                <c:pt idx="13">
                  <c:v>0.78680000000000005</c:v>
                </c:pt>
                <c:pt idx="14">
                  <c:v>0.82140000000000002</c:v>
                </c:pt>
                <c:pt idx="15">
                  <c:v>0.84499999999999997</c:v>
                </c:pt>
              </c:numCache>
            </c:numRef>
          </c:yVal>
          <c:smooth val="0"/>
          <c:extLst>
            <c:ext xmlns:c16="http://schemas.microsoft.com/office/drawing/2014/chart" uri="{C3380CC4-5D6E-409C-BE32-E72D297353CC}">
              <c16:uniqueId val="{00000002-06EB-48AD-91FD-DE792FB6AC3C}"/>
            </c:ext>
          </c:extLst>
        </c:ser>
        <c:ser>
          <c:idx val="3"/>
          <c:order val="3"/>
          <c:tx>
            <c:v>Day 7</c:v>
          </c:tx>
          <c:spPr>
            <a:ln w="25400" cap="rnd">
              <a:noFill/>
              <a:round/>
            </a:ln>
            <a:effectLst/>
          </c:spPr>
          <c:marker>
            <c:symbol val="circle"/>
            <c:size val="5"/>
            <c:spPr>
              <a:solidFill>
                <a:schemeClr val="accent4"/>
              </a:solidFill>
              <a:ln w="9525">
                <a:solidFill>
                  <a:schemeClr val="accent4"/>
                </a:solidFill>
              </a:ln>
              <a:effectLst/>
            </c:spPr>
          </c:marker>
          <c:errBars>
            <c:errDir val="x"/>
            <c:errBarType val="both"/>
            <c:errValType val="cust"/>
            <c:noEndCap val="0"/>
            <c:plus>
              <c:numRef>
                <c:f>All!$E$19:$E$34</c:f>
                <c:numCache>
                  <c:formatCode>General</c:formatCode>
                  <c:ptCount val="16"/>
                  <c:pt idx="0">
                    <c:v>1.2603567440000001E-3</c:v>
                  </c:pt>
                  <c:pt idx="1">
                    <c:v>4.0594018719999998E-3</c:v>
                  </c:pt>
                  <c:pt idx="2">
                    <c:v>5.3800453300000004E-3</c:v>
                  </c:pt>
                  <c:pt idx="3">
                    <c:v>9.7377820659999993E-3</c:v>
                  </c:pt>
                  <c:pt idx="4">
                    <c:v>1.4827401259999999E-2</c:v>
                  </c:pt>
                  <c:pt idx="5">
                    <c:v>2.1402313740000001E-2</c:v>
                  </c:pt>
                  <c:pt idx="6">
                    <c:v>2.858030973E-2</c:v>
                  </c:pt>
                  <c:pt idx="7">
                    <c:v>3.2269050319999999E-2</c:v>
                  </c:pt>
                  <c:pt idx="8">
                    <c:v>3.7397578590000001E-2</c:v>
                  </c:pt>
                  <c:pt idx="9">
                    <c:v>4.0211518969999999E-2</c:v>
                  </c:pt>
                  <c:pt idx="10">
                    <c:v>4.8102867530000003E-2</c:v>
                  </c:pt>
                  <c:pt idx="11">
                    <c:v>5.0664816729999999E-2</c:v>
                  </c:pt>
                  <c:pt idx="12">
                    <c:v>5.5223111110000001E-2</c:v>
                  </c:pt>
                  <c:pt idx="13">
                    <c:v>6.3217626939999993E-2</c:v>
                  </c:pt>
                  <c:pt idx="14">
                    <c:v>6.4799796879999996E-2</c:v>
                  </c:pt>
                  <c:pt idx="15">
                    <c:v>6.3908429449999998E-2</c:v>
                  </c:pt>
                </c:numCache>
              </c:numRef>
            </c:plus>
            <c:minus>
              <c:numRef>
                <c:f>All!$E$19:$E$34</c:f>
                <c:numCache>
                  <c:formatCode>General</c:formatCode>
                  <c:ptCount val="16"/>
                  <c:pt idx="0">
                    <c:v>1.2603567440000001E-3</c:v>
                  </c:pt>
                  <c:pt idx="1">
                    <c:v>4.0594018719999998E-3</c:v>
                  </c:pt>
                  <c:pt idx="2">
                    <c:v>5.3800453300000004E-3</c:v>
                  </c:pt>
                  <c:pt idx="3">
                    <c:v>9.7377820659999993E-3</c:v>
                  </c:pt>
                  <c:pt idx="4">
                    <c:v>1.4827401259999999E-2</c:v>
                  </c:pt>
                  <c:pt idx="5">
                    <c:v>2.1402313740000001E-2</c:v>
                  </c:pt>
                  <c:pt idx="6">
                    <c:v>2.858030973E-2</c:v>
                  </c:pt>
                  <c:pt idx="7">
                    <c:v>3.2269050319999999E-2</c:v>
                  </c:pt>
                  <c:pt idx="8">
                    <c:v>3.7397578590000001E-2</c:v>
                  </c:pt>
                  <c:pt idx="9">
                    <c:v>4.0211518969999999E-2</c:v>
                  </c:pt>
                  <c:pt idx="10">
                    <c:v>4.8102867530000003E-2</c:v>
                  </c:pt>
                  <c:pt idx="11">
                    <c:v>5.0664816729999999E-2</c:v>
                  </c:pt>
                  <c:pt idx="12">
                    <c:v>5.5223111110000001E-2</c:v>
                  </c:pt>
                  <c:pt idx="13">
                    <c:v>6.3217626939999993E-2</c:v>
                  </c:pt>
                  <c:pt idx="14">
                    <c:v>6.4799796879999996E-2</c:v>
                  </c:pt>
                  <c:pt idx="15">
                    <c:v>6.3908429449999998E-2</c:v>
                  </c:pt>
                </c:numCache>
              </c:numRef>
            </c:minus>
            <c:spPr>
              <a:noFill/>
              <a:ln w="9525" cap="flat" cmpd="sng" algn="ctr">
                <a:solidFill>
                  <a:schemeClr val="tx1">
                    <a:lumMod val="65000"/>
                    <a:lumOff val="35000"/>
                  </a:schemeClr>
                </a:solidFill>
                <a:round/>
              </a:ln>
              <a:effectLst/>
            </c:spPr>
          </c:errBars>
          <c:errBars>
            <c:errDir val="y"/>
            <c:errBarType val="both"/>
            <c:errValType val="stdErr"/>
            <c:noEndCap val="0"/>
            <c:spPr>
              <a:noFill/>
              <a:ln w="9525" cap="flat" cmpd="sng" algn="ctr">
                <a:solidFill>
                  <a:schemeClr val="tx1">
                    <a:lumMod val="65000"/>
                    <a:lumOff val="35000"/>
                  </a:schemeClr>
                </a:solidFill>
                <a:round/>
              </a:ln>
              <a:effectLst/>
            </c:spPr>
          </c:errBars>
          <c:xVal>
            <c:numRef>
              <c:f>All!$A$2:$A$17</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All!$E$2:$E$17</c:f>
              <c:numCache>
                <c:formatCode>General</c:formatCode>
                <c:ptCount val="16"/>
                <c:pt idx="0">
                  <c:v>-2.7000000000000001E-3</c:v>
                </c:pt>
                <c:pt idx="1">
                  <c:v>8.2299999999999998E-2</c:v>
                </c:pt>
                <c:pt idx="2">
                  <c:v>0.15110000000000001</c:v>
                </c:pt>
                <c:pt idx="3">
                  <c:v>0.20780000000000001</c:v>
                </c:pt>
                <c:pt idx="4">
                  <c:v>0.24959999999999999</c:v>
                </c:pt>
                <c:pt idx="5">
                  <c:v>0.28470000000000001</c:v>
                </c:pt>
                <c:pt idx="6">
                  <c:v>0.31850000000000001</c:v>
                </c:pt>
                <c:pt idx="7">
                  <c:v>0.34610000000000002</c:v>
                </c:pt>
                <c:pt idx="8">
                  <c:v>0.36799999999999999</c:v>
                </c:pt>
                <c:pt idx="9">
                  <c:v>0.40010000000000001</c:v>
                </c:pt>
                <c:pt idx="10">
                  <c:v>0.4199</c:v>
                </c:pt>
                <c:pt idx="11" formatCode="0.00E+00">
                  <c:v>0.437</c:v>
                </c:pt>
                <c:pt idx="12" formatCode="0.00E+00">
                  <c:v>0.45300000000000001</c:v>
                </c:pt>
                <c:pt idx="13" formatCode="0.00E+00">
                  <c:v>0.46200000000000002</c:v>
                </c:pt>
                <c:pt idx="14" formatCode="0.00E+00">
                  <c:v>0.47499999999999998</c:v>
                </c:pt>
                <c:pt idx="15" formatCode="0.00E+00">
                  <c:v>0.48499999999999999</c:v>
                </c:pt>
              </c:numCache>
            </c:numRef>
          </c:yVal>
          <c:smooth val="0"/>
          <c:extLst>
            <c:ext xmlns:c16="http://schemas.microsoft.com/office/drawing/2014/chart" uri="{C3380CC4-5D6E-409C-BE32-E72D297353CC}">
              <c16:uniqueId val="{00000003-06EB-48AD-91FD-DE792FB6AC3C}"/>
            </c:ext>
          </c:extLst>
        </c:ser>
        <c:dLbls>
          <c:showLegendKey val="0"/>
          <c:showVal val="0"/>
          <c:showCatName val="0"/>
          <c:showSerName val="0"/>
          <c:showPercent val="0"/>
          <c:showBubbleSize val="0"/>
        </c:dLbls>
        <c:axId val="2134876783"/>
        <c:axId val="1998076047"/>
      </c:scatterChart>
      <c:valAx>
        <c:axId val="2134876783"/>
        <c:scaling>
          <c:orientation val="minMax"/>
          <c:max val="650"/>
          <c:min val="0"/>
        </c:scaling>
        <c:delete val="0"/>
        <c:axPos val="b"/>
        <c:title>
          <c:tx>
            <c:rich>
              <a:bodyPr rot="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r>
                  <a:rPr lang="en-US" sz="1600"/>
                  <a:t>Xanthine Concentration (uM)</a:t>
                </a:r>
              </a:p>
            </c:rich>
          </c:tx>
          <c:overlay val="0"/>
          <c:spPr>
            <a:noFill/>
            <a:ln>
              <a:noFill/>
            </a:ln>
            <a:effectLst/>
          </c:spPr>
          <c:txPr>
            <a:bodyPr rot="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998076047"/>
        <c:crosses val="autoZero"/>
        <c:crossBetween val="midCat"/>
        <c:majorUnit val="100"/>
      </c:valAx>
      <c:valAx>
        <c:axId val="1998076047"/>
        <c:scaling>
          <c:orientation val="minMax"/>
          <c:min val="0"/>
        </c:scaling>
        <c:delete val="0"/>
        <c:axPos val="l"/>
        <c:title>
          <c:tx>
            <c:rich>
              <a:bodyPr rot="-540000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r>
                  <a:rPr lang="en-US" sz="1600"/>
                  <a:t>Current (uA)</a:t>
                </a:r>
              </a:p>
            </c:rich>
          </c:tx>
          <c:overlay val="0"/>
          <c:spPr>
            <a:noFill/>
            <a:ln>
              <a:noFill/>
            </a:ln>
            <a:effectLst/>
          </c:spPr>
          <c:txPr>
            <a:bodyPr rot="-540000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0.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134876783"/>
        <c:crosses val="autoZero"/>
        <c:crossBetween val="midCat"/>
      </c:valAx>
      <c:spPr>
        <a:noFill/>
        <a:ln>
          <a:noFill/>
        </a:ln>
        <a:effectLst/>
      </c:spPr>
    </c:plotArea>
    <c:legend>
      <c:legendPos val="b"/>
      <c:layout>
        <c:manualLayout>
          <c:xMode val="edge"/>
          <c:yMode val="edge"/>
          <c:x val="0.1871221363746686"/>
          <c:y val="0.10620684842352147"/>
          <c:w val="0.11696402313410621"/>
          <c:h val="0.25412958026819021"/>
        </c:manualLayout>
      </c:layout>
      <c:overlay val="0"/>
      <c:spPr>
        <a:noFill/>
        <a:ln>
          <a:solidFill>
            <a:schemeClr val="bg1">
              <a:lumMod val="75000"/>
            </a:schemeClr>
          </a:solidFill>
        </a:ln>
        <a:effectLst/>
      </c:spPr>
      <c:txPr>
        <a:bodyPr rot="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131596355333633"/>
          <c:y val="3.6657531105552067E-2"/>
          <c:w val="0.84416277233638481"/>
          <c:h val="0.71649202124769129"/>
        </c:manualLayout>
      </c:layout>
      <c:scatterChart>
        <c:scatterStyle val="lineMarker"/>
        <c:varyColors val="0"/>
        <c:ser>
          <c:idx val="0"/>
          <c:order val="0"/>
          <c:tx>
            <c:strRef>
              <c:f>Sheet1!$M$21</c:f>
              <c:strCache>
                <c:ptCount val="1"/>
                <c:pt idx="0">
                  <c:v>Hypoxanthine</c:v>
                </c:pt>
              </c:strCache>
            </c:strRef>
          </c:tx>
          <c:spPr>
            <a:ln w="19050" cap="rnd">
              <a:noFill/>
              <a:round/>
            </a:ln>
            <a:effectLst/>
          </c:spPr>
          <c:marker>
            <c:symbol val="circle"/>
            <c:size val="8"/>
            <c:spPr>
              <a:noFill/>
              <a:ln w="9525">
                <a:solidFill>
                  <a:srgbClr val="FF0000"/>
                </a:solidFill>
              </a:ln>
              <a:effectLst/>
            </c:spPr>
          </c:marker>
          <c:errBars>
            <c:errDir val="y"/>
            <c:errBarType val="both"/>
            <c:errValType val="cust"/>
            <c:noEndCap val="0"/>
            <c:plus>
              <c:numRef>
                <c:f>Sheet1!$K$5:$K$20</c:f>
                <c:numCache>
                  <c:formatCode>General</c:formatCode>
                  <c:ptCount val="16"/>
                  <c:pt idx="0">
                    <c:v>4.5499371457840224E-3</c:v>
                  </c:pt>
                  <c:pt idx="1">
                    <c:v>3.2120735023183564E-2</c:v>
                  </c:pt>
                  <c:pt idx="2">
                    <c:v>2.417604502039479E-2</c:v>
                  </c:pt>
                  <c:pt idx="3">
                    <c:v>2.5911113623971971E-2</c:v>
                  </c:pt>
                  <c:pt idx="4">
                    <c:v>2.9660156206426033E-2</c:v>
                  </c:pt>
                  <c:pt idx="5">
                    <c:v>3.2627496894079705E-2</c:v>
                  </c:pt>
                  <c:pt idx="6">
                    <c:v>3.8383523202615719E-2</c:v>
                  </c:pt>
                  <c:pt idx="7">
                    <c:v>4.5638667463525649E-2</c:v>
                  </c:pt>
                  <c:pt idx="8">
                    <c:v>5.0717820922062978E-2</c:v>
                  </c:pt>
                  <c:pt idx="9">
                    <c:v>5.5484872332370268E-2</c:v>
                  </c:pt>
                  <c:pt idx="10">
                    <c:v>5.8419383816079716E-2</c:v>
                  </c:pt>
                  <c:pt idx="11">
                    <c:v>6.1644610614727799E-2</c:v>
                  </c:pt>
                  <c:pt idx="12">
                    <c:v>6.6721659166871228E-2</c:v>
                  </c:pt>
                  <c:pt idx="13">
                    <c:v>6.8593985091310289E-2</c:v>
                  </c:pt>
                  <c:pt idx="14">
                    <c:v>7.2560313655148326E-2</c:v>
                  </c:pt>
                  <c:pt idx="15">
                    <c:v>7.5796822610264838E-2</c:v>
                  </c:pt>
                </c:numCache>
              </c:numRef>
            </c:plus>
            <c:minus>
              <c:numRef>
                <c:f>Sheet1!$K$5:$K$20</c:f>
                <c:numCache>
                  <c:formatCode>General</c:formatCode>
                  <c:ptCount val="16"/>
                  <c:pt idx="0">
                    <c:v>4.5499371457840224E-3</c:v>
                  </c:pt>
                  <c:pt idx="1">
                    <c:v>3.2120735023183564E-2</c:v>
                  </c:pt>
                  <c:pt idx="2">
                    <c:v>2.417604502039479E-2</c:v>
                  </c:pt>
                  <c:pt idx="3">
                    <c:v>2.5911113623971971E-2</c:v>
                  </c:pt>
                  <c:pt idx="4">
                    <c:v>2.9660156206426033E-2</c:v>
                  </c:pt>
                  <c:pt idx="5">
                    <c:v>3.2627496894079705E-2</c:v>
                  </c:pt>
                  <c:pt idx="6">
                    <c:v>3.8383523202615719E-2</c:v>
                  </c:pt>
                  <c:pt idx="7">
                    <c:v>4.5638667463525649E-2</c:v>
                  </c:pt>
                  <c:pt idx="8">
                    <c:v>5.0717820922062978E-2</c:v>
                  </c:pt>
                  <c:pt idx="9">
                    <c:v>5.5484872332370268E-2</c:v>
                  </c:pt>
                  <c:pt idx="10">
                    <c:v>5.8419383816079716E-2</c:v>
                  </c:pt>
                  <c:pt idx="11">
                    <c:v>6.1644610614727799E-2</c:v>
                  </c:pt>
                  <c:pt idx="12">
                    <c:v>6.6721659166871228E-2</c:v>
                  </c:pt>
                  <c:pt idx="13">
                    <c:v>6.8593985091310289E-2</c:v>
                  </c:pt>
                  <c:pt idx="14">
                    <c:v>7.2560313655148326E-2</c:v>
                  </c:pt>
                  <c:pt idx="15">
                    <c:v>7.5796822610264838E-2</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Sheet1!$L$22:$L$37</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Sheet1!$M$22:$M$37</c:f>
              <c:numCache>
                <c:formatCode>0.0000</c:formatCode>
                <c:ptCount val="16"/>
                <c:pt idx="0">
                  <c:v>3.6099999999999986E-3</c:v>
                </c:pt>
                <c:pt idx="1">
                  <c:v>0.10614673267326732</c:v>
                </c:pt>
                <c:pt idx="2">
                  <c:v>0.18579801980198013</c:v>
                </c:pt>
                <c:pt idx="3">
                  <c:v>0.27582772277227724</c:v>
                </c:pt>
                <c:pt idx="4">
                  <c:v>0.36618019801980201</c:v>
                </c:pt>
                <c:pt idx="5">
                  <c:v>0.44382178217821783</c:v>
                </c:pt>
                <c:pt idx="6">
                  <c:v>0.53644554455445537</c:v>
                </c:pt>
                <c:pt idx="7">
                  <c:v>0.64456237623762369</c:v>
                </c:pt>
                <c:pt idx="8">
                  <c:v>0.74086336633663374</c:v>
                </c:pt>
                <c:pt idx="9">
                  <c:v>0.83388316831683151</c:v>
                </c:pt>
                <c:pt idx="10">
                  <c:v>0.92530891089108902</c:v>
                </c:pt>
                <c:pt idx="11">
                  <c:v>1.0123900990099011</c:v>
                </c:pt>
                <c:pt idx="12">
                  <c:v>1.1003584158415838</c:v>
                </c:pt>
                <c:pt idx="13">
                  <c:v>1.1770297029702981</c:v>
                </c:pt>
                <c:pt idx="14">
                  <c:v>1.2593861386138621</c:v>
                </c:pt>
                <c:pt idx="15">
                  <c:v>1.3304950495049517</c:v>
                </c:pt>
              </c:numCache>
            </c:numRef>
          </c:yVal>
          <c:smooth val="0"/>
          <c:extLst>
            <c:ext xmlns:c16="http://schemas.microsoft.com/office/drawing/2014/chart" uri="{C3380CC4-5D6E-409C-BE32-E72D297353CC}">
              <c16:uniqueId val="{00000000-07F8-4364-AE3E-63E34B4182F5}"/>
            </c:ext>
          </c:extLst>
        </c:ser>
        <c:ser>
          <c:idx val="1"/>
          <c:order val="1"/>
          <c:tx>
            <c:strRef>
              <c:f>Sheet1!$N$21</c:f>
              <c:strCache>
                <c:ptCount val="1"/>
                <c:pt idx="0">
                  <c:v>Xanthine</c:v>
                </c:pt>
              </c:strCache>
            </c:strRef>
          </c:tx>
          <c:spPr>
            <a:ln w="19050" cap="rnd">
              <a:noFill/>
              <a:round/>
            </a:ln>
            <a:effectLst/>
          </c:spPr>
          <c:marker>
            <c:symbol val="circle"/>
            <c:size val="8"/>
            <c:spPr>
              <a:solidFill>
                <a:schemeClr val="tx1"/>
              </a:solidFill>
              <a:ln w="9525">
                <a:noFill/>
              </a:ln>
              <a:effectLst/>
            </c:spPr>
          </c:marker>
          <c:errBars>
            <c:errDir val="y"/>
            <c:errBarType val="both"/>
            <c:errValType val="cust"/>
            <c:noEndCap val="0"/>
            <c:plus>
              <c:numRef>
                <c:f>Sheet1!$M$5:$M$20</c:f>
                <c:numCache>
                  <c:formatCode>General</c:formatCode>
                  <c:ptCount val="16"/>
                  <c:pt idx="0">
                    <c:v>2.0969693059999998E-3</c:v>
                  </c:pt>
                  <c:pt idx="1">
                    <c:v>6.1181736769999997E-3</c:v>
                  </c:pt>
                  <c:pt idx="2">
                    <c:v>1.5926794349999999E-2</c:v>
                  </c:pt>
                  <c:pt idx="3">
                    <c:v>2.7879390810000002E-2</c:v>
                  </c:pt>
                  <c:pt idx="4">
                    <c:v>4.1567103209999998E-2</c:v>
                  </c:pt>
                  <c:pt idx="5">
                    <c:v>5.6047530310000003E-2</c:v>
                  </c:pt>
                  <c:pt idx="6">
                    <c:v>6.9217637200000001E-2</c:v>
                  </c:pt>
                  <c:pt idx="7">
                    <c:v>7.8117331109999993E-2</c:v>
                  </c:pt>
                  <c:pt idx="8">
                    <c:v>8.2325861449999996E-2</c:v>
                  </c:pt>
                  <c:pt idx="9">
                    <c:v>8.2717582780000007E-2</c:v>
                  </c:pt>
                  <c:pt idx="10">
                    <c:v>8.1867418959999994E-2</c:v>
                  </c:pt>
                  <c:pt idx="11">
                    <c:v>8.0252069960000005E-2</c:v>
                  </c:pt>
                  <c:pt idx="12">
                    <c:v>7.8603567959999995E-2</c:v>
                  </c:pt>
                  <c:pt idx="13">
                    <c:v>7.8404089529999998E-2</c:v>
                  </c:pt>
                  <c:pt idx="14">
                    <c:v>7.6291481549999998E-2</c:v>
                  </c:pt>
                  <c:pt idx="15">
                    <c:v>7.7305305029999993E-2</c:v>
                  </c:pt>
                </c:numCache>
              </c:numRef>
            </c:plus>
            <c:minus>
              <c:numRef>
                <c:f>Sheet1!$M$5:$M$20</c:f>
                <c:numCache>
                  <c:formatCode>General</c:formatCode>
                  <c:ptCount val="16"/>
                  <c:pt idx="0">
                    <c:v>2.0969693059999998E-3</c:v>
                  </c:pt>
                  <c:pt idx="1">
                    <c:v>6.1181736769999997E-3</c:v>
                  </c:pt>
                  <c:pt idx="2">
                    <c:v>1.5926794349999999E-2</c:v>
                  </c:pt>
                  <c:pt idx="3">
                    <c:v>2.7879390810000002E-2</c:v>
                  </c:pt>
                  <c:pt idx="4">
                    <c:v>4.1567103209999998E-2</c:v>
                  </c:pt>
                  <c:pt idx="5">
                    <c:v>5.6047530310000003E-2</c:v>
                  </c:pt>
                  <c:pt idx="6">
                    <c:v>6.9217637200000001E-2</c:v>
                  </c:pt>
                  <c:pt idx="7">
                    <c:v>7.8117331109999993E-2</c:v>
                  </c:pt>
                  <c:pt idx="8">
                    <c:v>8.2325861449999996E-2</c:v>
                  </c:pt>
                  <c:pt idx="9">
                    <c:v>8.2717582780000007E-2</c:v>
                  </c:pt>
                  <c:pt idx="10">
                    <c:v>8.1867418959999994E-2</c:v>
                  </c:pt>
                  <c:pt idx="11">
                    <c:v>8.0252069960000005E-2</c:v>
                  </c:pt>
                  <c:pt idx="12">
                    <c:v>7.8603567959999995E-2</c:v>
                  </c:pt>
                  <c:pt idx="13">
                    <c:v>7.8404089529999998E-2</c:v>
                  </c:pt>
                  <c:pt idx="14">
                    <c:v>7.6291481549999998E-2</c:v>
                  </c:pt>
                  <c:pt idx="15">
                    <c:v>7.7305305029999993E-2</c:v>
                  </c:pt>
                </c:numCache>
              </c:numRef>
            </c:minus>
            <c:spPr>
              <a:noFill/>
              <a:ln w="9525" cap="flat" cmpd="sng" algn="ctr">
                <a:solidFill>
                  <a:schemeClr val="tx1">
                    <a:lumMod val="65000"/>
                    <a:lumOff val="35000"/>
                  </a:schemeClr>
                </a:solidFill>
                <a:round/>
              </a:ln>
              <a:effectLst/>
            </c:spPr>
          </c:errBars>
          <c:errBars>
            <c:errDir val="x"/>
            <c:errBarType val="both"/>
            <c:errValType val="fixedVal"/>
            <c:noEndCap val="0"/>
            <c:val val="1"/>
            <c:spPr>
              <a:noFill/>
              <a:ln w="9525" cap="flat" cmpd="sng" algn="ctr">
                <a:solidFill>
                  <a:schemeClr val="tx1">
                    <a:lumMod val="65000"/>
                    <a:lumOff val="35000"/>
                  </a:schemeClr>
                </a:solidFill>
                <a:round/>
              </a:ln>
              <a:effectLst/>
            </c:spPr>
          </c:errBars>
          <c:xVal>
            <c:numRef>
              <c:f>Sheet1!$L$22:$L$37</c:f>
              <c:numCache>
                <c:formatCode>General</c:formatCode>
                <c:ptCount val="16"/>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pt idx="11">
                  <c:v>440.87100809999998</c:v>
                </c:pt>
                <c:pt idx="12">
                  <c:v>480.71217339999998</c:v>
                </c:pt>
                <c:pt idx="13">
                  <c:v>520.51400880000006</c:v>
                </c:pt>
                <c:pt idx="14">
                  <c:v>560.27659189999997</c:v>
                </c:pt>
                <c:pt idx="15">
                  <c:v>600</c:v>
                </c:pt>
              </c:numCache>
            </c:numRef>
          </c:xVal>
          <c:yVal>
            <c:numRef>
              <c:f>Sheet1!$N$22:$N$37</c:f>
              <c:numCache>
                <c:formatCode>General</c:formatCode>
                <c:ptCount val="16"/>
                <c:pt idx="0">
                  <c:v>5.1999999999999998E-3</c:v>
                </c:pt>
                <c:pt idx="1">
                  <c:v>0.15129999999999999</c:v>
                </c:pt>
                <c:pt idx="2">
                  <c:v>0.27950000000000003</c:v>
                </c:pt>
                <c:pt idx="3">
                  <c:v>0.40179999999999999</c:v>
                </c:pt>
                <c:pt idx="4">
                  <c:v>0.51949999999999996</c:v>
                </c:pt>
                <c:pt idx="5">
                  <c:v>0.63239999999999996</c:v>
                </c:pt>
                <c:pt idx="6">
                  <c:v>0.74180000000000001</c:v>
                </c:pt>
                <c:pt idx="7">
                  <c:v>0.85040000000000004</c:v>
                </c:pt>
                <c:pt idx="8">
                  <c:v>0.95209999999999995</c:v>
                </c:pt>
                <c:pt idx="9">
                  <c:v>1.0542</c:v>
                </c:pt>
                <c:pt idx="10">
                  <c:v>1.1499999999999999</c:v>
                </c:pt>
                <c:pt idx="11">
                  <c:v>1.2452000000000001</c:v>
                </c:pt>
                <c:pt idx="12">
                  <c:v>1.3363</c:v>
                </c:pt>
                <c:pt idx="13">
                  <c:v>1.4068000000000001</c:v>
                </c:pt>
                <c:pt idx="14">
                  <c:v>1.4752000000000001</c:v>
                </c:pt>
                <c:pt idx="15">
                  <c:v>1.5361</c:v>
                </c:pt>
              </c:numCache>
            </c:numRef>
          </c:yVal>
          <c:smooth val="0"/>
          <c:extLst>
            <c:ext xmlns:c16="http://schemas.microsoft.com/office/drawing/2014/chart" uri="{C3380CC4-5D6E-409C-BE32-E72D297353CC}">
              <c16:uniqueId val="{00000001-07F8-4364-AE3E-63E34B4182F5}"/>
            </c:ext>
          </c:extLst>
        </c:ser>
        <c:ser>
          <c:idx val="2"/>
          <c:order val="2"/>
          <c:tx>
            <c:v>Regression</c:v>
          </c:tx>
          <c:spPr>
            <a:ln w="25400" cap="rnd">
              <a:noFill/>
              <a:round/>
            </a:ln>
            <a:effectLst/>
          </c:spPr>
          <c:marker>
            <c:symbol val="none"/>
          </c:marker>
          <c:trendline>
            <c:spPr>
              <a:ln w="19050" cap="rnd">
                <a:solidFill>
                  <a:schemeClr val="bg1">
                    <a:lumMod val="50000"/>
                  </a:schemeClr>
                </a:solidFill>
                <a:prstDash val="sysDot"/>
              </a:ln>
              <a:effectLst/>
            </c:spPr>
            <c:trendlineType val="linear"/>
            <c:dispRSqr val="1"/>
            <c:dispEq val="1"/>
            <c:trendlineLbl>
              <c:layout>
                <c:manualLayout>
                  <c:x val="3.7398089466458971E-2"/>
                  <c:y val="0.15863378717062063"/>
                </c:manualLayout>
              </c:layout>
              <c:numFmt formatCode="General" sourceLinked="0"/>
              <c:spPr>
                <a:noFill/>
                <a:ln>
                  <a:noFill/>
                </a:ln>
                <a:effectLst/>
              </c:spPr>
              <c:txPr>
                <a:bodyPr rot="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rendlineLbl>
          </c:trendline>
          <c:xVal>
            <c:numRef>
              <c:f>Sheet1!$L$22:$L$32</c:f>
              <c:numCache>
                <c:formatCode>General</c:formatCode>
                <c:ptCount val="11"/>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numCache>
            </c:numRef>
          </c:xVal>
          <c:yVal>
            <c:numRef>
              <c:f>Sheet1!$M$22:$M$32</c:f>
              <c:numCache>
                <c:formatCode>0.0000</c:formatCode>
                <c:ptCount val="11"/>
                <c:pt idx="0">
                  <c:v>3.6099999999999986E-3</c:v>
                </c:pt>
                <c:pt idx="1">
                  <c:v>0.10614673267326732</c:v>
                </c:pt>
                <c:pt idx="2">
                  <c:v>0.18579801980198013</c:v>
                </c:pt>
                <c:pt idx="3">
                  <c:v>0.27582772277227724</c:v>
                </c:pt>
                <c:pt idx="4">
                  <c:v>0.36618019801980201</c:v>
                </c:pt>
                <c:pt idx="5">
                  <c:v>0.44382178217821783</c:v>
                </c:pt>
                <c:pt idx="6">
                  <c:v>0.53644554455445537</c:v>
                </c:pt>
                <c:pt idx="7">
                  <c:v>0.64456237623762369</c:v>
                </c:pt>
                <c:pt idx="8">
                  <c:v>0.74086336633663374</c:v>
                </c:pt>
                <c:pt idx="9">
                  <c:v>0.83388316831683151</c:v>
                </c:pt>
                <c:pt idx="10">
                  <c:v>0.92530891089108902</c:v>
                </c:pt>
              </c:numCache>
            </c:numRef>
          </c:yVal>
          <c:smooth val="0"/>
          <c:extLst>
            <c:ext xmlns:c16="http://schemas.microsoft.com/office/drawing/2014/chart" uri="{C3380CC4-5D6E-409C-BE32-E72D297353CC}">
              <c16:uniqueId val="{00000003-07F8-4364-AE3E-63E34B4182F5}"/>
            </c:ext>
          </c:extLst>
        </c:ser>
        <c:ser>
          <c:idx val="3"/>
          <c:order val="3"/>
          <c:tx>
            <c:v>Regression-XAN</c:v>
          </c:tx>
          <c:spPr>
            <a:ln w="25400" cap="rnd">
              <a:noFill/>
              <a:round/>
            </a:ln>
            <a:effectLst/>
          </c:spPr>
          <c:marker>
            <c:symbol val="none"/>
          </c:marker>
          <c:trendline>
            <c:spPr>
              <a:ln w="19050" cap="rnd">
                <a:solidFill>
                  <a:schemeClr val="bg1">
                    <a:lumMod val="50000"/>
                  </a:schemeClr>
                </a:solidFill>
                <a:prstDash val="sysDot"/>
              </a:ln>
              <a:effectLst/>
            </c:spPr>
            <c:trendlineType val="linear"/>
            <c:dispRSqr val="1"/>
            <c:dispEq val="1"/>
            <c:trendlineLbl>
              <c:layout>
                <c:manualLayout>
                  <c:x val="1.3911187930776945E-2"/>
                  <c:y val="-3.81036220251623E-2"/>
                </c:manualLayout>
              </c:layout>
              <c:numFmt formatCode="General" sourceLinked="0"/>
              <c:spPr>
                <a:noFill/>
                <a:ln>
                  <a:noFill/>
                </a:ln>
                <a:effectLst/>
              </c:spPr>
              <c:txPr>
                <a:bodyPr rot="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rendlineLbl>
          </c:trendline>
          <c:xVal>
            <c:numRef>
              <c:f>Sheet1!$L$22:$L$32</c:f>
              <c:numCache>
                <c:formatCode>General</c:formatCode>
                <c:ptCount val="11"/>
                <c:pt idx="0">
                  <c:v>0</c:v>
                </c:pt>
                <c:pt idx="1">
                  <c:v>40.278980269999998</c:v>
                </c:pt>
                <c:pt idx="2">
                  <c:v>80.517761949999993</c:v>
                </c:pt>
                <c:pt idx="3">
                  <c:v>120.7164252</c:v>
                </c:pt>
                <c:pt idx="4">
                  <c:v>160.87504999999999</c:v>
                </c:pt>
                <c:pt idx="5">
                  <c:v>200.99371590000001</c:v>
                </c:pt>
                <c:pt idx="6">
                  <c:v>241.07250239999999</c:v>
                </c:pt>
                <c:pt idx="7">
                  <c:v>281.11148880000002</c:v>
                </c:pt>
                <c:pt idx="8">
                  <c:v>321.11075390000002</c:v>
                </c:pt>
                <c:pt idx="9">
                  <c:v>361.07037650000001</c:v>
                </c:pt>
                <c:pt idx="10">
                  <c:v>400.99043519999998</c:v>
                </c:pt>
              </c:numCache>
            </c:numRef>
          </c:xVal>
          <c:yVal>
            <c:numRef>
              <c:f>Sheet1!$N$22:$N$32</c:f>
              <c:numCache>
                <c:formatCode>General</c:formatCode>
                <c:ptCount val="11"/>
                <c:pt idx="0">
                  <c:v>5.1999999999999998E-3</c:v>
                </c:pt>
                <c:pt idx="1">
                  <c:v>0.15129999999999999</c:v>
                </c:pt>
                <c:pt idx="2">
                  <c:v>0.27950000000000003</c:v>
                </c:pt>
                <c:pt idx="3">
                  <c:v>0.40179999999999999</c:v>
                </c:pt>
                <c:pt idx="4">
                  <c:v>0.51949999999999996</c:v>
                </c:pt>
                <c:pt idx="5">
                  <c:v>0.63239999999999996</c:v>
                </c:pt>
                <c:pt idx="6">
                  <c:v>0.74180000000000001</c:v>
                </c:pt>
                <c:pt idx="7">
                  <c:v>0.85040000000000004</c:v>
                </c:pt>
                <c:pt idx="8">
                  <c:v>0.95209999999999995</c:v>
                </c:pt>
                <c:pt idx="9">
                  <c:v>1.0542</c:v>
                </c:pt>
                <c:pt idx="10">
                  <c:v>1.1499999999999999</c:v>
                </c:pt>
              </c:numCache>
            </c:numRef>
          </c:yVal>
          <c:smooth val="0"/>
          <c:extLst>
            <c:ext xmlns:c16="http://schemas.microsoft.com/office/drawing/2014/chart" uri="{C3380CC4-5D6E-409C-BE32-E72D297353CC}">
              <c16:uniqueId val="{00000005-07F8-4364-AE3E-63E34B4182F5}"/>
            </c:ext>
          </c:extLst>
        </c:ser>
        <c:dLbls>
          <c:showLegendKey val="0"/>
          <c:showVal val="0"/>
          <c:showCatName val="0"/>
          <c:showSerName val="0"/>
          <c:showPercent val="0"/>
          <c:showBubbleSize val="0"/>
        </c:dLbls>
        <c:axId val="63890384"/>
        <c:axId val="856220799"/>
      </c:scatterChart>
      <c:valAx>
        <c:axId val="63890384"/>
        <c:scaling>
          <c:orientation val="minMax"/>
          <c:max val="650"/>
          <c:min val="0"/>
        </c:scaling>
        <c:delete val="0"/>
        <c:axPos val="b"/>
        <c:title>
          <c:tx>
            <c:rich>
              <a:bodyPr rot="0" spcFirstLastPara="1" vertOverflow="ellipsis" vert="horz" wrap="square" anchor="ctr" anchorCtr="1"/>
              <a:lstStyle/>
              <a:p>
                <a:pPr>
                  <a:defRPr sz="16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600" b="1">
                    <a:solidFill>
                      <a:sysClr val="windowText" lastClr="000000"/>
                    </a:solidFill>
                  </a:rPr>
                  <a:t>Concentration (</a:t>
                </a:r>
                <a:r>
                  <a:rPr lang="el-GR" sz="1600" b="1">
                    <a:solidFill>
                      <a:sysClr val="windowText" lastClr="000000"/>
                    </a:solidFill>
                  </a:rPr>
                  <a:t>μ</a:t>
                </a:r>
                <a:r>
                  <a:rPr lang="en-US" sz="1600" b="1">
                    <a:solidFill>
                      <a:sysClr val="windowText" lastClr="000000"/>
                    </a:solidFill>
                  </a:rPr>
                  <a:t>M)</a:t>
                </a:r>
              </a:p>
            </c:rich>
          </c:tx>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856220799"/>
        <c:crosses val="autoZero"/>
        <c:crossBetween val="midCat"/>
      </c:valAx>
      <c:valAx>
        <c:axId val="856220799"/>
        <c:scaling>
          <c:orientation val="minMax"/>
          <c:min val="0"/>
        </c:scaling>
        <c:delete val="0"/>
        <c:axPos val="l"/>
        <c:title>
          <c:tx>
            <c:rich>
              <a:bodyPr rot="-5400000" spcFirstLastPara="1" vertOverflow="ellipsis" vert="horz" wrap="square" anchor="ctr" anchorCtr="1"/>
              <a:lstStyle/>
              <a:p>
                <a:pPr>
                  <a:defRPr sz="16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600" b="1">
                    <a:solidFill>
                      <a:sysClr val="windowText" lastClr="000000"/>
                    </a:solidFill>
                  </a:rPr>
                  <a:t>Current (</a:t>
                </a:r>
                <a:r>
                  <a:rPr lang="el-GR" sz="1600" b="1">
                    <a:solidFill>
                      <a:sysClr val="windowText" lastClr="000000"/>
                    </a:solidFill>
                  </a:rPr>
                  <a:t>μ</a:t>
                </a:r>
                <a:r>
                  <a:rPr lang="en-US" sz="1600" b="1">
                    <a:solidFill>
                      <a:sysClr val="windowText" lastClr="000000"/>
                    </a:solidFill>
                  </a:rPr>
                  <a:t>A)</a:t>
                </a:r>
              </a:p>
            </c:rich>
          </c:tx>
          <c:overlay val="0"/>
          <c:spPr>
            <a:noFill/>
            <a:ln>
              <a:noFill/>
            </a:ln>
            <a:effectLst/>
          </c:spPr>
          <c:txPr>
            <a:bodyPr rot="-5400000" spcFirstLastPara="1" vertOverflow="ellipsis" vert="horz" wrap="square" anchor="ctr" anchorCtr="1"/>
            <a:lstStyle/>
            <a:p>
              <a:pPr>
                <a:defRPr sz="16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63890384"/>
        <c:crosses val="autoZero"/>
        <c:crossBetween val="midCat"/>
      </c:valAx>
      <c:spPr>
        <a:noFill/>
        <a:ln>
          <a:noFill/>
        </a:ln>
        <a:effectLst/>
      </c:spPr>
    </c:plotArea>
    <c:legend>
      <c:legendPos val="b"/>
      <c:layout>
        <c:manualLayout>
          <c:xMode val="edge"/>
          <c:yMode val="edge"/>
          <c:x val="0.13859732980531908"/>
          <c:y val="8.119078107449286E-2"/>
          <c:w val="0.30468102056348645"/>
          <c:h val="0.23157954853237542"/>
        </c:manualLayout>
      </c:layout>
      <c:overlay val="0"/>
      <c:spPr>
        <a:noFill/>
        <a:ln>
          <a:solidFill>
            <a:sysClr val="windowText" lastClr="000000"/>
          </a:solidFill>
        </a:ln>
        <a:effectLst/>
      </c:spPr>
      <c:txPr>
        <a:bodyPr rot="0" spcFirstLastPara="1" vertOverflow="ellipsis" vert="horz" wrap="square" anchor="ctr" anchorCtr="1"/>
        <a:lstStyle/>
        <a:p>
          <a:pPr>
            <a:defRPr sz="16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B08CDC13-FF64-C896-5233-F691DE476807}"/>
              </a:ext>
            </a:extLst>
          </p:cNvPr>
          <p:cNvSpPr>
            <a:spLocks noGrp="1"/>
          </p:cNvSpPr>
          <p:nvPr>
            <p:ph type="hdr" sz="quarter"/>
          </p:nvPr>
        </p:nvSpPr>
        <p:spPr>
          <a:xfrm>
            <a:off x="1" y="1"/>
            <a:ext cx="3038475" cy="466725"/>
          </a:xfrm>
          <a:prstGeom prst="rect">
            <a:avLst/>
          </a:prstGeom>
        </p:spPr>
        <p:txBody>
          <a:bodyPr vert="horz" lIns="91431" tIns="45716" rIns="91431" bIns="45716" rtlCol="0"/>
          <a:lstStyle>
            <a:lvl1pPr algn="l">
              <a:defRPr sz="1200"/>
            </a:lvl1pPr>
          </a:lstStyle>
          <a:p>
            <a:endParaRPr lang="en-US"/>
          </a:p>
        </p:txBody>
      </p:sp>
      <p:sp>
        <p:nvSpPr>
          <p:cNvPr id="3" name="Date Placeholder 2">
            <a:extLst>
              <a:ext uri="{FF2B5EF4-FFF2-40B4-BE49-F238E27FC236}">
                <a16:creationId xmlns:a16="http://schemas.microsoft.com/office/drawing/2014/main" id="{D8F9642B-64E1-BB65-ED89-4351D53A9215}"/>
              </a:ext>
            </a:extLst>
          </p:cNvPr>
          <p:cNvSpPr>
            <a:spLocks noGrp="1"/>
          </p:cNvSpPr>
          <p:nvPr>
            <p:ph type="dt" sz="quarter" idx="1"/>
          </p:nvPr>
        </p:nvSpPr>
        <p:spPr>
          <a:xfrm>
            <a:off x="3970339" y="1"/>
            <a:ext cx="3038475" cy="466725"/>
          </a:xfrm>
          <a:prstGeom prst="rect">
            <a:avLst/>
          </a:prstGeom>
        </p:spPr>
        <p:txBody>
          <a:bodyPr vert="horz" lIns="91431" tIns="45716" rIns="91431" bIns="45716" rtlCol="0"/>
          <a:lstStyle>
            <a:lvl1pPr algn="r">
              <a:defRPr sz="1200"/>
            </a:lvl1pPr>
          </a:lstStyle>
          <a:p>
            <a:fld id="{57BE253F-964B-44B0-BFBA-F78D558D622A}" type="datetimeFigureOut">
              <a:rPr lang="en-US" smtClean="0"/>
              <a:t>5/24/2023</a:t>
            </a:fld>
            <a:endParaRPr lang="en-US"/>
          </a:p>
        </p:txBody>
      </p:sp>
      <p:sp>
        <p:nvSpPr>
          <p:cNvPr id="4" name="Footer Placeholder 3">
            <a:extLst>
              <a:ext uri="{FF2B5EF4-FFF2-40B4-BE49-F238E27FC236}">
                <a16:creationId xmlns:a16="http://schemas.microsoft.com/office/drawing/2014/main" id="{1B80120D-D89E-F417-AD6B-E0C38B490AE3}"/>
              </a:ext>
            </a:extLst>
          </p:cNvPr>
          <p:cNvSpPr>
            <a:spLocks noGrp="1"/>
          </p:cNvSpPr>
          <p:nvPr>
            <p:ph type="ftr" sz="quarter" idx="2"/>
          </p:nvPr>
        </p:nvSpPr>
        <p:spPr>
          <a:xfrm>
            <a:off x="1" y="8829676"/>
            <a:ext cx="3038475" cy="466725"/>
          </a:xfrm>
          <a:prstGeom prst="rect">
            <a:avLst/>
          </a:prstGeom>
        </p:spPr>
        <p:txBody>
          <a:bodyPr vert="horz" lIns="91431" tIns="45716" rIns="91431" bIns="45716"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8E7F08CE-C245-FF1D-5D8E-28884D066F87}"/>
              </a:ext>
            </a:extLst>
          </p:cNvPr>
          <p:cNvSpPr>
            <a:spLocks noGrp="1"/>
          </p:cNvSpPr>
          <p:nvPr>
            <p:ph type="sldNum" sz="quarter" idx="3"/>
          </p:nvPr>
        </p:nvSpPr>
        <p:spPr>
          <a:xfrm>
            <a:off x="3970339" y="8829676"/>
            <a:ext cx="3038475" cy="466725"/>
          </a:xfrm>
          <a:prstGeom prst="rect">
            <a:avLst/>
          </a:prstGeom>
        </p:spPr>
        <p:txBody>
          <a:bodyPr vert="horz" lIns="91431" tIns="45716" rIns="91431" bIns="45716" rtlCol="0" anchor="b"/>
          <a:lstStyle>
            <a:lvl1pPr algn="r">
              <a:defRPr sz="1200"/>
            </a:lvl1pPr>
          </a:lstStyle>
          <a:p>
            <a:fld id="{C5EDE2C1-E4A6-407F-8647-99ADCD733131}" type="slidenum">
              <a:rPr lang="en-US" smtClean="0"/>
              <a:t>‹#›</a:t>
            </a:fld>
            <a:endParaRPr lang="en-US"/>
          </a:p>
        </p:txBody>
      </p:sp>
    </p:spTree>
    <p:extLst>
      <p:ext uri="{BB962C8B-B14F-4D97-AF65-F5344CB8AC3E}">
        <p14:creationId xmlns:p14="http://schemas.microsoft.com/office/powerpoint/2010/main" val="301288144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1"/>
            <a:ext cx="3038475" cy="466725"/>
          </a:xfrm>
          <a:prstGeom prst="rect">
            <a:avLst/>
          </a:prstGeom>
        </p:spPr>
        <p:txBody>
          <a:bodyPr vert="horz" lIns="91431" tIns="45716" rIns="91431" bIns="45716" rtlCol="0"/>
          <a:lstStyle>
            <a:lvl1pPr algn="l">
              <a:defRPr sz="1200"/>
            </a:lvl1pPr>
          </a:lstStyle>
          <a:p>
            <a:endParaRPr lang="en-US"/>
          </a:p>
        </p:txBody>
      </p:sp>
      <p:sp>
        <p:nvSpPr>
          <p:cNvPr id="3" name="Date Placeholder 2"/>
          <p:cNvSpPr>
            <a:spLocks noGrp="1"/>
          </p:cNvSpPr>
          <p:nvPr>
            <p:ph type="dt" idx="1"/>
          </p:nvPr>
        </p:nvSpPr>
        <p:spPr>
          <a:xfrm>
            <a:off x="3970339" y="1"/>
            <a:ext cx="3038475" cy="466725"/>
          </a:xfrm>
          <a:prstGeom prst="rect">
            <a:avLst/>
          </a:prstGeom>
        </p:spPr>
        <p:txBody>
          <a:bodyPr vert="horz" lIns="91431" tIns="45716" rIns="91431" bIns="45716" rtlCol="0"/>
          <a:lstStyle>
            <a:lvl1pPr algn="r">
              <a:defRPr sz="1200"/>
            </a:lvl1pPr>
          </a:lstStyle>
          <a:p>
            <a:fld id="{8F56AE25-4F7E-42BC-A7A2-63ADFEBCD1F6}" type="datetimeFigureOut">
              <a:rPr lang="en-US" smtClean="0"/>
              <a:t>5/24/2023</a:t>
            </a:fld>
            <a:endParaRPr lang="en-US"/>
          </a:p>
        </p:txBody>
      </p:sp>
      <p:sp>
        <p:nvSpPr>
          <p:cNvPr id="4" name="Slide Image Placeholder 3"/>
          <p:cNvSpPr>
            <a:spLocks noGrp="1" noRot="1" noChangeAspect="1"/>
          </p:cNvSpPr>
          <p:nvPr>
            <p:ph type="sldImg" idx="2"/>
          </p:nvPr>
        </p:nvSpPr>
        <p:spPr>
          <a:xfrm>
            <a:off x="2293938" y="1162050"/>
            <a:ext cx="2422525" cy="3136900"/>
          </a:xfrm>
          <a:prstGeom prst="rect">
            <a:avLst/>
          </a:prstGeom>
          <a:noFill/>
          <a:ln w="12700">
            <a:solidFill>
              <a:prstClr val="black"/>
            </a:solidFill>
          </a:ln>
        </p:spPr>
        <p:txBody>
          <a:bodyPr vert="horz" lIns="91431" tIns="45716" rIns="91431" bIns="45716" rtlCol="0" anchor="ctr"/>
          <a:lstStyle/>
          <a:p>
            <a:endParaRPr lang="en-US"/>
          </a:p>
        </p:txBody>
      </p:sp>
      <p:sp>
        <p:nvSpPr>
          <p:cNvPr id="5" name="Notes Placeholder 4"/>
          <p:cNvSpPr>
            <a:spLocks noGrp="1"/>
          </p:cNvSpPr>
          <p:nvPr>
            <p:ph type="body" sz="quarter" idx="3"/>
          </p:nvPr>
        </p:nvSpPr>
        <p:spPr>
          <a:xfrm>
            <a:off x="701675" y="4473576"/>
            <a:ext cx="5607050" cy="3660775"/>
          </a:xfrm>
          <a:prstGeom prst="rect">
            <a:avLst/>
          </a:prstGeom>
        </p:spPr>
        <p:txBody>
          <a:bodyPr vert="horz" lIns="91431" tIns="45716" rIns="91431" bIns="45716"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8829676"/>
            <a:ext cx="3038475" cy="466725"/>
          </a:xfrm>
          <a:prstGeom prst="rect">
            <a:avLst/>
          </a:prstGeom>
        </p:spPr>
        <p:txBody>
          <a:bodyPr vert="horz" lIns="91431" tIns="45716" rIns="91431" bIns="45716" rtlCol="0" anchor="b"/>
          <a:lstStyle>
            <a:lvl1pPr algn="l">
              <a:defRPr sz="1200"/>
            </a:lvl1pPr>
          </a:lstStyle>
          <a:p>
            <a:endParaRPr lang="en-US"/>
          </a:p>
        </p:txBody>
      </p:sp>
      <p:sp>
        <p:nvSpPr>
          <p:cNvPr id="7" name="Slide Number Placeholder 6"/>
          <p:cNvSpPr>
            <a:spLocks noGrp="1"/>
          </p:cNvSpPr>
          <p:nvPr>
            <p:ph type="sldNum" sz="quarter" idx="5"/>
          </p:nvPr>
        </p:nvSpPr>
        <p:spPr>
          <a:xfrm>
            <a:off x="3970339" y="8829676"/>
            <a:ext cx="3038475" cy="466725"/>
          </a:xfrm>
          <a:prstGeom prst="rect">
            <a:avLst/>
          </a:prstGeom>
        </p:spPr>
        <p:txBody>
          <a:bodyPr vert="horz" lIns="91431" tIns="45716" rIns="91431" bIns="45716" rtlCol="0" anchor="b"/>
          <a:lstStyle>
            <a:lvl1pPr algn="r">
              <a:defRPr sz="1200"/>
            </a:lvl1pPr>
          </a:lstStyle>
          <a:p>
            <a:fld id="{C0A4971B-0E36-491B-82E1-5DDB2898E23F}" type="slidenum">
              <a:rPr lang="en-US" smtClean="0"/>
              <a:t>‹#›</a:t>
            </a:fld>
            <a:endParaRPr lang="en-US"/>
          </a:p>
        </p:txBody>
      </p:sp>
    </p:spTree>
    <p:extLst>
      <p:ext uri="{BB962C8B-B14F-4D97-AF65-F5344CB8AC3E}">
        <p14:creationId xmlns:p14="http://schemas.microsoft.com/office/powerpoint/2010/main" val="38787263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0A4971B-0E36-491B-82E1-5DDB2898E23F}" type="slidenum">
              <a:rPr lang="en-US" smtClean="0"/>
              <a:t>9</a:t>
            </a:fld>
            <a:endParaRPr lang="en-US"/>
          </a:p>
        </p:txBody>
      </p:sp>
    </p:spTree>
    <p:extLst>
      <p:ext uri="{BB962C8B-B14F-4D97-AF65-F5344CB8AC3E}">
        <p14:creationId xmlns:p14="http://schemas.microsoft.com/office/powerpoint/2010/main" val="12351361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0A4971B-0E36-491B-82E1-5DDB2898E23F}" type="slidenum">
              <a:rPr lang="en-US" smtClean="0"/>
              <a:t>10</a:t>
            </a:fld>
            <a:endParaRPr lang="en-US"/>
          </a:p>
        </p:txBody>
      </p:sp>
    </p:spTree>
    <p:extLst>
      <p:ext uri="{BB962C8B-B14F-4D97-AF65-F5344CB8AC3E}">
        <p14:creationId xmlns:p14="http://schemas.microsoft.com/office/powerpoint/2010/main" val="8307199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p>
        </p:txBody>
      </p:sp>
      <p:sp>
        <p:nvSpPr>
          <p:cNvPr id="4" name="Date Placeholder 3"/>
          <p:cNvSpPr>
            <a:spLocks noGrp="1"/>
          </p:cNvSpPr>
          <p:nvPr>
            <p:ph type="dt" sz="half" idx="10"/>
          </p:nvPr>
        </p:nvSpPr>
        <p:spPr/>
        <p:txBody>
          <a:bodyPr/>
          <a:lstStyle/>
          <a:p>
            <a:fld id="{0B17A59C-399B-47EF-B68F-D97F72CCE8A0}" type="datetime1">
              <a:rPr lang="en-US" smtClean="0"/>
              <a:t>5/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lvl1pPr>
              <a:defRPr sz="1200">
                <a:solidFill>
                  <a:schemeClr val="tx1"/>
                </a:solidFill>
                <a:latin typeface="+mn-lt"/>
              </a:defRPr>
            </a:lvl1pPr>
          </a:lstStyle>
          <a:p>
            <a:r>
              <a:rPr lang="en-US"/>
              <a:t>S</a:t>
            </a:r>
            <a:fld id="{0DD34403-E6AF-9B44-8A22-D75A397E6552}" type="slidenum">
              <a:rPr lang="en-US" smtClean="0"/>
              <a:pPr/>
              <a:t>‹#›</a:t>
            </a:fld>
            <a:endParaRPr lang="en-US"/>
          </a:p>
        </p:txBody>
      </p:sp>
    </p:spTree>
    <p:extLst>
      <p:ext uri="{BB962C8B-B14F-4D97-AF65-F5344CB8AC3E}">
        <p14:creationId xmlns:p14="http://schemas.microsoft.com/office/powerpoint/2010/main" val="13252463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808E97C-B762-4D57-B046-7EDB4941D5C3}" type="datetime1">
              <a:rPr lang="en-US" smtClean="0"/>
              <a:t>5/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DD34403-E6AF-9B44-8A22-D75A397E6552}" type="slidenum">
              <a:rPr lang="en-US" smtClean="0"/>
              <a:t>‹#›</a:t>
            </a:fld>
            <a:endParaRPr lang="en-US"/>
          </a:p>
        </p:txBody>
      </p:sp>
    </p:spTree>
    <p:extLst>
      <p:ext uri="{BB962C8B-B14F-4D97-AF65-F5344CB8AC3E}">
        <p14:creationId xmlns:p14="http://schemas.microsoft.com/office/powerpoint/2010/main" val="7107539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05739E0-B266-457F-B568-026E94A21A04}" type="datetime1">
              <a:rPr lang="en-US" smtClean="0"/>
              <a:t>5/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DD34403-E6AF-9B44-8A22-D75A397E6552}" type="slidenum">
              <a:rPr lang="en-US" smtClean="0"/>
              <a:t>‹#›</a:t>
            </a:fld>
            <a:endParaRPr lang="en-US"/>
          </a:p>
        </p:txBody>
      </p:sp>
    </p:spTree>
    <p:extLst>
      <p:ext uri="{BB962C8B-B14F-4D97-AF65-F5344CB8AC3E}">
        <p14:creationId xmlns:p14="http://schemas.microsoft.com/office/powerpoint/2010/main" val="2534193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11" name="Date Placeholder 10">
            <a:extLst>
              <a:ext uri="{FF2B5EF4-FFF2-40B4-BE49-F238E27FC236}">
                <a16:creationId xmlns:a16="http://schemas.microsoft.com/office/drawing/2014/main" id="{471DBC96-5FF5-4847-9B58-AC86AE3FB9B7}"/>
              </a:ext>
            </a:extLst>
          </p:cNvPr>
          <p:cNvSpPr>
            <a:spLocks noGrp="1"/>
          </p:cNvSpPr>
          <p:nvPr>
            <p:ph type="dt" sz="half" idx="10"/>
          </p:nvPr>
        </p:nvSpPr>
        <p:spPr/>
        <p:txBody>
          <a:bodyPr/>
          <a:lstStyle/>
          <a:p>
            <a:fld id="{9B73E752-37BC-40E3-80B3-B9BC734115AC}" type="datetime1">
              <a:rPr lang="en-US" smtClean="0"/>
              <a:t>5/24/2023</a:t>
            </a:fld>
            <a:endParaRPr lang="en-US"/>
          </a:p>
        </p:txBody>
      </p:sp>
      <p:sp>
        <p:nvSpPr>
          <p:cNvPr id="12" name="Footer Placeholder 11">
            <a:extLst>
              <a:ext uri="{FF2B5EF4-FFF2-40B4-BE49-F238E27FC236}">
                <a16:creationId xmlns:a16="http://schemas.microsoft.com/office/drawing/2014/main" id="{67C0D704-7E1D-47F4-B581-3269F46D78A3}"/>
              </a:ext>
            </a:extLst>
          </p:cNvPr>
          <p:cNvSpPr>
            <a:spLocks noGrp="1"/>
          </p:cNvSpPr>
          <p:nvPr>
            <p:ph type="ftr" sz="quarter" idx="11"/>
          </p:nvPr>
        </p:nvSpPr>
        <p:spPr/>
        <p:txBody>
          <a:bodyPr/>
          <a:lstStyle/>
          <a:p>
            <a:endParaRPr lang="en-US"/>
          </a:p>
        </p:txBody>
      </p:sp>
      <p:sp>
        <p:nvSpPr>
          <p:cNvPr id="13" name="Slide Number Placeholder 12">
            <a:extLst>
              <a:ext uri="{FF2B5EF4-FFF2-40B4-BE49-F238E27FC236}">
                <a16:creationId xmlns:a16="http://schemas.microsoft.com/office/drawing/2014/main" id="{06A20E1E-A585-4A5F-94D6-DF2054EDCDF1}"/>
              </a:ext>
            </a:extLst>
          </p:cNvPr>
          <p:cNvSpPr>
            <a:spLocks noGrp="1"/>
          </p:cNvSpPr>
          <p:nvPr>
            <p:ph type="sldNum" sz="quarter" idx="12"/>
          </p:nvPr>
        </p:nvSpPr>
        <p:spPr/>
        <p:txBody>
          <a:bodyPr/>
          <a:lstStyle>
            <a:lvl1pPr>
              <a:defRPr sz="1200" b="0">
                <a:solidFill>
                  <a:schemeClr val="tx1"/>
                </a:solidFill>
              </a:defRPr>
            </a:lvl1pPr>
          </a:lstStyle>
          <a:p>
            <a:r>
              <a:rPr lang="en-US"/>
              <a:t>S</a:t>
            </a:r>
            <a:fld id="{0DD34403-E6AF-9B44-8A22-D75A397E6552}" type="slidenum">
              <a:rPr lang="en-US" smtClean="0"/>
              <a:pPr/>
              <a:t>‹#›</a:t>
            </a:fld>
            <a:endParaRPr lang="en-US"/>
          </a:p>
        </p:txBody>
      </p:sp>
    </p:spTree>
    <p:extLst>
      <p:ext uri="{BB962C8B-B14F-4D97-AF65-F5344CB8AC3E}">
        <p14:creationId xmlns:p14="http://schemas.microsoft.com/office/powerpoint/2010/main" val="32863934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0494AF5-2A3C-4B49-AFBF-9083E34BEE79}" type="datetime1">
              <a:rPr lang="en-US" smtClean="0"/>
              <a:t>5/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r>
              <a:rPr lang="en-US"/>
              <a:t>S</a:t>
            </a:r>
            <a:fld id="{0DD34403-E6AF-9B44-8A22-D75A397E6552}" type="slidenum">
              <a:rPr lang="en-US" smtClean="0"/>
              <a:pPr/>
              <a:t>‹#›</a:t>
            </a:fld>
            <a:endParaRPr lang="en-US"/>
          </a:p>
        </p:txBody>
      </p:sp>
    </p:spTree>
    <p:extLst>
      <p:ext uri="{BB962C8B-B14F-4D97-AF65-F5344CB8AC3E}">
        <p14:creationId xmlns:p14="http://schemas.microsoft.com/office/powerpoint/2010/main" val="2125416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534353"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934778"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EE5F0F60-FD9A-4604-A1EE-E42FA193EDA4}" type="datetime1">
              <a:rPr lang="en-US" smtClean="0"/>
              <a:t>5/2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r>
              <a:rPr lang="en-US"/>
              <a:t>S</a:t>
            </a:r>
            <a:fld id="{0DD34403-E6AF-9B44-8A22-D75A397E6552}" type="slidenum">
              <a:rPr lang="en-US" smtClean="0"/>
              <a:pPr/>
              <a:t>‹#›</a:t>
            </a:fld>
            <a:endParaRPr lang="en-US"/>
          </a:p>
        </p:txBody>
      </p:sp>
    </p:spTree>
    <p:extLst>
      <p:ext uri="{BB962C8B-B14F-4D97-AF65-F5344CB8AC3E}">
        <p14:creationId xmlns:p14="http://schemas.microsoft.com/office/powerpoint/2010/main" val="10822680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26EA64D-5DBD-41BA-BE1E-9A46562CD718}" type="datetime1">
              <a:rPr lang="en-US" smtClean="0"/>
              <a:t>5/24/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r>
              <a:rPr lang="en-US"/>
              <a:t>S</a:t>
            </a:r>
            <a:fld id="{0DD34403-E6AF-9B44-8A22-D75A397E6552}" type="slidenum">
              <a:rPr lang="en-US" smtClean="0"/>
              <a:pPr/>
              <a:t>‹#›</a:t>
            </a:fld>
            <a:endParaRPr lang="en-US"/>
          </a:p>
        </p:txBody>
      </p:sp>
    </p:spTree>
    <p:extLst>
      <p:ext uri="{BB962C8B-B14F-4D97-AF65-F5344CB8AC3E}">
        <p14:creationId xmlns:p14="http://schemas.microsoft.com/office/powerpoint/2010/main" val="21970167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E2D920E0-4DC4-46FE-BEF8-A611031AD5EE}" type="datetime1">
              <a:rPr lang="en-US" smtClean="0"/>
              <a:t>5/24/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DD34403-E6AF-9B44-8A22-D75A397E6552}" type="slidenum">
              <a:rPr lang="en-US" smtClean="0"/>
              <a:t>‹#›</a:t>
            </a:fld>
            <a:endParaRPr lang="en-US"/>
          </a:p>
        </p:txBody>
      </p:sp>
    </p:spTree>
    <p:extLst>
      <p:ext uri="{BB962C8B-B14F-4D97-AF65-F5344CB8AC3E}">
        <p14:creationId xmlns:p14="http://schemas.microsoft.com/office/powerpoint/2010/main" val="41912023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91D47EC-7827-4474-A20D-DC7C71250D93}" type="datetime1">
              <a:rPr lang="en-US" smtClean="0"/>
              <a:t>5/24/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DD34403-E6AF-9B44-8A22-D75A397E6552}" type="slidenum">
              <a:rPr lang="en-US" smtClean="0"/>
              <a:t>‹#›</a:t>
            </a:fld>
            <a:endParaRPr lang="en-US"/>
          </a:p>
        </p:txBody>
      </p:sp>
    </p:spTree>
    <p:extLst>
      <p:ext uri="{BB962C8B-B14F-4D97-AF65-F5344CB8AC3E}">
        <p14:creationId xmlns:p14="http://schemas.microsoft.com/office/powerpoint/2010/main" val="20749371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E176BB05-6AAF-496C-B9C6-B6AAE62DAD3B}" type="datetime1">
              <a:rPr lang="en-US" smtClean="0"/>
              <a:t>5/2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DD34403-E6AF-9B44-8A22-D75A397E6552}" type="slidenum">
              <a:rPr lang="en-US" smtClean="0"/>
              <a:t>‹#›</a:t>
            </a:fld>
            <a:endParaRPr lang="en-US"/>
          </a:p>
        </p:txBody>
      </p:sp>
    </p:spTree>
    <p:extLst>
      <p:ext uri="{BB962C8B-B14F-4D97-AF65-F5344CB8AC3E}">
        <p14:creationId xmlns:p14="http://schemas.microsoft.com/office/powerpoint/2010/main" val="31363808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FA2F4E6D-3CE3-4194-A116-46CAD1C269D0}" type="datetime1">
              <a:rPr lang="en-US" smtClean="0"/>
              <a:t>5/2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DD34403-E6AF-9B44-8A22-D75A397E6552}" type="slidenum">
              <a:rPr lang="en-US" smtClean="0"/>
              <a:t>‹#›</a:t>
            </a:fld>
            <a:endParaRPr lang="en-US"/>
          </a:p>
        </p:txBody>
      </p:sp>
    </p:spTree>
    <p:extLst>
      <p:ext uri="{BB962C8B-B14F-4D97-AF65-F5344CB8AC3E}">
        <p14:creationId xmlns:p14="http://schemas.microsoft.com/office/powerpoint/2010/main" val="18671304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4DD73C8D-2E5E-4514-BD4E-E49E1DDD5F69}" type="datetime1">
              <a:rPr lang="en-US" smtClean="0"/>
              <a:t>5/24/2023</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200">
                <a:solidFill>
                  <a:schemeClr val="tx1"/>
                </a:solidFill>
              </a:defRPr>
            </a:lvl1pPr>
          </a:lstStyle>
          <a:p>
            <a:r>
              <a:rPr lang="en-US"/>
              <a:t>S</a:t>
            </a:r>
            <a:fld id="{0DD34403-E6AF-9B44-8A22-D75A397E6552}" type="slidenum">
              <a:rPr lang="en-US" smtClean="0"/>
              <a:pPr/>
              <a:t>‹#›</a:t>
            </a:fld>
            <a:endParaRPr lang="en-US"/>
          </a:p>
        </p:txBody>
      </p:sp>
    </p:spTree>
    <p:extLst>
      <p:ext uri="{BB962C8B-B14F-4D97-AF65-F5344CB8AC3E}">
        <p14:creationId xmlns:p14="http://schemas.microsoft.com/office/powerpoint/2010/main" val="156092920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hf hdr="0" ftr="0" dt="0"/>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mleopold@richmond.edu" TargetMode="Externa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chart" Target="../charts/chart8.xml"/><Relationship Id="rId4" Type="http://schemas.openxmlformats.org/officeDocument/2006/relationships/chart" Target="../charts/chart7.xml"/></Relationships>
</file>

<file path=ppt/slides/_rels/slide11.xml.rels><?xml version="1.0" encoding="UTF-8" standalone="yes"?>
<Relationships xmlns="http://schemas.openxmlformats.org/package/2006/relationships"><Relationship Id="rId2" Type="http://schemas.openxmlformats.org/officeDocument/2006/relationships/chart" Target="../charts/chart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chart" Target="../charts/chart11.xml"/><Relationship Id="rId2" Type="http://schemas.openxmlformats.org/officeDocument/2006/relationships/chart" Target="../charts/chart10.xml"/><Relationship Id="rId1" Type="http://schemas.openxmlformats.org/officeDocument/2006/relationships/slideLayout" Target="../slideLayouts/slideLayout2.xml"/><Relationship Id="rId4" Type="http://schemas.openxmlformats.org/officeDocument/2006/relationships/chart" Target="../charts/chart12.xml"/></Relationships>
</file>

<file path=ppt/slides/_rels/slide14.xml.rels><?xml version="1.0" encoding="UTF-8" standalone="yes"?>
<Relationships xmlns="http://schemas.openxmlformats.org/package/2006/relationships"><Relationship Id="rId3" Type="http://schemas.openxmlformats.org/officeDocument/2006/relationships/chart" Target="../charts/chart14.xml"/><Relationship Id="rId2" Type="http://schemas.openxmlformats.org/officeDocument/2006/relationships/chart" Target="../charts/chart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1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 Id="rId5" Type="http://schemas.openxmlformats.org/officeDocument/2006/relationships/image" Target="../media/image13.png"/><Relationship Id="rId4" Type="http://schemas.openxmlformats.org/officeDocument/2006/relationships/image" Target="../media/image12.png"/></Relationships>
</file>

<file path=ppt/slides/_rels/slide17.xml.rels><?xml version="1.0" encoding="UTF-8" standalone="yes"?>
<Relationships xmlns="http://schemas.openxmlformats.org/package/2006/relationships"><Relationship Id="rId2" Type="http://schemas.openxmlformats.org/officeDocument/2006/relationships/image" Target="../media/image14.emf"/><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15.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chart" Target="../charts/chart5.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07622" y="271105"/>
            <a:ext cx="7315200" cy="9779600"/>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orting Information</a:t>
            </a:r>
            <a:endParaRPr lang="en-US" sz="1200" b="1" dirty="0">
              <a:highlight>
                <a:srgbClr val="FFFF00"/>
              </a:highlight>
              <a:latin typeface="Times New Roman" panose="02020603050405020304" pitchFamily="18" charset="0"/>
              <a:cs typeface="Times New Roman" panose="02020603050405020304" pitchFamily="18" charset="0"/>
            </a:endParaRPr>
          </a:p>
          <a:p>
            <a:endParaRPr lang="en-US" b="1" dirty="0"/>
          </a:p>
          <a:p>
            <a:r>
              <a:rPr lang="en-US" b="1" dirty="0"/>
              <a:t>Nanomaterial-Doped Xerogels for Biosensing Measurements of Xanthine in Clinical and Industrial Applications</a:t>
            </a:r>
            <a:r>
              <a:rPr lang="en-US" b="1" i="1" dirty="0"/>
              <a:t>   </a:t>
            </a:r>
            <a:endParaRPr lang="en-US" dirty="0"/>
          </a:p>
          <a:p>
            <a:endParaRPr lang="en-US" sz="1200" b="1" i="1" dirty="0"/>
          </a:p>
          <a:p>
            <a:r>
              <a:rPr lang="en-US" sz="1200" dirty="0"/>
              <a:t>Quang Minh Dang,</a:t>
            </a:r>
            <a:r>
              <a:rPr lang="en-US" sz="1200" baseline="30000" dirty="0"/>
              <a:t>=</a:t>
            </a:r>
            <a:r>
              <a:rPr lang="en-US" sz="1200" dirty="0"/>
              <a:t> Ann H. Wemple,</a:t>
            </a:r>
            <a:r>
              <a:rPr lang="en-US" sz="1200" baseline="30000" dirty="0"/>
              <a:t>=</a:t>
            </a:r>
            <a:r>
              <a:rPr lang="en-US" sz="1200" dirty="0"/>
              <a:t> and Michael C. Leopold*  </a:t>
            </a:r>
          </a:p>
          <a:p>
            <a:r>
              <a:rPr lang="en-US" sz="1200" i="1" dirty="0"/>
              <a:t> </a:t>
            </a:r>
            <a:endParaRPr lang="en-US" sz="1200" dirty="0"/>
          </a:p>
          <a:p>
            <a:r>
              <a:rPr lang="en-US" sz="1200" i="1" dirty="0"/>
              <a:t>Department of Chemistry, Gottwald Center for the Sciences, University of Richmond, Richmond, Virginia 23173, United States</a:t>
            </a:r>
            <a:endParaRPr lang="en-US" sz="1200" dirty="0"/>
          </a:p>
          <a:p>
            <a:pPr algn="just"/>
            <a:r>
              <a:rPr lang="en-US" sz="1200" i="1" dirty="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a:p>
            <a:pPr algn="just">
              <a:spcAft>
                <a:spcPts val="600"/>
              </a:spcAft>
            </a:pPr>
            <a:r>
              <a:rPr lang="en-US" sz="1200" dirty="0">
                <a:solidFill>
                  <a:srgbClr val="FF0000"/>
                </a:solidFill>
                <a:latin typeface="Times New Roman" panose="02020603050405020304" pitchFamily="18" charset="0"/>
                <a:cs typeface="Times New Roman" panose="02020603050405020304" pitchFamily="18" charset="0"/>
              </a:rPr>
              <a:t> </a:t>
            </a:r>
          </a:p>
          <a:p>
            <a:pPr algn="just">
              <a:spcAft>
                <a:spcPts val="600"/>
              </a:spcAft>
            </a:pPr>
            <a:r>
              <a:rPr lang="en-US" sz="1200" b="1" dirty="0">
                <a:latin typeface="Times New Roman" panose="02020603050405020304" pitchFamily="18" charset="0"/>
                <a:cs typeface="Times New Roman" panose="02020603050405020304" pitchFamily="18" charset="0"/>
              </a:rPr>
              <a:t>Table of Contents:</a:t>
            </a:r>
          </a:p>
          <a:p>
            <a:pPr algn="just">
              <a:spcAft>
                <a:spcPts val="600"/>
              </a:spcAft>
            </a:pPr>
            <a:r>
              <a:rPr lang="en-US" sz="1200" dirty="0">
                <a:latin typeface="Times New Roman" panose="02020603050405020304" pitchFamily="18" charset="0"/>
                <a:cs typeface="Times New Roman" panose="02020603050405020304" pitchFamily="18" charset="0"/>
              </a:rPr>
              <a:t>▪ Mechanistic pathway of purine metabolism (Scheme S1), p. S2</a:t>
            </a:r>
          </a:p>
          <a:p>
            <a:pPr algn="just">
              <a:spcAft>
                <a:spcPts val="600"/>
              </a:spcAft>
            </a:pPr>
            <a:r>
              <a:rPr lang="en-US" sz="1200" dirty="0">
                <a:latin typeface="Times New Roman" panose="02020603050405020304" pitchFamily="18" charset="0"/>
                <a:cs typeface="Times New Roman" panose="02020603050405020304" pitchFamily="18" charset="0"/>
              </a:rPr>
              <a:t>▪ Cyclic voltammetry of potassium ferricyanide at one and two layers of HMTES or TEES xerogel layers, p. S3</a:t>
            </a:r>
          </a:p>
          <a:p>
            <a:pPr algn="just">
              <a:spcAft>
                <a:spcPts val="600"/>
              </a:spcAft>
            </a:pPr>
            <a:r>
              <a:rPr lang="en-US" sz="1200" dirty="0">
                <a:latin typeface="Times New Roman" panose="02020603050405020304" pitchFamily="18" charset="0"/>
                <a:cs typeface="Times New Roman" panose="02020603050405020304" pitchFamily="18" charset="0"/>
              </a:rPr>
              <a:t>▪ Summary of permeability indices for peroxide and xanthine measured at various formulations of different sol-gel mixtures to form different xerogels, p. S4</a:t>
            </a:r>
          </a:p>
          <a:p>
            <a:pPr algn="just"/>
            <a:r>
              <a:rPr lang="en-US" sz="1200" dirty="0">
                <a:latin typeface="Times New Roman" panose="02020603050405020304" pitchFamily="18" charset="0"/>
                <a:cs typeface="Times New Roman" panose="02020603050405020304" pitchFamily="18" charset="0"/>
              </a:rPr>
              <a:t>▪ Xanthine calibration curves for the </a:t>
            </a:r>
            <a:r>
              <a:rPr lang="en-US" sz="1200" dirty="0"/>
              <a:t>Pt / TEES (</a:t>
            </a:r>
            <a:r>
              <a:rPr lang="en-US" sz="1200" dirty="0" err="1"/>
              <a:t>XOx</a:t>
            </a:r>
            <a:r>
              <a:rPr lang="en-US" sz="1200" dirty="0"/>
              <a:t>)  / PU (75:25) system with various loadings of </a:t>
            </a:r>
            <a:r>
              <a:rPr lang="en-US" sz="1200" dirty="0" err="1"/>
              <a:t>XOx</a:t>
            </a:r>
            <a:r>
              <a:rPr lang="en-US" sz="1200" dirty="0"/>
              <a:t> enzyme in the xerogel deposition mixtures (i.e., enzyme loading effects), p. S5</a:t>
            </a:r>
          </a:p>
          <a:p>
            <a:pPr algn="just"/>
            <a:endParaRPr lang="en-US" sz="1200" dirty="0">
              <a:solidFill>
                <a:srgbClr val="FF0000"/>
              </a:solidFill>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 Scheme illustration of NP-doped xerogel signal enhancement (Scheme S2), p. S6</a:t>
            </a:r>
            <a:endParaRPr lang="en-US" sz="1200" dirty="0">
              <a:solidFill>
                <a:srgbClr val="FF0000"/>
              </a:solidFill>
              <a:latin typeface="Times New Roman" panose="02020603050405020304" pitchFamily="18" charset="0"/>
              <a:cs typeface="Times New Roman" panose="02020603050405020304" pitchFamily="18" charset="0"/>
            </a:endParaRPr>
          </a:p>
          <a:p>
            <a:pPr algn="just"/>
            <a:endParaRPr lang="en-US" sz="600" dirty="0">
              <a:solidFill>
                <a:srgbClr val="FF0000"/>
              </a:solidFill>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 Xanthine calibration curves for MPC-doped and undoped xerogel layers for both the HMTES and TEES </a:t>
            </a:r>
            <a:r>
              <a:rPr lang="en-US" sz="1200" dirty="0"/>
              <a:t>systems, p. S7-9</a:t>
            </a:r>
            <a:r>
              <a:rPr lang="en-US" sz="1200" dirty="0">
                <a:solidFill>
                  <a:srgbClr val="FF0000"/>
                </a:solidFill>
                <a:latin typeface="Times New Roman" panose="02020603050405020304" pitchFamily="18" charset="0"/>
                <a:cs typeface="Times New Roman" panose="02020603050405020304" pitchFamily="18" charset="0"/>
              </a:rPr>
              <a:t> </a:t>
            </a:r>
          </a:p>
          <a:p>
            <a:pPr algn="just"/>
            <a:endParaRPr lang="en-US" sz="600" dirty="0">
              <a:solidFill>
                <a:srgbClr val="FF0000"/>
              </a:solidFill>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 Xanthine calibration curves of MPC-doped TEES systems monitored over a week for sensitivity (slope), p. S10</a:t>
            </a:r>
          </a:p>
          <a:p>
            <a:pPr algn="just"/>
            <a:endParaRPr lang="en-US" sz="600"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 Xanthine and hypoxanthine calibration curves for </a:t>
            </a:r>
            <a:r>
              <a:rPr lang="en-US" sz="1200" dirty="0"/>
              <a:t>Pt / TEES (</a:t>
            </a:r>
            <a:r>
              <a:rPr lang="en-US" sz="1200" dirty="0" err="1"/>
              <a:t>XOx</a:t>
            </a:r>
            <a:r>
              <a:rPr lang="en-US" sz="1200" dirty="0"/>
              <a:t>) + C6 MPC / PU (75:25) system, p. S11</a:t>
            </a:r>
          </a:p>
          <a:p>
            <a:pPr algn="just"/>
            <a:endParaRPr lang="en-US" sz="1200" dirty="0">
              <a:solidFill>
                <a:srgbClr val="FF0000"/>
              </a:solidFill>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 Selectivity coefficient measurements over time for common interferents at MPC-doped systems of both HMTES and TEES sensors, p. S12-S14.</a:t>
            </a:r>
          </a:p>
          <a:p>
            <a:pPr algn="just"/>
            <a:endParaRPr lang="en-US" sz="600"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 Cyclic voltammetry of 100 mM solutions of xanthine, uric acid, and hypoxanthine (in PBS) at a Pt electrode, p. S15</a:t>
            </a:r>
          </a:p>
          <a:p>
            <a:pPr algn="just"/>
            <a:endParaRPr lang="en-US" sz="600"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 </a:t>
            </a:r>
            <a:r>
              <a:rPr lang="en-US" sz="1200" dirty="0" err="1"/>
              <a:t>Amperometric</a:t>
            </a:r>
            <a:r>
              <a:rPr lang="en-US" sz="1200" dirty="0"/>
              <a:t> I-t curves and summary result table from UA and H</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O</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injections at Pt electrode held at various potentials, p. S16-17.  </a:t>
            </a:r>
          </a:p>
          <a:p>
            <a:pPr algn="just"/>
            <a:endParaRPr lang="en-US" sz="1200"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 Additional experimental details for evaluating xanthine biosensor performance, p. S18</a:t>
            </a:r>
          </a:p>
          <a:p>
            <a:pPr algn="just"/>
            <a:endParaRPr lang="en-US" sz="1200" dirty="0">
              <a:latin typeface="Times New Roman" panose="02020603050405020304" pitchFamily="18" charset="0"/>
              <a:cs typeface="Times New Roman" panose="02020603050405020304" pitchFamily="18" charset="0"/>
            </a:endParaRPr>
          </a:p>
          <a:p>
            <a:pPr algn="just"/>
            <a:endParaRPr lang="en-US" sz="600" dirty="0">
              <a:solidFill>
                <a:srgbClr val="FF0000"/>
              </a:solidFill>
              <a:latin typeface="Times New Roman" panose="02020603050405020304" pitchFamily="18" charset="0"/>
              <a:cs typeface="Times New Roman" panose="02020603050405020304" pitchFamily="18" charset="0"/>
            </a:endParaRPr>
          </a:p>
          <a:p>
            <a:pPr algn="just"/>
            <a:endParaRPr lang="en-US" sz="1200" dirty="0">
              <a:solidFill>
                <a:srgbClr val="FF0000"/>
              </a:solidFill>
              <a:latin typeface="Times New Roman" panose="02020603050405020304" pitchFamily="18" charset="0"/>
              <a:cs typeface="Times New Roman" panose="02020603050405020304" pitchFamily="18" charset="0"/>
            </a:endParaRPr>
          </a:p>
          <a:p>
            <a:pPr algn="just"/>
            <a:endParaRPr lang="en-US" sz="1200" dirty="0">
              <a:solidFill>
                <a:srgbClr val="FF0000"/>
              </a:solidFill>
              <a:latin typeface="Times New Roman" panose="02020603050405020304" pitchFamily="18" charset="0"/>
              <a:cs typeface="Times New Roman" panose="02020603050405020304" pitchFamily="18" charset="0"/>
            </a:endParaRPr>
          </a:p>
          <a:p>
            <a:pPr algn="just"/>
            <a:endParaRPr lang="en-US" sz="1200" dirty="0">
              <a:solidFill>
                <a:srgbClr val="FF0000"/>
              </a:solidFill>
              <a:latin typeface="Times New Roman" panose="02020603050405020304" pitchFamily="18" charset="0"/>
              <a:cs typeface="Times New Roman" panose="02020603050405020304" pitchFamily="18" charset="0"/>
            </a:endParaRPr>
          </a:p>
          <a:p>
            <a:pPr algn="just"/>
            <a:endParaRPr lang="en-US" sz="1200" dirty="0">
              <a:solidFill>
                <a:srgbClr val="FF0000"/>
              </a:solidFill>
              <a:latin typeface="Times New Roman" panose="02020603050405020304" pitchFamily="18" charset="0"/>
              <a:cs typeface="Times New Roman" panose="02020603050405020304" pitchFamily="18" charset="0"/>
            </a:endParaRPr>
          </a:p>
          <a:p>
            <a:pPr algn="just"/>
            <a:endParaRPr lang="en-US" sz="1200" dirty="0">
              <a:solidFill>
                <a:srgbClr val="FF0000"/>
              </a:solidFill>
              <a:latin typeface="Times New Roman" panose="02020603050405020304" pitchFamily="18" charset="0"/>
              <a:cs typeface="Times New Roman" panose="02020603050405020304" pitchFamily="18" charset="0"/>
            </a:endParaRPr>
          </a:p>
          <a:p>
            <a:r>
              <a:rPr lang="en-US" sz="1600" dirty="0"/>
              <a:t>*</a:t>
            </a:r>
            <a:r>
              <a:rPr lang="en-US" sz="1200" dirty="0"/>
              <a:t>Corresponding Author: </a:t>
            </a:r>
            <a:r>
              <a:rPr lang="en-US" sz="1200" dirty="0">
                <a:hlinkClick r:id="rId2"/>
              </a:rPr>
              <a:t>mleopold@richmond.edu</a:t>
            </a:r>
            <a:r>
              <a:rPr lang="en-US" sz="1200" dirty="0"/>
              <a:t>;         </a:t>
            </a:r>
            <a:r>
              <a:rPr lang="en-US" sz="1200" baseline="30000" dirty="0"/>
              <a:t>= </a:t>
            </a:r>
            <a:r>
              <a:rPr lang="en-US" sz="1200" i="1" dirty="0"/>
              <a:t>These authors are co-contributing first authors.</a:t>
            </a:r>
            <a:endParaRPr lang="en-US" sz="1200" dirty="0"/>
          </a:p>
          <a:p>
            <a:pPr algn="just">
              <a:spcAft>
                <a:spcPts val="600"/>
              </a:spcAft>
            </a:pPr>
            <a:endParaRPr lang="en-US" sz="1050" dirty="0">
              <a:solidFill>
                <a:srgbClr val="FF0000"/>
              </a:solidFill>
              <a:latin typeface="Times New Roman" panose="02020603050405020304" pitchFamily="18" charset="0"/>
              <a:cs typeface="Times New Roman" panose="02020603050405020304" pitchFamily="18" charset="0"/>
            </a:endParaRPr>
          </a:p>
          <a:p>
            <a:pPr algn="just">
              <a:spcAft>
                <a:spcPts val="600"/>
              </a:spcAft>
            </a:pPr>
            <a:endParaRPr lang="en-US" sz="1200" dirty="0">
              <a:solidFill>
                <a:srgbClr val="FF0000"/>
              </a:solidFill>
              <a:latin typeface="Times New Roman" panose="02020603050405020304" pitchFamily="18" charset="0"/>
              <a:cs typeface="Times New Roman" panose="02020603050405020304" pitchFamily="18" charset="0"/>
            </a:endParaRPr>
          </a:p>
          <a:p>
            <a:pPr algn="just">
              <a:spcAft>
                <a:spcPts val="600"/>
              </a:spcAft>
            </a:pPr>
            <a:endParaRPr lang="en-US" sz="1200" dirty="0">
              <a:solidFill>
                <a:srgbClr val="FF0000"/>
              </a:solidFill>
              <a:latin typeface="Times New Roman" panose="02020603050405020304" pitchFamily="18" charset="0"/>
              <a:cs typeface="Times New Roman" panose="02020603050405020304" pitchFamily="18" charset="0"/>
            </a:endParaRPr>
          </a:p>
          <a:p>
            <a:pPr algn="just">
              <a:spcAft>
                <a:spcPts val="600"/>
              </a:spcAft>
            </a:pPr>
            <a:endParaRPr lang="en-US" sz="1200" b="1" dirty="0">
              <a:solidFill>
                <a:srgbClr val="FF0000"/>
              </a:solidFill>
              <a:latin typeface="Times New Roman" panose="02020603050405020304" pitchFamily="18" charset="0"/>
              <a:cs typeface="Times New Roman" panose="02020603050405020304" pitchFamily="18" charset="0"/>
            </a:endParaRPr>
          </a:p>
        </p:txBody>
      </p:sp>
      <p:sp>
        <p:nvSpPr>
          <p:cNvPr id="5" name="Slide Number Placeholder 4">
            <a:extLst>
              <a:ext uri="{FF2B5EF4-FFF2-40B4-BE49-F238E27FC236}">
                <a16:creationId xmlns:a16="http://schemas.microsoft.com/office/drawing/2014/main" id="{18B07BA0-8F1D-4A46-9F38-83348A8193AD}"/>
              </a:ext>
            </a:extLst>
          </p:cNvPr>
          <p:cNvSpPr>
            <a:spLocks noGrp="1"/>
          </p:cNvSpPr>
          <p:nvPr>
            <p:ph type="sldNum" sz="quarter" idx="12"/>
          </p:nvPr>
        </p:nvSpPr>
        <p:spPr/>
        <p:txBody>
          <a:bodyPr/>
          <a:lstStyle/>
          <a:p>
            <a:r>
              <a:rPr lang="en-US" dirty="0"/>
              <a:t>S</a:t>
            </a:r>
            <a:fld id="{0DD34403-E6AF-9B44-8A22-D75A397E6552}" type="slidenum">
              <a:rPr lang="en-US" smtClean="0"/>
              <a:pPr/>
              <a:t>1</a:t>
            </a:fld>
            <a:endParaRPr lang="en-US" dirty="0"/>
          </a:p>
        </p:txBody>
      </p:sp>
    </p:spTree>
    <p:extLst>
      <p:ext uri="{BB962C8B-B14F-4D97-AF65-F5344CB8AC3E}">
        <p14:creationId xmlns:p14="http://schemas.microsoft.com/office/powerpoint/2010/main" val="176143530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B8F01CF5-694D-4974-A8A3-7CD5A9377CF7}"/>
              </a:ext>
            </a:extLst>
          </p:cNvPr>
          <p:cNvSpPr txBox="1"/>
          <p:nvPr/>
        </p:nvSpPr>
        <p:spPr>
          <a:xfrm>
            <a:off x="457200" y="9030500"/>
            <a:ext cx="6858000" cy="738664"/>
          </a:xfrm>
          <a:prstGeom prst="rect">
            <a:avLst/>
          </a:prstGeom>
          <a:solidFill>
            <a:schemeClr val="bg1"/>
          </a:solidFill>
        </p:spPr>
        <p:txBody>
          <a:bodyPr wrap="square" lIns="0" tIns="0" rIns="0" bIns="0" rtlCol="0">
            <a:spAutoFit/>
          </a:bodyPr>
          <a:lstStyle/>
          <a:p>
            <a:pPr algn="just"/>
            <a:r>
              <a:rPr lang="en-US" sz="1200" b="1" dirty="0"/>
              <a:t>Figure S7.  </a:t>
            </a:r>
            <a:r>
              <a:rPr lang="en-US" sz="1200" dirty="0"/>
              <a:t>Xanthine calibration curves over time (~ 1 week) for platinum electrodes modified with </a:t>
            </a:r>
            <a:r>
              <a:rPr lang="en-US" sz="1200" b="1" dirty="0"/>
              <a:t>(A)</a:t>
            </a:r>
            <a:r>
              <a:rPr lang="en-US" sz="1200" dirty="0"/>
              <a:t> TEES (</a:t>
            </a:r>
            <a:r>
              <a:rPr lang="en-US" sz="1200" dirty="0" err="1"/>
              <a:t>XOx</a:t>
            </a:r>
            <a:r>
              <a:rPr lang="en-US" sz="1200" dirty="0"/>
              <a:t>) + C6 MPC; </a:t>
            </a:r>
            <a:r>
              <a:rPr lang="en-US" sz="1200" b="1" dirty="0"/>
              <a:t>(B)</a:t>
            </a:r>
            <a:r>
              <a:rPr lang="en-US" sz="1200" dirty="0"/>
              <a:t> TEES (</a:t>
            </a:r>
            <a:r>
              <a:rPr lang="en-US" sz="1200" dirty="0" err="1"/>
              <a:t>XOx</a:t>
            </a:r>
            <a:r>
              <a:rPr lang="en-US" sz="1200" dirty="0"/>
              <a:t>) + C4 MPC; and </a:t>
            </a:r>
            <a:r>
              <a:rPr lang="en-US" sz="1200" b="1" dirty="0"/>
              <a:t>(C)</a:t>
            </a:r>
            <a:r>
              <a:rPr lang="en-US" sz="1200" dirty="0"/>
              <a:t> TEES (</a:t>
            </a:r>
            <a:r>
              <a:rPr lang="en-US" sz="1200" dirty="0" err="1"/>
              <a:t>XOx</a:t>
            </a:r>
            <a:r>
              <a:rPr lang="en-US" sz="1200" dirty="0"/>
              <a:t>) + C3 MPC all capped with PU (75:25).  Note: In some cases, error bars are smaller than markers.</a:t>
            </a:r>
          </a:p>
          <a:p>
            <a:pPr algn="just"/>
            <a:endParaRPr lang="en-US" sz="1200" b="1" dirty="0"/>
          </a:p>
        </p:txBody>
      </p:sp>
      <p:sp>
        <p:nvSpPr>
          <p:cNvPr id="3" name="Slide Number Placeholder 2">
            <a:extLst>
              <a:ext uri="{FF2B5EF4-FFF2-40B4-BE49-F238E27FC236}">
                <a16:creationId xmlns:a16="http://schemas.microsoft.com/office/drawing/2014/main" id="{93D893A6-B4B5-4787-B8FC-2804A6874B9F}"/>
              </a:ext>
            </a:extLst>
          </p:cNvPr>
          <p:cNvSpPr>
            <a:spLocks noGrp="1"/>
          </p:cNvSpPr>
          <p:nvPr>
            <p:ph type="sldNum" sz="quarter" idx="12"/>
          </p:nvPr>
        </p:nvSpPr>
        <p:spPr/>
        <p:txBody>
          <a:bodyPr/>
          <a:lstStyle/>
          <a:p>
            <a:r>
              <a:rPr lang="en-US"/>
              <a:t>S</a:t>
            </a:r>
            <a:fld id="{0DD34403-E6AF-9B44-8A22-D75A397E6552}" type="slidenum">
              <a:rPr lang="en-US" smtClean="0"/>
              <a:pPr/>
              <a:t>10</a:t>
            </a:fld>
            <a:endParaRPr lang="en-US"/>
          </a:p>
        </p:txBody>
      </p:sp>
      <p:graphicFrame>
        <p:nvGraphicFramePr>
          <p:cNvPr id="5" name="Chart 4">
            <a:extLst>
              <a:ext uri="{FF2B5EF4-FFF2-40B4-BE49-F238E27FC236}">
                <a16:creationId xmlns:a16="http://schemas.microsoft.com/office/drawing/2014/main" id="{5F943310-0E1F-4F09-A291-71FAB691FA94}"/>
              </a:ext>
            </a:extLst>
          </p:cNvPr>
          <p:cNvGraphicFramePr>
            <a:graphicFrameLocks/>
          </p:cNvGraphicFramePr>
          <p:nvPr>
            <p:extLst>
              <p:ext uri="{D42A27DB-BD31-4B8C-83A1-F6EECF244321}">
                <p14:modId xmlns:p14="http://schemas.microsoft.com/office/powerpoint/2010/main" val="1856588541"/>
              </p:ext>
            </p:extLst>
          </p:nvPr>
        </p:nvGraphicFramePr>
        <p:xfrm>
          <a:off x="1976744" y="57047"/>
          <a:ext cx="5603285" cy="33528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9" name="Chart 8">
            <a:extLst>
              <a:ext uri="{FF2B5EF4-FFF2-40B4-BE49-F238E27FC236}">
                <a16:creationId xmlns:a16="http://schemas.microsoft.com/office/drawing/2014/main" id="{E4A89FE8-8B02-45AC-B772-7B3AB5EA9DD4}"/>
              </a:ext>
            </a:extLst>
          </p:cNvPr>
          <p:cNvGraphicFramePr>
            <a:graphicFrameLocks/>
          </p:cNvGraphicFramePr>
          <p:nvPr>
            <p:extLst>
              <p:ext uri="{D42A27DB-BD31-4B8C-83A1-F6EECF244321}">
                <p14:modId xmlns:p14="http://schemas.microsoft.com/office/powerpoint/2010/main" val="1664796410"/>
              </p:ext>
            </p:extLst>
          </p:nvPr>
        </p:nvGraphicFramePr>
        <p:xfrm>
          <a:off x="2057422" y="5904256"/>
          <a:ext cx="5261303" cy="3278302"/>
        </p:xfrm>
        <a:graphic>
          <a:graphicData uri="http://schemas.openxmlformats.org/drawingml/2006/chart">
            <c:chart xmlns:c="http://schemas.openxmlformats.org/drawingml/2006/chart" xmlns:r="http://schemas.openxmlformats.org/officeDocument/2006/relationships" r:id="rId4"/>
          </a:graphicData>
        </a:graphic>
      </p:graphicFrame>
      <p:sp>
        <p:nvSpPr>
          <p:cNvPr id="11" name="TextBox 10">
            <a:extLst>
              <a:ext uri="{FF2B5EF4-FFF2-40B4-BE49-F238E27FC236}">
                <a16:creationId xmlns:a16="http://schemas.microsoft.com/office/drawing/2014/main" id="{9BA32D6A-9AD5-4D01-8EDD-79FCDF87A0B8}"/>
              </a:ext>
            </a:extLst>
          </p:cNvPr>
          <p:cNvSpPr txBox="1"/>
          <p:nvPr/>
        </p:nvSpPr>
        <p:spPr>
          <a:xfrm>
            <a:off x="1137220" y="1006313"/>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A</a:t>
            </a:r>
          </a:p>
        </p:txBody>
      </p:sp>
      <p:sp>
        <p:nvSpPr>
          <p:cNvPr id="12" name="TextBox 11">
            <a:extLst>
              <a:ext uri="{FF2B5EF4-FFF2-40B4-BE49-F238E27FC236}">
                <a16:creationId xmlns:a16="http://schemas.microsoft.com/office/drawing/2014/main" id="{3F375E5B-6BE0-4DA4-9B35-E0B34C2844A9}"/>
              </a:ext>
            </a:extLst>
          </p:cNvPr>
          <p:cNvSpPr txBox="1"/>
          <p:nvPr/>
        </p:nvSpPr>
        <p:spPr>
          <a:xfrm>
            <a:off x="1137220" y="3812459"/>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B</a:t>
            </a:r>
          </a:p>
        </p:txBody>
      </p:sp>
      <p:sp>
        <p:nvSpPr>
          <p:cNvPr id="13" name="TextBox 12">
            <a:extLst>
              <a:ext uri="{FF2B5EF4-FFF2-40B4-BE49-F238E27FC236}">
                <a16:creationId xmlns:a16="http://schemas.microsoft.com/office/drawing/2014/main" id="{6F692654-7FCB-4876-AF6C-DD6C8BAF5804}"/>
              </a:ext>
            </a:extLst>
          </p:cNvPr>
          <p:cNvSpPr txBox="1"/>
          <p:nvPr/>
        </p:nvSpPr>
        <p:spPr>
          <a:xfrm>
            <a:off x="1186627" y="6699758"/>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C</a:t>
            </a:r>
          </a:p>
        </p:txBody>
      </p:sp>
      <p:sp>
        <p:nvSpPr>
          <p:cNvPr id="2" name="Rectangle 1">
            <a:extLst>
              <a:ext uri="{FF2B5EF4-FFF2-40B4-BE49-F238E27FC236}">
                <a16:creationId xmlns:a16="http://schemas.microsoft.com/office/drawing/2014/main" id="{5C78AB23-E2E3-4B38-A922-22B94A8E4549}"/>
              </a:ext>
            </a:extLst>
          </p:cNvPr>
          <p:cNvSpPr/>
          <p:nvPr/>
        </p:nvSpPr>
        <p:spPr>
          <a:xfrm>
            <a:off x="3765013" y="4844534"/>
            <a:ext cx="242374" cy="369332"/>
          </a:xfrm>
          <a:prstGeom prst="rect">
            <a:avLst/>
          </a:prstGeom>
        </p:spPr>
        <p:txBody>
          <a:bodyPr wrap="none">
            <a:spAutoFit/>
          </a:bodyPr>
          <a:lstStyle/>
          <a:p>
            <a:r>
              <a:rPr lang="en-US" dirty="0">
                <a:solidFill>
                  <a:srgbClr val="000000"/>
                </a:solidFill>
                <a:latin typeface="Times New Roman" panose="02020603050405020304" pitchFamily="18" charset="0"/>
              </a:rPr>
              <a:t> </a:t>
            </a:r>
            <a:endParaRPr lang="en-US" dirty="0"/>
          </a:p>
        </p:txBody>
      </p:sp>
      <p:graphicFrame>
        <p:nvGraphicFramePr>
          <p:cNvPr id="14" name="Chart 13">
            <a:extLst>
              <a:ext uri="{FF2B5EF4-FFF2-40B4-BE49-F238E27FC236}">
                <a16:creationId xmlns:a16="http://schemas.microsoft.com/office/drawing/2014/main" id="{CA962D1D-4ED2-4223-871B-C38C47D1ABF3}"/>
              </a:ext>
            </a:extLst>
          </p:cNvPr>
          <p:cNvGraphicFramePr>
            <a:graphicFrameLocks/>
          </p:cNvGraphicFramePr>
          <p:nvPr>
            <p:extLst>
              <p:ext uri="{D42A27DB-BD31-4B8C-83A1-F6EECF244321}">
                <p14:modId xmlns:p14="http://schemas.microsoft.com/office/powerpoint/2010/main" val="2323720236"/>
              </p:ext>
            </p:extLst>
          </p:nvPr>
        </p:nvGraphicFramePr>
        <p:xfrm>
          <a:off x="1976744" y="3137061"/>
          <a:ext cx="5566327" cy="3295795"/>
        </p:xfrm>
        <a:graphic>
          <a:graphicData uri="http://schemas.openxmlformats.org/drawingml/2006/chart">
            <c:chart xmlns:c="http://schemas.openxmlformats.org/drawingml/2006/chart" xmlns:r="http://schemas.openxmlformats.org/officeDocument/2006/relationships" r:id="rId5"/>
          </a:graphicData>
        </a:graphic>
      </p:graphicFrame>
    </p:spTree>
    <p:extLst>
      <p:ext uri="{BB962C8B-B14F-4D97-AF65-F5344CB8AC3E}">
        <p14:creationId xmlns:p14="http://schemas.microsoft.com/office/powerpoint/2010/main" val="158150029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377D58A7-0A5F-41D6-AA77-4EC57D8E8293}"/>
              </a:ext>
            </a:extLst>
          </p:cNvPr>
          <p:cNvSpPr>
            <a:spLocks noGrp="1"/>
          </p:cNvSpPr>
          <p:nvPr>
            <p:ph type="sldNum" sz="quarter" idx="12"/>
          </p:nvPr>
        </p:nvSpPr>
        <p:spPr/>
        <p:txBody>
          <a:bodyPr/>
          <a:lstStyle/>
          <a:p>
            <a:r>
              <a:rPr lang="en-US"/>
              <a:t>S</a:t>
            </a:r>
            <a:fld id="{0DD34403-E6AF-9B44-8A22-D75A397E6552}" type="slidenum">
              <a:rPr lang="en-US" smtClean="0"/>
              <a:pPr/>
              <a:t>11</a:t>
            </a:fld>
            <a:endParaRPr lang="en-US"/>
          </a:p>
        </p:txBody>
      </p:sp>
      <p:sp>
        <p:nvSpPr>
          <p:cNvPr id="8" name="TextBox 7">
            <a:extLst>
              <a:ext uri="{FF2B5EF4-FFF2-40B4-BE49-F238E27FC236}">
                <a16:creationId xmlns:a16="http://schemas.microsoft.com/office/drawing/2014/main" id="{2E014ED0-BBC0-479D-B445-48611D72F74B}"/>
              </a:ext>
            </a:extLst>
          </p:cNvPr>
          <p:cNvSpPr txBox="1"/>
          <p:nvPr/>
        </p:nvSpPr>
        <p:spPr>
          <a:xfrm>
            <a:off x="704746" y="4881769"/>
            <a:ext cx="6781376" cy="861774"/>
          </a:xfrm>
          <a:prstGeom prst="rect">
            <a:avLst/>
          </a:prstGeom>
          <a:solidFill>
            <a:schemeClr val="bg1"/>
          </a:solidFill>
        </p:spPr>
        <p:txBody>
          <a:bodyPr wrap="square" lIns="0" tIns="0" rIns="0" bIns="0" rtlCol="0">
            <a:spAutoFit/>
          </a:bodyPr>
          <a:lstStyle/>
          <a:p>
            <a:pPr algn="just"/>
            <a:r>
              <a:rPr lang="en-US" sz="1400" b="1" dirty="0">
                <a:latin typeface="Times New Roman" panose="02020603050405020304" pitchFamily="18" charset="0"/>
                <a:cs typeface="Times New Roman" panose="02020603050405020304" pitchFamily="18" charset="0"/>
              </a:rPr>
              <a:t>Figure S8. </a:t>
            </a:r>
            <a:r>
              <a:rPr lang="en-US" sz="1400" dirty="0">
                <a:latin typeface="Times New Roman" panose="02020603050405020304" pitchFamily="18" charset="0"/>
                <a:ea typeface="Calibri" panose="020F0502020204030204" pitchFamily="34" charset="0"/>
                <a:cs typeface="Times New Roman" panose="02020603050405020304" pitchFamily="18" charset="0"/>
              </a:rPr>
              <a:t>Calibration curves for both XAN an optimized Pt / TEES (</a:t>
            </a:r>
            <a:r>
              <a:rPr lang="en-US" sz="1400" dirty="0" err="1">
                <a:latin typeface="Times New Roman" panose="02020603050405020304" pitchFamily="18" charset="0"/>
                <a:ea typeface="Calibri" panose="020F0502020204030204" pitchFamily="34" charset="0"/>
                <a:cs typeface="Times New Roman" panose="02020603050405020304" pitchFamily="18" charset="0"/>
              </a:rPr>
              <a:t>XOx</a:t>
            </a:r>
            <a:r>
              <a:rPr lang="en-US" sz="1400" dirty="0">
                <a:latin typeface="Times New Roman" panose="02020603050405020304" pitchFamily="18" charset="0"/>
                <a:ea typeface="Calibri" panose="020F0502020204030204" pitchFamily="34" charset="0"/>
                <a:cs typeface="Times New Roman" panose="02020603050405020304" pitchFamily="18" charset="0"/>
              </a:rPr>
              <a:t>) + C6-MPCs / PU (75:25) biosensing scheme. These calibration curves resulted in average sensitivities of 2.8 and 2.3 </a:t>
            </a:r>
            <a:r>
              <a:rPr lang="en-US" sz="1400" dirty="0" err="1">
                <a:latin typeface="Times New Roman" panose="02020603050405020304" pitchFamily="18" charset="0"/>
                <a:ea typeface="Calibri" panose="020F0502020204030204" pitchFamily="34" charset="0"/>
                <a:cs typeface="Times New Roman" panose="02020603050405020304" pitchFamily="18" charset="0"/>
              </a:rPr>
              <a:t>nA</a:t>
            </a:r>
            <a:r>
              <a:rPr lang="en-US" sz="1400" dirty="0">
                <a:latin typeface="Times New Roman" panose="02020603050405020304" pitchFamily="18" charset="0"/>
                <a:ea typeface="Calibri" panose="020F0502020204030204" pitchFamily="34" charset="0"/>
                <a:cs typeface="Times New Roman" panose="02020603050405020304" pitchFamily="18" charset="0"/>
              </a:rPr>
              <a:t>/</a:t>
            </a:r>
            <a:r>
              <a:rPr lang="el-GR" sz="1400" dirty="0">
                <a:latin typeface="Times New Roman" panose="02020603050405020304" pitchFamily="18" charset="0"/>
                <a:ea typeface="Calibri" panose="020F0502020204030204" pitchFamily="34" charset="0"/>
                <a:cs typeface="Times New Roman" panose="02020603050405020304" pitchFamily="18" charset="0"/>
              </a:rPr>
              <a:t>μ</a:t>
            </a:r>
            <a:r>
              <a:rPr lang="en-US" sz="1400" dirty="0">
                <a:latin typeface="Times New Roman" panose="02020603050405020304" pitchFamily="18" charset="0"/>
                <a:ea typeface="Calibri" panose="020F0502020204030204" pitchFamily="34" charset="0"/>
                <a:cs typeface="Times New Roman" panose="02020603050405020304" pitchFamily="18" charset="0"/>
              </a:rPr>
              <a:t>M, linear ranges &gt; 400 </a:t>
            </a:r>
            <a:r>
              <a:rPr lang="el-GR" sz="1400" dirty="0">
                <a:latin typeface="Times New Roman" panose="02020603050405020304" pitchFamily="18" charset="0"/>
                <a:ea typeface="Calibri" panose="020F0502020204030204" pitchFamily="34" charset="0"/>
                <a:cs typeface="Times New Roman" panose="02020603050405020304" pitchFamily="18" charset="0"/>
              </a:rPr>
              <a:t>μ</a:t>
            </a:r>
            <a:r>
              <a:rPr lang="en-US" sz="1400" dirty="0">
                <a:latin typeface="Times New Roman" panose="02020603050405020304" pitchFamily="18" charset="0"/>
                <a:ea typeface="Calibri" panose="020F0502020204030204" pitchFamily="34" charset="0"/>
                <a:cs typeface="Times New Roman" panose="02020603050405020304" pitchFamily="18" charset="0"/>
              </a:rPr>
              <a:t>M, and limits of detection of 2.5 and 3.0 </a:t>
            </a:r>
            <a:r>
              <a:rPr lang="el-GR" sz="1400" dirty="0">
                <a:latin typeface="Times New Roman" panose="02020603050405020304" pitchFamily="18" charset="0"/>
                <a:ea typeface="Calibri" panose="020F0502020204030204" pitchFamily="34" charset="0"/>
                <a:cs typeface="Times New Roman" panose="02020603050405020304" pitchFamily="18" charset="0"/>
              </a:rPr>
              <a:t>μ</a:t>
            </a:r>
            <a:r>
              <a:rPr lang="en-US" sz="1400" dirty="0">
                <a:latin typeface="Times New Roman" panose="02020603050405020304" pitchFamily="18" charset="0"/>
                <a:ea typeface="Calibri" panose="020F0502020204030204" pitchFamily="34" charset="0"/>
                <a:cs typeface="Times New Roman" panose="02020603050405020304" pitchFamily="18" charset="0"/>
              </a:rPr>
              <a:t>M for XAN and HXAN, respectively. (Note: Error bars reflect standard error)</a:t>
            </a:r>
            <a:r>
              <a:rPr lang="en-US" sz="1400" b="1" dirty="0">
                <a:latin typeface="Times New Roman" panose="02020603050405020304" pitchFamily="18" charset="0"/>
                <a:cs typeface="Times New Roman" panose="02020603050405020304" pitchFamily="18" charset="0"/>
              </a:rPr>
              <a:t>  </a:t>
            </a:r>
          </a:p>
        </p:txBody>
      </p:sp>
      <p:graphicFrame>
        <p:nvGraphicFramePr>
          <p:cNvPr id="11" name="Chart 10">
            <a:extLst>
              <a:ext uri="{FF2B5EF4-FFF2-40B4-BE49-F238E27FC236}">
                <a16:creationId xmlns:a16="http://schemas.microsoft.com/office/drawing/2014/main" id="{B38C0755-E482-3A42-9F6C-F26B242219D4}"/>
              </a:ext>
            </a:extLst>
          </p:cNvPr>
          <p:cNvGraphicFramePr>
            <a:graphicFrameLocks/>
          </p:cNvGraphicFramePr>
          <p:nvPr>
            <p:extLst>
              <p:ext uri="{D42A27DB-BD31-4B8C-83A1-F6EECF244321}">
                <p14:modId xmlns:p14="http://schemas.microsoft.com/office/powerpoint/2010/main" val="375760107"/>
              </p:ext>
            </p:extLst>
          </p:nvPr>
        </p:nvGraphicFramePr>
        <p:xfrm>
          <a:off x="456672" y="685829"/>
          <a:ext cx="7029450" cy="4692651"/>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55447012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93D893A6-B4B5-4787-B8FC-2804A6874B9F}"/>
              </a:ext>
            </a:extLst>
          </p:cNvPr>
          <p:cNvSpPr>
            <a:spLocks noGrp="1"/>
          </p:cNvSpPr>
          <p:nvPr>
            <p:ph type="sldNum" sz="quarter" idx="12"/>
          </p:nvPr>
        </p:nvSpPr>
        <p:spPr/>
        <p:txBody>
          <a:bodyPr/>
          <a:lstStyle/>
          <a:p>
            <a:r>
              <a:rPr lang="en-US"/>
              <a:t>S</a:t>
            </a:r>
            <a:fld id="{0DD34403-E6AF-9B44-8A22-D75A397E6552}" type="slidenum">
              <a:rPr lang="en-US" smtClean="0"/>
              <a:pPr/>
              <a:t>12</a:t>
            </a:fld>
            <a:endParaRPr lang="en-US"/>
          </a:p>
        </p:txBody>
      </p:sp>
      <p:pic>
        <p:nvPicPr>
          <p:cNvPr id="5" name="Picture 4">
            <a:extLst>
              <a:ext uri="{FF2B5EF4-FFF2-40B4-BE49-F238E27FC236}">
                <a16:creationId xmlns:a16="http://schemas.microsoft.com/office/drawing/2014/main" id="{EDAD8150-8C79-4488-8E31-AD3320142CC3}"/>
              </a:ext>
            </a:extLst>
          </p:cNvPr>
          <p:cNvPicPr>
            <a:picLocks/>
          </p:cNvPicPr>
          <p:nvPr/>
        </p:nvPicPr>
        <p:blipFill>
          <a:blip r:embed="rId2"/>
          <a:stretch>
            <a:fillRect/>
          </a:stretch>
        </p:blipFill>
        <p:spPr>
          <a:xfrm>
            <a:off x="0" y="960163"/>
            <a:ext cx="7772400" cy="3125808"/>
          </a:xfrm>
          <a:prstGeom prst="rect">
            <a:avLst/>
          </a:prstGeom>
        </p:spPr>
      </p:pic>
      <p:sp>
        <p:nvSpPr>
          <p:cNvPr id="6" name="TextBox 5">
            <a:extLst>
              <a:ext uri="{FF2B5EF4-FFF2-40B4-BE49-F238E27FC236}">
                <a16:creationId xmlns:a16="http://schemas.microsoft.com/office/drawing/2014/main" id="{BBA5D869-88B1-4C5F-BAD0-45E76CDD90DF}"/>
              </a:ext>
            </a:extLst>
          </p:cNvPr>
          <p:cNvSpPr txBox="1"/>
          <p:nvPr/>
        </p:nvSpPr>
        <p:spPr>
          <a:xfrm>
            <a:off x="457200" y="4202247"/>
            <a:ext cx="6858000" cy="553998"/>
          </a:xfrm>
          <a:prstGeom prst="rect">
            <a:avLst/>
          </a:prstGeom>
          <a:solidFill>
            <a:schemeClr val="bg1"/>
          </a:solidFill>
        </p:spPr>
        <p:txBody>
          <a:bodyPr wrap="square" lIns="0" tIns="0" rIns="0" bIns="0" rtlCol="0">
            <a:spAutoFit/>
          </a:bodyPr>
          <a:lstStyle/>
          <a:p>
            <a:pPr algn="just"/>
            <a:r>
              <a:rPr lang="en-US" sz="1200" b="1" dirty="0"/>
              <a:t>Figure S9.  </a:t>
            </a:r>
            <a:r>
              <a:rPr lang="en-US" sz="1200" dirty="0"/>
              <a:t>Selectivity coefficients for common interferents (</a:t>
            </a:r>
            <a:r>
              <a:rPr lang="en-US" sz="1200" dirty="0">
                <a:latin typeface="Times New Roman" panose="02020603050405020304" pitchFamily="18" charset="0"/>
                <a:cs typeface="Times New Roman" panose="02020603050405020304" pitchFamily="18" charset="0"/>
              </a:rPr>
              <a:t>ascorbic acid (4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glucose (10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sodium benzoate (4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uric acid (10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creatinine (5 mM), urea (150 mM), and </a:t>
            </a:r>
            <a:r>
              <a:rPr lang="en-US" sz="1200" dirty="0"/>
              <a:t>xanthine (3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a:t>
            </a:r>
            <a:r>
              <a:rPr lang="en-US" sz="1200" dirty="0"/>
              <a:t> monitored over 10 days for the Pt / HMTES (</a:t>
            </a:r>
            <a:r>
              <a:rPr lang="en-US" sz="1200" dirty="0" err="1"/>
              <a:t>XOx</a:t>
            </a:r>
            <a:r>
              <a:rPr lang="en-US" sz="1200" dirty="0"/>
              <a:t>) + C6 MPC / PU (75:25) system.  </a:t>
            </a:r>
            <a:endParaRPr lang="en-US" sz="1200" b="1" dirty="0"/>
          </a:p>
        </p:txBody>
      </p:sp>
    </p:spTree>
    <p:extLst>
      <p:ext uri="{BB962C8B-B14F-4D97-AF65-F5344CB8AC3E}">
        <p14:creationId xmlns:p14="http://schemas.microsoft.com/office/powerpoint/2010/main" val="425238356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93D893A6-B4B5-4787-B8FC-2804A6874B9F}"/>
              </a:ext>
            </a:extLst>
          </p:cNvPr>
          <p:cNvSpPr>
            <a:spLocks noGrp="1"/>
          </p:cNvSpPr>
          <p:nvPr>
            <p:ph type="sldNum" sz="quarter" idx="12"/>
          </p:nvPr>
        </p:nvSpPr>
        <p:spPr/>
        <p:txBody>
          <a:bodyPr/>
          <a:lstStyle/>
          <a:p>
            <a:r>
              <a:rPr lang="en-US"/>
              <a:t>S</a:t>
            </a:r>
            <a:fld id="{0DD34403-E6AF-9B44-8A22-D75A397E6552}" type="slidenum">
              <a:rPr lang="en-US" smtClean="0"/>
              <a:pPr/>
              <a:t>13</a:t>
            </a:fld>
            <a:endParaRPr lang="en-US"/>
          </a:p>
        </p:txBody>
      </p:sp>
      <p:graphicFrame>
        <p:nvGraphicFramePr>
          <p:cNvPr id="5" name="Chart 4">
            <a:extLst>
              <a:ext uri="{FF2B5EF4-FFF2-40B4-BE49-F238E27FC236}">
                <a16:creationId xmlns:a16="http://schemas.microsoft.com/office/drawing/2014/main" id="{0A786D93-51F9-4B82-915E-570BADAF76F5}"/>
              </a:ext>
            </a:extLst>
          </p:cNvPr>
          <p:cNvGraphicFramePr>
            <a:graphicFrameLocks/>
          </p:cNvGraphicFramePr>
          <p:nvPr>
            <p:extLst>
              <p:ext uri="{D42A27DB-BD31-4B8C-83A1-F6EECF244321}">
                <p14:modId xmlns:p14="http://schemas.microsoft.com/office/powerpoint/2010/main" val="2111998109"/>
              </p:ext>
            </p:extLst>
          </p:nvPr>
        </p:nvGraphicFramePr>
        <p:xfrm>
          <a:off x="-22578" y="6711247"/>
          <a:ext cx="8443137" cy="475262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Chart 5">
            <a:extLst>
              <a:ext uri="{FF2B5EF4-FFF2-40B4-BE49-F238E27FC236}">
                <a16:creationId xmlns:a16="http://schemas.microsoft.com/office/drawing/2014/main" id="{EF8AC41A-6BA4-4A11-A28D-72C65818E3F4}"/>
              </a:ext>
            </a:extLst>
          </p:cNvPr>
          <p:cNvGraphicFramePr>
            <a:graphicFrameLocks/>
          </p:cNvGraphicFramePr>
          <p:nvPr>
            <p:extLst>
              <p:ext uri="{D42A27DB-BD31-4B8C-83A1-F6EECF244321}">
                <p14:modId xmlns:p14="http://schemas.microsoft.com/office/powerpoint/2010/main" val="200095937"/>
              </p:ext>
            </p:extLst>
          </p:nvPr>
        </p:nvGraphicFramePr>
        <p:xfrm>
          <a:off x="126295" y="2799645"/>
          <a:ext cx="5644832" cy="3697112"/>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 name="Chart 3">
            <a:extLst>
              <a:ext uri="{FF2B5EF4-FFF2-40B4-BE49-F238E27FC236}">
                <a16:creationId xmlns:a16="http://schemas.microsoft.com/office/drawing/2014/main" id="{844EED0C-F5F3-4E7B-8337-BFDFB76FD104}"/>
              </a:ext>
            </a:extLst>
          </p:cNvPr>
          <p:cNvGraphicFramePr>
            <a:graphicFrameLocks/>
          </p:cNvGraphicFramePr>
          <p:nvPr>
            <p:extLst>
              <p:ext uri="{D42A27DB-BD31-4B8C-83A1-F6EECF244321}">
                <p14:modId xmlns:p14="http://schemas.microsoft.com/office/powerpoint/2010/main" val="3633929102"/>
              </p:ext>
            </p:extLst>
          </p:nvPr>
        </p:nvGraphicFramePr>
        <p:xfrm>
          <a:off x="126295" y="0"/>
          <a:ext cx="6616700" cy="4278489"/>
        </p:xfrm>
        <a:graphic>
          <a:graphicData uri="http://schemas.openxmlformats.org/drawingml/2006/chart">
            <c:chart xmlns:c="http://schemas.openxmlformats.org/drawingml/2006/chart" xmlns:r="http://schemas.openxmlformats.org/officeDocument/2006/relationships" r:id="rId4"/>
          </a:graphicData>
        </a:graphic>
      </p:graphicFrame>
      <p:sp>
        <p:nvSpPr>
          <p:cNvPr id="7" name="TextBox 6">
            <a:extLst>
              <a:ext uri="{FF2B5EF4-FFF2-40B4-BE49-F238E27FC236}">
                <a16:creationId xmlns:a16="http://schemas.microsoft.com/office/drawing/2014/main" id="{0E2CBECE-73CD-43D3-8AFF-79B9B087CBE2}"/>
              </a:ext>
            </a:extLst>
          </p:cNvPr>
          <p:cNvSpPr txBox="1"/>
          <p:nvPr/>
        </p:nvSpPr>
        <p:spPr>
          <a:xfrm>
            <a:off x="3995248" y="514231"/>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53E952F0-7DB7-427D-927A-735E28B43FA9}"/>
              </a:ext>
            </a:extLst>
          </p:cNvPr>
          <p:cNvSpPr txBox="1"/>
          <p:nvPr/>
        </p:nvSpPr>
        <p:spPr>
          <a:xfrm>
            <a:off x="4832938" y="3947926"/>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AF38C144-8AFC-4CE1-A4BF-4244E96E9CB5}"/>
              </a:ext>
            </a:extLst>
          </p:cNvPr>
          <p:cNvSpPr txBox="1"/>
          <p:nvPr/>
        </p:nvSpPr>
        <p:spPr>
          <a:xfrm>
            <a:off x="4832938" y="6835225"/>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C</a:t>
            </a:r>
          </a:p>
        </p:txBody>
      </p:sp>
      <p:sp>
        <p:nvSpPr>
          <p:cNvPr id="10" name="TextBox 9">
            <a:extLst>
              <a:ext uri="{FF2B5EF4-FFF2-40B4-BE49-F238E27FC236}">
                <a16:creationId xmlns:a16="http://schemas.microsoft.com/office/drawing/2014/main" id="{6F54C049-6E1F-41B7-A4BB-6997481EDFC0}"/>
              </a:ext>
            </a:extLst>
          </p:cNvPr>
          <p:cNvSpPr txBox="1"/>
          <p:nvPr/>
        </p:nvSpPr>
        <p:spPr>
          <a:xfrm>
            <a:off x="4879929" y="471179"/>
            <a:ext cx="2604736" cy="2123658"/>
          </a:xfrm>
          <a:prstGeom prst="rect">
            <a:avLst/>
          </a:prstGeom>
          <a:solidFill>
            <a:schemeClr val="bg1"/>
          </a:solidFill>
        </p:spPr>
        <p:txBody>
          <a:bodyPr wrap="square" rtlCol="0">
            <a:spAutoFit/>
          </a:bodyPr>
          <a:lstStyle/>
          <a:p>
            <a:pPr algn="just"/>
            <a:r>
              <a:rPr lang="en-US" sz="1200" b="1" dirty="0"/>
              <a:t>Figure S10.  </a:t>
            </a:r>
            <a:r>
              <a:rPr lang="en-US" sz="1200" dirty="0"/>
              <a:t>Initial</a:t>
            </a:r>
            <a:r>
              <a:rPr lang="en-US" sz="1200" b="1" dirty="0"/>
              <a:t> s</a:t>
            </a:r>
            <a:r>
              <a:rPr lang="en-US" sz="1200" dirty="0"/>
              <a:t>electivity coefficients for common interferents (</a:t>
            </a:r>
            <a:r>
              <a:rPr lang="en-US" sz="1200" dirty="0">
                <a:latin typeface="Times New Roman" panose="02020603050405020304" pitchFamily="18" charset="0"/>
                <a:cs typeface="Times New Roman" panose="02020603050405020304" pitchFamily="18" charset="0"/>
              </a:rPr>
              <a:t>ascorbic acid (4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glucose (10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sodium benzoate (4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uric acid (10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creatinine (5 mM), urea (150 mM), and </a:t>
            </a:r>
            <a:r>
              <a:rPr lang="en-US" sz="1200" dirty="0"/>
              <a:t>xanthine (3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a:t>
            </a:r>
            <a:r>
              <a:rPr lang="en-US" sz="1200" dirty="0"/>
              <a:t> for the Pt / TEES (</a:t>
            </a:r>
            <a:r>
              <a:rPr lang="en-US" sz="1200" dirty="0" err="1"/>
              <a:t>XOx</a:t>
            </a:r>
            <a:r>
              <a:rPr lang="en-US" sz="1200" dirty="0"/>
              <a:t>) + MPC / PU (75:25) systems where TEES is doped with </a:t>
            </a:r>
            <a:r>
              <a:rPr lang="en-US" sz="1200" b="1" dirty="0"/>
              <a:t>(A)</a:t>
            </a:r>
            <a:r>
              <a:rPr lang="en-US" sz="1200" dirty="0"/>
              <a:t> C6 MPC, </a:t>
            </a:r>
            <a:r>
              <a:rPr lang="en-US" sz="1200" b="1" dirty="0"/>
              <a:t>(B)</a:t>
            </a:r>
            <a:r>
              <a:rPr lang="en-US" sz="1200" dirty="0"/>
              <a:t> C4 MPC, and </a:t>
            </a:r>
            <a:r>
              <a:rPr lang="en-US" sz="1200" b="1" dirty="0"/>
              <a:t>(C) </a:t>
            </a:r>
            <a:r>
              <a:rPr lang="en-US" sz="1200" dirty="0"/>
              <a:t>C3 MPC.  Note: Legend at bottom applies to all three figures.</a:t>
            </a:r>
            <a:endParaRPr lang="en-US" sz="1200" b="1" dirty="0"/>
          </a:p>
        </p:txBody>
      </p:sp>
    </p:spTree>
    <p:extLst>
      <p:ext uri="{BB962C8B-B14F-4D97-AF65-F5344CB8AC3E}">
        <p14:creationId xmlns:p14="http://schemas.microsoft.com/office/powerpoint/2010/main" val="395423129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93D893A6-B4B5-4787-B8FC-2804A6874B9F}"/>
              </a:ext>
            </a:extLst>
          </p:cNvPr>
          <p:cNvSpPr>
            <a:spLocks noGrp="1"/>
          </p:cNvSpPr>
          <p:nvPr>
            <p:ph type="sldNum" sz="quarter" idx="12"/>
          </p:nvPr>
        </p:nvSpPr>
        <p:spPr/>
        <p:txBody>
          <a:bodyPr/>
          <a:lstStyle/>
          <a:p>
            <a:r>
              <a:rPr lang="en-US">
                <a:latin typeface="Arial" panose="020B0604020202020204" pitchFamily="34" charset="0"/>
                <a:cs typeface="Arial" panose="020B0604020202020204" pitchFamily="34" charset="0"/>
              </a:rPr>
              <a:t>S</a:t>
            </a:r>
            <a:fld id="{0DD34403-E6AF-9B44-8A22-D75A397E6552}" type="slidenum">
              <a:rPr lang="en-US" smtClean="0">
                <a:latin typeface="Arial" panose="020B0604020202020204" pitchFamily="34" charset="0"/>
                <a:cs typeface="Arial" panose="020B0604020202020204" pitchFamily="34" charset="0"/>
              </a:rPr>
              <a:pPr/>
              <a:t>14</a:t>
            </a:fld>
            <a:endParaRPr lang="en-US">
              <a:latin typeface="Arial" panose="020B0604020202020204" pitchFamily="34" charset="0"/>
              <a:cs typeface="Arial" panose="020B0604020202020204" pitchFamily="34" charset="0"/>
            </a:endParaRPr>
          </a:p>
        </p:txBody>
      </p:sp>
      <p:graphicFrame>
        <p:nvGraphicFramePr>
          <p:cNvPr id="4" name="Chart 3">
            <a:extLst>
              <a:ext uri="{FF2B5EF4-FFF2-40B4-BE49-F238E27FC236}">
                <a16:creationId xmlns:a16="http://schemas.microsoft.com/office/drawing/2014/main" id="{DCBA98A1-B90B-402C-B674-956E67AA9E18}"/>
              </a:ext>
            </a:extLst>
          </p:cNvPr>
          <p:cNvGraphicFramePr>
            <a:graphicFrameLocks/>
          </p:cNvGraphicFramePr>
          <p:nvPr>
            <p:extLst>
              <p:ext uri="{D42A27DB-BD31-4B8C-83A1-F6EECF244321}">
                <p14:modId xmlns:p14="http://schemas.microsoft.com/office/powerpoint/2010/main" val="3171375441"/>
              </p:ext>
            </p:extLst>
          </p:nvPr>
        </p:nvGraphicFramePr>
        <p:xfrm>
          <a:off x="1245304" y="200234"/>
          <a:ext cx="5602569" cy="368300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D45BF925-D7D0-4407-AF23-6ECF06A46BA3}"/>
              </a:ext>
            </a:extLst>
          </p:cNvPr>
          <p:cNvGraphicFramePr>
            <a:graphicFrameLocks/>
          </p:cNvGraphicFramePr>
          <p:nvPr>
            <p:extLst>
              <p:ext uri="{D42A27DB-BD31-4B8C-83A1-F6EECF244321}">
                <p14:modId xmlns:p14="http://schemas.microsoft.com/office/powerpoint/2010/main" val="1585934912"/>
              </p:ext>
            </p:extLst>
          </p:nvPr>
        </p:nvGraphicFramePr>
        <p:xfrm>
          <a:off x="951793" y="4110038"/>
          <a:ext cx="6487585" cy="4477264"/>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a:extLst>
              <a:ext uri="{FF2B5EF4-FFF2-40B4-BE49-F238E27FC236}">
                <a16:creationId xmlns:a16="http://schemas.microsoft.com/office/drawing/2014/main" id="{0E2629CC-66B6-47CC-BFD3-EEB694C49556}"/>
              </a:ext>
            </a:extLst>
          </p:cNvPr>
          <p:cNvSpPr txBox="1"/>
          <p:nvPr/>
        </p:nvSpPr>
        <p:spPr>
          <a:xfrm>
            <a:off x="837820" y="295113"/>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D2C6B359-77C5-4B71-AFBD-00ADA909A05D}"/>
              </a:ext>
            </a:extLst>
          </p:cNvPr>
          <p:cNvSpPr txBox="1"/>
          <p:nvPr/>
        </p:nvSpPr>
        <p:spPr>
          <a:xfrm>
            <a:off x="748051" y="4101425"/>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74CC8790-2487-45F5-BAD4-571E9778520A}"/>
              </a:ext>
            </a:extLst>
          </p:cNvPr>
          <p:cNvSpPr txBox="1"/>
          <p:nvPr/>
        </p:nvSpPr>
        <p:spPr>
          <a:xfrm>
            <a:off x="457200" y="8447144"/>
            <a:ext cx="6858000" cy="923330"/>
          </a:xfrm>
          <a:prstGeom prst="rect">
            <a:avLst/>
          </a:prstGeom>
          <a:solidFill>
            <a:schemeClr val="bg1"/>
          </a:solidFill>
        </p:spPr>
        <p:txBody>
          <a:bodyPr wrap="square" lIns="0" tIns="0" rIns="0" bIns="0" rtlCol="0">
            <a:spAutoFit/>
          </a:bodyPr>
          <a:lstStyle/>
          <a:p>
            <a:pPr algn="just"/>
            <a:r>
              <a:rPr lang="en-US" sz="1200" b="1" dirty="0"/>
              <a:t>Figure S11.  </a:t>
            </a:r>
            <a:r>
              <a:rPr lang="en-US" sz="1200" dirty="0"/>
              <a:t>Selectivity coefficients for common interferents (</a:t>
            </a:r>
            <a:r>
              <a:rPr lang="en-US" sz="1200" dirty="0">
                <a:latin typeface="Times New Roman" panose="02020603050405020304" pitchFamily="18" charset="0"/>
                <a:cs typeface="Times New Roman" panose="02020603050405020304" pitchFamily="18" charset="0"/>
              </a:rPr>
              <a:t>ascorbic acid (4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glucose (10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sodium benzoate (4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uric acid (10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creatinine (5 mM), urea (150 mM), and </a:t>
            </a:r>
            <a:r>
              <a:rPr lang="en-US" sz="1200" dirty="0"/>
              <a:t>xanthine (3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a:t>
            </a:r>
            <a:r>
              <a:rPr lang="en-US" sz="1200" dirty="0"/>
              <a:t> monitored over 10 days for the (A) Pt / TEES (</a:t>
            </a:r>
            <a:r>
              <a:rPr lang="en-US" sz="1200" dirty="0" err="1"/>
              <a:t>XOx</a:t>
            </a:r>
            <a:r>
              <a:rPr lang="en-US" sz="1200" dirty="0"/>
              <a:t>) + C6 MPC / PU (75:25)  and (B) ) Pt / TEES (</a:t>
            </a:r>
            <a:r>
              <a:rPr lang="en-US" sz="1200" dirty="0" err="1"/>
              <a:t>XOx</a:t>
            </a:r>
            <a:r>
              <a:rPr lang="en-US" sz="1200" dirty="0"/>
              <a:t>) + C4 MPC / PU (75:25) systems. Note: The analogous system doped with C3 was discontinued in the study due to poor stability. </a:t>
            </a:r>
            <a:endParaRPr lang="en-US" sz="1200" b="1" dirty="0"/>
          </a:p>
        </p:txBody>
      </p:sp>
    </p:spTree>
    <p:extLst>
      <p:ext uri="{BB962C8B-B14F-4D97-AF65-F5344CB8AC3E}">
        <p14:creationId xmlns:p14="http://schemas.microsoft.com/office/powerpoint/2010/main" val="96196175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166DE082-BAA1-445B-9111-B527FD6FC50F}"/>
              </a:ext>
            </a:extLst>
          </p:cNvPr>
          <p:cNvSpPr>
            <a:spLocks noGrp="1"/>
          </p:cNvSpPr>
          <p:nvPr>
            <p:ph type="sldNum" sz="quarter" idx="12"/>
          </p:nvPr>
        </p:nvSpPr>
        <p:spPr/>
        <p:txBody>
          <a:bodyPr/>
          <a:lstStyle/>
          <a:p>
            <a:r>
              <a:rPr lang="en-US"/>
              <a:t>S</a:t>
            </a:r>
            <a:fld id="{0DD34403-E6AF-9B44-8A22-D75A397E6552}" type="slidenum">
              <a:rPr lang="en-US" smtClean="0"/>
              <a:pPr/>
              <a:t>15</a:t>
            </a:fld>
            <a:endParaRPr lang="en-US"/>
          </a:p>
        </p:txBody>
      </p:sp>
      <p:pic>
        <p:nvPicPr>
          <p:cNvPr id="4" name="Content Placeholder 5">
            <a:extLst>
              <a:ext uri="{FF2B5EF4-FFF2-40B4-BE49-F238E27FC236}">
                <a16:creationId xmlns:a16="http://schemas.microsoft.com/office/drawing/2014/main" id="{4148EFD7-90BD-4057-B741-5AFB07CE41B7}"/>
              </a:ext>
            </a:extLst>
          </p:cNvPr>
          <p:cNvPicPr>
            <a:picLocks noGrp="1" noChangeAspect="1"/>
          </p:cNvPicPr>
          <p:nvPr>
            <p:ph idx="1"/>
          </p:nvPr>
        </p:nvPicPr>
        <p:blipFill rotWithShape="1">
          <a:blip r:embed="rId2">
            <a:extLst>
              <a:ext uri="{28A0092B-C50C-407E-A947-70E740481C1C}">
                <a14:useLocalDpi xmlns:a14="http://schemas.microsoft.com/office/drawing/2010/main" val="0"/>
              </a:ext>
            </a:extLst>
          </a:blip>
          <a:srcRect l="50215" t="15125" r="1610" b="8660"/>
          <a:stretch/>
        </p:blipFill>
        <p:spPr>
          <a:xfrm>
            <a:off x="237061" y="128765"/>
            <a:ext cx="3239913" cy="3201458"/>
          </a:xfrm>
        </p:spPr>
      </p:pic>
      <p:pic>
        <p:nvPicPr>
          <p:cNvPr id="5" name="Content Placeholder 5" descr="Graphical user interface, chart&#10;&#10;Description automatically generated">
            <a:extLst>
              <a:ext uri="{FF2B5EF4-FFF2-40B4-BE49-F238E27FC236}">
                <a16:creationId xmlns:a16="http://schemas.microsoft.com/office/drawing/2014/main" id="{AD2C5ED1-F36F-4068-9E7E-C0EDDA2B9FA1}"/>
              </a:ext>
            </a:extLst>
          </p:cNvPr>
          <p:cNvPicPr>
            <a:picLocks noChangeAspect="1"/>
          </p:cNvPicPr>
          <p:nvPr/>
        </p:nvPicPr>
        <p:blipFill rotWithShape="1">
          <a:blip r:embed="rId3">
            <a:extLst>
              <a:ext uri="{28A0092B-C50C-407E-A947-70E740481C1C}">
                <a14:useLocalDpi xmlns:a14="http://schemas.microsoft.com/office/drawing/2010/main" val="0"/>
              </a:ext>
            </a:extLst>
          </a:blip>
          <a:srcRect l="1306" t="14602" r="51824" b="9182"/>
          <a:stretch/>
        </p:blipFill>
        <p:spPr>
          <a:xfrm>
            <a:off x="324882" y="3410916"/>
            <a:ext cx="3152094" cy="3201459"/>
          </a:xfrm>
          <a:prstGeom prst="rect">
            <a:avLst/>
          </a:prstGeom>
        </p:spPr>
      </p:pic>
      <p:pic>
        <p:nvPicPr>
          <p:cNvPr id="6" name="Content Placeholder 5" descr="Graphical user interface, chart&#10;&#10;Description automatically generated">
            <a:extLst>
              <a:ext uri="{FF2B5EF4-FFF2-40B4-BE49-F238E27FC236}">
                <a16:creationId xmlns:a16="http://schemas.microsoft.com/office/drawing/2014/main" id="{6F98EDD4-D387-48D8-BF9D-1C7A14375CC8}"/>
              </a:ext>
            </a:extLst>
          </p:cNvPr>
          <p:cNvPicPr>
            <a:picLocks noChangeAspect="1"/>
          </p:cNvPicPr>
          <p:nvPr/>
        </p:nvPicPr>
        <p:blipFill rotWithShape="1">
          <a:blip r:embed="rId4">
            <a:extLst>
              <a:ext uri="{28A0092B-C50C-407E-A947-70E740481C1C}">
                <a14:useLocalDpi xmlns:a14="http://schemas.microsoft.com/office/drawing/2010/main" val="0"/>
              </a:ext>
            </a:extLst>
          </a:blip>
          <a:srcRect l="1306" t="14238" r="51824" b="9546"/>
          <a:stretch/>
        </p:blipFill>
        <p:spPr>
          <a:xfrm>
            <a:off x="324882" y="6733201"/>
            <a:ext cx="3152094" cy="3201458"/>
          </a:xfrm>
          <a:prstGeom prst="rect">
            <a:avLst/>
          </a:prstGeom>
        </p:spPr>
      </p:pic>
      <p:sp>
        <p:nvSpPr>
          <p:cNvPr id="7" name="TextBox 6">
            <a:extLst>
              <a:ext uri="{FF2B5EF4-FFF2-40B4-BE49-F238E27FC236}">
                <a16:creationId xmlns:a16="http://schemas.microsoft.com/office/drawing/2014/main" id="{CCCAD9FD-85FB-4009-B124-A6BD3577001B}"/>
              </a:ext>
            </a:extLst>
          </p:cNvPr>
          <p:cNvSpPr txBox="1"/>
          <p:nvPr/>
        </p:nvSpPr>
        <p:spPr>
          <a:xfrm>
            <a:off x="3476978" y="128765"/>
            <a:ext cx="3970540" cy="646331"/>
          </a:xfrm>
          <a:prstGeom prst="rect">
            <a:avLst/>
          </a:prstGeom>
          <a:noFill/>
        </p:spPr>
        <p:txBody>
          <a:bodyPr wrap="square" rtlCol="0">
            <a:spAutoFit/>
          </a:bodyPr>
          <a:lstStyle/>
          <a:p>
            <a:pPr algn="just"/>
            <a:r>
              <a:rPr lang="en-US" sz="1200" b="1" dirty="0"/>
              <a:t>Figure S12.  </a:t>
            </a:r>
            <a:r>
              <a:rPr lang="en-US" sz="1200" dirty="0"/>
              <a:t>Cyclic voltammetry (100 mV/sec) of 100 mM uric acid solution (10 mM PBS) showing onset and peak current of uric acid oxidation at a bare platinum electrode. </a:t>
            </a:r>
          </a:p>
        </p:txBody>
      </p:sp>
      <p:sp>
        <p:nvSpPr>
          <p:cNvPr id="8" name="TextBox 7">
            <a:extLst>
              <a:ext uri="{FF2B5EF4-FFF2-40B4-BE49-F238E27FC236}">
                <a16:creationId xmlns:a16="http://schemas.microsoft.com/office/drawing/2014/main" id="{48B2EE82-35A8-41F8-8579-01C7DE894A02}"/>
              </a:ext>
            </a:extLst>
          </p:cNvPr>
          <p:cNvSpPr txBox="1"/>
          <p:nvPr/>
        </p:nvSpPr>
        <p:spPr>
          <a:xfrm>
            <a:off x="3476977" y="3433947"/>
            <a:ext cx="3970541" cy="646331"/>
          </a:xfrm>
          <a:prstGeom prst="rect">
            <a:avLst/>
          </a:prstGeom>
          <a:noFill/>
        </p:spPr>
        <p:txBody>
          <a:bodyPr wrap="square" rtlCol="0">
            <a:spAutoFit/>
          </a:bodyPr>
          <a:lstStyle/>
          <a:p>
            <a:pPr algn="just"/>
            <a:r>
              <a:rPr lang="en-US" sz="1200" b="1" dirty="0"/>
              <a:t>Figure S13.  </a:t>
            </a:r>
            <a:r>
              <a:rPr lang="en-US" sz="1200" dirty="0"/>
              <a:t>Cyclic voltammetry (100 mV/sec) of 100 mM xanthine solution (10 mM PBS) showing onset and peak current of xanthine oxidation at a bare platinum electrode. </a:t>
            </a:r>
          </a:p>
        </p:txBody>
      </p:sp>
      <p:sp>
        <p:nvSpPr>
          <p:cNvPr id="9" name="TextBox 8">
            <a:extLst>
              <a:ext uri="{FF2B5EF4-FFF2-40B4-BE49-F238E27FC236}">
                <a16:creationId xmlns:a16="http://schemas.microsoft.com/office/drawing/2014/main" id="{86E96B1A-5008-4EA3-858B-41D79923C0C4}"/>
              </a:ext>
            </a:extLst>
          </p:cNvPr>
          <p:cNvSpPr txBox="1"/>
          <p:nvPr/>
        </p:nvSpPr>
        <p:spPr>
          <a:xfrm>
            <a:off x="3476976" y="6824847"/>
            <a:ext cx="3970542" cy="830997"/>
          </a:xfrm>
          <a:prstGeom prst="rect">
            <a:avLst/>
          </a:prstGeom>
          <a:noFill/>
        </p:spPr>
        <p:txBody>
          <a:bodyPr wrap="square" rtlCol="0">
            <a:spAutoFit/>
          </a:bodyPr>
          <a:lstStyle/>
          <a:p>
            <a:pPr algn="just"/>
            <a:r>
              <a:rPr lang="en-US" sz="1200" b="1" dirty="0"/>
              <a:t>Figure S14.  </a:t>
            </a:r>
            <a:r>
              <a:rPr lang="en-US" sz="1200" dirty="0"/>
              <a:t>Cyclic voltammetry (100 mV/sec) of 100 mM hypoxanthine solution (10 mM PBS) showing onset and peak current of hypoxanthine oxidation at a bare platinum electrode. </a:t>
            </a:r>
          </a:p>
        </p:txBody>
      </p:sp>
    </p:spTree>
    <p:extLst>
      <p:ext uri="{BB962C8B-B14F-4D97-AF65-F5344CB8AC3E}">
        <p14:creationId xmlns:p14="http://schemas.microsoft.com/office/powerpoint/2010/main" val="54291048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a:extLst>
              <a:ext uri="{FF2B5EF4-FFF2-40B4-BE49-F238E27FC236}">
                <a16:creationId xmlns:a16="http://schemas.microsoft.com/office/drawing/2014/main" id="{40DC75AA-1539-8987-6B7A-39470DC99E7D}"/>
              </a:ext>
            </a:extLst>
          </p:cNvPr>
          <p:cNvPicPr>
            <a:picLocks noChangeAspect="1"/>
          </p:cNvPicPr>
          <p:nvPr/>
        </p:nvPicPr>
        <p:blipFill>
          <a:blip r:embed="rId2"/>
          <a:stretch>
            <a:fillRect/>
          </a:stretch>
        </p:blipFill>
        <p:spPr>
          <a:xfrm>
            <a:off x="398131" y="511574"/>
            <a:ext cx="3392424" cy="2155680"/>
          </a:xfrm>
          <a:prstGeom prst="rect">
            <a:avLst/>
          </a:prstGeom>
        </p:spPr>
      </p:pic>
      <p:sp>
        <p:nvSpPr>
          <p:cNvPr id="3" name="Slide Number Placeholder 2">
            <a:extLst>
              <a:ext uri="{FF2B5EF4-FFF2-40B4-BE49-F238E27FC236}">
                <a16:creationId xmlns:a16="http://schemas.microsoft.com/office/drawing/2014/main" id="{166DE082-BAA1-445B-9111-B527FD6FC50F}"/>
              </a:ext>
            </a:extLst>
          </p:cNvPr>
          <p:cNvSpPr>
            <a:spLocks noGrp="1"/>
          </p:cNvSpPr>
          <p:nvPr>
            <p:ph type="sldNum" sz="quarter" idx="12"/>
          </p:nvPr>
        </p:nvSpPr>
        <p:spPr/>
        <p:txBody>
          <a:bodyPr/>
          <a:lstStyle/>
          <a:p>
            <a:r>
              <a:rPr lang="en-US"/>
              <a:t>S</a:t>
            </a:r>
            <a:fld id="{0DD34403-E6AF-9B44-8A22-D75A397E6552}" type="slidenum">
              <a:rPr lang="en-US" smtClean="0"/>
              <a:pPr/>
              <a:t>16</a:t>
            </a:fld>
            <a:endParaRPr lang="en-US"/>
          </a:p>
        </p:txBody>
      </p:sp>
      <p:pic>
        <p:nvPicPr>
          <p:cNvPr id="5" name="Picture 4">
            <a:extLst>
              <a:ext uri="{FF2B5EF4-FFF2-40B4-BE49-F238E27FC236}">
                <a16:creationId xmlns:a16="http://schemas.microsoft.com/office/drawing/2014/main" id="{A83BA5E7-AA8A-465D-B8BD-337FD56DD507}"/>
              </a:ext>
            </a:extLst>
          </p:cNvPr>
          <p:cNvPicPr>
            <a:picLocks noChangeAspect="1"/>
          </p:cNvPicPr>
          <p:nvPr/>
        </p:nvPicPr>
        <p:blipFill rotWithShape="1">
          <a:blip r:embed="rId3"/>
          <a:srcRect l="5348" r="22155" b="3666"/>
          <a:stretch/>
        </p:blipFill>
        <p:spPr>
          <a:xfrm>
            <a:off x="3981052" y="406638"/>
            <a:ext cx="3388431" cy="2377440"/>
          </a:xfrm>
          <a:prstGeom prst="rect">
            <a:avLst/>
          </a:prstGeom>
        </p:spPr>
      </p:pic>
      <p:pic>
        <p:nvPicPr>
          <p:cNvPr id="6" name="Picture 5">
            <a:extLst>
              <a:ext uri="{FF2B5EF4-FFF2-40B4-BE49-F238E27FC236}">
                <a16:creationId xmlns:a16="http://schemas.microsoft.com/office/drawing/2014/main" id="{ABE66B94-70F6-41A9-84C6-C6B0A499EABE}"/>
              </a:ext>
            </a:extLst>
          </p:cNvPr>
          <p:cNvPicPr>
            <a:picLocks noChangeAspect="1"/>
          </p:cNvPicPr>
          <p:nvPr/>
        </p:nvPicPr>
        <p:blipFill rotWithShape="1">
          <a:blip r:embed="rId4"/>
          <a:srcRect l="5134" r="22207" b="2835"/>
          <a:stretch/>
        </p:blipFill>
        <p:spPr>
          <a:xfrm>
            <a:off x="3981052" y="2946819"/>
            <a:ext cx="3392424" cy="2395427"/>
          </a:xfrm>
          <a:prstGeom prst="rect">
            <a:avLst/>
          </a:prstGeom>
        </p:spPr>
      </p:pic>
      <p:pic>
        <p:nvPicPr>
          <p:cNvPr id="7" name="Picture 6">
            <a:extLst>
              <a:ext uri="{FF2B5EF4-FFF2-40B4-BE49-F238E27FC236}">
                <a16:creationId xmlns:a16="http://schemas.microsoft.com/office/drawing/2014/main" id="{AA214282-9CD5-477A-BE0D-77BC25D7BECE}"/>
              </a:ext>
            </a:extLst>
          </p:cNvPr>
          <p:cNvPicPr>
            <a:picLocks noChangeAspect="1"/>
          </p:cNvPicPr>
          <p:nvPr/>
        </p:nvPicPr>
        <p:blipFill rotWithShape="1">
          <a:blip r:embed="rId5"/>
          <a:srcRect l="5240" t="2411" r="22323" b="3636"/>
          <a:stretch/>
        </p:blipFill>
        <p:spPr>
          <a:xfrm>
            <a:off x="294993" y="3018895"/>
            <a:ext cx="3392424" cy="2323351"/>
          </a:xfrm>
          <a:prstGeom prst="rect">
            <a:avLst/>
          </a:prstGeom>
        </p:spPr>
      </p:pic>
      <p:sp>
        <p:nvSpPr>
          <p:cNvPr id="2" name="Arrow: Down 1">
            <a:extLst>
              <a:ext uri="{FF2B5EF4-FFF2-40B4-BE49-F238E27FC236}">
                <a16:creationId xmlns:a16="http://schemas.microsoft.com/office/drawing/2014/main" id="{2FB44CB3-A0A0-4D7E-8D38-ADA7107DEE8E}"/>
              </a:ext>
            </a:extLst>
          </p:cNvPr>
          <p:cNvSpPr/>
          <p:nvPr/>
        </p:nvSpPr>
        <p:spPr>
          <a:xfrm>
            <a:off x="2473546" y="2968931"/>
            <a:ext cx="152400" cy="213360"/>
          </a:xfrm>
          <a:prstGeom prst="down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Down 7">
            <a:extLst>
              <a:ext uri="{FF2B5EF4-FFF2-40B4-BE49-F238E27FC236}">
                <a16:creationId xmlns:a16="http://schemas.microsoft.com/office/drawing/2014/main" id="{AA570505-DA00-4AEC-ABA9-20E1C1A8CE94}"/>
              </a:ext>
            </a:extLst>
          </p:cNvPr>
          <p:cNvSpPr/>
          <p:nvPr/>
        </p:nvSpPr>
        <p:spPr>
          <a:xfrm>
            <a:off x="5820250" y="2982856"/>
            <a:ext cx="152400" cy="213360"/>
          </a:xfrm>
          <a:prstGeom prst="down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Arrow: Down 8">
            <a:extLst>
              <a:ext uri="{FF2B5EF4-FFF2-40B4-BE49-F238E27FC236}">
                <a16:creationId xmlns:a16="http://schemas.microsoft.com/office/drawing/2014/main" id="{54B215F5-A410-41D3-A591-3EEE11213178}"/>
              </a:ext>
            </a:extLst>
          </p:cNvPr>
          <p:cNvSpPr/>
          <p:nvPr/>
        </p:nvSpPr>
        <p:spPr>
          <a:xfrm>
            <a:off x="6180773" y="243897"/>
            <a:ext cx="152400" cy="213360"/>
          </a:xfrm>
          <a:prstGeom prst="down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0FAB3204-401C-47ED-94E8-836EC1189EC8}"/>
              </a:ext>
            </a:extLst>
          </p:cNvPr>
          <p:cNvSpPr txBox="1"/>
          <p:nvPr/>
        </p:nvSpPr>
        <p:spPr>
          <a:xfrm>
            <a:off x="294993" y="411795"/>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11" name="TextBox 10">
            <a:extLst>
              <a:ext uri="{FF2B5EF4-FFF2-40B4-BE49-F238E27FC236}">
                <a16:creationId xmlns:a16="http://schemas.microsoft.com/office/drawing/2014/main" id="{06DAB9C9-E217-4299-9D73-B775ACCE5660}"/>
              </a:ext>
            </a:extLst>
          </p:cNvPr>
          <p:cNvSpPr txBox="1"/>
          <p:nvPr/>
        </p:nvSpPr>
        <p:spPr>
          <a:xfrm>
            <a:off x="3932442" y="406638"/>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12" name="TextBox 11">
            <a:extLst>
              <a:ext uri="{FF2B5EF4-FFF2-40B4-BE49-F238E27FC236}">
                <a16:creationId xmlns:a16="http://schemas.microsoft.com/office/drawing/2014/main" id="{A9B5C35F-E419-41A8-B0F3-4DF6190CAA86}"/>
              </a:ext>
            </a:extLst>
          </p:cNvPr>
          <p:cNvSpPr txBox="1"/>
          <p:nvPr/>
        </p:nvSpPr>
        <p:spPr>
          <a:xfrm>
            <a:off x="222442" y="2946819"/>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sp>
        <p:nvSpPr>
          <p:cNvPr id="13" name="TextBox 12">
            <a:extLst>
              <a:ext uri="{FF2B5EF4-FFF2-40B4-BE49-F238E27FC236}">
                <a16:creationId xmlns:a16="http://schemas.microsoft.com/office/drawing/2014/main" id="{C5BDA3A8-799E-4B83-BFA3-ECDEA6FCEB16}"/>
              </a:ext>
            </a:extLst>
          </p:cNvPr>
          <p:cNvSpPr txBox="1"/>
          <p:nvPr/>
        </p:nvSpPr>
        <p:spPr>
          <a:xfrm>
            <a:off x="3909296" y="2949875"/>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D</a:t>
            </a:r>
          </a:p>
        </p:txBody>
      </p:sp>
      <p:sp>
        <p:nvSpPr>
          <p:cNvPr id="14" name="TextBox 13">
            <a:extLst>
              <a:ext uri="{FF2B5EF4-FFF2-40B4-BE49-F238E27FC236}">
                <a16:creationId xmlns:a16="http://schemas.microsoft.com/office/drawing/2014/main" id="{6C2A89D5-0BDF-400C-A3D8-BB827BC2040F}"/>
              </a:ext>
            </a:extLst>
          </p:cNvPr>
          <p:cNvSpPr txBox="1"/>
          <p:nvPr/>
        </p:nvSpPr>
        <p:spPr>
          <a:xfrm>
            <a:off x="457200" y="5452727"/>
            <a:ext cx="6858000" cy="553998"/>
          </a:xfrm>
          <a:prstGeom prst="rect">
            <a:avLst/>
          </a:prstGeom>
          <a:noFill/>
        </p:spPr>
        <p:txBody>
          <a:bodyPr wrap="square" lIns="0" tIns="0" rIns="0" bIns="0" rtlCol="0">
            <a:spAutoFit/>
          </a:bodyPr>
          <a:lstStyle/>
          <a:p>
            <a:pPr algn="just"/>
            <a:r>
              <a:rPr lang="en-US" sz="1200" b="1" dirty="0">
                <a:latin typeface="Times New Roman" panose="02020603050405020304" pitchFamily="18" charset="0"/>
                <a:cs typeface="Times New Roman" panose="02020603050405020304" pitchFamily="18" charset="0"/>
              </a:rPr>
              <a:t>Figure S15.  </a:t>
            </a:r>
            <a:r>
              <a:rPr lang="en-US" sz="1200" dirty="0" err="1">
                <a:latin typeface="Times New Roman" panose="02020603050405020304" pitchFamily="18" charset="0"/>
                <a:cs typeface="Times New Roman" panose="02020603050405020304" pitchFamily="18" charset="0"/>
              </a:rPr>
              <a:t>Amperometric</a:t>
            </a:r>
            <a:r>
              <a:rPr lang="en-US" sz="1200" dirty="0">
                <a:latin typeface="Times New Roman" panose="02020603050405020304" pitchFamily="18" charset="0"/>
                <a:cs typeface="Times New Roman" panose="02020603050405020304" pitchFamily="18" charset="0"/>
              </a:rPr>
              <a:t> I-t curves showing injections (</a:t>
            </a:r>
            <a:r>
              <a:rPr lang="en-US" sz="1200" b="1" dirty="0">
                <a:latin typeface="Times New Roman" panose="02020603050405020304" pitchFamily="18" charset="0"/>
                <a:cs typeface="Times New Roman" panose="02020603050405020304" pitchFamily="18" charset="0"/>
              </a:rPr>
              <a:t>black arrow</a:t>
            </a:r>
            <a:r>
              <a:rPr lang="en-US" sz="1200" dirty="0">
                <a:latin typeface="Times New Roman" panose="02020603050405020304" pitchFamily="18" charset="0"/>
                <a:cs typeface="Times New Roman" panose="02020603050405020304" pitchFamily="18" charset="0"/>
              </a:rPr>
              <a:t>) of either 10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uric acid (</a:t>
            </a:r>
            <a:r>
              <a:rPr lang="en-US" sz="1200" b="1" dirty="0">
                <a:solidFill>
                  <a:srgbClr val="0000C1"/>
                </a:solidFill>
                <a:latin typeface="Times New Roman" panose="02020603050405020304" pitchFamily="18" charset="0"/>
                <a:cs typeface="Times New Roman" panose="02020603050405020304" pitchFamily="18" charset="0"/>
              </a:rPr>
              <a:t>blue</a:t>
            </a:r>
            <a:r>
              <a:rPr lang="en-US" sz="1200" dirty="0">
                <a:latin typeface="Times New Roman" panose="02020603050405020304" pitchFamily="18" charset="0"/>
                <a:cs typeface="Times New Roman" panose="02020603050405020304" pitchFamily="18" charset="0"/>
              </a:rPr>
              <a:t>) or 10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H</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O</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a:t>
            </a:r>
            <a:r>
              <a:rPr lang="en-US" sz="1200" b="1" dirty="0">
                <a:solidFill>
                  <a:srgbClr val="FF0000"/>
                </a:solidFill>
                <a:latin typeface="Times New Roman" panose="02020603050405020304" pitchFamily="18" charset="0"/>
                <a:cs typeface="Times New Roman" panose="02020603050405020304" pitchFamily="18" charset="0"/>
              </a:rPr>
              <a:t>red</a:t>
            </a:r>
            <a:r>
              <a:rPr lang="en-US" sz="1200" dirty="0">
                <a:latin typeface="Times New Roman" panose="02020603050405020304" pitchFamily="18" charset="0"/>
                <a:cs typeface="Times New Roman" panose="02020603050405020304" pitchFamily="18" charset="0"/>
              </a:rPr>
              <a:t>) at a bare Pt electrode being held at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0.65 V,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0.5 V,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0.4 V, or </a:t>
            </a:r>
            <a:r>
              <a:rPr lang="en-US" sz="1200" b="1" dirty="0">
                <a:latin typeface="Times New Roman" panose="02020603050405020304" pitchFamily="18" charset="0"/>
                <a:cs typeface="Times New Roman" panose="02020603050405020304" pitchFamily="18" charset="0"/>
              </a:rPr>
              <a:t>(D)</a:t>
            </a:r>
            <a:r>
              <a:rPr lang="en-US" sz="1200" dirty="0">
                <a:latin typeface="Times New Roman" panose="02020603050405020304" pitchFamily="18" charset="0"/>
                <a:cs typeface="Times New Roman" panose="02020603050405020304" pitchFamily="18" charset="0"/>
              </a:rPr>
              <a:t> +0.35 V versus the Ag/AgCl (</a:t>
            </a:r>
            <a:r>
              <a:rPr lang="en-US" sz="1200" dirty="0" err="1">
                <a:latin typeface="Times New Roman" panose="02020603050405020304" pitchFamily="18" charset="0"/>
                <a:cs typeface="Times New Roman" panose="02020603050405020304" pitchFamily="18" charset="0"/>
              </a:rPr>
              <a:t>satrd</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KCl</a:t>
            </a:r>
            <a:r>
              <a:rPr lang="en-US" sz="1200" dirty="0">
                <a:latin typeface="Times New Roman" panose="02020603050405020304" pitchFamily="18" charset="0"/>
                <a:cs typeface="Times New Roman" panose="02020603050405020304" pitchFamily="18" charset="0"/>
              </a:rPr>
              <a:t>) reference electrode.   </a:t>
            </a:r>
            <a:r>
              <a:rPr lang="en-US" sz="1200" b="1" dirty="0">
                <a:latin typeface="Times New Roman" panose="02020603050405020304" pitchFamily="18" charset="0"/>
                <a:cs typeface="Times New Roman" panose="02020603050405020304" pitchFamily="18" charset="0"/>
              </a:rPr>
              <a:t> </a:t>
            </a:r>
          </a:p>
        </p:txBody>
      </p:sp>
      <p:sp>
        <p:nvSpPr>
          <p:cNvPr id="18" name="TextBox 17">
            <a:extLst>
              <a:ext uri="{FF2B5EF4-FFF2-40B4-BE49-F238E27FC236}">
                <a16:creationId xmlns:a16="http://schemas.microsoft.com/office/drawing/2014/main" id="{235487F1-E598-4D6C-BC4B-35CAAEE3F77B}"/>
              </a:ext>
            </a:extLst>
          </p:cNvPr>
          <p:cNvSpPr txBox="1"/>
          <p:nvPr/>
        </p:nvSpPr>
        <p:spPr>
          <a:xfrm>
            <a:off x="962409" y="621526"/>
            <a:ext cx="940322" cy="369332"/>
          </a:xfrm>
          <a:prstGeom prst="rect">
            <a:avLst/>
          </a:prstGeom>
          <a:noFill/>
        </p:spPr>
        <p:txBody>
          <a:bodyPr wrap="none" rtlCol="0">
            <a:spAutoFit/>
          </a:bodyPr>
          <a:lstStyle/>
          <a:p>
            <a:pPr>
              <a:spcAft>
                <a:spcPts val="800"/>
              </a:spcAft>
            </a:pPr>
            <a:r>
              <a:rPr lang="en-US" b="1" dirty="0">
                <a:latin typeface="Times New Roman" panose="02020603050405020304" pitchFamily="18" charset="0"/>
                <a:cs typeface="Times New Roman" panose="02020603050405020304" pitchFamily="18" charset="0"/>
              </a:rPr>
              <a:t>+0.65 V</a:t>
            </a:r>
          </a:p>
        </p:txBody>
      </p:sp>
      <p:sp>
        <p:nvSpPr>
          <p:cNvPr id="19" name="TextBox 18">
            <a:extLst>
              <a:ext uri="{FF2B5EF4-FFF2-40B4-BE49-F238E27FC236}">
                <a16:creationId xmlns:a16="http://schemas.microsoft.com/office/drawing/2014/main" id="{72BE04E6-482D-4BED-896D-2DD6583DB51D}"/>
              </a:ext>
            </a:extLst>
          </p:cNvPr>
          <p:cNvSpPr txBox="1"/>
          <p:nvPr/>
        </p:nvSpPr>
        <p:spPr>
          <a:xfrm>
            <a:off x="4466256" y="553204"/>
            <a:ext cx="824906" cy="369332"/>
          </a:xfrm>
          <a:prstGeom prst="rect">
            <a:avLst/>
          </a:prstGeom>
          <a:noFill/>
        </p:spPr>
        <p:txBody>
          <a:bodyPr wrap="none" rtlCol="0">
            <a:spAutoFit/>
          </a:bodyPr>
          <a:lstStyle/>
          <a:p>
            <a:pPr>
              <a:spcAft>
                <a:spcPts val="800"/>
              </a:spcAft>
            </a:pPr>
            <a:r>
              <a:rPr lang="en-US" b="1" dirty="0">
                <a:latin typeface="Times New Roman" panose="02020603050405020304" pitchFamily="18" charset="0"/>
                <a:cs typeface="Times New Roman" panose="02020603050405020304" pitchFamily="18" charset="0"/>
              </a:rPr>
              <a:t>+0.5 V</a:t>
            </a:r>
          </a:p>
        </p:txBody>
      </p:sp>
      <p:sp>
        <p:nvSpPr>
          <p:cNvPr id="20" name="TextBox 19">
            <a:extLst>
              <a:ext uri="{FF2B5EF4-FFF2-40B4-BE49-F238E27FC236}">
                <a16:creationId xmlns:a16="http://schemas.microsoft.com/office/drawing/2014/main" id="{91C94176-305A-4295-9DCE-FED15685641E}"/>
              </a:ext>
            </a:extLst>
          </p:cNvPr>
          <p:cNvSpPr txBox="1"/>
          <p:nvPr/>
        </p:nvSpPr>
        <p:spPr>
          <a:xfrm>
            <a:off x="778176" y="3281164"/>
            <a:ext cx="824906" cy="369332"/>
          </a:xfrm>
          <a:prstGeom prst="rect">
            <a:avLst/>
          </a:prstGeom>
          <a:noFill/>
        </p:spPr>
        <p:txBody>
          <a:bodyPr wrap="none" rtlCol="0">
            <a:spAutoFit/>
          </a:bodyPr>
          <a:lstStyle/>
          <a:p>
            <a:pPr>
              <a:spcAft>
                <a:spcPts val="800"/>
              </a:spcAft>
            </a:pPr>
            <a:r>
              <a:rPr lang="en-US" b="1" dirty="0">
                <a:latin typeface="Times New Roman" panose="02020603050405020304" pitchFamily="18" charset="0"/>
                <a:cs typeface="Times New Roman" panose="02020603050405020304" pitchFamily="18" charset="0"/>
              </a:rPr>
              <a:t>+0.4 V</a:t>
            </a:r>
          </a:p>
        </p:txBody>
      </p:sp>
      <p:sp>
        <p:nvSpPr>
          <p:cNvPr id="21" name="TextBox 20">
            <a:extLst>
              <a:ext uri="{FF2B5EF4-FFF2-40B4-BE49-F238E27FC236}">
                <a16:creationId xmlns:a16="http://schemas.microsoft.com/office/drawing/2014/main" id="{4633E227-AEC1-41C6-8BC4-7D48AE6EE653}"/>
              </a:ext>
            </a:extLst>
          </p:cNvPr>
          <p:cNvSpPr txBox="1"/>
          <p:nvPr/>
        </p:nvSpPr>
        <p:spPr>
          <a:xfrm>
            <a:off x="4466256" y="3225622"/>
            <a:ext cx="940322" cy="369332"/>
          </a:xfrm>
          <a:prstGeom prst="rect">
            <a:avLst/>
          </a:prstGeom>
          <a:noFill/>
        </p:spPr>
        <p:txBody>
          <a:bodyPr wrap="none" rtlCol="0">
            <a:spAutoFit/>
          </a:bodyPr>
          <a:lstStyle/>
          <a:p>
            <a:pPr>
              <a:spcAft>
                <a:spcPts val="800"/>
              </a:spcAft>
            </a:pPr>
            <a:r>
              <a:rPr lang="en-US" b="1" dirty="0">
                <a:latin typeface="Times New Roman" panose="02020603050405020304" pitchFamily="18" charset="0"/>
                <a:cs typeface="Times New Roman" panose="02020603050405020304" pitchFamily="18" charset="0"/>
              </a:rPr>
              <a:t>+0.35 V</a:t>
            </a:r>
          </a:p>
        </p:txBody>
      </p:sp>
    </p:spTree>
    <p:extLst>
      <p:ext uri="{BB962C8B-B14F-4D97-AF65-F5344CB8AC3E}">
        <p14:creationId xmlns:p14="http://schemas.microsoft.com/office/powerpoint/2010/main" val="288353029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166DE082-BAA1-445B-9111-B527FD6FC50F}"/>
              </a:ext>
            </a:extLst>
          </p:cNvPr>
          <p:cNvSpPr>
            <a:spLocks noGrp="1"/>
          </p:cNvSpPr>
          <p:nvPr>
            <p:ph type="sldNum" sz="quarter" idx="12"/>
          </p:nvPr>
        </p:nvSpPr>
        <p:spPr/>
        <p:txBody>
          <a:bodyPr/>
          <a:lstStyle/>
          <a:p>
            <a:r>
              <a:rPr lang="en-US"/>
              <a:t>S</a:t>
            </a:r>
            <a:fld id="{0DD34403-E6AF-9B44-8A22-D75A397E6552}" type="slidenum">
              <a:rPr lang="en-US" smtClean="0"/>
              <a:pPr/>
              <a:t>17</a:t>
            </a:fld>
            <a:endParaRPr lang="en-US"/>
          </a:p>
        </p:txBody>
      </p:sp>
      <p:pic>
        <p:nvPicPr>
          <p:cNvPr id="4" name="Picture 3">
            <a:extLst>
              <a:ext uri="{FF2B5EF4-FFF2-40B4-BE49-F238E27FC236}">
                <a16:creationId xmlns:a16="http://schemas.microsoft.com/office/drawing/2014/main" id="{91FEC151-06ED-45F4-A5A3-413A55E1A076}"/>
              </a:ext>
            </a:extLst>
          </p:cNvPr>
          <p:cNvPicPr>
            <a:picLocks noChangeAspect="1"/>
          </p:cNvPicPr>
          <p:nvPr/>
        </p:nvPicPr>
        <p:blipFill rotWithShape="1">
          <a:blip r:embed="rId2"/>
          <a:srcRect r="23431"/>
          <a:stretch/>
        </p:blipFill>
        <p:spPr>
          <a:xfrm>
            <a:off x="765749" y="55454"/>
            <a:ext cx="6240901" cy="4354634"/>
          </a:xfrm>
          <a:prstGeom prst="rect">
            <a:avLst/>
          </a:prstGeom>
        </p:spPr>
      </p:pic>
      <p:sp>
        <p:nvSpPr>
          <p:cNvPr id="5" name="TextBox 4">
            <a:extLst>
              <a:ext uri="{FF2B5EF4-FFF2-40B4-BE49-F238E27FC236}">
                <a16:creationId xmlns:a16="http://schemas.microsoft.com/office/drawing/2014/main" id="{0E99018A-7931-44BF-A286-17A5254ED662}"/>
              </a:ext>
            </a:extLst>
          </p:cNvPr>
          <p:cNvSpPr txBox="1"/>
          <p:nvPr/>
        </p:nvSpPr>
        <p:spPr>
          <a:xfrm>
            <a:off x="457200" y="4536396"/>
            <a:ext cx="6858000" cy="553998"/>
          </a:xfrm>
          <a:prstGeom prst="rect">
            <a:avLst/>
          </a:prstGeom>
          <a:noFill/>
        </p:spPr>
        <p:txBody>
          <a:bodyPr wrap="square" lIns="0" tIns="0" rIns="0" bIns="0" rtlCol="0">
            <a:spAutoFit/>
          </a:bodyPr>
          <a:lstStyle/>
          <a:p>
            <a:r>
              <a:rPr lang="en-US" sz="1200" b="1" dirty="0">
                <a:latin typeface="Times New Roman" panose="02020603050405020304" pitchFamily="18" charset="0"/>
                <a:cs typeface="Times New Roman" panose="02020603050405020304" pitchFamily="18" charset="0"/>
              </a:rPr>
              <a:t>Figure S16. </a:t>
            </a:r>
            <a:r>
              <a:rPr lang="en-US" sz="1200" dirty="0">
                <a:latin typeface="Times New Roman" panose="02020603050405020304" pitchFamily="18" charset="0"/>
                <a:cs typeface="Times New Roman" panose="02020603050405020304" pitchFamily="18" charset="0"/>
              </a:rPr>
              <a:t>Relative comparison of </a:t>
            </a:r>
            <a:r>
              <a:rPr lang="en-US" sz="1200" dirty="0" err="1">
                <a:latin typeface="Times New Roman" panose="02020603050405020304" pitchFamily="18" charset="0"/>
                <a:cs typeface="Times New Roman" panose="02020603050405020304" pitchFamily="18" charset="0"/>
              </a:rPr>
              <a:t>amperometric</a:t>
            </a:r>
            <a:r>
              <a:rPr lang="en-US" sz="1200" dirty="0">
                <a:latin typeface="Times New Roman" panose="02020603050405020304" pitchFamily="18" charset="0"/>
                <a:cs typeface="Times New Roman" panose="02020603050405020304" pitchFamily="18" charset="0"/>
              </a:rPr>
              <a:t> I-t curves with injections of 10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uric acid and 100 </a:t>
            </a:r>
            <a:r>
              <a:rPr lang="el-GR" sz="1200" dirty="0">
                <a:latin typeface="Times New Roman" panose="02020603050405020304" pitchFamily="18" charset="0"/>
                <a:cs typeface="Times New Roman" panose="02020603050405020304" pitchFamily="18" charset="0"/>
              </a:rPr>
              <a:t>μ</a:t>
            </a:r>
            <a:r>
              <a:rPr lang="en-US" sz="1200" dirty="0">
                <a:latin typeface="Times New Roman" panose="02020603050405020304" pitchFamily="18" charset="0"/>
                <a:cs typeface="Times New Roman" panose="02020603050405020304" pitchFamily="18" charset="0"/>
              </a:rPr>
              <a:t>M H</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O</a:t>
            </a:r>
            <a:r>
              <a:rPr lang="en-US" sz="1200" baseline="-25000" dirty="0">
                <a:latin typeface="Times New Roman" panose="02020603050405020304" pitchFamily="18" charset="0"/>
                <a:cs typeface="Times New Roman" panose="02020603050405020304" pitchFamily="18" charset="0"/>
              </a:rPr>
              <a:t>2 </a:t>
            </a:r>
            <a:r>
              <a:rPr lang="en-US" sz="1200" dirty="0">
                <a:latin typeface="Times New Roman" panose="02020603050405020304" pitchFamily="18" charset="0"/>
                <a:cs typeface="Times New Roman" panose="02020603050405020304" pitchFamily="18" charset="0"/>
              </a:rPr>
              <a:t> with bare platinum electrode held at different potentials versus the Ag/AgCl (</a:t>
            </a:r>
            <a:r>
              <a:rPr lang="en-US" sz="1200" dirty="0" err="1">
                <a:latin typeface="Times New Roman" panose="02020603050405020304" pitchFamily="18" charset="0"/>
                <a:cs typeface="Times New Roman" panose="02020603050405020304" pitchFamily="18" charset="0"/>
              </a:rPr>
              <a:t>satrd</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KCl</a:t>
            </a:r>
            <a:r>
              <a:rPr lang="en-US" sz="1200" dirty="0">
                <a:latin typeface="Times New Roman" panose="02020603050405020304" pitchFamily="18" charset="0"/>
                <a:cs typeface="Times New Roman" panose="02020603050405020304" pitchFamily="18" charset="0"/>
              </a:rPr>
              <a:t>) reference electrode. </a:t>
            </a:r>
            <a:endParaRPr lang="en-US" sz="1200" b="1" dirty="0">
              <a:latin typeface="Times New Roman" panose="02020603050405020304" pitchFamily="18" charset="0"/>
              <a:cs typeface="Times New Roman" panose="02020603050405020304" pitchFamily="18" charset="0"/>
            </a:endParaRPr>
          </a:p>
        </p:txBody>
      </p:sp>
      <p:graphicFrame>
        <p:nvGraphicFramePr>
          <p:cNvPr id="7" name="Table 6">
            <a:extLst>
              <a:ext uri="{FF2B5EF4-FFF2-40B4-BE49-F238E27FC236}">
                <a16:creationId xmlns:a16="http://schemas.microsoft.com/office/drawing/2014/main" id="{254FA955-67E0-49D4-B56F-FB96B3547FD8}"/>
              </a:ext>
            </a:extLst>
          </p:cNvPr>
          <p:cNvGraphicFramePr>
            <a:graphicFrameLocks noGrp="1"/>
          </p:cNvGraphicFramePr>
          <p:nvPr>
            <p:extLst>
              <p:ext uri="{D42A27DB-BD31-4B8C-83A1-F6EECF244321}">
                <p14:modId xmlns:p14="http://schemas.microsoft.com/office/powerpoint/2010/main" val="2893820"/>
              </p:ext>
            </p:extLst>
          </p:nvPr>
        </p:nvGraphicFramePr>
        <p:xfrm>
          <a:off x="457200" y="6171552"/>
          <a:ext cx="6858000" cy="1885273"/>
        </p:xfrm>
        <a:graphic>
          <a:graphicData uri="http://schemas.openxmlformats.org/drawingml/2006/table">
            <a:tbl>
              <a:tblPr firstRow="1" firstCol="1" bandRow="1"/>
              <a:tblGrid>
                <a:gridCol w="1068245">
                  <a:extLst>
                    <a:ext uri="{9D8B030D-6E8A-4147-A177-3AD203B41FA5}">
                      <a16:colId xmlns:a16="http://schemas.microsoft.com/office/drawing/2014/main" val="392907118"/>
                    </a:ext>
                  </a:extLst>
                </a:gridCol>
                <a:gridCol w="2038292">
                  <a:extLst>
                    <a:ext uri="{9D8B030D-6E8A-4147-A177-3AD203B41FA5}">
                      <a16:colId xmlns:a16="http://schemas.microsoft.com/office/drawing/2014/main" val="3821702917"/>
                    </a:ext>
                  </a:extLst>
                </a:gridCol>
                <a:gridCol w="2182669">
                  <a:extLst>
                    <a:ext uri="{9D8B030D-6E8A-4147-A177-3AD203B41FA5}">
                      <a16:colId xmlns:a16="http://schemas.microsoft.com/office/drawing/2014/main" val="615640076"/>
                    </a:ext>
                  </a:extLst>
                </a:gridCol>
                <a:gridCol w="1568794">
                  <a:extLst>
                    <a:ext uri="{9D8B030D-6E8A-4147-A177-3AD203B41FA5}">
                      <a16:colId xmlns:a16="http://schemas.microsoft.com/office/drawing/2014/main" val="48682649"/>
                    </a:ext>
                  </a:extLst>
                </a:gridCol>
              </a:tblGrid>
              <a:tr h="540165">
                <a:tc>
                  <a:txBody>
                    <a:bodyPr/>
                    <a:lstStyle/>
                    <a:p>
                      <a:pPr marL="0" marR="0" algn="ctr">
                        <a:lnSpc>
                          <a:spcPct val="115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otential</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solidFill>
                      <a:srgbClr val="D9D9D9"/>
                    </a:solidFill>
                  </a:tcPr>
                </a:tc>
                <a:tc>
                  <a:txBody>
                    <a:bodyPr/>
                    <a:lstStyle/>
                    <a:p>
                      <a:pPr marL="0" marR="0" algn="ctr">
                        <a:lnSpc>
                          <a:spcPct val="115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sponse of H</a:t>
                      </a:r>
                      <a:r>
                        <a:rPr lang="en-US" sz="1400" baseline="-25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2</a:t>
                      </a:r>
                      <a:r>
                        <a:rPr lang="en-US" sz="1400" baseline="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O</a:t>
                      </a:r>
                      <a:r>
                        <a:rPr lang="en-US" sz="1400" baseline="-25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2</a:t>
                      </a:r>
                      <a:r>
                        <a:rPr lang="en-US" sz="1400" baseline="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p>
                    <a:p>
                      <a:pPr marL="0" marR="0" algn="ctr">
                        <a:lnSpc>
                          <a:spcPct val="115000"/>
                        </a:lnSpc>
                        <a:spcBef>
                          <a:spcPts val="0"/>
                        </a:spcBef>
                        <a:spcAft>
                          <a:spcPts val="0"/>
                        </a:spcAft>
                      </a:pPr>
                      <a:r>
                        <a:rPr lang="en-US" sz="1400" baseline="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400" dirty="0">
                          <a:latin typeface="Times New Roman" panose="02020603050405020304" pitchFamily="18" charset="0"/>
                          <a:cs typeface="Times New Roman" panose="02020603050405020304" pitchFamily="18" charset="0"/>
                        </a:rPr>
                        <a:t>µA)</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solidFill>
                      <a:srgbClr val="D9D9D9"/>
                    </a:solidFill>
                  </a:tcPr>
                </a:tc>
                <a:tc>
                  <a:txBody>
                    <a:bodyPr/>
                    <a:lstStyle/>
                    <a:p>
                      <a:pPr marL="0" marR="0" algn="ctr">
                        <a:lnSpc>
                          <a:spcPct val="115000"/>
                        </a:lnSpc>
                        <a:spcBef>
                          <a:spcPts val="0"/>
                        </a:spcBef>
                        <a:spcAft>
                          <a:spcPts val="0"/>
                        </a:spcAft>
                      </a:pPr>
                      <a:r>
                        <a:rPr lang="en-US" sz="14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sponse of Uric Acid</a:t>
                      </a:r>
                      <a:r>
                        <a:rPr lang="en-US" sz="1400" baseline="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p>
                    <a:p>
                      <a:pPr marL="0" marR="0" algn="ctr">
                        <a:lnSpc>
                          <a:spcPct val="115000"/>
                        </a:lnSpc>
                        <a:spcBef>
                          <a:spcPts val="0"/>
                        </a:spcBef>
                        <a:spcAft>
                          <a:spcPts val="0"/>
                        </a:spcAft>
                      </a:pPr>
                      <a:r>
                        <a:rPr lang="en-US" sz="1400" baseline="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400" dirty="0">
                          <a:latin typeface="Times New Roman" panose="02020603050405020304" pitchFamily="18" charset="0"/>
                          <a:cs typeface="Times New Roman" panose="02020603050405020304" pitchFamily="18" charset="0"/>
                        </a:rPr>
                        <a:t>µA)</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solidFill>
                      <a:srgbClr val="D9D9D9"/>
                    </a:solidFill>
                  </a:tcPr>
                </a:tc>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H</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400" baseline="0" dirty="0">
                          <a:effectLst/>
                          <a:latin typeface="Times New Roman" panose="02020603050405020304" pitchFamily="18" charset="0"/>
                          <a:ea typeface="Calibri" panose="020F0502020204030204" pitchFamily="34" charset="0"/>
                          <a:cs typeface="Times New Roman" panose="02020603050405020304" pitchFamily="18" charset="0"/>
                        </a:rPr>
                        <a:t>O</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400" baseline="0" dirty="0">
                          <a:effectLst/>
                          <a:latin typeface="Times New Roman" panose="02020603050405020304" pitchFamily="18" charset="0"/>
                          <a:ea typeface="Calibri" panose="020F0502020204030204" pitchFamily="34" charset="0"/>
                          <a:cs typeface="Times New Roman" panose="02020603050405020304" pitchFamily="18" charset="0"/>
                        </a:rPr>
                        <a:t>/Uric Acid </a:t>
                      </a:r>
                    </a:p>
                    <a:p>
                      <a:pPr marL="0" marR="0" algn="ctr">
                        <a:lnSpc>
                          <a:spcPct val="115000"/>
                        </a:lnSpc>
                        <a:spcBef>
                          <a:spcPts val="0"/>
                        </a:spcBef>
                        <a:spcAft>
                          <a:spcPts val="0"/>
                        </a:spcAft>
                      </a:pPr>
                      <a:r>
                        <a:rPr lang="en-US" sz="1400" baseline="0" dirty="0">
                          <a:effectLst/>
                          <a:latin typeface="Times New Roman" panose="02020603050405020304" pitchFamily="18" charset="0"/>
                          <a:ea typeface="Calibri" panose="020F0502020204030204" pitchFamily="34" charset="0"/>
                          <a:cs typeface="Times New Roman" panose="02020603050405020304" pitchFamily="18" charset="0"/>
                        </a:rPr>
                        <a:t>Signal Ratio</a:t>
                      </a:r>
                      <a:endParaRPr lang="en-US" sz="14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solidFill>
                      <a:srgbClr val="D9D9D9"/>
                    </a:solidFill>
                  </a:tcPr>
                </a:tc>
                <a:extLst>
                  <a:ext uri="{0D108BD9-81ED-4DB2-BD59-A6C34878D82A}">
                    <a16:rowId xmlns:a16="http://schemas.microsoft.com/office/drawing/2014/main" val="547844057"/>
                  </a:ext>
                </a:extLst>
              </a:tr>
              <a:tr h="336277">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0.65V</a:t>
                      </a:r>
                    </a:p>
                  </a:txBody>
                  <a:tcPr marL="68580" marR="68580" marT="0" marB="0" anchor="ctr">
                    <a:lnL>
                      <a:noFill/>
                    </a:lnL>
                    <a:lnR>
                      <a:noFill/>
                    </a:lnR>
                    <a:lnT>
                      <a:noFill/>
                    </a:lnT>
                    <a:lnB>
                      <a:noFill/>
                    </a:lnB>
                  </a:tcPr>
                </a:tc>
                <a:tc>
                  <a:txBody>
                    <a:bodyPr/>
                    <a:lstStyle/>
                    <a:p>
                      <a:pPr marL="0" marR="0" lvl="0" indent="0" algn="ctr" defTabSz="777240" rtl="0" eaLnBrk="1" fontAlgn="auto" latinLnBrk="0" hangingPunct="1">
                        <a:lnSpc>
                          <a:spcPct val="115000"/>
                        </a:lnSpc>
                        <a:spcBef>
                          <a:spcPts val="0"/>
                        </a:spcBef>
                        <a:spcAft>
                          <a:spcPts val="0"/>
                        </a:spcAft>
                        <a:buClrTx/>
                        <a:buSzTx/>
                        <a:buFontTx/>
                        <a:buNone/>
                        <a:tabLst/>
                        <a:defRPr/>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3.84 </a:t>
                      </a:r>
                      <a:r>
                        <a:rPr lang="en-US" sz="1530" kern="1200" dirty="0">
                          <a:solidFill>
                            <a:schemeClr val="tx1"/>
                          </a:solidFill>
                          <a:effectLst/>
                          <a:latin typeface="+mn-lt"/>
                          <a:ea typeface="+mn-ea"/>
                          <a:cs typeface="+mn-cs"/>
                        </a:rPr>
                        <a:t>±</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0.22</a:t>
                      </a:r>
                    </a:p>
                  </a:txBody>
                  <a:tcPr marL="68580" marR="68580" marT="0" marB="0" anchor="ctr">
                    <a:lnL>
                      <a:noFill/>
                    </a:lnL>
                    <a:lnR>
                      <a:noFill/>
                    </a:lnR>
                    <a:lnT>
                      <a:noFill/>
                    </a:lnT>
                    <a:lnB>
                      <a:noFill/>
                    </a:lnB>
                  </a:tcPr>
                </a:tc>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2.09 </a:t>
                      </a:r>
                      <a:r>
                        <a:rPr lang="en-US" sz="1400" kern="1200" dirty="0">
                          <a:solidFill>
                            <a:schemeClr val="tx1"/>
                          </a:solidFill>
                          <a:effectLst/>
                          <a:latin typeface="+mn-lt"/>
                          <a:ea typeface="+mn-ea"/>
                          <a:cs typeface="+mn-cs"/>
                        </a:rPr>
                        <a:t>±</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0.016</a:t>
                      </a:r>
                    </a:p>
                  </a:txBody>
                  <a:tcPr marL="68580" marR="68580" marT="0" marB="0" anchor="ctr">
                    <a:lnL>
                      <a:noFill/>
                    </a:lnL>
                    <a:lnR>
                      <a:noFill/>
                    </a:lnR>
                    <a:lnT>
                      <a:noFill/>
                    </a:lnT>
                    <a:lnB>
                      <a:noFill/>
                    </a:lnB>
                  </a:tcPr>
                </a:tc>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1.84</a:t>
                      </a:r>
                    </a:p>
                  </a:txBody>
                  <a:tcPr marL="68580" marR="68580" marT="0" marB="0" anchor="ctr">
                    <a:lnL>
                      <a:noFill/>
                    </a:lnL>
                    <a:lnR>
                      <a:noFill/>
                    </a:lnR>
                    <a:lnT>
                      <a:noFill/>
                    </a:lnT>
                    <a:lnB>
                      <a:noFill/>
                    </a:lnB>
                  </a:tcPr>
                </a:tc>
                <a:extLst>
                  <a:ext uri="{0D108BD9-81ED-4DB2-BD59-A6C34878D82A}">
                    <a16:rowId xmlns:a16="http://schemas.microsoft.com/office/drawing/2014/main" val="1460609730"/>
                  </a:ext>
                </a:extLst>
              </a:tr>
              <a:tr h="336277">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0.5V</a:t>
                      </a:r>
                    </a:p>
                  </a:txBody>
                  <a:tcPr marL="68580" marR="68580" marT="0" marB="0" anchor="ctr">
                    <a:lnL>
                      <a:noFill/>
                    </a:lnL>
                    <a:lnR>
                      <a:noFill/>
                    </a:lnR>
                    <a:lnT>
                      <a:noFill/>
                    </a:lnT>
                    <a:lnB>
                      <a:noFill/>
                    </a:lnB>
                  </a:tcPr>
                </a:tc>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3.93 </a:t>
                      </a:r>
                      <a:r>
                        <a:rPr lang="en-US" sz="1400" kern="1200" dirty="0">
                          <a:solidFill>
                            <a:schemeClr val="tx1"/>
                          </a:solidFill>
                          <a:effectLst/>
                          <a:latin typeface="+mn-lt"/>
                          <a:ea typeface="+mn-ea"/>
                          <a:cs typeface="+mn-cs"/>
                        </a:rPr>
                        <a:t>±</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0.23</a:t>
                      </a:r>
                    </a:p>
                  </a:txBody>
                  <a:tcPr marL="68580" marR="68580" marT="0" marB="0" anchor="ctr">
                    <a:lnL>
                      <a:noFill/>
                    </a:lnL>
                    <a:lnR>
                      <a:noFill/>
                    </a:lnR>
                    <a:lnT>
                      <a:noFill/>
                    </a:lnT>
                    <a:lnB>
                      <a:noFill/>
                    </a:lnB>
                  </a:tcPr>
                </a:tc>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1.31 </a:t>
                      </a:r>
                      <a:r>
                        <a:rPr lang="en-US" sz="1400" kern="1200" dirty="0">
                          <a:solidFill>
                            <a:schemeClr val="tx1"/>
                          </a:solidFill>
                          <a:effectLst/>
                          <a:latin typeface="+mn-lt"/>
                          <a:ea typeface="+mn-ea"/>
                          <a:cs typeface="+mn-cs"/>
                        </a:rPr>
                        <a:t>±</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0.015</a:t>
                      </a:r>
                    </a:p>
                  </a:txBody>
                  <a:tcPr marL="68580" marR="68580" marT="0" marB="0" anchor="ctr">
                    <a:lnL>
                      <a:noFill/>
                    </a:lnL>
                    <a:lnR>
                      <a:noFill/>
                    </a:lnR>
                    <a:lnT>
                      <a:noFill/>
                    </a:lnT>
                    <a:lnB>
                      <a:noFill/>
                    </a:lnB>
                  </a:tcPr>
                </a:tc>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3.00</a:t>
                      </a:r>
                    </a:p>
                  </a:txBody>
                  <a:tcPr marL="68580" marR="68580" marT="0" marB="0" anchor="ctr">
                    <a:lnL>
                      <a:noFill/>
                    </a:lnL>
                    <a:lnR>
                      <a:noFill/>
                    </a:lnR>
                    <a:lnT>
                      <a:noFill/>
                    </a:lnT>
                    <a:lnB>
                      <a:noFill/>
                    </a:lnB>
                  </a:tcPr>
                </a:tc>
                <a:extLst>
                  <a:ext uri="{0D108BD9-81ED-4DB2-BD59-A6C34878D82A}">
                    <a16:rowId xmlns:a16="http://schemas.microsoft.com/office/drawing/2014/main" val="3945879710"/>
                  </a:ext>
                </a:extLst>
              </a:tr>
              <a:tr h="336277">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0.4V </a:t>
                      </a:r>
                    </a:p>
                  </a:txBody>
                  <a:tcPr marL="68580" marR="68580" marT="0" marB="0" anchor="ctr">
                    <a:lnL>
                      <a:noFill/>
                    </a:lnL>
                    <a:lnR>
                      <a:noFill/>
                    </a:lnR>
                    <a:lnT>
                      <a:noFill/>
                    </a:lnT>
                    <a:lnB>
                      <a:noFill/>
                    </a:lnB>
                  </a:tcPr>
                </a:tc>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3.22 </a:t>
                      </a:r>
                      <a:r>
                        <a:rPr lang="en-US" sz="1400" kern="1200" dirty="0">
                          <a:solidFill>
                            <a:schemeClr val="tx1"/>
                          </a:solidFill>
                          <a:effectLst/>
                          <a:latin typeface="+mn-lt"/>
                          <a:ea typeface="+mn-ea"/>
                          <a:cs typeface="+mn-cs"/>
                        </a:rPr>
                        <a:t>±</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0.24</a:t>
                      </a:r>
                    </a:p>
                  </a:txBody>
                  <a:tcPr marL="68580" marR="68580" marT="0" marB="0" anchor="ctr">
                    <a:lnL>
                      <a:noFill/>
                    </a:lnL>
                    <a:lnR>
                      <a:noFill/>
                    </a:lnR>
                    <a:lnT>
                      <a:noFill/>
                    </a:lnT>
                    <a:lnB>
                      <a:noFill/>
                    </a:lnB>
                  </a:tcPr>
                </a:tc>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0.16 </a:t>
                      </a:r>
                      <a:r>
                        <a:rPr lang="en-US" sz="1400" kern="1200" dirty="0">
                          <a:solidFill>
                            <a:schemeClr val="tx1"/>
                          </a:solidFill>
                          <a:effectLst/>
                          <a:latin typeface="+mn-lt"/>
                          <a:ea typeface="+mn-ea"/>
                          <a:cs typeface="+mn-cs"/>
                        </a:rPr>
                        <a:t>±</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0.018</a:t>
                      </a:r>
                    </a:p>
                  </a:txBody>
                  <a:tcPr marL="68580" marR="68580" marT="0" marB="0" anchor="ctr">
                    <a:lnL>
                      <a:noFill/>
                    </a:lnL>
                    <a:lnR>
                      <a:noFill/>
                    </a:lnR>
                    <a:lnT>
                      <a:noFill/>
                    </a:lnT>
                    <a:lnB>
                      <a:noFill/>
                    </a:lnB>
                  </a:tcPr>
                </a:tc>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20.1</a:t>
                      </a:r>
                    </a:p>
                  </a:txBody>
                  <a:tcPr marL="68580" marR="68580" marT="0" marB="0" anchor="ctr">
                    <a:lnL>
                      <a:noFill/>
                    </a:lnL>
                    <a:lnR>
                      <a:noFill/>
                    </a:lnR>
                    <a:lnT>
                      <a:noFill/>
                    </a:lnT>
                    <a:lnB>
                      <a:noFill/>
                    </a:lnB>
                  </a:tcPr>
                </a:tc>
                <a:extLst>
                  <a:ext uri="{0D108BD9-81ED-4DB2-BD59-A6C34878D82A}">
                    <a16:rowId xmlns:a16="http://schemas.microsoft.com/office/drawing/2014/main" val="1717429637"/>
                  </a:ext>
                </a:extLst>
              </a:tr>
              <a:tr h="336277">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0.35V </a:t>
                      </a:r>
                    </a:p>
                  </a:txBody>
                  <a:tcPr marL="68580" marR="68580" marT="0" marB="0" anchor="ctr">
                    <a:lnL>
                      <a:noFill/>
                    </a:lnL>
                    <a:lnR>
                      <a:noFill/>
                    </a:lnR>
                    <a:lnT>
                      <a:noFill/>
                    </a:lnT>
                    <a:lnB>
                      <a:noFill/>
                    </a:lnB>
                  </a:tcPr>
                </a:tc>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2.47 </a:t>
                      </a:r>
                      <a:r>
                        <a:rPr lang="en-US" sz="1400" kern="1200" dirty="0">
                          <a:solidFill>
                            <a:schemeClr val="tx1"/>
                          </a:solidFill>
                          <a:effectLst/>
                          <a:latin typeface="+mn-lt"/>
                          <a:ea typeface="+mn-ea"/>
                          <a:cs typeface="+mn-cs"/>
                        </a:rPr>
                        <a:t>±</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0.21</a:t>
                      </a:r>
                    </a:p>
                  </a:txBody>
                  <a:tcPr marL="68580" marR="68580" marT="0" marB="0" anchor="ctr">
                    <a:lnL>
                      <a:noFill/>
                    </a:lnL>
                    <a:lnR>
                      <a:noFill/>
                    </a:lnR>
                    <a:lnT>
                      <a:noFill/>
                    </a:lnT>
                    <a:lnB>
                      <a:noFill/>
                    </a:lnB>
                  </a:tcPr>
                </a:tc>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0.27 </a:t>
                      </a:r>
                      <a:r>
                        <a:rPr lang="en-US" sz="1400" kern="1200" dirty="0">
                          <a:solidFill>
                            <a:schemeClr val="tx1"/>
                          </a:solidFill>
                          <a:effectLst/>
                          <a:latin typeface="+mn-lt"/>
                          <a:ea typeface="+mn-ea"/>
                          <a:cs typeface="+mn-cs"/>
                        </a:rPr>
                        <a:t>±</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0.016</a:t>
                      </a:r>
                    </a:p>
                  </a:txBody>
                  <a:tcPr marL="68580" marR="68580" marT="0" marB="0" anchor="ctr">
                    <a:lnL>
                      <a:noFill/>
                    </a:lnL>
                    <a:lnR>
                      <a:noFill/>
                    </a:lnR>
                    <a:lnT>
                      <a:noFill/>
                    </a:lnT>
                    <a:lnB>
                      <a:noFill/>
                    </a:lnB>
                  </a:tcPr>
                </a:tc>
                <a:tc>
                  <a:txBody>
                    <a:bodyPr/>
                    <a:lstStyle/>
                    <a:p>
                      <a:pPr marL="0" marR="0" algn="ctr">
                        <a:lnSpc>
                          <a:spcPct val="115000"/>
                        </a:lnSpc>
                        <a:spcBef>
                          <a:spcPts val="0"/>
                        </a:spcBef>
                        <a:spcAft>
                          <a:spcPts val="0"/>
                        </a:spcAft>
                      </a:pP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9.15</a:t>
                      </a:r>
                    </a:p>
                  </a:txBody>
                  <a:tcPr marL="68580" marR="68580" marT="0" marB="0" anchor="ctr">
                    <a:lnL>
                      <a:noFill/>
                    </a:lnL>
                    <a:lnR>
                      <a:noFill/>
                    </a:lnR>
                    <a:lnT>
                      <a:noFill/>
                    </a:lnT>
                    <a:lnB>
                      <a:noFill/>
                    </a:lnB>
                  </a:tcPr>
                </a:tc>
                <a:extLst>
                  <a:ext uri="{0D108BD9-81ED-4DB2-BD59-A6C34878D82A}">
                    <a16:rowId xmlns:a16="http://schemas.microsoft.com/office/drawing/2014/main" val="2018182466"/>
                  </a:ext>
                </a:extLst>
              </a:tr>
            </a:tbl>
          </a:graphicData>
        </a:graphic>
      </p:graphicFrame>
      <p:sp>
        <p:nvSpPr>
          <p:cNvPr id="8" name="TextBox 7">
            <a:extLst>
              <a:ext uri="{FF2B5EF4-FFF2-40B4-BE49-F238E27FC236}">
                <a16:creationId xmlns:a16="http://schemas.microsoft.com/office/drawing/2014/main" id="{76128B72-6AF2-4E40-88FA-F306DA21F6E6}"/>
              </a:ext>
            </a:extLst>
          </p:cNvPr>
          <p:cNvSpPr txBox="1"/>
          <p:nvPr/>
        </p:nvSpPr>
        <p:spPr>
          <a:xfrm>
            <a:off x="457200" y="5723306"/>
            <a:ext cx="6858000" cy="369332"/>
          </a:xfrm>
          <a:prstGeom prst="rect">
            <a:avLst/>
          </a:prstGeom>
          <a:noFill/>
        </p:spPr>
        <p:txBody>
          <a:bodyPr wrap="square" lIns="0" tIns="0" rIns="0" bIns="0" rtlCol="0">
            <a:spAutoFit/>
          </a:bodyPr>
          <a:lstStyle/>
          <a:p>
            <a:pPr algn="just"/>
            <a:r>
              <a:rPr lang="en-US" sz="1200" b="1" dirty="0"/>
              <a:t>Table S1. </a:t>
            </a:r>
            <a:r>
              <a:rPr lang="en-US" sz="1200" dirty="0"/>
              <a:t>Current response and response ratios of </a:t>
            </a:r>
            <a:r>
              <a:rPr lang="en-US" sz="1200" dirty="0">
                <a:latin typeface="Times New Roman" panose="02020603050405020304" pitchFamily="18" charset="0"/>
                <a:ea typeface="Calibri" panose="020F0502020204030204" pitchFamily="34" charset="0"/>
                <a:cs typeface="Times New Roman" panose="02020603050405020304" pitchFamily="18" charset="0"/>
              </a:rPr>
              <a:t>H</a:t>
            </a:r>
            <a:r>
              <a:rPr lang="en-US" sz="1200" baseline="-25000" dirty="0">
                <a:latin typeface="Times New Roman" panose="02020603050405020304" pitchFamily="18" charset="0"/>
                <a:ea typeface="Calibri" panose="020F0502020204030204" pitchFamily="34" charset="0"/>
                <a:cs typeface="Times New Roman" panose="02020603050405020304" pitchFamily="18" charset="0"/>
              </a:rPr>
              <a:t>2</a:t>
            </a:r>
            <a:r>
              <a:rPr lang="en-US" sz="1200" dirty="0">
                <a:latin typeface="Times New Roman" panose="02020603050405020304" pitchFamily="18" charset="0"/>
                <a:ea typeface="Calibri" panose="020F0502020204030204" pitchFamily="34" charset="0"/>
                <a:cs typeface="Times New Roman" panose="02020603050405020304" pitchFamily="18" charset="0"/>
              </a:rPr>
              <a:t>O</a:t>
            </a:r>
            <a:r>
              <a:rPr lang="en-US" sz="1200" baseline="-25000" dirty="0">
                <a:latin typeface="Times New Roman" panose="02020603050405020304" pitchFamily="18" charset="0"/>
                <a:ea typeface="Calibri" panose="020F0502020204030204" pitchFamily="34" charset="0"/>
                <a:cs typeface="Times New Roman" panose="02020603050405020304" pitchFamily="18" charset="0"/>
              </a:rPr>
              <a:t>2</a:t>
            </a:r>
            <a:r>
              <a:rPr lang="en-US" sz="1200" dirty="0">
                <a:latin typeface="Times New Roman" panose="02020603050405020304" pitchFamily="18" charset="0"/>
                <a:ea typeface="Calibri" panose="020F0502020204030204" pitchFamily="34" charset="0"/>
                <a:cs typeface="Times New Roman" panose="02020603050405020304" pitchFamily="18" charset="0"/>
              </a:rPr>
              <a:t>/Uric Acid at bare Pt electrode held at different potentials.</a:t>
            </a:r>
            <a:r>
              <a:rPr lang="en-US" sz="1200" dirty="0"/>
              <a:t>  </a:t>
            </a:r>
          </a:p>
        </p:txBody>
      </p:sp>
    </p:spTree>
    <p:extLst>
      <p:ext uri="{BB962C8B-B14F-4D97-AF65-F5344CB8AC3E}">
        <p14:creationId xmlns:p14="http://schemas.microsoft.com/office/powerpoint/2010/main" val="259359790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FFBE0832-575D-534C-C979-63D00210B899}"/>
              </a:ext>
            </a:extLst>
          </p:cNvPr>
          <p:cNvSpPr>
            <a:spLocks noGrp="1"/>
          </p:cNvSpPr>
          <p:nvPr>
            <p:ph type="sldNum" sz="quarter" idx="12"/>
          </p:nvPr>
        </p:nvSpPr>
        <p:spPr/>
        <p:txBody>
          <a:bodyPr/>
          <a:lstStyle/>
          <a:p>
            <a:r>
              <a:rPr lang="en-US"/>
              <a:t>S</a:t>
            </a:r>
            <a:fld id="{0DD34403-E6AF-9B44-8A22-D75A397E6552}" type="slidenum">
              <a:rPr lang="en-US" smtClean="0"/>
              <a:pPr/>
              <a:t>18</a:t>
            </a:fld>
            <a:endParaRPr lang="en-US"/>
          </a:p>
        </p:txBody>
      </p:sp>
      <p:sp>
        <p:nvSpPr>
          <p:cNvPr id="4" name="TextBox 3">
            <a:extLst>
              <a:ext uri="{FF2B5EF4-FFF2-40B4-BE49-F238E27FC236}">
                <a16:creationId xmlns:a16="http://schemas.microsoft.com/office/drawing/2014/main" id="{3E67F6B7-E1C0-67BD-582E-1C3ED79D9E78}"/>
              </a:ext>
            </a:extLst>
          </p:cNvPr>
          <p:cNvSpPr txBox="1"/>
          <p:nvPr/>
        </p:nvSpPr>
        <p:spPr>
          <a:xfrm>
            <a:off x="515155" y="489398"/>
            <a:ext cx="6938759" cy="646331"/>
          </a:xfrm>
          <a:prstGeom prst="rect">
            <a:avLst/>
          </a:prstGeom>
          <a:noFill/>
        </p:spPr>
        <p:txBody>
          <a:bodyPr wrap="none" rtlCol="0">
            <a:spAutoFit/>
          </a:bodyPr>
          <a:lstStyle/>
          <a:p>
            <a:r>
              <a:rPr lang="en-US" b="1" dirty="0"/>
              <a:t>Additional Experimental Details for Evaluating Xanthine Biosensors</a:t>
            </a:r>
          </a:p>
          <a:p>
            <a:r>
              <a:rPr lang="en-US" b="1" dirty="0"/>
              <a:t>(Section 2.4 – Supplement)</a:t>
            </a:r>
          </a:p>
        </p:txBody>
      </p:sp>
      <p:pic>
        <p:nvPicPr>
          <p:cNvPr id="12" name="Picture 11">
            <a:extLst>
              <a:ext uri="{FF2B5EF4-FFF2-40B4-BE49-F238E27FC236}">
                <a16:creationId xmlns:a16="http://schemas.microsoft.com/office/drawing/2014/main" id="{B3FAC334-BF29-80A4-0D96-EA96FC83486B}"/>
              </a:ext>
            </a:extLst>
          </p:cNvPr>
          <p:cNvPicPr>
            <a:picLocks noChangeAspect="1"/>
          </p:cNvPicPr>
          <p:nvPr/>
        </p:nvPicPr>
        <p:blipFill>
          <a:blip r:embed="rId2"/>
          <a:stretch>
            <a:fillRect/>
          </a:stretch>
        </p:blipFill>
        <p:spPr>
          <a:xfrm>
            <a:off x="579562" y="1135729"/>
            <a:ext cx="6613276" cy="5356258"/>
          </a:xfrm>
          <a:prstGeom prst="rect">
            <a:avLst/>
          </a:prstGeom>
        </p:spPr>
      </p:pic>
    </p:spTree>
    <p:extLst>
      <p:ext uri="{BB962C8B-B14F-4D97-AF65-F5344CB8AC3E}">
        <p14:creationId xmlns:p14="http://schemas.microsoft.com/office/powerpoint/2010/main" val="14528418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B7F5AED4-4314-7A31-B643-432309C9B23D}"/>
              </a:ext>
            </a:extLst>
          </p:cNvPr>
          <p:cNvSpPr>
            <a:spLocks noGrp="1"/>
          </p:cNvSpPr>
          <p:nvPr>
            <p:ph type="sldNum" sz="quarter" idx="12"/>
          </p:nvPr>
        </p:nvSpPr>
        <p:spPr/>
        <p:txBody>
          <a:bodyPr/>
          <a:lstStyle/>
          <a:p>
            <a:r>
              <a:rPr lang="en-US"/>
              <a:t>S</a:t>
            </a:r>
            <a:fld id="{0DD34403-E6AF-9B44-8A22-D75A397E6552}" type="slidenum">
              <a:rPr lang="en-US" smtClean="0"/>
              <a:pPr/>
              <a:t>2</a:t>
            </a:fld>
            <a:endParaRPr lang="en-US"/>
          </a:p>
        </p:txBody>
      </p:sp>
      <p:sp>
        <p:nvSpPr>
          <p:cNvPr id="4" name="Rectangle 2">
            <a:extLst>
              <a:ext uri="{FF2B5EF4-FFF2-40B4-BE49-F238E27FC236}">
                <a16:creationId xmlns:a16="http://schemas.microsoft.com/office/drawing/2014/main" id="{818701AC-4D0F-F84B-F283-17E476ECE22A}"/>
              </a:ext>
            </a:extLst>
          </p:cNvPr>
          <p:cNvSpPr>
            <a:spLocks noChangeArrowheads="1"/>
          </p:cNvSpPr>
          <p:nvPr/>
        </p:nvSpPr>
        <p:spPr bwMode="auto">
          <a:xfrm>
            <a:off x="0" y="0"/>
            <a:ext cx="77724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1025" name="Picture 2" descr="A picture containing text, diagram, screenshot, font&#10;&#10;Description automatically generated">
            <a:extLst>
              <a:ext uri="{FF2B5EF4-FFF2-40B4-BE49-F238E27FC236}">
                <a16:creationId xmlns:a16="http://schemas.microsoft.com/office/drawing/2014/main" id="{AE37BB62-16F6-6B26-8C38-DEFA537D294C}"/>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493949" y="1065895"/>
            <a:ext cx="4443212" cy="6664818"/>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a:extLst>
              <a:ext uri="{FF2B5EF4-FFF2-40B4-BE49-F238E27FC236}">
                <a16:creationId xmlns:a16="http://schemas.microsoft.com/office/drawing/2014/main" id="{15A9ABC8-F213-403E-2ED0-EF9F80604A47}"/>
              </a:ext>
            </a:extLst>
          </p:cNvPr>
          <p:cNvSpPr>
            <a:spLocks noChangeArrowheads="1"/>
          </p:cNvSpPr>
          <p:nvPr/>
        </p:nvSpPr>
        <p:spPr bwMode="auto">
          <a:xfrm>
            <a:off x="599110" y="7825901"/>
            <a:ext cx="6638938" cy="5232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1" i="0" u="none" strike="noStrike" cap="none" normalizeH="0" baseline="0" dirty="0">
                <a:ln>
                  <a:noFill/>
                </a:ln>
                <a:solidFill>
                  <a:srgbClr val="000000"/>
                </a:solidFill>
                <a:effectLst/>
                <a:latin typeface="+mj-lt"/>
                <a:ea typeface="Calibri" panose="020F0502020204030204" pitchFamily="34" charset="0"/>
                <a:cs typeface="Times New Roman" panose="02020603050405020304" pitchFamily="18" charset="0"/>
              </a:rPr>
              <a:t>Scheme S1. </a:t>
            </a:r>
            <a:r>
              <a:rPr kumimoji="0" lang="en-US" altLang="en-US" sz="1400" b="0" i="0" u="none" strike="noStrike" cap="none" normalizeH="0" baseline="0" dirty="0">
                <a:ln>
                  <a:noFill/>
                </a:ln>
                <a:solidFill>
                  <a:srgbClr val="000000"/>
                </a:solidFill>
                <a:effectLst/>
                <a:latin typeface="+mj-lt"/>
                <a:ea typeface="Calibri" panose="020F0502020204030204" pitchFamily="34" charset="0"/>
                <a:cs typeface="Times New Roman" panose="02020603050405020304" pitchFamily="18" charset="0"/>
              </a:rPr>
              <a:t>Mechanistic pathway of purine metabolism in mammals highlighting the role of hypoxanthine, xanthine, and uric acid in conjunction with xanthine oxidase enzyme.</a:t>
            </a:r>
            <a:endParaRPr kumimoji="0" lang="en-US" altLang="en-US" sz="3600" b="0" i="0" u="none" strike="noStrike" cap="none" normalizeH="0" baseline="0" dirty="0">
              <a:ln>
                <a:noFill/>
              </a:ln>
              <a:solidFill>
                <a:schemeClr val="tx1"/>
              </a:solidFill>
              <a:effectLst/>
              <a:latin typeface="+mj-lt"/>
            </a:endParaRPr>
          </a:p>
        </p:txBody>
      </p:sp>
    </p:spTree>
    <p:extLst>
      <p:ext uri="{BB962C8B-B14F-4D97-AF65-F5344CB8AC3E}">
        <p14:creationId xmlns:p14="http://schemas.microsoft.com/office/powerpoint/2010/main" val="28665319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extBox 24">
            <a:extLst>
              <a:ext uri="{FF2B5EF4-FFF2-40B4-BE49-F238E27FC236}">
                <a16:creationId xmlns:a16="http://schemas.microsoft.com/office/drawing/2014/main" id="{86AE2367-5831-48AB-B351-17290B634EE4}"/>
              </a:ext>
            </a:extLst>
          </p:cNvPr>
          <p:cNvSpPr txBox="1"/>
          <p:nvPr/>
        </p:nvSpPr>
        <p:spPr>
          <a:xfrm>
            <a:off x="457200" y="8432408"/>
            <a:ext cx="6858000" cy="1246495"/>
          </a:xfrm>
          <a:prstGeom prst="rect">
            <a:avLst/>
          </a:prstGeom>
          <a:solidFill>
            <a:schemeClr val="bg1"/>
          </a:solidFill>
        </p:spPr>
        <p:txBody>
          <a:bodyPr wrap="square" lIns="0" tIns="0" rIns="0" bIns="0" rtlCol="0">
            <a:spAutoFit/>
          </a:bodyPr>
          <a:lstStyle/>
          <a:p>
            <a:pPr algn="just"/>
            <a:r>
              <a:rPr lang="en-US" sz="1350" b="1" dirty="0">
                <a:latin typeface="Times New Roman" panose="02020603050405020304" pitchFamily="18" charset="0"/>
                <a:cs typeface="Times New Roman" panose="02020603050405020304" pitchFamily="18" charset="0"/>
              </a:rPr>
              <a:t>Figure S1.  </a:t>
            </a:r>
            <a:r>
              <a:rPr lang="en-US" sz="1350" dirty="0">
                <a:latin typeface="Times New Roman" panose="02020603050405020304" pitchFamily="18" charset="0"/>
                <a:cs typeface="Times New Roman" panose="02020603050405020304" pitchFamily="18" charset="0"/>
              </a:rPr>
              <a:t>Cyclic voltammetry (50 mV/sec) of 5 mM potassium ferricyanide (0.5 M </a:t>
            </a:r>
            <a:r>
              <a:rPr lang="en-US" sz="1350" dirty="0" err="1">
                <a:latin typeface="Times New Roman" panose="02020603050405020304" pitchFamily="18" charset="0"/>
                <a:cs typeface="Times New Roman" panose="02020603050405020304" pitchFamily="18" charset="0"/>
              </a:rPr>
              <a:t>KCl</a:t>
            </a:r>
            <a:r>
              <a:rPr lang="en-US" sz="1350" dirty="0">
                <a:latin typeface="Times New Roman" panose="02020603050405020304" pitchFamily="18" charset="0"/>
                <a:cs typeface="Times New Roman" panose="02020603050405020304" pitchFamily="18" charset="0"/>
              </a:rPr>
              <a:t>) at single and double layered xerogel films formed from </a:t>
            </a:r>
            <a:r>
              <a:rPr lang="en-US" sz="1350" b="1" dirty="0">
                <a:latin typeface="Times New Roman" panose="02020603050405020304" pitchFamily="18" charset="0"/>
                <a:cs typeface="Times New Roman" panose="02020603050405020304" pitchFamily="18" charset="0"/>
              </a:rPr>
              <a:t>(A)</a:t>
            </a:r>
            <a:r>
              <a:rPr lang="en-US" sz="1350" dirty="0">
                <a:latin typeface="Times New Roman" panose="02020603050405020304" pitchFamily="18" charset="0"/>
                <a:cs typeface="Times New Roman" panose="02020603050405020304" pitchFamily="18" charset="0"/>
              </a:rPr>
              <a:t> HMTES and </a:t>
            </a:r>
            <a:r>
              <a:rPr lang="en-US" sz="1350" b="1" dirty="0">
                <a:latin typeface="Times New Roman" panose="02020603050405020304" pitchFamily="18" charset="0"/>
                <a:cs typeface="Times New Roman" panose="02020603050405020304" pitchFamily="18" charset="0"/>
              </a:rPr>
              <a:t>(B) </a:t>
            </a:r>
            <a:r>
              <a:rPr lang="en-US" sz="1350" dirty="0">
                <a:latin typeface="Times New Roman" panose="02020603050405020304" pitchFamily="18" charset="0"/>
                <a:cs typeface="Times New Roman" panose="02020603050405020304" pitchFamily="18" charset="0"/>
              </a:rPr>
              <a:t>TEES silane precursors.  Note: An order of magnitude difference in the current scale exists between A and B and shows that the HMTES is forming a significantly more blocking and less porous gel at the electrode versus the TEES xerogel (the bare electrode response is not included in the HMTES comparison for this reason).</a:t>
            </a:r>
            <a:endParaRPr lang="en-US" sz="1350" b="1" dirty="0">
              <a:latin typeface="Times New Roman" panose="02020603050405020304" pitchFamily="18" charset="0"/>
              <a:cs typeface="Times New Roman" panose="02020603050405020304" pitchFamily="18" charset="0"/>
            </a:endParaRPr>
          </a:p>
        </p:txBody>
      </p:sp>
      <p:sp>
        <p:nvSpPr>
          <p:cNvPr id="3" name="Slide Number Placeholder 2">
            <a:extLst>
              <a:ext uri="{FF2B5EF4-FFF2-40B4-BE49-F238E27FC236}">
                <a16:creationId xmlns:a16="http://schemas.microsoft.com/office/drawing/2014/main" id="{E5DE0A5F-8935-44CE-A8D2-F2D8691E52C6}"/>
              </a:ext>
            </a:extLst>
          </p:cNvPr>
          <p:cNvSpPr>
            <a:spLocks noGrp="1"/>
          </p:cNvSpPr>
          <p:nvPr>
            <p:ph type="sldNum" sz="quarter" idx="12"/>
          </p:nvPr>
        </p:nvSpPr>
        <p:spPr/>
        <p:txBody>
          <a:bodyPr/>
          <a:lstStyle/>
          <a:p>
            <a:r>
              <a:rPr lang="en-US" dirty="0"/>
              <a:t>S</a:t>
            </a:r>
            <a:fld id="{0DD34403-E6AF-9B44-8A22-D75A397E6552}" type="slidenum">
              <a:rPr lang="en-US" smtClean="0"/>
              <a:pPr/>
              <a:t>3</a:t>
            </a:fld>
            <a:endParaRPr lang="en-US" dirty="0"/>
          </a:p>
        </p:txBody>
      </p:sp>
      <p:pic>
        <p:nvPicPr>
          <p:cNvPr id="4" name="Content Placeholder 5" descr="Chart, line chart&#10;&#10;Description automatically generated">
            <a:extLst>
              <a:ext uri="{FF2B5EF4-FFF2-40B4-BE49-F238E27FC236}">
                <a16:creationId xmlns:a16="http://schemas.microsoft.com/office/drawing/2014/main" id="{3CFC7136-F968-43CC-921D-73AC862EC21D}"/>
              </a:ext>
            </a:extLst>
          </p:cNvPr>
          <p:cNvPicPr>
            <a:picLocks noGrp="1" noChangeAspect="1"/>
          </p:cNvPicPr>
          <p:nvPr>
            <p:ph idx="1"/>
          </p:nvPr>
        </p:nvPicPr>
        <p:blipFill rotWithShape="1">
          <a:blip r:embed="rId2">
            <a:extLst>
              <a:ext uri="{28A0092B-C50C-407E-A947-70E740481C1C}">
                <a14:useLocalDpi xmlns:a14="http://schemas.microsoft.com/office/drawing/2010/main" val="0"/>
              </a:ext>
            </a:extLst>
          </a:blip>
          <a:srcRect l="5116" t="9183" r="21406" b="8034"/>
          <a:stretch/>
        </p:blipFill>
        <p:spPr>
          <a:xfrm>
            <a:off x="1227532" y="527250"/>
            <a:ext cx="5805446" cy="4087858"/>
          </a:xfrm>
        </p:spPr>
      </p:pic>
      <p:pic>
        <p:nvPicPr>
          <p:cNvPr id="5" name="Picture 4" descr="Chart, line chart&#10;&#10;Description automatically generated">
            <a:extLst>
              <a:ext uri="{FF2B5EF4-FFF2-40B4-BE49-F238E27FC236}">
                <a16:creationId xmlns:a16="http://schemas.microsoft.com/office/drawing/2014/main" id="{073BFD07-6497-482B-B173-6CBBE0F8D14F}"/>
              </a:ext>
            </a:extLst>
          </p:cNvPr>
          <p:cNvPicPr>
            <a:picLocks noChangeAspect="1"/>
          </p:cNvPicPr>
          <p:nvPr/>
        </p:nvPicPr>
        <p:blipFill rotWithShape="1">
          <a:blip r:embed="rId3">
            <a:extLst>
              <a:ext uri="{28A0092B-C50C-407E-A947-70E740481C1C}">
                <a14:useLocalDpi xmlns:a14="http://schemas.microsoft.com/office/drawing/2010/main" val="0"/>
              </a:ext>
            </a:extLst>
          </a:blip>
          <a:srcRect l="4697" t="8909" r="21667" b="8325"/>
          <a:stretch/>
        </p:blipFill>
        <p:spPr>
          <a:xfrm>
            <a:off x="1137220" y="4225410"/>
            <a:ext cx="5950347" cy="4180074"/>
          </a:xfrm>
          <a:prstGeom prst="rect">
            <a:avLst/>
          </a:prstGeom>
        </p:spPr>
      </p:pic>
      <p:sp>
        <p:nvSpPr>
          <p:cNvPr id="6" name="TextBox 5">
            <a:extLst>
              <a:ext uri="{FF2B5EF4-FFF2-40B4-BE49-F238E27FC236}">
                <a16:creationId xmlns:a16="http://schemas.microsoft.com/office/drawing/2014/main" id="{60489C69-41AB-42BB-9186-FEDD2EBE6908}"/>
              </a:ext>
            </a:extLst>
          </p:cNvPr>
          <p:cNvSpPr txBox="1"/>
          <p:nvPr/>
        </p:nvSpPr>
        <p:spPr>
          <a:xfrm>
            <a:off x="1172943" y="527250"/>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72F8156A-4E2F-43BC-9AED-4A32BDB2C928}"/>
              </a:ext>
            </a:extLst>
          </p:cNvPr>
          <p:cNvSpPr txBox="1"/>
          <p:nvPr/>
        </p:nvSpPr>
        <p:spPr>
          <a:xfrm>
            <a:off x="1137220" y="4225410"/>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B</a:t>
            </a:r>
          </a:p>
        </p:txBody>
      </p:sp>
      <p:cxnSp>
        <p:nvCxnSpPr>
          <p:cNvPr id="10" name="Straight Arrow Connector 9">
            <a:extLst>
              <a:ext uri="{FF2B5EF4-FFF2-40B4-BE49-F238E27FC236}">
                <a16:creationId xmlns:a16="http://schemas.microsoft.com/office/drawing/2014/main" id="{1FE84DB3-583A-479C-9018-F58F08804657}"/>
              </a:ext>
            </a:extLst>
          </p:cNvPr>
          <p:cNvCxnSpPr>
            <a:cxnSpLocks/>
          </p:cNvCxnSpPr>
          <p:nvPr/>
        </p:nvCxnSpPr>
        <p:spPr>
          <a:xfrm>
            <a:off x="3886200" y="2117573"/>
            <a:ext cx="392289"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1" name="Straight Arrow Connector 10">
            <a:extLst>
              <a:ext uri="{FF2B5EF4-FFF2-40B4-BE49-F238E27FC236}">
                <a16:creationId xmlns:a16="http://schemas.microsoft.com/office/drawing/2014/main" id="{790AA974-ACF4-4261-96DB-787CC442E5C6}"/>
              </a:ext>
            </a:extLst>
          </p:cNvPr>
          <p:cNvCxnSpPr>
            <a:cxnSpLocks/>
          </p:cNvCxnSpPr>
          <p:nvPr/>
        </p:nvCxnSpPr>
        <p:spPr>
          <a:xfrm flipH="1" flipV="1">
            <a:off x="4684889" y="3078359"/>
            <a:ext cx="355600" cy="18626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4" name="Straight Arrow Connector 13">
            <a:extLst>
              <a:ext uri="{FF2B5EF4-FFF2-40B4-BE49-F238E27FC236}">
                <a16:creationId xmlns:a16="http://schemas.microsoft.com/office/drawing/2014/main" id="{8973CD23-9F93-49A5-B236-DF66B783DA34}"/>
              </a:ext>
            </a:extLst>
          </p:cNvPr>
          <p:cNvCxnSpPr>
            <a:cxnSpLocks/>
          </p:cNvCxnSpPr>
          <p:nvPr/>
        </p:nvCxnSpPr>
        <p:spPr>
          <a:xfrm>
            <a:off x="4580467" y="4697083"/>
            <a:ext cx="392289"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5" name="Straight Arrow Connector 14">
            <a:extLst>
              <a:ext uri="{FF2B5EF4-FFF2-40B4-BE49-F238E27FC236}">
                <a16:creationId xmlns:a16="http://schemas.microsoft.com/office/drawing/2014/main" id="{44595FFA-10BB-45F6-B7C0-DEE65DC9262D}"/>
              </a:ext>
            </a:extLst>
          </p:cNvPr>
          <p:cNvCxnSpPr>
            <a:cxnSpLocks/>
          </p:cNvCxnSpPr>
          <p:nvPr/>
        </p:nvCxnSpPr>
        <p:spPr>
          <a:xfrm flipH="1">
            <a:off x="5240902" y="4793039"/>
            <a:ext cx="383822"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7" name="Straight Arrow Connector 16">
            <a:extLst>
              <a:ext uri="{FF2B5EF4-FFF2-40B4-BE49-F238E27FC236}">
                <a16:creationId xmlns:a16="http://schemas.microsoft.com/office/drawing/2014/main" id="{4C3C0C76-A0E5-48F5-84F4-87A693756BCD}"/>
              </a:ext>
            </a:extLst>
          </p:cNvPr>
          <p:cNvCxnSpPr>
            <a:cxnSpLocks/>
          </p:cNvCxnSpPr>
          <p:nvPr/>
        </p:nvCxnSpPr>
        <p:spPr>
          <a:xfrm flipH="1" flipV="1">
            <a:off x="5240972" y="5119299"/>
            <a:ext cx="285010" cy="220134"/>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19" name="TextBox 18">
            <a:extLst>
              <a:ext uri="{FF2B5EF4-FFF2-40B4-BE49-F238E27FC236}">
                <a16:creationId xmlns:a16="http://schemas.microsoft.com/office/drawing/2014/main" id="{956B5686-32B9-4CAA-AAAA-DE3DB7FF2FC7}"/>
              </a:ext>
            </a:extLst>
          </p:cNvPr>
          <p:cNvSpPr txBox="1"/>
          <p:nvPr/>
        </p:nvSpPr>
        <p:spPr>
          <a:xfrm>
            <a:off x="3032056" y="1761844"/>
            <a:ext cx="1050288" cy="646331"/>
          </a:xfrm>
          <a:prstGeom prst="rect">
            <a:avLst/>
          </a:prstGeom>
          <a:noFill/>
        </p:spPr>
        <p:txBody>
          <a:bodyPr wrap="none" rtlCol="0">
            <a:spAutoFit/>
          </a:bodyPr>
          <a:lstStyle/>
          <a:p>
            <a:pPr algn="ctr"/>
            <a:r>
              <a:rPr lang="en-US" dirty="0"/>
              <a:t>1 xerogel</a:t>
            </a:r>
          </a:p>
          <a:p>
            <a:pPr algn="ctr"/>
            <a:r>
              <a:rPr lang="en-US" dirty="0"/>
              <a:t>layer </a:t>
            </a:r>
          </a:p>
        </p:txBody>
      </p:sp>
      <p:sp>
        <p:nvSpPr>
          <p:cNvPr id="20" name="TextBox 19">
            <a:extLst>
              <a:ext uri="{FF2B5EF4-FFF2-40B4-BE49-F238E27FC236}">
                <a16:creationId xmlns:a16="http://schemas.microsoft.com/office/drawing/2014/main" id="{72D8889C-9BC3-405E-BDD6-A125D3CCC7D8}"/>
              </a:ext>
            </a:extLst>
          </p:cNvPr>
          <p:cNvSpPr txBox="1"/>
          <p:nvPr/>
        </p:nvSpPr>
        <p:spPr>
          <a:xfrm>
            <a:off x="5000837" y="2977705"/>
            <a:ext cx="1050289" cy="646331"/>
          </a:xfrm>
          <a:prstGeom prst="rect">
            <a:avLst/>
          </a:prstGeom>
          <a:noFill/>
        </p:spPr>
        <p:txBody>
          <a:bodyPr wrap="none" rtlCol="0">
            <a:spAutoFit/>
          </a:bodyPr>
          <a:lstStyle/>
          <a:p>
            <a:pPr algn="ctr"/>
            <a:r>
              <a:rPr lang="en-US" dirty="0"/>
              <a:t>2 xerogel</a:t>
            </a:r>
          </a:p>
          <a:p>
            <a:pPr algn="ctr"/>
            <a:r>
              <a:rPr lang="en-US" dirty="0"/>
              <a:t>layers </a:t>
            </a:r>
          </a:p>
        </p:txBody>
      </p:sp>
      <p:sp>
        <p:nvSpPr>
          <p:cNvPr id="22" name="TextBox 21">
            <a:extLst>
              <a:ext uri="{FF2B5EF4-FFF2-40B4-BE49-F238E27FC236}">
                <a16:creationId xmlns:a16="http://schemas.microsoft.com/office/drawing/2014/main" id="{2C5A6583-66BD-40F4-8A34-EB69107B6FF2}"/>
              </a:ext>
            </a:extLst>
          </p:cNvPr>
          <p:cNvSpPr txBox="1"/>
          <p:nvPr/>
        </p:nvSpPr>
        <p:spPr>
          <a:xfrm>
            <a:off x="5099579" y="5252727"/>
            <a:ext cx="1050289" cy="646331"/>
          </a:xfrm>
          <a:prstGeom prst="rect">
            <a:avLst/>
          </a:prstGeom>
          <a:noFill/>
        </p:spPr>
        <p:txBody>
          <a:bodyPr wrap="none" rtlCol="0">
            <a:spAutoFit/>
          </a:bodyPr>
          <a:lstStyle/>
          <a:p>
            <a:pPr algn="ctr"/>
            <a:r>
              <a:rPr lang="en-US" dirty="0"/>
              <a:t>2 xerogel</a:t>
            </a:r>
          </a:p>
          <a:p>
            <a:pPr algn="ctr"/>
            <a:r>
              <a:rPr lang="en-US" dirty="0"/>
              <a:t>layers </a:t>
            </a:r>
          </a:p>
        </p:txBody>
      </p:sp>
      <p:sp>
        <p:nvSpPr>
          <p:cNvPr id="23" name="TextBox 22">
            <a:extLst>
              <a:ext uri="{FF2B5EF4-FFF2-40B4-BE49-F238E27FC236}">
                <a16:creationId xmlns:a16="http://schemas.microsoft.com/office/drawing/2014/main" id="{CF8BB171-5BD0-45CC-B5E7-F0B1846B064F}"/>
              </a:ext>
            </a:extLst>
          </p:cNvPr>
          <p:cNvSpPr txBox="1"/>
          <p:nvPr/>
        </p:nvSpPr>
        <p:spPr>
          <a:xfrm>
            <a:off x="5584892" y="4469873"/>
            <a:ext cx="1050288" cy="646331"/>
          </a:xfrm>
          <a:prstGeom prst="rect">
            <a:avLst/>
          </a:prstGeom>
          <a:noFill/>
        </p:spPr>
        <p:txBody>
          <a:bodyPr wrap="none" rtlCol="0">
            <a:spAutoFit/>
          </a:bodyPr>
          <a:lstStyle/>
          <a:p>
            <a:pPr algn="ctr"/>
            <a:r>
              <a:rPr lang="en-US" dirty="0"/>
              <a:t>1 xerogel</a:t>
            </a:r>
          </a:p>
          <a:p>
            <a:pPr algn="ctr"/>
            <a:r>
              <a:rPr lang="en-US" dirty="0"/>
              <a:t>layer </a:t>
            </a:r>
          </a:p>
        </p:txBody>
      </p:sp>
      <p:sp>
        <p:nvSpPr>
          <p:cNvPr id="24" name="TextBox 23">
            <a:extLst>
              <a:ext uri="{FF2B5EF4-FFF2-40B4-BE49-F238E27FC236}">
                <a16:creationId xmlns:a16="http://schemas.microsoft.com/office/drawing/2014/main" id="{443013AB-5751-4E5F-83D1-325C6394179E}"/>
              </a:ext>
            </a:extLst>
          </p:cNvPr>
          <p:cNvSpPr txBox="1"/>
          <p:nvPr/>
        </p:nvSpPr>
        <p:spPr>
          <a:xfrm>
            <a:off x="3677419" y="4516011"/>
            <a:ext cx="928459" cy="369332"/>
          </a:xfrm>
          <a:prstGeom prst="rect">
            <a:avLst/>
          </a:prstGeom>
          <a:noFill/>
        </p:spPr>
        <p:txBody>
          <a:bodyPr wrap="none" rtlCol="0">
            <a:spAutoFit/>
          </a:bodyPr>
          <a:lstStyle/>
          <a:p>
            <a:pPr algn="ctr"/>
            <a:r>
              <a:rPr lang="en-US" dirty="0"/>
              <a:t>Bare Pt </a:t>
            </a:r>
          </a:p>
        </p:txBody>
      </p:sp>
      <p:sp>
        <p:nvSpPr>
          <p:cNvPr id="2" name="Rectangle 1">
            <a:extLst>
              <a:ext uri="{FF2B5EF4-FFF2-40B4-BE49-F238E27FC236}">
                <a16:creationId xmlns:a16="http://schemas.microsoft.com/office/drawing/2014/main" id="{3017E14A-C380-E48D-233D-804567F69328}"/>
              </a:ext>
            </a:extLst>
          </p:cNvPr>
          <p:cNvSpPr/>
          <p:nvPr/>
        </p:nvSpPr>
        <p:spPr>
          <a:xfrm>
            <a:off x="1172943" y="8290560"/>
            <a:ext cx="2052857" cy="14184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2375686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5115E525-6C93-4FB0-AE3E-6BC964CC337B}"/>
              </a:ext>
            </a:extLst>
          </p:cNvPr>
          <p:cNvSpPr txBox="1"/>
          <p:nvPr/>
        </p:nvSpPr>
        <p:spPr>
          <a:xfrm>
            <a:off x="457200" y="8910901"/>
            <a:ext cx="6858000" cy="646331"/>
          </a:xfrm>
          <a:prstGeom prst="rect">
            <a:avLst/>
          </a:prstGeom>
          <a:solidFill>
            <a:schemeClr val="bg1"/>
          </a:solidFill>
        </p:spPr>
        <p:txBody>
          <a:bodyPr wrap="square" lIns="0" tIns="0" rIns="0" bIns="0" rtlCol="0">
            <a:spAutoFit/>
          </a:bodyPr>
          <a:lstStyle/>
          <a:p>
            <a:pPr algn="just"/>
            <a:r>
              <a:rPr lang="en-US" sz="1400" b="1" dirty="0">
                <a:latin typeface="Times New Roman" panose="02020603050405020304" pitchFamily="18" charset="0"/>
                <a:cs typeface="Times New Roman" panose="02020603050405020304" pitchFamily="18" charset="0"/>
              </a:rPr>
              <a:t>Figure S2. </a:t>
            </a:r>
            <a:r>
              <a:rPr lang="en-US" sz="1400" dirty="0">
                <a:latin typeface="Times New Roman" panose="02020603050405020304" pitchFamily="18" charset="0"/>
                <a:cs typeface="Times New Roman" panose="02020603050405020304" pitchFamily="18" charset="0"/>
              </a:rPr>
              <a:t>Permeability indices (PI) for hydrogen peroxide (100 mM) and xanthine (10 mM) at various xerogel systems that vary by silane precursor, deposition volume and composition, as well as xerogel age time.</a:t>
            </a:r>
          </a:p>
        </p:txBody>
      </p:sp>
      <p:sp>
        <p:nvSpPr>
          <p:cNvPr id="3" name="Slide Number Placeholder 2">
            <a:extLst>
              <a:ext uri="{FF2B5EF4-FFF2-40B4-BE49-F238E27FC236}">
                <a16:creationId xmlns:a16="http://schemas.microsoft.com/office/drawing/2014/main" id="{185E0A95-B64B-46F5-A0C5-F58083546907}"/>
              </a:ext>
            </a:extLst>
          </p:cNvPr>
          <p:cNvSpPr>
            <a:spLocks noGrp="1"/>
          </p:cNvSpPr>
          <p:nvPr>
            <p:ph type="sldNum" sz="quarter" idx="12"/>
          </p:nvPr>
        </p:nvSpPr>
        <p:spPr/>
        <p:txBody>
          <a:bodyPr/>
          <a:lstStyle/>
          <a:p>
            <a:r>
              <a:rPr lang="en-US"/>
              <a:t>S</a:t>
            </a:r>
            <a:fld id="{0DD34403-E6AF-9B44-8A22-D75A397E6552}" type="slidenum">
              <a:rPr lang="en-US" smtClean="0"/>
              <a:pPr/>
              <a:t>4</a:t>
            </a:fld>
            <a:endParaRPr lang="en-US"/>
          </a:p>
        </p:txBody>
      </p:sp>
      <p:pic>
        <p:nvPicPr>
          <p:cNvPr id="4" name="Picture 3">
            <a:extLst>
              <a:ext uri="{FF2B5EF4-FFF2-40B4-BE49-F238E27FC236}">
                <a16:creationId xmlns:a16="http://schemas.microsoft.com/office/drawing/2014/main" id="{D4E986D5-6DAA-481A-ADEB-DACCB7723D97}"/>
              </a:ext>
            </a:extLst>
          </p:cNvPr>
          <p:cNvPicPr>
            <a:picLocks noChangeAspect="1"/>
          </p:cNvPicPr>
          <p:nvPr/>
        </p:nvPicPr>
        <p:blipFill>
          <a:blip r:embed="rId2"/>
          <a:stretch>
            <a:fillRect/>
          </a:stretch>
        </p:blipFill>
        <p:spPr>
          <a:xfrm rot="16200000">
            <a:off x="-251697" y="1475040"/>
            <a:ext cx="8275795" cy="6400800"/>
          </a:xfrm>
          <a:prstGeom prst="rect">
            <a:avLst/>
          </a:prstGeom>
        </p:spPr>
      </p:pic>
    </p:spTree>
    <p:extLst>
      <p:ext uri="{BB962C8B-B14F-4D97-AF65-F5344CB8AC3E}">
        <p14:creationId xmlns:p14="http://schemas.microsoft.com/office/powerpoint/2010/main" val="2549803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93D893A6-B4B5-4787-B8FC-2804A6874B9F}"/>
              </a:ext>
            </a:extLst>
          </p:cNvPr>
          <p:cNvSpPr>
            <a:spLocks noGrp="1"/>
          </p:cNvSpPr>
          <p:nvPr>
            <p:ph type="sldNum" sz="quarter" idx="12"/>
          </p:nvPr>
        </p:nvSpPr>
        <p:spPr/>
        <p:txBody>
          <a:bodyPr/>
          <a:lstStyle/>
          <a:p>
            <a:r>
              <a:rPr lang="en-US"/>
              <a:t>S</a:t>
            </a:r>
            <a:fld id="{0DD34403-E6AF-9B44-8A22-D75A397E6552}" type="slidenum">
              <a:rPr lang="en-US" smtClean="0"/>
              <a:pPr/>
              <a:t>5</a:t>
            </a:fld>
            <a:endParaRPr lang="en-US"/>
          </a:p>
        </p:txBody>
      </p:sp>
      <p:graphicFrame>
        <p:nvGraphicFramePr>
          <p:cNvPr id="4" name="Chart 3">
            <a:extLst>
              <a:ext uri="{FF2B5EF4-FFF2-40B4-BE49-F238E27FC236}">
                <a16:creationId xmlns:a16="http://schemas.microsoft.com/office/drawing/2014/main" id="{1F68ABFE-5DCE-4BFE-8A1C-757FFB98E47D}"/>
              </a:ext>
            </a:extLst>
          </p:cNvPr>
          <p:cNvGraphicFramePr>
            <a:graphicFrameLocks/>
          </p:cNvGraphicFramePr>
          <p:nvPr>
            <p:extLst>
              <p:ext uri="{D42A27DB-BD31-4B8C-83A1-F6EECF244321}">
                <p14:modId xmlns:p14="http://schemas.microsoft.com/office/powerpoint/2010/main" val="3173576245"/>
              </p:ext>
            </p:extLst>
          </p:nvPr>
        </p:nvGraphicFramePr>
        <p:xfrm>
          <a:off x="591254" y="1042047"/>
          <a:ext cx="6646793" cy="4150841"/>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a:extLst>
              <a:ext uri="{FF2B5EF4-FFF2-40B4-BE49-F238E27FC236}">
                <a16:creationId xmlns:a16="http://schemas.microsoft.com/office/drawing/2014/main" id="{F07C4B85-6EB8-4FAC-AE8F-443E7E3FBBB5}"/>
              </a:ext>
            </a:extLst>
          </p:cNvPr>
          <p:cNvSpPr txBox="1"/>
          <p:nvPr/>
        </p:nvSpPr>
        <p:spPr>
          <a:xfrm>
            <a:off x="457200" y="5192888"/>
            <a:ext cx="6858000" cy="861774"/>
          </a:xfrm>
          <a:prstGeom prst="rect">
            <a:avLst/>
          </a:prstGeom>
          <a:solidFill>
            <a:schemeClr val="bg1"/>
          </a:solidFill>
        </p:spPr>
        <p:txBody>
          <a:bodyPr wrap="square" lIns="0" tIns="0" rIns="0" bIns="0" rtlCol="0">
            <a:spAutoFit/>
          </a:bodyPr>
          <a:lstStyle/>
          <a:p>
            <a:pPr algn="just"/>
            <a:r>
              <a:rPr lang="en-US" sz="1400" b="1" dirty="0">
                <a:latin typeface="Times New Roman" panose="02020603050405020304" pitchFamily="18" charset="0"/>
                <a:cs typeface="Times New Roman" panose="02020603050405020304" pitchFamily="18" charset="0"/>
              </a:rPr>
              <a:t>Figure S3.  </a:t>
            </a:r>
            <a:r>
              <a:rPr lang="en-US" sz="1400" dirty="0">
                <a:latin typeface="Times New Roman" panose="02020603050405020304" pitchFamily="18" charset="0"/>
                <a:cs typeface="Times New Roman" panose="02020603050405020304" pitchFamily="18" charset="0"/>
              </a:rPr>
              <a:t>Calibration curves derived from </a:t>
            </a:r>
            <a:r>
              <a:rPr lang="en-US" sz="1400" dirty="0" err="1">
                <a:latin typeface="Times New Roman" panose="02020603050405020304" pitchFamily="18" charset="0"/>
                <a:cs typeface="Times New Roman" panose="02020603050405020304" pitchFamily="18" charset="0"/>
              </a:rPr>
              <a:t>amperometric</a:t>
            </a:r>
            <a:r>
              <a:rPr lang="en-US" sz="1400" dirty="0">
                <a:latin typeface="Times New Roman" panose="02020603050405020304" pitchFamily="18" charset="0"/>
                <a:cs typeface="Times New Roman" panose="02020603050405020304" pitchFamily="18" charset="0"/>
              </a:rPr>
              <a:t> I-t curves during 40 mM injections of xanthine every 100 seconds at a modified electrode (Pt / TEES (</a:t>
            </a:r>
            <a:r>
              <a:rPr lang="en-US" sz="1400" dirty="0" err="1">
                <a:latin typeface="Times New Roman" panose="02020603050405020304" pitchFamily="18" charset="0"/>
                <a:cs typeface="Times New Roman" panose="02020603050405020304" pitchFamily="18" charset="0"/>
              </a:rPr>
              <a:t>XOx</a:t>
            </a:r>
            <a:r>
              <a:rPr lang="en-US" sz="1400" dirty="0">
                <a:latin typeface="Times New Roman" panose="02020603050405020304" pitchFamily="18" charset="0"/>
                <a:cs typeface="Times New Roman" panose="02020603050405020304" pitchFamily="18" charset="0"/>
              </a:rPr>
              <a:t>)  / PU (75:25)) where the TEES xerogel layer is aged for 24 hours and the amount of </a:t>
            </a:r>
            <a:r>
              <a:rPr lang="en-US" sz="1400" dirty="0" err="1">
                <a:latin typeface="Times New Roman" panose="02020603050405020304" pitchFamily="18" charset="0"/>
                <a:cs typeface="Times New Roman" panose="02020603050405020304" pitchFamily="18" charset="0"/>
              </a:rPr>
              <a:t>XOx</a:t>
            </a:r>
            <a:r>
              <a:rPr lang="en-US" sz="1400" dirty="0">
                <a:latin typeface="Times New Roman" panose="02020603050405020304" pitchFamily="18" charset="0"/>
                <a:cs typeface="Times New Roman" panose="02020603050405020304" pitchFamily="18" charset="0"/>
              </a:rPr>
              <a:t> enzyme in the silane precursor mixture used to form the xerogel is systematically varied (n = 3-4).   </a:t>
            </a:r>
            <a:endParaRPr lang="en-US" sz="14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0999764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08639DE0-F4FA-971E-6DD3-60B17DDD6713}"/>
              </a:ext>
            </a:extLst>
          </p:cNvPr>
          <p:cNvSpPr>
            <a:spLocks noGrp="1"/>
          </p:cNvSpPr>
          <p:nvPr>
            <p:ph type="sldNum" sz="quarter" idx="12"/>
          </p:nvPr>
        </p:nvSpPr>
        <p:spPr/>
        <p:txBody>
          <a:bodyPr/>
          <a:lstStyle/>
          <a:p>
            <a:r>
              <a:rPr lang="en-US"/>
              <a:t>S</a:t>
            </a:r>
            <a:fld id="{0DD34403-E6AF-9B44-8A22-D75A397E6552}" type="slidenum">
              <a:rPr lang="en-US" smtClean="0"/>
              <a:pPr/>
              <a:t>6</a:t>
            </a:fld>
            <a:endParaRPr lang="en-US"/>
          </a:p>
        </p:txBody>
      </p:sp>
      <p:sp>
        <p:nvSpPr>
          <p:cNvPr id="4" name="TextBox 3">
            <a:extLst>
              <a:ext uri="{FF2B5EF4-FFF2-40B4-BE49-F238E27FC236}">
                <a16:creationId xmlns:a16="http://schemas.microsoft.com/office/drawing/2014/main" id="{C7C0E639-0889-6C8D-07AB-943080AE9B5F}"/>
              </a:ext>
            </a:extLst>
          </p:cNvPr>
          <p:cNvSpPr txBox="1"/>
          <p:nvPr/>
        </p:nvSpPr>
        <p:spPr>
          <a:xfrm>
            <a:off x="685800" y="5414544"/>
            <a:ext cx="6400800" cy="2154436"/>
          </a:xfrm>
          <a:prstGeom prst="rect">
            <a:avLst/>
          </a:prstGeom>
          <a:solidFill>
            <a:schemeClr val="bg1"/>
          </a:solidFill>
        </p:spPr>
        <p:txBody>
          <a:bodyPr wrap="square" lIns="0" tIns="0" rIns="0" bIns="0" rtlCol="0">
            <a:spAutoFit/>
          </a:bodyPr>
          <a:lstStyle/>
          <a:p>
            <a:pPr algn="just"/>
            <a:r>
              <a:rPr lang="en-US" sz="1400" b="1" dirty="0">
                <a:latin typeface="Times New Roman" panose="02020603050405020304" pitchFamily="18" charset="0"/>
                <a:cs typeface="Times New Roman" panose="02020603050405020304" pitchFamily="18" charset="0"/>
              </a:rPr>
              <a:t>Scheme S2.  </a:t>
            </a:r>
            <a:r>
              <a:rPr lang="en-US" sz="1400" dirty="0">
                <a:latin typeface="Times New Roman" panose="02020603050405020304" pitchFamily="18" charset="0"/>
                <a:cs typeface="Times New Roman" panose="02020603050405020304" pitchFamily="18" charset="0"/>
              </a:rPr>
              <a:t>Schematic illustration of signal enhancement mechanism of the NP-doped xerogel featuring the </a:t>
            </a:r>
            <a:r>
              <a:rPr lang="en-US" sz="1400" b="1" dirty="0">
                <a:latin typeface="Times New Roman" panose="02020603050405020304" pitchFamily="18" charset="0"/>
                <a:cs typeface="Times New Roman" panose="02020603050405020304" pitchFamily="18" charset="0"/>
              </a:rPr>
              <a:t>MPC-network</a:t>
            </a:r>
            <a:r>
              <a:rPr lang="en-US" sz="1400" dirty="0">
                <a:latin typeface="Times New Roman" panose="02020603050405020304" pitchFamily="18" charset="0"/>
                <a:cs typeface="Times New Roman" panose="02020603050405020304" pitchFamily="18" charset="0"/>
              </a:rPr>
              <a:t> (Au-spheres).  </a:t>
            </a:r>
            <a:r>
              <a:rPr lang="en-US" sz="1400" b="1" dirty="0">
                <a:solidFill>
                  <a:srgbClr val="0000C1"/>
                </a:solidFill>
                <a:latin typeface="Times New Roman" panose="02020603050405020304" pitchFamily="18" charset="0"/>
                <a:cs typeface="Times New Roman" panose="02020603050405020304" pitchFamily="18" charset="0"/>
              </a:rPr>
              <a:t>XAN</a:t>
            </a:r>
            <a:r>
              <a:rPr lang="en-US" sz="1400" dirty="0">
                <a:latin typeface="Times New Roman" panose="02020603050405020304" pitchFamily="18" charset="0"/>
                <a:cs typeface="Times New Roman" panose="02020603050405020304" pitchFamily="18" charset="0"/>
              </a:rPr>
              <a:t> diffuses through the semi-permeable PU layer and into the </a:t>
            </a:r>
            <a:r>
              <a:rPr lang="en-US" sz="1400" b="1" dirty="0">
                <a:solidFill>
                  <a:srgbClr val="00B050"/>
                </a:solidFill>
                <a:latin typeface="Times New Roman" panose="02020603050405020304" pitchFamily="18" charset="0"/>
                <a:cs typeface="Times New Roman" panose="02020603050405020304" pitchFamily="18" charset="0"/>
              </a:rPr>
              <a:t>xerogel </a:t>
            </a:r>
            <a:r>
              <a:rPr lang="en-US" sz="1400" b="1" dirty="0">
                <a:latin typeface="Times New Roman" panose="02020603050405020304" pitchFamily="18" charset="0"/>
                <a:cs typeface="Times New Roman" panose="02020603050405020304" pitchFamily="18" charset="0"/>
              </a:rPr>
              <a:t>film, </a:t>
            </a:r>
            <a:r>
              <a:rPr lang="en-US" sz="1400" dirty="0">
                <a:latin typeface="Times New Roman" panose="02020603050405020304" pitchFamily="18" charset="0"/>
                <a:cs typeface="Times New Roman" panose="02020603050405020304" pitchFamily="18" charset="0"/>
              </a:rPr>
              <a:t>eventually reacting with embedded </a:t>
            </a:r>
            <a:r>
              <a:rPr lang="en-US" sz="1400" b="1" dirty="0" err="1">
                <a:latin typeface="Times New Roman" panose="02020603050405020304" pitchFamily="18" charset="0"/>
                <a:cs typeface="Times New Roman" panose="02020603050405020304" pitchFamily="18" charset="0"/>
              </a:rPr>
              <a:t>XOx</a:t>
            </a:r>
            <a:r>
              <a:rPr lang="en-US" sz="1400" dirty="0">
                <a:latin typeface="Times New Roman" panose="02020603050405020304" pitchFamily="18" charset="0"/>
                <a:cs typeface="Times New Roman" panose="02020603050405020304" pitchFamily="18" charset="0"/>
              </a:rPr>
              <a:t> to produce </a:t>
            </a:r>
            <a:r>
              <a:rPr lang="en-US" sz="1400" b="1" dirty="0">
                <a:solidFill>
                  <a:srgbClr val="BF005E"/>
                </a:solidFill>
                <a:latin typeface="Times New Roman" panose="02020603050405020304" pitchFamily="18" charset="0"/>
                <a:cs typeface="Times New Roman" panose="02020603050405020304" pitchFamily="18" charset="0"/>
              </a:rPr>
              <a:t>H</a:t>
            </a:r>
            <a:r>
              <a:rPr lang="en-US" sz="1400" b="1" baseline="-25000" dirty="0">
                <a:solidFill>
                  <a:srgbClr val="BF005E"/>
                </a:solidFill>
                <a:latin typeface="Times New Roman" panose="02020603050405020304" pitchFamily="18" charset="0"/>
                <a:cs typeface="Times New Roman" panose="02020603050405020304" pitchFamily="18" charset="0"/>
              </a:rPr>
              <a:t>2</a:t>
            </a:r>
            <a:r>
              <a:rPr lang="en-US" sz="1400" b="1" dirty="0">
                <a:solidFill>
                  <a:srgbClr val="BF005E"/>
                </a:solidFill>
                <a:latin typeface="Times New Roman" panose="02020603050405020304" pitchFamily="18" charset="0"/>
                <a:cs typeface="Times New Roman" panose="02020603050405020304" pitchFamily="18" charset="0"/>
              </a:rPr>
              <a:t>O</a:t>
            </a:r>
            <a:r>
              <a:rPr lang="en-US" sz="1400" b="1" baseline="-25000" dirty="0">
                <a:solidFill>
                  <a:srgbClr val="BF005E"/>
                </a:solidFill>
                <a:latin typeface="Times New Roman" panose="02020603050405020304" pitchFamily="18" charset="0"/>
                <a:cs typeface="Times New Roman" panose="02020603050405020304" pitchFamily="18" charset="0"/>
              </a:rPr>
              <a:t>2</a:t>
            </a:r>
            <a:r>
              <a:rPr lang="en-US" sz="1400" b="1" dirty="0">
                <a:solidFill>
                  <a:srgbClr val="BF005E"/>
                </a:solidFill>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which is subsequently and efficiently </a:t>
            </a:r>
            <a:r>
              <a:rPr lang="en-US" sz="1400" b="1" dirty="0">
                <a:solidFill>
                  <a:srgbClr val="FF0000"/>
                </a:solidFill>
                <a:latin typeface="Times New Roman" panose="02020603050405020304" pitchFamily="18" charset="0"/>
                <a:cs typeface="Times New Roman" panose="02020603050405020304" pitchFamily="18" charset="0"/>
              </a:rPr>
              <a:t>oxidized</a:t>
            </a:r>
            <a:r>
              <a:rPr lang="en-US" sz="1400" dirty="0">
                <a:latin typeface="Times New Roman" panose="02020603050405020304" pitchFamily="18" charset="0"/>
                <a:cs typeface="Times New Roman" panose="02020603050405020304" pitchFamily="18" charset="0"/>
              </a:rPr>
              <a:t> at the NPs in the film.   The electronic connectivity of the MPC-network, allows for fast electron transfer of the current signal to the Pt electrode transducer (</a:t>
            </a:r>
            <a:r>
              <a:rPr lang="en-US" sz="1400" dirty="0">
                <a:solidFill>
                  <a:srgbClr val="FF0000"/>
                </a:solidFill>
                <a:latin typeface="Times New Roman" panose="02020603050405020304" pitchFamily="18" charset="0"/>
                <a:cs typeface="Times New Roman" panose="02020603050405020304" pitchFamily="18" charset="0"/>
              </a:rPr>
              <a:t>▪▪▪▪▪▪▪▪▪</a:t>
            </a:r>
            <a:r>
              <a:rPr lang="en-US" sz="1400" dirty="0">
                <a:latin typeface="Times New Roman" panose="02020603050405020304" pitchFamily="18" charset="0"/>
                <a:cs typeface="Times New Roman" panose="02020603050405020304" pitchFamily="18" charset="0"/>
              </a:rPr>
              <a:t>). Analogous films without NP-doping require the </a:t>
            </a:r>
            <a:r>
              <a:rPr lang="en-US" sz="1400" b="1" dirty="0">
                <a:solidFill>
                  <a:srgbClr val="BF005E"/>
                </a:solidFill>
                <a:latin typeface="Times New Roman" panose="02020603050405020304" pitchFamily="18" charset="0"/>
                <a:cs typeface="Times New Roman" panose="02020603050405020304" pitchFamily="18" charset="0"/>
              </a:rPr>
              <a:t>H</a:t>
            </a:r>
            <a:r>
              <a:rPr lang="en-US" sz="1400" b="1" baseline="-25000" dirty="0">
                <a:solidFill>
                  <a:srgbClr val="BF005E"/>
                </a:solidFill>
                <a:latin typeface="Times New Roman" panose="02020603050405020304" pitchFamily="18" charset="0"/>
                <a:cs typeface="Times New Roman" panose="02020603050405020304" pitchFamily="18" charset="0"/>
              </a:rPr>
              <a:t>2</a:t>
            </a:r>
            <a:r>
              <a:rPr lang="en-US" sz="1400" b="1" dirty="0">
                <a:solidFill>
                  <a:srgbClr val="BF005E"/>
                </a:solidFill>
                <a:latin typeface="Times New Roman" panose="02020603050405020304" pitchFamily="18" charset="0"/>
                <a:cs typeface="Times New Roman" panose="02020603050405020304" pitchFamily="18" charset="0"/>
              </a:rPr>
              <a:t>O</a:t>
            </a:r>
            <a:r>
              <a:rPr lang="en-US" sz="1400" b="1" baseline="-25000" dirty="0">
                <a:solidFill>
                  <a:srgbClr val="BF005E"/>
                </a:solidFill>
                <a:latin typeface="Times New Roman" panose="02020603050405020304" pitchFamily="18" charset="0"/>
                <a:cs typeface="Times New Roman" panose="02020603050405020304" pitchFamily="18" charset="0"/>
              </a:rPr>
              <a:t>2</a:t>
            </a:r>
            <a:r>
              <a:rPr lang="en-US" sz="1400" b="1" dirty="0">
                <a:solidFill>
                  <a:srgbClr val="BF005E"/>
                </a:solidFill>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to diffuse through the film to the Pt electrode, thereby lowering sensitivity.</a:t>
            </a:r>
            <a:endParaRPr lang="en-US" sz="1400" b="1" dirty="0">
              <a:solidFill>
                <a:srgbClr val="BF005E"/>
              </a:solidFill>
              <a:latin typeface="Times New Roman" panose="02020603050405020304" pitchFamily="18" charset="0"/>
              <a:cs typeface="Times New Roman" panose="02020603050405020304" pitchFamily="18" charset="0"/>
            </a:endParaRPr>
          </a:p>
          <a:p>
            <a:pPr algn="just"/>
            <a:endParaRPr lang="en-US" sz="1400" b="1" dirty="0">
              <a:solidFill>
                <a:srgbClr val="FF0000"/>
              </a:solidFill>
              <a:latin typeface="Times New Roman" panose="02020603050405020304" pitchFamily="18" charset="0"/>
              <a:cs typeface="Times New Roman" panose="02020603050405020304" pitchFamily="18" charset="0"/>
            </a:endParaRPr>
          </a:p>
          <a:p>
            <a:pPr algn="just"/>
            <a:endParaRPr lang="en-US" sz="1400" b="1" dirty="0">
              <a:solidFill>
                <a:srgbClr val="FF0000"/>
              </a:solidFill>
              <a:latin typeface="Times New Roman" panose="02020603050405020304" pitchFamily="18" charset="0"/>
              <a:cs typeface="Times New Roman" panose="02020603050405020304" pitchFamily="18" charset="0"/>
            </a:endParaRPr>
          </a:p>
        </p:txBody>
      </p:sp>
      <p:pic>
        <p:nvPicPr>
          <p:cNvPr id="5" name="Picture 4">
            <a:extLst>
              <a:ext uri="{FF2B5EF4-FFF2-40B4-BE49-F238E27FC236}">
                <a16:creationId xmlns:a16="http://schemas.microsoft.com/office/drawing/2014/main" id="{6483B489-3A64-E8BF-DCF6-249FFA20E25C}"/>
              </a:ext>
            </a:extLst>
          </p:cNvPr>
          <p:cNvPicPr>
            <a:picLocks noChangeAspect="1"/>
          </p:cNvPicPr>
          <p:nvPr/>
        </p:nvPicPr>
        <p:blipFill>
          <a:blip r:embed="rId2"/>
          <a:stretch>
            <a:fillRect/>
          </a:stretch>
        </p:blipFill>
        <p:spPr>
          <a:xfrm>
            <a:off x="531114" y="387619"/>
            <a:ext cx="6710172" cy="4898136"/>
          </a:xfrm>
          <a:prstGeom prst="rect">
            <a:avLst/>
          </a:prstGeom>
        </p:spPr>
      </p:pic>
    </p:spTree>
    <p:extLst>
      <p:ext uri="{BB962C8B-B14F-4D97-AF65-F5344CB8AC3E}">
        <p14:creationId xmlns:p14="http://schemas.microsoft.com/office/powerpoint/2010/main" val="404983808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93D893A6-B4B5-4787-B8FC-2804A6874B9F}"/>
              </a:ext>
            </a:extLst>
          </p:cNvPr>
          <p:cNvSpPr>
            <a:spLocks noGrp="1"/>
          </p:cNvSpPr>
          <p:nvPr>
            <p:ph type="sldNum" sz="quarter" idx="12"/>
          </p:nvPr>
        </p:nvSpPr>
        <p:spPr/>
        <p:txBody>
          <a:bodyPr/>
          <a:lstStyle/>
          <a:p>
            <a:r>
              <a:rPr lang="en-US"/>
              <a:t>S</a:t>
            </a:r>
            <a:fld id="{0DD34403-E6AF-9B44-8A22-D75A397E6552}" type="slidenum">
              <a:rPr lang="en-US" smtClean="0"/>
              <a:pPr/>
              <a:t>7</a:t>
            </a:fld>
            <a:endParaRPr lang="en-US"/>
          </a:p>
        </p:txBody>
      </p:sp>
      <p:graphicFrame>
        <p:nvGraphicFramePr>
          <p:cNvPr id="6" name="Chart 5">
            <a:extLst>
              <a:ext uri="{FF2B5EF4-FFF2-40B4-BE49-F238E27FC236}">
                <a16:creationId xmlns:a16="http://schemas.microsoft.com/office/drawing/2014/main" id="{C7FE1462-BEEF-46F2-A001-AEA0099B43A0}"/>
              </a:ext>
            </a:extLst>
          </p:cNvPr>
          <p:cNvGraphicFramePr>
            <a:graphicFrameLocks/>
          </p:cNvGraphicFramePr>
          <p:nvPr>
            <p:extLst>
              <p:ext uri="{D42A27DB-BD31-4B8C-83A1-F6EECF244321}">
                <p14:modId xmlns:p14="http://schemas.microsoft.com/office/powerpoint/2010/main" val="2221678398"/>
              </p:ext>
            </p:extLst>
          </p:nvPr>
        </p:nvGraphicFramePr>
        <p:xfrm>
          <a:off x="685800" y="648191"/>
          <a:ext cx="6400800" cy="4572000"/>
        </p:xfrm>
        <a:graphic>
          <a:graphicData uri="http://schemas.openxmlformats.org/drawingml/2006/chart">
            <c:chart xmlns:c="http://schemas.openxmlformats.org/drawingml/2006/chart" xmlns:r="http://schemas.openxmlformats.org/officeDocument/2006/relationships" r:id="rId2"/>
          </a:graphicData>
        </a:graphic>
      </p:graphicFrame>
      <p:sp>
        <p:nvSpPr>
          <p:cNvPr id="7" name="TextBox 6">
            <a:extLst>
              <a:ext uri="{FF2B5EF4-FFF2-40B4-BE49-F238E27FC236}">
                <a16:creationId xmlns:a16="http://schemas.microsoft.com/office/drawing/2014/main" id="{5086E33F-8DD5-475D-B731-A74D8CE6F758}"/>
              </a:ext>
            </a:extLst>
          </p:cNvPr>
          <p:cNvSpPr txBox="1"/>
          <p:nvPr/>
        </p:nvSpPr>
        <p:spPr>
          <a:xfrm>
            <a:off x="685800" y="5285755"/>
            <a:ext cx="6400800" cy="1077218"/>
          </a:xfrm>
          <a:prstGeom prst="rect">
            <a:avLst/>
          </a:prstGeom>
          <a:solidFill>
            <a:schemeClr val="bg1"/>
          </a:solidFill>
        </p:spPr>
        <p:txBody>
          <a:bodyPr wrap="square" lIns="0" tIns="0" rIns="0" bIns="0" rtlCol="0">
            <a:spAutoFit/>
          </a:bodyPr>
          <a:lstStyle/>
          <a:p>
            <a:pPr algn="just"/>
            <a:r>
              <a:rPr lang="en-US" sz="1400" b="1" dirty="0">
                <a:latin typeface="Times New Roman" panose="02020603050405020304" pitchFamily="18" charset="0"/>
                <a:cs typeface="Times New Roman" panose="02020603050405020304" pitchFamily="18" charset="0"/>
              </a:rPr>
              <a:t>Figure S4.  </a:t>
            </a:r>
            <a:r>
              <a:rPr lang="en-US" sz="1400" dirty="0">
                <a:latin typeface="Times New Roman" panose="02020603050405020304" pitchFamily="18" charset="0"/>
                <a:cs typeface="Times New Roman" panose="02020603050405020304" pitchFamily="18" charset="0"/>
              </a:rPr>
              <a:t>Calibration curves derived from </a:t>
            </a:r>
            <a:r>
              <a:rPr lang="en-US" sz="1400" dirty="0" err="1">
                <a:latin typeface="Times New Roman" panose="02020603050405020304" pitchFamily="18" charset="0"/>
                <a:cs typeface="Times New Roman" panose="02020603050405020304" pitchFamily="18" charset="0"/>
              </a:rPr>
              <a:t>amperometric</a:t>
            </a:r>
            <a:r>
              <a:rPr lang="en-US" sz="1400" dirty="0">
                <a:latin typeface="Times New Roman" panose="02020603050405020304" pitchFamily="18" charset="0"/>
                <a:cs typeface="Times New Roman" panose="02020603050405020304" pitchFamily="18" charset="0"/>
              </a:rPr>
              <a:t> I-t curves during 40 mM injections of xanthine every 100 seconds at a modified electrode (Pt / TEES (</a:t>
            </a:r>
            <a:r>
              <a:rPr lang="en-US" sz="1400" dirty="0" err="1">
                <a:latin typeface="Times New Roman" panose="02020603050405020304" pitchFamily="18" charset="0"/>
                <a:cs typeface="Times New Roman" panose="02020603050405020304" pitchFamily="18" charset="0"/>
              </a:rPr>
              <a:t>XOx</a:t>
            </a:r>
            <a:r>
              <a:rPr lang="en-US" sz="1400" dirty="0">
                <a:latin typeface="Times New Roman" panose="02020603050405020304" pitchFamily="18" charset="0"/>
                <a:cs typeface="Times New Roman" panose="02020603050405020304" pitchFamily="18" charset="0"/>
              </a:rPr>
              <a:t>)  / PU (75:25)) where the TEES xerogel layer is aged for 24 hours and doped with C3, C4, or C6 MPCs. Note: An undoped system (i.e., TEES xerogel without MPCs incorporated in the xerogel) is included for comparison (n = 3-5). </a:t>
            </a:r>
            <a:endParaRPr lang="en-US" sz="14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050951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a:extLst>
              <a:ext uri="{FF2B5EF4-FFF2-40B4-BE49-F238E27FC236}">
                <a16:creationId xmlns:a16="http://schemas.microsoft.com/office/drawing/2014/main" id="{93D893A6-B4B5-4787-B8FC-2804A6874B9F}"/>
              </a:ext>
            </a:extLst>
          </p:cNvPr>
          <p:cNvSpPr>
            <a:spLocks noGrp="1"/>
          </p:cNvSpPr>
          <p:nvPr>
            <p:ph type="sldNum" sz="quarter" idx="12"/>
          </p:nvPr>
        </p:nvSpPr>
        <p:spPr/>
        <p:txBody>
          <a:bodyPr/>
          <a:lstStyle/>
          <a:p>
            <a:r>
              <a:rPr lang="en-US"/>
              <a:t>S</a:t>
            </a:r>
            <a:fld id="{0DD34403-E6AF-9B44-8A22-D75A397E6552}" type="slidenum">
              <a:rPr lang="en-US" smtClean="0"/>
              <a:pPr/>
              <a:t>8</a:t>
            </a:fld>
            <a:endParaRPr lang="en-US"/>
          </a:p>
        </p:txBody>
      </p:sp>
      <p:sp>
        <p:nvSpPr>
          <p:cNvPr id="4" name="Slide Number Placeholder 1">
            <a:extLst>
              <a:ext uri="{FF2B5EF4-FFF2-40B4-BE49-F238E27FC236}">
                <a16:creationId xmlns:a16="http://schemas.microsoft.com/office/drawing/2014/main" id="{FDF8ABD5-7597-48CF-AEB1-096753EB2F3F}"/>
              </a:ext>
            </a:extLst>
          </p:cNvPr>
          <p:cNvSpPr txBox="1">
            <a:spLocks/>
          </p:cNvSpPr>
          <p:nvPr/>
        </p:nvSpPr>
        <p:spPr>
          <a:xfrm>
            <a:off x="7646010" y="7203865"/>
            <a:ext cx="2263140" cy="413808"/>
          </a:xfrm>
          <a:prstGeom prst="rect">
            <a:avLst/>
          </a:prstGeom>
        </p:spPr>
        <p:txBody>
          <a:bodyPr vert="horz" lIns="91440" tIns="45720" rIns="91440" bIns="45720" rtlCol="0" anchor="ctr"/>
          <a:lstStyle>
            <a:defPPr>
              <a:defRPr lang="en-US"/>
            </a:defPPr>
            <a:lvl1pPr marL="0" algn="r" defTabSz="914400" rtl="0" eaLnBrk="1" latinLnBrk="0" hangingPunct="1">
              <a:defRPr sz="1200" b="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CAB36CEA-80F1-4F16-9E50-AE765B148A58}" type="slidenum">
              <a:rPr lang="en-US" smtClean="0">
                <a:latin typeface="Arial" panose="020B0604020202020204" pitchFamily="34" charset="0"/>
                <a:cs typeface="Arial" panose="020B0604020202020204" pitchFamily="34" charset="0"/>
              </a:rPr>
              <a:pPr/>
              <a:t>8</a:t>
            </a:fld>
            <a:endParaRPr lang="en-US" dirty="0">
              <a:latin typeface="Arial" panose="020B0604020202020204" pitchFamily="34" charset="0"/>
              <a:cs typeface="Arial" panose="020B0604020202020204" pitchFamily="34" charset="0"/>
            </a:endParaRPr>
          </a:p>
        </p:txBody>
      </p:sp>
      <p:graphicFrame>
        <p:nvGraphicFramePr>
          <p:cNvPr id="5" name="Chart 4">
            <a:extLst>
              <a:ext uri="{FF2B5EF4-FFF2-40B4-BE49-F238E27FC236}">
                <a16:creationId xmlns:a16="http://schemas.microsoft.com/office/drawing/2014/main" id="{DD4F2102-76F0-45CC-B8BF-8F6A04A56761}"/>
              </a:ext>
            </a:extLst>
          </p:cNvPr>
          <p:cNvGraphicFramePr>
            <a:graphicFrameLocks/>
          </p:cNvGraphicFramePr>
          <p:nvPr>
            <p:extLst>
              <p:ext uri="{D42A27DB-BD31-4B8C-83A1-F6EECF244321}">
                <p14:modId xmlns:p14="http://schemas.microsoft.com/office/powerpoint/2010/main" val="2819826568"/>
              </p:ext>
            </p:extLst>
          </p:nvPr>
        </p:nvGraphicFramePr>
        <p:xfrm>
          <a:off x="457200" y="748065"/>
          <a:ext cx="6858000" cy="5513837"/>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a:extLst>
              <a:ext uri="{FF2B5EF4-FFF2-40B4-BE49-F238E27FC236}">
                <a16:creationId xmlns:a16="http://schemas.microsoft.com/office/drawing/2014/main" id="{C4B9405C-685F-4A8A-81FC-1CA89F77D1C2}"/>
              </a:ext>
            </a:extLst>
          </p:cNvPr>
          <p:cNvSpPr txBox="1"/>
          <p:nvPr/>
        </p:nvSpPr>
        <p:spPr>
          <a:xfrm>
            <a:off x="685800" y="6509877"/>
            <a:ext cx="6400800" cy="1292662"/>
          </a:xfrm>
          <a:prstGeom prst="rect">
            <a:avLst/>
          </a:prstGeom>
          <a:solidFill>
            <a:schemeClr val="bg1"/>
          </a:solidFill>
        </p:spPr>
        <p:txBody>
          <a:bodyPr wrap="square" lIns="0" tIns="0" rIns="0" bIns="0" rtlCol="0">
            <a:spAutoFit/>
          </a:bodyPr>
          <a:lstStyle/>
          <a:p>
            <a:pPr algn="just"/>
            <a:r>
              <a:rPr lang="en-US" sz="1400" b="1" dirty="0">
                <a:latin typeface="Times New Roman" panose="02020603050405020304" pitchFamily="18" charset="0"/>
                <a:cs typeface="Times New Roman" panose="02020603050405020304" pitchFamily="18" charset="0"/>
              </a:rPr>
              <a:t>Figure S5.  </a:t>
            </a:r>
            <a:r>
              <a:rPr lang="en-US" sz="1400" dirty="0">
                <a:latin typeface="Times New Roman" panose="02020603050405020304" pitchFamily="18" charset="0"/>
                <a:cs typeface="Times New Roman" panose="02020603050405020304" pitchFamily="18" charset="0"/>
              </a:rPr>
              <a:t>Calibration curves derived from </a:t>
            </a:r>
            <a:r>
              <a:rPr lang="en-US" sz="1400" dirty="0" err="1">
                <a:latin typeface="Times New Roman" panose="02020603050405020304" pitchFamily="18" charset="0"/>
                <a:cs typeface="Times New Roman" panose="02020603050405020304" pitchFamily="18" charset="0"/>
              </a:rPr>
              <a:t>amperometric</a:t>
            </a:r>
            <a:r>
              <a:rPr lang="en-US" sz="1400" dirty="0">
                <a:latin typeface="Times New Roman" panose="02020603050405020304" pitchFamily="18" charset="0"/>
                <a:cs typeface="Times New Roman" panose="02020603050405020304" pitchFamily="18" charset="0"/>
              </a:rPr>
              <a:t> I-t curves during 40 mM injections of xanthine every 100 seconds at a modified electrode (Pt / HMTES (</a:t>
            </a:r>
            <a:r>
              <a:rPr lang="en-US" sz="1400" dirty="0" err="1">
                <a:latin typeface="Times New Roman" panose="02020603050405020304" pitchFamily="18" charset="0"/>
                <a:cs typeface="Times New Roman" panose="02020603050405020304" pitchFamily="18" charset="0"/>
              </a:rPr>
              <a:t>XOx</a:t>
            </a:r>
            <a:r>
              <a:rPr lang="en-US" sz="1400" dirty="0">
                <a:latin typeface="Times New Roman" panose="02020603050405020304" pitchFamily="18" charset="0"/>
                <a:cs typeface="Times New Roman" panose="02020603050405020304" pitchFamily="18" charset="0"/>
              </a:rPr>
              <a:t>)  / PU (75:25)) where the HMTES xerogels of either a single layer (closed symbols) or two layers (open symbols) are aged for 48 hours and doped with C3, C4, or C6 MPCs. Note: An undoped systems (black symbols) without MPCs incorporated in the xerogel are included for comparison.   </a:t>
            </a:r>
            <a:endParaRPr lang="en-US" sz="14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95719856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a:extLst>
              <a:ext uri="{FF2B5EF4-FFF2-40B4-BE49-F238E27FC236}">
                <a16:creationId xmlns:a16="http://schemas.microsoft.com/office/drawing/2014/main" id="{9AEF80C4-78CD-4C41-9033-8151E74DB5B1}"/>
              </a:ext>
            </a:extLst>
          </p:cNvPr>
          <p:cNvGraphicFramePr>
            <a:graphicFrameLocks/>
          </p:cNvGraphicFramePr>
          <p:nvPr>
            <p:extLst>
              <p:ext uri="{D42A27DB-BD31-4B8C-83A1-F6EECF244321}">
                <p14:modId xmlns:p14="http://schemas.microsoft.com/office/powerpoint/2010/main" val="1578173041"/>
              </p:ext>
            </p:extLst>
          </p:nvPr>
        </p:nvGraphicFramePr>
        <p:xfrm>
          <a:off x="457200" y="5029200"/>
          <a:ext cx="6858000" cy="3730210"/>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a:extLst>
              <a:ext uri="{FF2B5EF4-FFF2-40B4-BE49-F238E27FC236}">
                <a16:creationId xmlns:a16="http://schemas.microsoft.com/office/drawing/2014/main" id="{BF790705-D999-483B-979B-BB7FA27B3824}"/>
              </a:ext>
            </a:extLst>
          </p:cNvPr>
          <p:cNvSpPr txBox="1"/>
          <p:nvPr/>
        </p:nvSpPr>
        <p:spPr>
          <a:xfrm>
            <a:off x="508423" y="8759410"/>
            <a:ext cx="6858000" cy="738664"/>
          </a:xfrm>
          <a:prstGeom prst="rect">
            <a:avLst/>
          </a:prstGeom>
          <a:solidFill>
            <a:schemeClr val="bg1"/>
          </a:solidFill>
        </p:spPr>
        <p:txBody>
          <a:bodyPr wrap="square" lIns="0" tIns="0" rIns="0" bIns="0" rtlCol="0">
            <a:spAutoFit/>
          </a:bodyPr>
          <a:lstStyle/>
          <a:p>
            <a:pPr algn="just"/>
            <a:r>
              <a:rPr lang="en-US" sz="1200" b="1" dirty="0">
                <a:latin typeface="Times New Roman" panose="02020603050405020304" pitchFamily="18" charset="0"/>
                <a:cs typeface="Times New Roman" panose="02020603050405020304" pitchFamily="18" charset="0"/>
              </a:rPr>
              <a:t>Figure S6.  </a:t>
            </a:r>
            <a:r>
              <a:rPr lang="en-US" sz="1200" dirty="0">
                <a:latin typeface="Times New Roman" panose="02020603050405020304" pitchFamily="18" charset="0"/>
                <a:cs typeface="Times New Roman" panose="02020603050405020304" pitchFamily="18" charset="0"/>
              </a:rPr>
              <a:t>Calibration curves derived from </a:t>
            </a:r>
            <a:r>
              <a:rPr lang="en-US" sz="1200" dirty="0" err="1">
                <a:latin typeface="Times New Roman" panose="02020603050405020304" pitchFamily="18" charset="0"/>
                <a:cs typeface="Times New Roman" panose="02020603050405020304" pitchFamily="18" charset="0"/>
              </a:rPr>
              <a:t>amperometric</a:t>
            </a:r>
            <a:r>
              <a:rPr lang="en-US" sz="1200" dirty="0">
                <a:latin typeface="Times New Roman" panose="02020603050405020304" pitchFamily="18" charset="0"/>
                <a:cs typeface="Times New Roman" panose="02020603050405020304" pitchFamily="18" charset="0"/>
              </a:rPr>
              <a:t> I-t curves during 40 mM injections of xanthine every 100 seconds at a modified electrode (Pt / HMTES (</a:t>
            </a:r>
            <a:r>
              <a:rPr lang="en-US" sz="1200" dirty="0" err="1">
                <a:latin typeface="Times New Roman" panose="02020603050405020304" pitchFamily="18" charset="0"/>
                <a:cs typeface="Times New Roman" panose="02020603050405020304" pitchFamily="18" charset="0"/>
              </a:rPr>
              <a:t>XOx</a:t>
            </a:r>
            <a:r>
              <a:rPr lang="en-US" sz="1200" dirty="0">
                <a:latin typeface="Times New Roman" panose="02020603050405020304" pitchFamily="18" charset="0"/>
                <a:cs typeface="Times New Roman" panose="02020603050405020304" pitchFamily="18" charset="0"/>
              </a:rPr>
              <a:t>)  / PU (75:25)) with 1 layer of MPC doped or undoped HMTES (</a:t>
            </a:r>
            <a:r>
              <a:rPr lang="en-US" sz="1200" b="1" dirty="0">
                <a:latin typeface="Times New Roman" panose="02020603050405020304" pitchFamily="18" charset="0"/>
                <a:cs typeface="Times New Roman" panose="02020603050405020304" pitchFamily="18" charset="0"/>
              </a:rPr>
              <a:t>top</a:t>
            </a:r>
            <a:r>
              <a:rPr lang="en-US" sz="1200" dirty="0">
                <a:latin typeface="Times New Roman" panose="02020603050405020304" pitchFamily="18" charset="0"/>
                <a:cs typeface="Times New Roman" panose="02020603050405020304" pitchFamily="18" charset="0"/>
              </a:rPr>
              <a:t>) or two layers of doped or undoped HMTES xerogels </a:t>
            </a:r>
            <a:r>
              <a:rPr lang="en-US" sz="1200" b="1" dirty="0">
                <a:latin typeface="Times New Roman" panose="02020603050405020304" pitchFamily="18" charset="0"/>
                <a:cs typeface="Times New Roman" panose="02020603050405020304" pitchFamily="18" charset="0"/>
              </a:rPr>
              <a:t>(bottom</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Note: Xerogels are aged 48 hours and only the first layer is doped with MPCs.  </a:t>
            </a:r>
            <a:endParaRPr lang="en-US" sz="1200" b="1" dirty="0">
              <a:latin typeface="Times New Roman" panose="02020603050405020304" pitchFamily="18" charset="0"/>
              <a:cs typeface="Times New Roman" panose="02020603050405020304" pitchFamily="18" charset="0"/>
            </a:endParaRPr>
          </a:p>
        </p:txBody>
      </p:sp>
      <p:sp>
        <p:nvSpPr>
          <p:cNvPr id="3" name="Slide Number Placeholder 2">
            <a:extLst>
              <a:ext uri="{FF2B5EF4-FFF2-40B4-BE49-F238E27FC236}">
                <a16:creationId xmlns:a16="http://schemas.microsoft.com/office/drawing/2014/main" id="{93D893A6-B4B5-4787-B8FC-2804A6874B9F}"/>
              </a:ext>
            </a:extLst>
          </p:cNvPr>
          <p:cNvSpPr>
            <a:spLocks noGrp="1"/>
          </p:cNvSpPr>
          <p:nvPr>
            <p:ph type="sldNum" sz="quarter" idx="12"/>
          </p:nvPr>
        </p:nvSpPr>
        <p:spPr/>
        <p:txBody>
          <a:bodyPr/>
          <a:lstStyle/>
          <a:p>
            <a:r>
              <a:rPr lang="en-US"/>
              <a:t>S</a:t>
            </a:r>
            <a:fld id="{0DD34403-E6AF-9B44-8A22-D75A397E6552}" type="slidenum">
              <a:rPr lang="en-US" smtClean="0"/>
              <a:pPr/>
              <a:t>9</a:t>
            </a:fld>
            <a:endParaRPr lang="en-US"/>
          </a:p>
        </p:txBody>
      </p:sp>
      <p:graphicFrame>
        <p:nvGraphicFramePr>
          <p:cNvPr id="4" name="Chart 3">
            <a:extLst>
              <a:ext uri="{FF2B5EF4-FFF2-40B4-BE49-F238E27FC236}">
                <a16:creationId xmlns:a16="http://schemas.microsoft.com/office/drawing/2014/main" id="{59EB9760-B7B8-41AA-B14E-596BB499A898}"/>
              </a:ext>
            </a:extLst>
          </p:cNvPr>
          <p:cNvGraphicFramePr>
            <a:graphicFrameLocks/>
          </p:cNvGraphicFramePr>
          <p:nvPr>
            <p:extLst>
              <p:ext uri="{D42A27DB-BD31-4B8C-83A1-F6EECF244321}">
                <p14:modId xmlns:p14="http://schemas.microsoft.com/office/powerpoint/2010/main" val="1370339372"/>
              </p:ext>
            </p:extLst>
          </p:nvPr>
        </p:nvGraphicFramePr>
        <p:xfrm>
          <a:off x="457200" y="578732"/>
          <a:ext cx="6858000" cy="4090376"/>
        </p:xfrm>
        <a:graphic>
          <a:graphicData uri="http://schemas.openxmlformats.org/drawingml/2006/chart">
            <c:chart xmlns:c="http://schemas.openxmlformats.org/drawingml/2006/chart" xmlns:r="http://schemas.openxmlformats.org/officeDocument/2006/relationships" r:id="rId4"/>
          </a:graphicData>
        </a:graphic>
      </p:graphicFrame>
    </p:spTree>
    <p:extLst>
      <p:ext uri="{BB962C8B-B14F-4D97-AF65-F5344CB8AC3E}">
        <p14:creationId xmlns:p14="http://schemas.microsoft.com/office/powerpoint/2010/main" val="71400485"/>
      </p:ext>
    </p:extLst>
  </p:cSld>
  <p:clrMapOvr>
    <a:masterClrMapping/>
  </p:clrMapOvr>
</p:sld>
</file>

<file path=ppt/theme/theme1.xml><?xml version="1.0" encoding="utf-8"?>
<a:theme xmlns:a="http://schemas.openxmlformats.org/drawingml/2006/main" name="Office Theme">
  <a:themeElements>
    <a:clrScheme name="Custom 1">
      <a:dk1>
        <a:srgbClr val="000000"/>
      </a:dk1>
      <a:lt1>
        <a:srgbClr val="FFFFFF"/>
      </a:lt1>
      <a:dk2>
        <a:srgbClr val="44546A"/>
      </a:dk2>
      <a:lt2>
        <a:srgbClr val="E7E6E6"/>
      </a:lt2>
      <a:accent1>
        <a:srgbClr val="4472C4"/>
      </a:accent1>
      <a:accent2>
        <a:srgbClr val="ED7D31"/>
      </a:accent2>
      <a:accent3>
        <a:srgbClr val="000000"/>
      </a:accent3>
      <a:accent4>
        <a:srgbClr val="FFC000"/>
      </a:accent4>
      <a:accent5>
        <a:srgbClr val="5B9BD5"/>
      </a:accent5>
      <a:accent6>
        <a:srgbClr val="70AD47"/>
      </a:accent6>
      <a:hlink>
        <a:srgbClr val="0563C1"/>
      </a:hlink>
      <a:folHlink>
        <a:srgbClr val="954F72"/>
      </a:folHlink>
    </a:clrScheme>
    <a:fontScheme name="Custom 1">
      <a:majorFont>
        <a:latin typeface="Times New Roman"/>
        <a:ea typeface=""/>
        <a:cs typeface=""/>
      </a:majorFont>
      <a:minorFont>
        <a:latin typeface="Times New Roman"/>
        <a:ea typeface=""/>
        <a:cs typeface=""/>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0</TotalTime>
  <Words>1859</Words>
  <Application>Microsoft Office PowerPoint</Application>
  <PresentationFormat>Custom</PresentationFormat>
  <Paragraphs>159</Paragraphs>
  <Slides>18</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8</vt:i4>
      </vt:variant>
    </vt:vector>
  </HeadingPairs>
  <TitlesOfParts>
    <vt:vector size="22" baseType="lpstr">
      <vt:lpstr>Arial</vt:lpstr>
      <vt:lpstr>Calibri</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eopold, Leo</dc:creator>
  <cp:lastModifiedBy>Leopold, Leo</cp:lastModifiedBy>
  <cp:revision>754</cp:revision>
  <cp:lastPrinted>2023-05-24T17:12:51Z</cp:lastPrinted>
  <dcterms:created xsi:type="dcterms:W3CDTF">2018-07-11T13:19:33Z</dcterms:created>
  <dcterms:modified xsi:type="dcterms:W3CDTF">2023-05-24T17:19:49Z</dcterms:modified>
</cp:coreProperties>
</file>